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216" r:id="rId2"/>
    <p:sldId id="2235" r:id="rId3"/>
    <p:sldId id="2296" r:id="rId4"/>
    <p:sldId id="2270" r:id="rId5"/>
    <p:sldId id="2198" r:id="rId6"/>
    <p:sldId id="2131" r:id="rId7"/>
    <p:sldId id="2282" r:id="rId8"/>
    <p:sldId id="2278" r:id="rId9"/>
    <p:sldId id="245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47"/>
    <a:srgbClr val="F87A24"/>
    <a:srgbClr val="0A04EC"/>
    <a:srgbClr val="048EEC"/>
    <a:srgbClr val="699BFF"/>
    <a:srgbClr val="C630B4"/>
    <a:srgbClr val="0091C4"/>
    <a:srgbClr val="EE0000"/>
    <a:srgbClr val="FFFFFF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99" autoAdjust="0"/>
    <p:restoredTop sz="92615" autoAdjust="0"/>
  </p:normalViewPr>
  <p:slideViewPr>
    <p:cSldViewPr snapToGrid="0">
      <p:cViewPr varScale="1">
        <p:scale>
          <a:sx n="54" d="100"/>
          <a:sy n="54" d="100"/>
        </p:scale>
        <p:origin x="11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-1928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ADFE2B-9585-4CCE-AB42-2CA000B2A90E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DF26E0-AE71-4E16-BE84-5BC0C2DD5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503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DF26E0-AE71-4E16-BE84-5BC0C2DD543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900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98D81-67D9-4F63-9EC6-BBF5B54961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E121CE-F31E-4FE4-B9A9-2253A67B48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0EA3E4-B81A-4A28-A6D4-326C7C32F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3B3C1D-71A1-4828-AFCA-0F352CB2C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81F3F-DD21-4704-B879-2004939AD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330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2B25D7-B7EB-4E85-BC32-E98C9F8B1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69F682-FC24-41FD-B4D2-785C5EE787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C1C33-91D6-40D3-9DD6-C099C3B9A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BE708-2624-4486-AFD6-A7398D153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F007C6-A398-47BF-96AB-D2E13E465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887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9327F3-A150-4F38-97B6-2F6BC4A733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8CA4B7-822E-487C-AA0D-305EFF4E33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B03AA6-16D1-4DA3-8825-AEFEB35B1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AEE3B-0E1A-4B7F-9B11-B0D4ACA09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03A2D-06D5-449C-9370-CBAA01EE2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71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DA83F-E783-434D-B975-6CB580489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ED35CA-D702-4953-A8FF-52734A44D3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65A0D-41B3-4171-87E6-6636AD37A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03FF49-AF8C-4B72-B073-2C107D6CC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0920C1-45F0-4B53-BD9B-5ACF1ED59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551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D9C6A-9C0E-4928-99EC-37153D904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15D5BE-551E-4817-8561-80B702CEE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9A9D1-E372-4D6B-98CD-2213C17A9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9F4DA-7A09-49F5-8DD2-945CCA990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692CA7-5833-4559-8AB1-9D9C61048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567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7D42A-6870-41DD-BBE5-A2C82C868E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F74B1C-D424-443D-9BB8-5AFE910074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1EBE15-4FCD-4C58-A82A-0A4A48CB8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BDF19B-F2A0-4F73-BD46-56D2CA2D4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937991-7670-445D-8AF4-4C68E0411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EAA50-ED50-4736-92A4-669DC0C7D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765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DFDE51-1427-481D-8AA0-7BABBABDD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D763C2-8103-4558-A52A-1CBD6E90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475AA2-67A4-446B-A989-745B132E9A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E37FCE-1F61-4FD4-8DA8-1B02526AE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E340CF-D4C4-46C5-AB79-C3CE74AF6C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B8EA5E-F9D9-4EB8-A0C7-E174BD721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2C07F3-0B8A-433B-B352-75DBDCDDE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B05716-0EF1-4F2D-9409-D9BC0E243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01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F29F2-5EAC-4EF5-96B0-2B8038814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EE928F-5C47-4A90-B427-10D6CB627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9BC2F0-43BB-4E52-8886-A11877B9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63A699-D270-4B99-81D4-18CFD56CD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56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09F3F2-187B-4B84-9248-587058FB9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E134FF-5B41-4437-A7C8-BD2F9EDEC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8C8AAF-10A7-4C24-8704-EC12BFDED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922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C5A6B-7910-4B66-882B-D0F20270AD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3CD0-1ECB-4CC8-8FF4-1F4B1470A9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76679E-F910-47CF-8069-0B451676FC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BFB112-8134-4278-97AE-AA7A8F924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BAD415-36E8-4962-A662-A9EFEA8DC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ADCEA3-5288-4AD4-9C73-90C449D0E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331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BF3C5-0325-4D49-A2B4-C2104B1BB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880CAF-F94C-4CA1-9FA7-DC91C76984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6B37D-69EA-4ECA-A2FE-A4655DF63E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F33D5C-072D-43B8-A5E1-A86EDB5D5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296ECA-F46B-49D8-A8EA-C35B23F49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517718-B361-4B61-9354-7465ACD32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7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326541-8F91-4382-A53E-27C605AA4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622BD-4F31-4471-A88C-0F68253121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67B1D-788E-4738-B097-18410CF253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5E1C3-708A-477A-ACE1-75D95F64C17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3B1A0B-AF9E-43A5-98FC-4B312C39C6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4F5E5-8B71-4F25-B525-3F5F754515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51E85-FF89-4B09-AF29-1C56DC26A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98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7.emf"/><Relationship Id="rId18" Type="http://schemas.openxmlformats.org/officeDocument/2006/relationships/oleObject" Target="../embeddings/oleObject10.bin"/><Relationship Id="rId26" Type="http://schemas.openxmlformats.org/officeDocument/2006/relationships/oleObject" Target="../embeddings/oleObject14.bin"/><Relationship Id="rId3" Type="http://schemas.openxmlformats.org/officeDocument/2006/relationships/image" Target="../media/image2.emf"/><Relationship Id="rId21" Type="http://schemas.openxmlformats.org/officeDocument/2006/relationships/image" Target="../media/image11.emf"/><Relationship Id="rId34" Type="http://schemas.openxmlformats.org/officeDocument/2006/relationships/oleObject" Target="../embeddings/oleObject18.bin"/><Relationship Id="rId7" Type="http://schemas.openxmlformats.org/officeDocument/2006/relationships/image" Target="../media/image4.emf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9.emf"/><Relationship Id="rId25" Type="http://schemas.openxmlformats.org/officeDocument/2006/relationships/image" Target="../media/image13.emf"/><Relationship Id="rId33" Type="http://schemas.openxmlformats.org/officeDocument/2006/relationships/image" Target="../media/image17.emf"/><Relationship Id="rId2" Type="http://schemas.openxmlformats.org/officeDocument/2006/relationships/oleObject" Target="../embeddings/oleObject2.bin"/><Relationship Id="rId16" Type="http://schemas.openxmlformats.org/officeDocument/2006/relationships/oleObject" Target="../embeddings/oleObject9.bin"/><Relationship Id="rId20" Type="http://schemas.openxmlformats.org/officeDocument/2006/relationships/oleObject" Target="../embeddings/oleObject11.bin"/><Relationship Id="rId29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24" Type="http://schemas.openxmlformats.org/officeDocument/2006/relationships/oleObject" Target="../embeddings/oleObject13.bin"/><Relationship Id="rId32" Type="http://schemas.openxmlformats.org/officeDocument/2006/relationships/oleObject" Target="../embeddings/oleObject17.bin"/><Relationship Id="rId37" Type="http://schemas.openxmlformats.org/officeDocument/2006/relationships/image" Target="../media/image19.emf"/><Relationship Id="rId5" Type="http://schemas.openxmlformats.org/officeDocument/2006/relationships/image" Target="../media/image3.emf"/><Relationship Id="rId15" Type="http://schemas.openxmlformats.org/officeDocument/2006/relationships/image" Target="../media/image8.emf"/><Relationship Id="rId23" Type="http://schemas.openxmlformats.org/officeDocument/2006/relationships/image" Target="../media/image12.emf"/><Relationship Id="rId28" Type="http://schemas.openxmlformats.org/officeDocument/2006/relationships/oleObject" Target="../embeddings/oleObject15.bin"/><Relationship Id="rId36" Type="http://schemas.openxmlformats.org/officeDocument/2006/relationships/oleObject" Target="../embeddings/oleObject19.bin"/><Relationship Id="rId10" Type="http://schemas.openxmlformats.org/officeDocument/2006/relationships/oleObject" Target="../embeddings/oleObject6.bin"/><Relationship Id="rId19" Type="http://schemas.openxmlformats.org/officeDocument/2006/relationships/image" Target="../media/image10.emf"/><Relationship Id="rId31" Type="http://schemas.openxmlformats.org/officeDocument/2006/relationships/image" Target="../media/image16.emf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Relationship Id="rId14" Type="http://schemas.openxmlformats.org/officeDocument/2006/relationships/oleObject" Target="../embeddings/oleObject8.bin"/><Relationship Id="rId22" Type="http://schemas.openxmlformats.org/officeDocument/2006/relationships/oleObject" Target="../embeddings/oleObject12.bin"/><Relationship Id="rId27" Type="http://schemas.openxmlformats.org/officeDocument/2006/relationships/image" Target="../media/image14.emf"/><Relationship Id="rId30" Type="http://schemas.openxmlformats.org/officeDocument/2006/relationships/oleObject" Target="../embeddings/oleObject16.bin"/><Relationship Id="rId35" Type="http://schemas.openxmlformats.org/officeDocument/2006/relationships/image" Target="../media/image1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13" Type="http://schemas.openxmlformats.org/officeDocument/2006/relationships/image" Target="../media/image25.emf"/><Relationship Id="rId18" Type="http://schemas.openxmlformats.org/officeDocument/2006/relationships/oleObject" Target="../embeddings/oleObject28.bin"/><Relationship Id="rId26" Type="http://schemas.openxmlformats.org/officeDocument/2006/relationships/oleObject" Target="../embeddings/oleObject32.bin"/><Relationship Id="rId3" Type="http://schemas.openxmlformats.org/officeDocument/2006/relationships/image" Target="../media/image20.emf"/><Relationship Id="rId21" Type="http://schemas.openxmlformats.org/officeDocument/2006/relationships/image" Target="../media/image29.emf"/><Relationship Id="rId7" Type="http://schemas.openxmlformats.org/officeDocument/2006/relationships/image" Target="../media/image22.emf"/><Relationship Id="rId12" Type="http://schemas.openxmlformats.org/officeDocument/2006/relationships/oleObject" Target="../embeddings/oleObject25.bin"/><Relationship Id="rId17" Type="http://schemas.openxmlformats.org/officeDocument/2006/relationships/image" Target="../media/image27.emf"/><Relationship Id="rId25" Type="http://schemas.openxmlformats.org/officeDocument/2006/relationships/image" Target="../media/image31.emf"/><Relationship Id="rId2" Type="http://schemas.openxmlformats.org/officeDocument/2006/relationships/oleObject" Target="../embeddings/oleObject20.bin"/><Relationship Id="rId16" Type="http://schemas.openxmlformats.org/officeDocument/2006/relationships/oleObject" Target="../embeddings/oleObject27.bin"/><Relationship Id="rId20" Type="http://schemas.openxmlformats.org/officeDocument/2006/relationships/oleObject" Target="../embeddings/oleObject29.bin"/><Relationship Id="rId29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2.bin"/><Relationship Id="rId11" Type="http://schemas.openxmlformats.org/officeDocument/2006/relationships/image" Target="../media/image24.emf"/><Relationship Id="rId24" Type="http://schemas.openxmlformats.org/officeDocument/2006/relationships/oleObject" Target="../embeddings/oleObject31.bin"/><Relationship Id="rId5" Type="http://schemas.openxmlformats.org/officeDocument/2006/relationships/image" Target="../media/image21.emf"/><Relationship Id="rId15" Type="http://schemas.openxmlformats.org/officeDocument/2006/relationships/image" Target="../media/image26.emf"/><Relationship Id="rId23" Type="http://schemas.openxmlformats.org/officeDocument/2006/relationships/image" Target="../media/image30.emf"/><Relationship Id="rId28" Type="http://schemas.openxmlformats.org/officeDocument/2006/relationships/oleObject" Target="../embeddings/oleObject33.bin"/><Relationship Id="rId10" Type="http://schemas.openxmlformats.org/officeDocument/2006/relationships/oleObject" Target="../embeddings/oleObject24.bin"/><Relationship Id="rId19" Type="http://schemas.openxmlformats.org/officeDocument/2006/relationships/image" Target="../media/image28.emf"/><Relationship Id="rId31" Type="http://schemas.openxmlformats.org/officeDocument/2006/relationships/image" Target="../media/image34.emf"/><Relationship Id="rId4" Type="http://schemas.openxmlformats.org/officeDocument/2006/relationships/oleObject" Target="../embeddings/oleObject21.bin"/><Relationship Id="rId9" Type="http://schemas.openxmlformats.org/officeDocument/2006/relationships/image" Target="../media/image23.emf"/><Relationship Id="rId14" Type="http://schemas.openxmlformats.org/officeDocument/2006/relationships/oleObject" Target="../embeddings/oleObject26.bin"/><Relationship Id="rId22" Type="http://schemas.openxmlformats.org/officeDocument/2006/relationships/oleObject" Target="../embeddings/oleObject30.bin"/><Relationship Id="rId27" Type="http://schemas.openxmlformats.org/officeDocument/2006/relationships/image" Target="../media/image32.emf"/><Relationship Id="rId30" Type="http://schemas.openxmlformats.org/officeDocument/2006/relationships/oleObject" Target="../embeddings/oleObject3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8.bin"/><Relationship Id="rId13" Type="http://schemas.openxmlformats.org/officeDocument/2006/relationships/image" Target="../media/image40.emf"/><Relationship Id="rId3" Type="http://schemas.openxmlformats.org/officeDocument/2006/relationships/image" Target="../media/image35.emf"/><Relationship Id="rId7" Type="http://schemas.openxmlformats.org/officeDocument/2006/relationships/image" Target="../media/image37.emf"/><Relationship Id="rId12" Type="http://schemas.openxmlformats.org/officeDocument/2006/relationships/oleObject" Target="../embeddings/oleObject40.bin"/><Relationship Id="rId17" Type="http://schemas.openxmlformats.org/officeDocument/2006/relationships/image" Target="../media/image42.emf"/><Relationship Id="rId2" Type="http://schemas.openxmlformats.org/officeDocument/2006/relationships/oleObject" Target="../embeddings/oleObject35.bin"/><Relationship Id="rId16" Type="http://schemas.openxmlformats.org/officeDocument/2006/relationships/oleObject" Target="../embeddings/oleObject4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7.bin"/><Relationship Id="rId11" Type="http://schemas.openxmlformats.org/officeDocument/2006/relationships/image" Target="../media/image39.emf"/><Relationship Id="rId5" Type="http://schemas.openxmlformats.org/officeDocument/2006/relationships/image" Target="../media/image36.emf"/><Relationship Id="rId15" Type="http://schemas.openxmlformats.org/officeDocument/2006/relationships/image" Target="../media/image41.emf"/><Relationship Id="rId10" Type="http://schemas.openxmlformats.org/officeDocument/2006/relationships/oleObject" Target="../embeddings/oleObject39.bin"/><Relationship Id="rId4" Type="http://schemas.openxmlformats.org/officeDocument/2006/relationships/oleObject" Target="../embeddings/oleObject36.bin"/><Relationship Id="rId9" Type="http://schemas.openxmlformats.org/officeDocument/2006/relationships/image" Target="../media/image38.emf"/><Relationship Id="rId14" Type="http://schemas.openxmlformats.org/officeDocument/2006/relationships/oleObject" Target="../embeddings/oleObject41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6.bin"/><Relationship Id="rId13" Type="http://schemas.openxmlformats.org/officeDocument/2006/relationships/image" Target="../media/image48.emf"/><Relationship Id="rId18" Type="http://schemas.openxmlformats.org/officeDocument/2006/relationships/oleObject" Target="../embeddings/oleObject51.bin"/><Relationship Id="rId3" Type="http://schemas.openxmlformats.org/officeDocument/2006/relationships/image" Target="../media/image43.emf"/><Relationship Id="rId21" Type="http://schemas.openxmlformats.org/officeDocument/2006/relationships/image" Target="../media/image52.emf"/><Relationship Id="rId7" Type="http://schemas.openxmlformats.org/officeDocument/2006/relationships/image" Target="../media/image45.emf"/><Relationship Id="rId12" Type="http://schemas.openxmlformats.org/officeDocument/2006/relationships/oleObject" Target="../embeddings/oleObject48.bin"/><Relationship Id="rId17" Type="http://schemas.openxmlformats.org/officeDocument/2006/relationships/image" Target="../media/image50.emf"/><Relationship Id="rId25" Type="http://schemas.openxmlformats.org/officeDocument/2006/relationships/image" Target="../media/image54.emf"/><Relationship Id="rId2" Type="http://schemas.openxmlformats.org/officeDocument/2006/relationships/oleObject" Target="../embeddings/oleObject43.bin"/><Relationship Id="rId16" Type="http://schemas.openxmlformats.org/officeDocument/2006/relationships/oleObject" Target="../embeddings/oleObject50.bin"/><Relationship Id="rId20" Type="http://schemas.openxmlformats.org/officeDocument/2006/relationships/oleObject" Target="../embeddings/oleObject5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5.bin"/><Relationship Id="rId11" Type="http://schemas.openxmlformats.org/officeDocument/2006/relationships/image" Target="../media/image47.emf"/><Relationship Id="rId24" Type="http://schemas.openxmlformats.org/officeDocument/2006/relationships/oleObject" Target="../embeddings/oleObject54.bin"/><Relationship Id="rId5" Type="http://schemas.openxmlformats.org/officeDocument/2006/relationships/image" Target="../media/image44.emf"/><Relationship Id="rId15" Type="http://schemas.openxmlformats.org/officeDocument/2006/relationships/image" Target="../media/image49.emf"/><Relationship Id="rId23" Type="http://schemas.openxmlformats.org/officeDocument/2006/relationships/image" Target="../media/image53.emf"/><Relationship Id="rId10" Type="http://schemas.openxmlformats.org/officeDocument/2006/relationships/oleObject" Target="../embeddings/oleObject47.bin"/><Relationship Id="rId19" Type="http://schemas.openxmlformats.org/officeDocument/2006/relationships/image" Target="../media/image51.emf"/><Relationship Id="rId4" Type="http://schemas.openxmlformats.org/officeDocument/2006/relationships/oleObject" Target="../embeddings/oleObject44.bin"/><Relationship Id="rId9" Type="http://schemas.openxmlformats.org/officeDocument/2006/relationships/image" Target="../media/image46.emf"/><Relationship Id="rId14" Type="http://schemas.openxmlformats.org/officeDocument/2006/relationships/oleObject" Target="../embeddings/oleObject49.bin"/><Relationship Id="rId22" Type="http://schemas.openxmlformats.org/officeDocument/2006/relationships/oleObject" Target="../embeddings/oleObject5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8.bin"/><Relationship Id="rId13" Type="http://schemas.openxmlformats.org/officeDocument/2006/relationships/image" Target="../media/image60.emf"/><Relationship Id="rId18" Type="http://schemas.openxmlformats.org/officeDocument/2006/relationships/oleObject" Target="../embeddings/oleObject63.bin"/><Relationship Id="rId3" Type="http://schemas.openxmlformats.org/officeDocument/2006/relationships/image" Target="../media/image55.emf"/><Relationship Id="rId21" Type="http://schemas.openxmlformats.org/officeDocument/2006/relationships/image" Target="../media/image64.emf"/><Relationship Id="rId7" Type="http://schemas.openxmlformats.org/officeDocument/2006/relationships/image" Target="../media/image57.emf"/><Relationship Id="rId12" Type="http://schemas.openxmlformats.org/officeDocument/2006/relationships/oleObject" Target="../embeddings/oleObject60.bin"/><Relationship Id="rId17" Type="http://schemas.openxmlformats.org/officeDocument/2006/relationships/image" Target="../media/image62.emf"/><Relationship Id="rId25" Type="http://schemas.openxmlformats.org/officeDocument/2006/relationships/image" Target="../media/image66.emf"/><Relationship Id="rId2" Type="http://schemas.openxmlformats.org/officeDocument/2006/relationships/oleObject" Target="../embeddings/oleObject55.bin"/><Relationship Id="rId16" Type="http://schemas.openxmlformats.org/officeDocument/2006/relationships/oleObject" Target="../embeddings/oleObject62.bin"/><Relationship Id="rId20" Type="http://schemas.openxmlformats.org/officeDocument/2006/relationships/oleObject" Target="../embeddings/oleObject6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7.bin"/><Relationship Id="rId11" Type="http://schemas.openxmlformats.org/officeDocument/2006/relationships/image" Target="../media/image59.emf"/><Relationship Id="rId24" Type="http://schemas.openxmlformats.org/officeDocument/2006/relationships/oleObject" Target="../embeddings/oleObject66.bin"/><Relationship Id="rId5" Type="http://schemas.openxmlformats.org/officeDocument/2006/relationships/image" Target="../media/image56.emf"/><Relationship Id="rId15" Type="http://schemas.openxmlformats.org/officeDocument/2006/relationships/image" Target="../media/image61.emf"/><Relationship Id="rId23" Type="http://schemas.openxmlformats.org/officeDocument/2006/relationships/image" Target="../media/image65.emf"/><Relationship Id="rId10" Type="http://schemas.openxmlformats.org/officeDocument/2006/relationships/oleObject" Target="../embeddings/oleObject59.bin"/><Relationship Id="rId19" Type="http://schemas.openxmlformats.org/officeDocument/2006/relationships/image" Target="../media/image63.emf"/><Relationship Id="rId4" Type="http://schemas.openxmlformats.org/officeDocument/2006/relationships/oleObject" Target="../embeddings/oleObject56.bin"/><Relationship Id="rId9" Type="http://schemas.openxmlformats.org/officeDocument/2006/relationships/image" Target="../media/image58.emf"/><Relationship Id="rId14" Type="http://schemas.openxmlformats.org/officeDocument/2006/relationships/oleObject" Target="../embeddings/oleObject61.bin"/><Relationship Id="rId22" Type="http://schemas.openxmlformats.org/officeDocument/2006/relationships/oleObject" Target="../embeddings/oleObject65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0.bin"/><Relationship Id="rId13" Type="http://schemas.openxmlformats.org/officeDocument/2006/relationships/image" Target="../media/image72.emf"/><Relationship Id="rId3" Type="http://schemas.openxmlformats.org/officeDocument/2006/relationships/image" Target="../media/image67.emf"/><Relationship Id="rId7" Type="http://schemas.openxmlformats.org/officeDocument/2006/relationships/image" Target="../media/image69.emf"/><Relationship Id="rId12" Type="http://schemas.openxmlformats.org/officeDocument/2006/relationships/oleObject" Target="../embeddings/oleObject72.bin"/><Relationship Id="rId17" Type="http://schemas.openxmlformats.org/officeDocument/2006/relationships/image" Target="../media/image74.emf"/><Relationship Id="rId2" Type="http://schemas.openxmlformats.org/officeDocument/2006/relationships/oleObject" Target="../embeddings/oleObject67.bin"/><Relationship Id="rId16" Type="http://schemas.openxmlformats.org/officeDocument/2006/relationships/oleObject" Target="../embeddings/oleObject7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9.bin"/><Relationship Id="rId11" Type="http://schemas.openxmlformats.org/officeDocument/2006/relationships/image" Target="../media/image71.emf"/><Relationship Id="rId5" Type="http://schemas.openxmlformats.org/officeDocument/2006/relationships/image" Target="../media/image68.emf"/><Relationship Id="rId15" Type="http://schemas.openxmlformats.org/officeDocument/2006/relationships/image" Target="../media/image73.emf"/><Relationship Id="rId10" Type="http://schemas.openxmlformats.org/officeDocument/2006/relationships/oleObject" Target="../embeddings/oleObject71.bin"/><Relationship Id="rId4" Type="http://schemas.openxmlformats.org/officeDocument/2006/relationships/oleObject" Target="../embeddings/oleObject68.bin"/><Relationship Id="rId9" Type="http://schemas.openxmlformats.org/officeDocument/2006/relationships/image" Target="../media/image70.emf"/><Relationship Id="rId14" Type="http://schemas.openxmlformats.org/officeDocument/2006/relationships/oleObject" Target="../embeddings/oleObject73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8.bin"/><Relationship Id="rId13" Type="http://schemas.openxmlformats.org/officeDocument/2006/relationships/image" Target="../media/image80.emf"/><Relationship Id="rId18" Type="http://schemas.openxmlformats.org/officeDocument/2006/relationships/oleObject" Target="../embeddings/oleObject83.bin"/><Relationship Id="rId3" Type="http://schemas.openxmlformats.org/officeDocument/2006/relationships/image" Target="../media/image75.emf"/><Relationship Id="rId21" Type="http://schemas.openxmlformats.org/officeDocument/2006/relationships/image" Target="../media/image84.emf"/><Relationship Id="rId7" Type="http://schemas.openxmlformats.org/officeDocument/2006/relationships/image" Target="../media/image77.emf"/><Relationship Id="rId12" Type="http://schemas.openxmlformats.org/officeDocument/2006/relationships/oleObject" Target="../embeddings/oleObject80.bin"/><Relationship Id="rId17" Type="http://schemas.openxmlformats.org/officeDocument/2006/relationships/image" Target="../media/image82.emf"/><Relationship Id="rId2" Type="http://schemas.openxmlformats.org/officeDocument/2006/relationships/oleObject" Target="../embeddings/oleObject75.bin"/><Relationship Id="rId16" Type="http://schemas.openxmlformats.org/officeDocument/2006/relationships/oleObject" Target="../embeddings/oleObject82.bin"/><Relationship Id="rId20" Type="http://schemas.openxmlformats.org/officeDocument/2006/relationships/oleObject" Target="../embeddings/oleObject8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7.bin"/><Relationship Id="rId11" Type="http://schemas.openxmlformats.org/officeDocument/2006/relationships/image" Target="../media/image79.emf"/><Relationship Id="rId5" Type="http://schemas.openxmlformats.org/officeDocument/2006/relationships/image" Target="../media/image76.emf"/><Relationship Id="rId15" Type="http://schemas.openxmlformats.org/officeDocument/2006/relationships/image" Target="../media/image81.emf"/><Relationship Id="rId10" Type="http://schemas.openxmlformats.org/officeDocument/2006/relationships/oleObject" Target="../embeddings/oleObject79.bin"/><Relationship Id="rId19" Type="http://schemas.openxmlformats.org/officeDocument/2006/relationships/image" Target="../media/image83.emf"/><Relationship Id="rId4" Type="http://schemas.openxmlformats.org/officeDocument/2006/relationships/oleObject" Target="../embeddings/oleObject76.bin"/><Relationship Id="rId9" Type="http://schemas.openxmlformats.org/officeDocument/2006/relationships/image" Target="../media/image78.emf"/><Relationship Id="rId14" Type="http://schemas.openxmlformats.org/officeDocument/2006/relationships/oleObject" Target="../embeddings/oleObject81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emf"/><Relationship Id="rId13" Type="http://schemas.openxmlformats.org/officeDocument/2006/relationships/oleObject" Target="../embeddings/oleObject90.bin"/><Relationship Id="rId18" Type="http://schemas.openxmlformats.org/officeDocument/2006/relationships/image" Target="../media/image92.emf"/><Relationship Id="rId26" Type="http://schemas.openxmlformats.org/officeDocument/2006/relationships/image" Target="../media/image96.emf"/><Relationship Id="rId3" Type="http://schemas.openxmlformats.org/officeDocument/2006/relationships/oleObject" Target="../embeddings/oleObject85.bin"/><Relationship Id="rId21" Type="http://schemas.openxmlformats.org/officeDocument/2006/relationships/oleObject" Target="../embeddings/oleObject94.bin"/><Relationship Id="rId34" Type="http://schemas.openxmlformats.org/officeDocument/2006/relationships/image" Target="../media/image100.emf"/><Relationship Id="rId7" Type="http://schemas.openxmlformats.org/officeDocument/2006/relationships/oleObject" Target="../embeddings/oleObject87.bin"/><Relationship Id="rId12" Type="http://schemas.openxmlformats.org/officeDocument/2006/relationships/image" Target="../media/image89.emf"/><Relationship Id="rId17" Type="http://schemas.openxmlformats.org/officeDocument/2006/relationships/oleObject" Target="../embeddings/oleObject92.bin"/><Relationship Id="rId25" Type="http://schemas.openxmlformats.org/officeDocument/2006/relationships/oleObject" Target="../embeddings/oleObject96.bin"/><Relationship Id="rId33" Type="http://schemas.openxmlformats.org/officeDocument/2006/relationships/oleObject" Target="../embeddings/oleObject100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1.emf"/><Relationship Id="rId20" Type="http://schemas.openxmlformats.org/officeDocument/2006/relationships/image" Target="../media/image93.emf"/><Relationship Id="rId29" Type="http://schemas.openxmlformats.org/officeDocument/2006/relationships/oleObject" Target="../embeddings/oleObject98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emf"/><Relationship Id="rId11" Type="http://schemas.openxmlformats.org/officeDocument/2006/relationships/oleObject" Target="../embeddings/oleObject89.bin"/><Relationship Id="rId24" Type="http://schemas.openxmlformats.org/officeDocument/2006/relationships/image" Target="../media/image95.emf"/><Relationship Id="rId32" Type="http://schemas.openxmlformats.org/officeDocument/2006/relationships/image" Target="../media/image99.emf"/><Relationship Id="rId5" Type="http://schemas.openxmlformats.org/officeDocument/2006/relationships/oleObject" Target="../embeddings/oleObject86.bin"/><Relationship Id="rId15" Type="http://schemas.openxmlformats.org/officeDocument/2006/relationships/oleObject" Target="../embeddings/oleObject91.bin"/><Relationship Id="rId23" Type="http://schemas.openxmlformats.org/officeDocument/2006/relationships/oleObject" Target="../embeddings/oleObject95.bin"/><Relationship Id="rId28" Type="http://schemas.openxmlformats.org/officeDocument/2006/relationships/image" Target="../media/image97.emf"/><Relationship Id="rId10" Type="http://schemas.openxmlformats.org/officeDocument/2006/relationships/image" Target="../media/image88.emf"/><Relationship Id="rId19" Type="http://schemas.openxmlformats.org/officeDocument/2006/relationships/oleObject" Target="../embeddings/oleObject93.bin"/><Relationship Id="rId31" Type="http://schemas.openxmlformats.org/officeDocument/2006/relationships/oleObject" Target="../embeddings/oleObject99.bin"/><Relationship Id="rId4" Type="http://schemas.openxmlformats.org/officeDocument/2006/relationships/image" Target="../media/image85.emf"/><Relationship Id="rId9" Type="http://schemas.openxmlformats.org/officeDocument/2006/relationships/oleObject" Target="../embeddings/oleObject88.bin"/><Relationship Id="rId14" Type="http://schemas.openxmlformats.org/officeDocument/2006/relationships/image" Target="../media/image90.emf"/><Relationship Id="rId22" Type="http://schemas.openxmlformats.org/officeDocument/2006/relationships/image" Target="../media/image94.emf"/><Relationship Id="rId27" Type="http://schemas.openxmlformats.org/officeDocument/2006/relationships/oleObject" Target="../embeddings/oleObject97.bin"/><Relationship Id="rId30" Type="http://schemas.openxmlformats.org/officeDocument/2006/relationships/image" Target="../media/image9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2C92148-43ED-A37A-EC06-7214B7E92C5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41914" y="650546"/>
          <a:ext cx="4304887" cy="3654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2" imgW="2689779" imgH="2282918" progId="SigmaPlotGraphicObject.12">
                  <p:embed/>
                </p:oleObj>
              </mc:Choice>
              <mc:Fallback>
                <p:oleObj name="SPW 13.0 Graph" r:id="rId2" imgW="2689779" imgH="2282918" progId="SigmaPlotGraphicObject.12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2C92148-43ED-A37A-EC06-7214B7E92C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41914" y="650546"/>
                        <a:ext cx="4304887" cy="36543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90F6306-D70D-4051-50A5-1A96DB8FDA7A}"/>
              </a:ext>
            </a:extLst>
          </p:cNvPr>
          <p:cNvSpPr txBox="1"/>
          <p:nvPr/>
        </p:nvSpPr>
        <p:spPr>
          <a:xfrm>
            <a:off x="202035" y="263994"/>
            <a:ext cx="21928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</a:t>
            </a:r>
          </a:p>
        </p:txBody>
      </p:sp>
    </p:spTree>
    <p:extLst>
      <p:ext uri="{BB962C8B-B14F-4D97-AF65-F5344CB8AC3E}">
        <p14:creationId xmlns:p14="http://schemas.microsoft.com/office/powerpoint/2010/main" val="35997341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D6CE93C-330A-0EBC-3575-44FB4F8FB4FF}"/>
              </a:ext>
            </a:extLst>
          </p:cNvPr>
          <p:cNvSpPr txBox="1"/>
          <p:nvPr/>
        </p:nvSpPr>
        <p:spPr>
          <a:xfrm>
            <a:off x="235085" y="241960"/>
            <a:ext cx="24173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2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956B5731-0ED8-014D-23ED-4A960CB0A8F5}"/>
              </a:ext>
            </a:extLst>
          </p:cNvPr>
          <p:cNvGrpSpPr/>
          <p:nvPr/>
        </p:nvGrpSpPr>
        <p:grpSpPr>
          <a:xfrm>
            <a:off x="651632" y="676302"/>
            <a:ext cx="11215648" cy="5854784"/>
            <a:chOff x="651632" y="676302"/>
            <a:chExt cx="11215648" cy="5854784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86778DD-51F9-10D2-C70F-B0C65A130B1F}"/>
                </a:ext>
              </a:extLst>
            </p:cNvPr>
            <p:cNvGrpSpPr/>
            <p:nvPr/>
          </p:nvGrpSpPr>
          <p:grpSpPr>
            <a:xfrm>
              <a:off x="651632" y="676302"/>
              <a:ext cx="10165131" cy="5854784"/>
              <a:chOff x="651632" y="676302"/>
              <a:chExt cx="10165131" cy="5854784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41737E72-DC22-5859-3FC1-CAED37EDFD04}"/>
                  </a:ext>
                </a:extLst>
              </p:cNvPr>
              <p:cNvGrpSpPr/>
              <p:nvPr/>
            </p:nvGrpSpPr>
            <p:grpSpPr>
              <a:xfrm>
                <a:off x="1462156" y="850674"/>
                <a:ext cx="9133565" cy="246221"/>
                <a:chOff x="1437218" y="2458001"/>
                <a:chExt cx="9133565" cy="246221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78FC082D-5FDF-D447-4DE0-6C219A9AB843}"/>
                    </a:ext>
                  </a:extLst>
                </p:cNvPr>
                <p:cNvSpPr txBox="1"/>
                <p:nvPr/>
              </p:nvSpPr>
              <p:spPr>
                <a:xfrm>
                  <a:off x="1437218" y="2458001"/>
                  <a:ext cx="1061906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empol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0CD47F4F-B8B7-6152-A1C3-7215367DAAE0}"/>
                    </a:ext>
                  </a:extLst>
                </p:cNvPr>
                <p:cNvSpPr txBox="1"/>
                <p:nvPr/>
              </p:nvSpPr>
              <p:spPr>
                <a:xfrm>
                  <a:off x="3400719" y="2458001"/>
                  <a:ext cx="1061906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empol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1D6150FF-D5AE-1339-D746-F7E99AC062C3}"/>
                    </a:ext>
                  </a:extLst>
                </p:cNvPr>
                <p:cNvSpPr txBox="1"/>
                <p:nvPr/>
              </p:nvSpPr>
              <p:spPr>
                <a:xfrm>
                  <a:off x="5440882" y="2458001"/>
                  <a:ext cx="1141200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empol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B81F592C-D1F3-5C14-3E7B-9B80702199E8}"/>
                    </a:ext>
                  </a:extLst>
                </p:cNvPr>
                <p:cNvSpPr txBox="1"/>
                <p:nvPr/>
              </p:nvSpPr>
              <p:spPr>
                <a:xfrm>
                  <a:off x="7416060" y="2458001"/>
                  <a:ext cx="1141200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M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empol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4659F512-2D55-770D-2394-D710D41FAC1E}"/>
                    </a:ext>
                  </a:extLst>
                </p:cNvPr>
                <p:cNvSpPr txBox="1"/>
                <p:nvPr/>
              </p:nvSpPr>
              <p:spPr>
                <a:xfrm>
                  <a:off x="9388019" y="2458001"/>
                  <a:ext cx="1182764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mM Tempol</a:t>
                  </a:r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87F8E5A-7465-E169-AF78-43E34C6017DA}"/>
                  </a:ext>
                </a:extLst>
              </p:cNvPr>
              <p:cNvSpPr txBox="1"/>
              <p:nvPr/>
            </p:nvSpPr>
            <p:spPr>
              <a:xfrm>
                <a:off x="651632" y="863574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E726F684-A0D5-C5A8-5F9F-E68E8504650E}"/>
                  </a:ext>
                </a:extLst>
              </p:cNvPr>
              <p:cNvSpPr txBox="1"/>
              <p:nvPr/>
            </p:nvSpPr>
            <p:spPr>
              <a:xfrm>
                <a:off x="651634" y="2714053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95F73D3-62C8-BEE4-4A05-3E61B888D0FC}"/>
                  </a:ext>
                </a:extLst>
              </p:cNvPr>
              <p:cNvSpPr txBox="1"/>
              <p:nvPr/>
            </p:nvSpPr>
            <p:spPr>
              <a:xfrm>
                <a:off x="660196" y="4517151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65B8B7F5-71F8-B237-80BB-D9BF1B3C95BF}"/>
                  </a:ext>
                </a:extLst>
              </p:cNvPr>
              <p:cNvGrpSpPr/>
              <p:nvPr/>
            </p:nvGrpSpPr>
            <p:grpSpPr>
              <a:xfrm>
                <a:off x="819897" y="2435527"/>
                <a:ext cx="9992013" cy="2246313"/>
                <a:chOff x="337993" y="1242870"/>
                <a:chExt cx="9992013" cy="2246313"/>
              </a:xfrm>
            </p:grpSpPr>
            <p:graphicFrame>
              <p:nvGraphicFramePr>
                <p:cNvPr id="11" name="Object 10">
                  <a:extLst>
                    <a:ext uri="{FF2B5EF4-FFF2-40B4-BE49-F238E27FC236}">
                      <a16:creationId xmlns:a16="http://schemas.microsoft.com/office/drawing/2014/main" id="{E41C362B-CCDC-5D99-9563-1364A1252418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2316884" y="1242870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2075776" imgH="2246207" progId="SigmaPlotGraphicObject.12">
                        <p:embed/>
                      </p:oleObj>
                    </mc:Choice>
                    <mc:Fallback>
                      <p:oleObj name="SPW 13.0 Graph" r:id="rId2" imgW="2075776" imgH="2246207" progId="SigmaPlotGraphicObject.12">
                        <p:embed/>
                        <p:pic>
                          <p:nvPicPr>
                            <p:cNvPr id="11" name="Object 10">
                              <a:extLst>
                                <a:ext uri="{FF2B5EF4-FFF2-40B4-BE49-F238E27FC236}">
                                  <a16:creationId xmlns:a16="http://schemas.microsoft.com/office/drawing/2014/main" id="{E41C362B-CCDC-5D99-9563-1364A125241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316884" y="1242870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2" name="Object 11">
                  <a:extLst>
                    <a:ext uri="{FF2B5EF4-FFF2-40B4-BE49-F238E27FC236}">
                      <a16:creationId xmlns:a16="http://schemas.microsoft.com/office/drawing/2014/main" id="{F2F4A80F-8A5E-C756-831B-851436392665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4295775" y="1242870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075776" imgH="2246207" progId="SigmaPlotGraphicObject.12">
                        <p:embed/>
                      </p:oleObj>
                    </mc:Choice>
                    <mc:Fallback>
                      <p:oleObj name="SPW 13.0 Graph" r:id="rId4" imgW="2075776" imgH="2246207" progId="SigmaPlotGraphicObject.12">
                        <p:embed/>
                        <p:pic>
                          <p:nvPicPr>
                            <p:cNvPr id="12" name="Object 11">
                              <a:extLst>
                                <a:ext uri="{FF2B5EF4-FFF2-40B4-BE49-F238E27FC236}">
                                  <a16:creationId xmlns:a16="http://schemas.microsoft.com/office/drawing/2014/main" id="{F2F4A80F-8A5E-C756-831B-85143639266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295775" y="1242870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4" name="Object 13">
                  <a:extLst>
                    <a:ext uri="{FF2B5EF4-FFF2-40B4-BE49-F238E27FC236}">
                      <a16:creationId xmlns:a16="http://schemas.microsoft.com/office/drawing/2014/main" id="{88C4D8F0-4176-856B-3E66-CEF5B2D0BC15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8253556" y="1242870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075776" imgH="2246207" progId="SigmaPlotGraphicObject.12">
                        <p:embed/>
                      </p:oleObj>
                    </mc:Choice>
                    <mc:Fallback>
                      <p:oleObj name="SPW 13.0 Graph" r:id="rId6" imgW="2075776" imgH="2246207" progId="SigmaPlotGraphicObject.12">
                        <p:embed/>
                        <p:pic>
                          <p:nvPicPr>
                            <p:cNvPr id="14" name="Object 13">
                              <a:extLst>
                                <a:ext uri="{FF2B5EF4-FFF2-40B4-BE49-F238E27FC236}">
                                  <a16:creationId xmlns:a16="http://schemas.microsoft.com/office/drawing/2014/main" id="{88C4D8F0-4176-856B-3E66-CEF5B2D0BC1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253556" y="1242870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1" name="Object 20">
                  <a:extLst>
                    <a:ext uri="{FF2B5EF4-FFF2-40B4-BE49-F238E27FC236}">
                      <a16:creationId xmlns:a16="http://schemas.microsoft.com/office/drawing/2014/main" id="{3D163AB4-AE39-66C8-0CEC-EFE4DE18404F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37993" y="1242870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2075776" imgH="2246207" progId="SigmaPlotGraphicObject.12">
                        <p:embed/>
                      </p:oleObj>
                    </mc:Choice>
                    <mc:Fallback>
                      <p:oleObj name="SPW 13.0 Graph" r:id="rId8" imgW="2075776" imgH="2246207" progId="SigmaPlotGraphicObject.12">
                        <p:embed/>
                        <p:pic>
                          <p:nvPicPr>
                            <p:cNvPr id="21" name="Object 20">
                              <a:extLst>
                                <a:ext uri="{FF2B5EF4-FFF2-40B4-BE49-F238E27FC236}">
                                  <a16:creationId xmlns:a16="http://schemas.microsoft.com/office/drawing/2014/main" id="{3D163AB4-AE39-66C8-0CEC-EFE4DE18404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37993" y="1242870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2" name="Object 21">
                  <a:extLst>
                    <a:ext uri="{FF2B5EF4-FFF2-40B4-BE49-F238E27FC236}">
                      <a16:creationId xmlns:a16="http://schemas.microsoft.com/office/drawing/2014/main" id="{C39997CC-51D2-EC31-E422-DD58C248A0F1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6274666" y="1242870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2075776" imgH="2246207" progId="SigmaPlotGraphicObject.12">
                        <p:embed/>
                      </p:oleObj>
                    </mc:Choice>
                    <mc:Fallback>
                      <p:oleObj name="SPW 13.0 Graph" r:id="rId10" imgW="2075776" imgH="2246207" progId="SigmaPlotGraphicObject.12">
                        <p:embed/>
                        <p:pic>
                          <p:nvPicPr>
                            <p:cNvPr id="22" name="Object 21">
                              <a:extLst>
                                <a:ext uri="{FF2B5EF4-FFF2-40B4-BE49-F238E27FC236}">
                                  <a16:creationId xmlns:a16="http://schemas.microsoft.com/office/drawing/2014/main" id="{C39997CC-51D2-EC31-E422-DD58C248A0F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274666" y="1242870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F8D7E7EB-266B-9662-102C-EA03DA04A9E9}"/>
                  </a:ext>
                </a:extLst>
              </p:cNvPr>
              <p:cNvGrpSpPr/>
              <p:nvPr/>
            </p:nvGrpSpPr>
            <p:grpSpPr>
              <a:xfrm>
                <a:off x="819898" y="4284773"/>
                <a:ext cx="9992011" cy="2246313"/>
                <a:chOff x="337994" y="3274868"/>
                <a:chExt cx="9992011" cy="2246313"/>
              </a:xfrm>
            </p:grpSpPr>
            <p:graphicFrame>
              <p:nvGraphicFramePr>
                <p:cNvPr id="16" name="Object 15">
                  <a:extLst>
                    <a:ext uri="{FF2B5EF4-FFF2-40B4-BE49-F238E27FC236}">
                      <a16:creationId xmlns:a16="http://schemas.microsoft.com/office/drawing/2014/main" id="{710BDD6C-8E4E-9C69-7F74-014B96DCE9F3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37994" y="3274868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2075776" imgH="2246207" progId="SigmaPlotGraphicObject.12">
                        <p:embed/>
                      </p:oleObj>
                    </mc:Choice>
                    <mc:Fallback>
                      <p:oleObj name="SPW 13.0 Graph" r:id="rId12" imgW="2075776" imgH="2246207" progId="SigmaPlotGraphicObject.12">
                        <p:embed/>
                        <p:pic>
                          <p:nvPicPr>
                            <p:cNvPr id="16" name="Object 15">
                              <a:extLst>
                                <a:ext uri="{FF2B5EF4-FFF2-40B4-BE49-F238E27FC236}">
                                  <a16:creationId xmlns:a16="http://schemas.microsoft.com/office/drawing/2014/main" id="{710BDD6C-8E4E-9C69-7F74-014B96DCE9F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37994" y="3274868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7" name="Object 16">
                  <a:extLst>
                    <a:ext uri="{FF2B5EF4-FFF2-40B4-BE49-F238E27FC236}">
                      <a16:creationId xmlns:a16="http://schemas.microsoft.com/office/drawing/2014/main" id="{082D233E-62F8-A671-93C0-3C0C9569B1B4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2316884" y="3274868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4" imgW="2075776" imgH="2246207" progId="SigmaPlotGraphicObject.12">
                        <p:embed/>
                      </p:oleObj>
                    </mc:Choice>
                    <mc:Fallback>
                      <p:oleObj name="SPW 13.0 Graph" r:id="rId14" imgW="2075776" imgH="2246207" progId="SigmaPlotGraphicObject.12">
                        <p:embed/>
                        <p:pic>
                          <p:nvPicPr>
                            <p:cNvPr id="17" name="Object 16">
                              <a:extLst>
                                <a:ext uri="{FF2B5EF4-FFF2-40B4-BE49-F238E27FC236}">
                                  <a16:creationId xmlns:a16="http://schemas.microsoft.com/office/drawing/2014/main" id="{082D233E-62F8-A671-93C0-3C0C9569B1B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316884" y="3274868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8" name="Object 17">
                  <a:extLst>
                    <a:ext uri="{FF2B5EF4-FFF2-40B4-BE49-F238E27FC236}">
                      <a16:creationId xmlns:a16="http://schemas.microsoft.com/office/drawing/2014/main" id="{2AD2E1E6-0E8B-E0DB-ED97-9BAE5302FBF4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4295774" y="3274868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6" imgW="2075776" imgH="2246207" progId="SigmaPlotGraphicObject.12">
                        <p:embed/>
                      </p:oleObj>
                    </mc:Choice>
                    <mc:Fallback>
                      <p:oleObj name="SPW 13.0 Graph" r:id="rId16" imgW="2075776" imgH="2246207" progId="SigmaPlotGraphicObject.12">
                        <p:embed/>
                        <p:pic>
                          <p:nvPicPr>
                            <p:cNvPr id="18" name="Object 17">
                              <a:extLst>
                                <a:ext uri="{FF2B5EF4-FFF2-40B4-BE49-F238E27FC236}">
                                  <a16:creationId xmlns:a16="http://schemas.microsoft.com/office/drawing/2014/main" id="{2AD2E1E6-0E8B-E0DB-ED97-9BAE5302FBF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295774" y="3274868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9" name="Object 18">
                  <a:extLst>
                    <a:ext uri="{FF2B5EF4-FFF2-40B4-BE49-F238E27FC236}">
                      <a16:creationId xmlns:a16="http://schemas.microsoft.com/office/drawing/2014/main" id="{DD50F9A8-1BEA-34C4-B543-BA407AD45CA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6274664" y="3274868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8" imgW="2075776" imgH="2246207" progId="SigmaPlotGraphicObject.12">
                        <p:embed/>
                      </p:oleObj>
                    </mc:Choice>
                    <mc:Fallback>
                      <p:oleObj name="SPW 13.0 Graph" r:id="rId18" imgW="2075776" imgH="2246207" progId="SigmaPlotGraphicObject.12">
                        <p:embed/>
                        <p:pic>
                          <p:nvPicPr>
                            <p:cNvPr id="19" name="Object 18">
                              <a:extLst>
                                <a:ext uri="{FF2B5EF4-FFF2-40B4-BE49-F238E27FC236}">
                                  <a16:creationId xmlns:a16="http://schemas.microsoft.com/office/drawing/2014/main" id="{DD50F9A8-1BEA-34C4-B543-BA407AD45CA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274664" y="3274868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0" name="Object 19">
                  <a:extLst>
                    <a:ext uri="{FF2B5EF4-FFF2-40B4-BE49-F238E27FC236}">
                      <a16:creationId xmlns:a16="http://schemas.microsoft.com/office/drawing/2014/main" id="{B0642E08-83D5-BFB9-6F7D-6E5AB37C574B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8253555" y="3274868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0" imgW="2075776" imgH="2246207" progId="SigmaPlotGraphicObject.12">
                        <p:embed/>
                      </p:oleObj>
                    </mc:Choice>
                    <mc:Fallback>
                      <p:oleObj name="SPW 13.0 Graph" r:id="rId20" imgW="2075776" imgH="2246207" progId="SigmaPlotGraphicObject.12">
                        <p:embed/>
                        <p:pic>
                          <p:nvPicPr>
                            <p:cNvPr id="20" name="Object 19">
                              <a:extLst>
                                <a:ext uri="{FF2B5EF4-FFF2-40B4-BE49-F238E27FC236}">
                                  <a16:creationId xmlns:a16="http://schemas.microsoft.com/office/drawing/2014/main" id="{B0642E08-83D5-BFB9-6F7D-6E5AB37C574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253555" y="3274868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A38DE984-38E2-3253-268D-DFF16BD07743}"/>
                  </a:ext>
                </a:extLst>
              </p:cNvPr>
              <p:cNvGrpSpPr/>
              <p:nvPr/>
            </p:nvGrpSpPr>
            <p:grpSpPr>
              <a:xfrm>
                <a:off x="818936" y="676302"/>
                <a:ext cx="9997827" cy="2246313"/>
                <a:chOff x="793998" y="342685"/>
                <a:chExt cx="9997827" cy="2246313"/>
              </a:xfrm>
            </p:grpSpPr>
            <p:graphicFrame>
              <p:nvGraphicFramePr>
                <p:cNvPr id="42" name="Object 41">
                  <a:extLst>
                    <a:ext uri="{FF2B5EF4-FFF2-40B4-BE49-F238E27FC236}">
                      <a16:creationId xmlns:a16="http://schemas.microsoft.com/office/drawing/2014/main" id="{14DDA162-91B7-5BEA-FC80-28A03D57573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793998" y="342685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2" imgW="2075776" imgH="2246207" progId="SigmaPlotGraphicObject.12">
                        <p:embed/>
                      </p:oleObj>
                    </mc:Choice>
                    <mc:Fallback>
                      <p:oleObj name="SPW 13.0 Graph" r:id="rId22" imgW="2075776" imgH="2246207" progId="SigmaPlotGraphicObject.12">
                        <p:embed/>
                        <p:pic>
                          <p:nvPicPr>
                            <p:cNvPr id="42" name="Object 41">
                              <a:extLst>
                                <a:ext uri="{FF2B5EF4-FFF2-40B4-BE49-F238E27FC236}">
                                  <a16:creationId xmlns:a16="http://schemas.microsoft.com/office/drawing/2014/main" id="{14DDA162-91B7-5BEA-FC80-28A03D57573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3998" y="342685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3" name="Object 42">
                  <a:extLst>
                    <a:ext uri="{FF2B5EF4-FFF2-40B4-BE49-F238E27FC236}">
                      <a16:creationId xmlns:a16="http://schemas.microsoft.com/office/drawing/2014/main" id="{B6BBD98B-699D-A179-A728-0B991702F10B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2776913" y="342685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4" imgW="2075776" imgH="2246207" progId="SigmaPlotGraphicObject.12">
                        <p:embed/>
                      </p:oleObj>
                    </mc:Choice>
                    <mc:Fallback>
                      <p:oleObj name="SPW 13.0 Graph" r:id="rId24" imgW="2075776" imgH="2246207" progId="SigmaPlotGraphicObject.12">
                        <p:embed/>
                        <p:pic>
                          <p:nvPicPr>
                            <p:cNvPr id="43" name="Object 42">
                              <a:extLst>
                                <a:ext uri="{FF2B5EF4-FFF2-40B4-BE49-F238E27FC236}">
                                  <a16:creationId xmlns:a16="http://schemas.microsoft.com/office/drawing/2014/main" id="{B6BBD98B-699D-A179-A728-0B991702F10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776913" y="342685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4" name="Object 43">
                  <a:extLst>
                    <a:ext uri="{FF2B5EF4-FFF2-40B4-BE49-F238E27FC236}">
                      <a16:creationId xmlns:a16="http://schemas.microsoft.com/office/drawing/2014/main" id="{165F5582-58BB-38DB-27EF-D6781AC6E691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4759823" y="342685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6" imgW="2075776" imgH="2246207" progId="SigmaPlotGraphicObject.12">
                        <p:embed/>
                      </p:oleObj>
                    </mc:Choice>
                    <mc:Fallback>
                      <p:oleObj name="SPW 13.0 Graph" r:id="rId26" imgW="2075776" imgH="2246207" progId="SigmaPlotGraphicObject.12">
                        <p:embed/>
                        <p:pic>
                          <p:nvPicPr>
                            <p:cNvPr id="44" name="Object 43">
                              <a:extLst>
                                <a:ext uri="{FF2B5EF4-FFF2-40B4-BE49-F238E27FC236}">
                                  <a16:creationId xmlns:a16="http://schemas.microsoft.com/office/drawing/2014/main" id="{165F5582-58BB-38DB-27EF-D6781AC6E69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759823" y="342685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5" name="Object 44">
                  <a:extLst>
                    <a:ext uri="{FF2B5EF4-FFF2-40B4-BE49-F238E27FC236}">
                      <a16:creationId xmlns:a16="http://schemas.microsoft.com/office/drawing/2014/main" id="{AF6B2767-3D80-CEDA-584C-D7A2D43784A5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6732463" y="342685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8" imgW="2075776" imgH="2246207" progId="SigmaPlotGraphicObject.12">
                        <p:embed/>
                      </p:oleObj>
                    </mc:Choice>
                    <mc:Fallback>
                      <p:oleObj name="SPW 13.0 Graph" r:id="rId28" imgW="2075776" imgH="2246207" progId="SigmaPlotGraphicObject.12">
                        <p:embed/>
                        <p:pic>
                          <p:nvPicPr>
                            <p:cNvPr id="45" name="Object 44">
                              <a:extLst>
                                <a:ext uri="{FF2B5EF4-FFF2-40B4-BE49-F238E27FC236}">
                                  <a16:creationId xmlns:a16="http://schemas.microsoft.com/office/drawing/2014/main" id="{AF6B2767-3D80-CEDA-584C-D7A2D43784A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32463" y="342685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6" name="Object 45">
                  <a:extLst>
                    <a:ext uri="{FF2B5EF4-FFF2-40B4-BE49-F238E27FC236}">
                      <a16:creationId xmlns:a16="http://schemas.microsoft.com/office/drawing/2014/main" id="{ADDECDB2-E29B-2104-5A82-7BE90DDCCDC3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8715375" y="342685"/>
                <a:ext cx="2076450" cy="22463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30" imgW="2075776" imgH="2246207" progId="SigmaPlotGraphicObject.12">
                        <p:embed/>
                      </p:oleObj>
                    </mc:Choice>
                    <mc:Fallback>
                      <p:oleObj name="SPW 13.0 Graph" r:id="rId30" imgW="2075776" imgH="2246207" progId="SigmaPlotGraphicObject.12">
                        <p:embed/>
                        <p:pic>
                          <p:nvPicPr>
                            <p:cNvPr id="46" name="Object 45">
                              <a:extLst>
                                <a:ext uri="{FF2B5EF4-FFF2-40B4-BE49-F238E27FC236}">
                                  <a16:creationId xmlns:a16="http://schemas.microsoft.com/office/drawing/2014/main" id="{ADDECDB2-E29B-2104-5A82-7BE90DDCCDC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715375" y="342685"/>
                              <a:ext cx="2076450" cy="22463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</p:grpSp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93E189AB-0131-0350-7351-D5347D1A91C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522667" y="1609378"/>
            <a:ext cx="1344613" cy="661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32" imgW="1344168" imgH="661517" progId="SigmaPlotGraphicObject.12">
                    <p:embed/>
                  </p:oleObj>
                </mc:Choice>
                <mc:Fallback>
                  <p:oleObj name="SPW 13.0 Graph" r:id="rId32" imgW="1344168" imgH="661517" progId="SigmaPlotGraphicObject.12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93E189AB-0131-0350-7351-D5347D1A91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3"/>
                        <a:stretch>
                          <a:fillRect/>
                        </a:stretch>
                      </p:blipFill>
                      <p:spPr>
                        <a:xfrm>
                          <a:off x="10522667" y="1609378"/>
                          <a:ext cx="1344613" cy="6619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D3BD6161-E36C-9DC9-A227-366526AA32A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506909" y="3352935"/>
            <a:ext cx="1298575" cy="661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34" imgW="1298352" imgH="661517" progId="SigmaPlotGraphicObject.12">
                    <p:embed/>
                  </p:oleObj>
                </mc:Choice>
                <mc:Fallback>
                  <p:oleObj name="SPW 13.0 Graph" r:id="rId34" imgW="1298352" imgH="661517" progId="SigmaPlotGraphicObject.12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D3BD6161-E36C-9DC9-A227-366526AA32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5"/>
                        <a:stretch>
                          <a:fillRect/>
                        </a:stretch>
                      </p:blipFill>
                      <p:spPr>
                        <a:xfrm>
                          <a:off x="10506909" y="3352935"/>
                          <a:ext cx="1298575" cy="6619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BA47B3D4-F47D-D6CE-2F92-E2762E6F690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525584" y="5212733"/>
            <a:ext cx="1292225" cy="661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36" imgW="1292219" imgH="661517" progId="SigmaPlotGraphicObject.12">
                    <p:embed/>
                  </p:oleObj>
                </mc:Choice>
                <mc:Fallback>
                  <p:oleObj name="SPW 13.0 Graph" r:id="rId36" imgW="1292219" imgH="661517" progId="SigmaPlotGraphicObject.12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BA47B3D4-F47D-D6CE-2F92-E2762E6F690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7"/>
                        <a:stretch>
                          <a:fillRect/>
                        </a:stretch>
                      </p:blipFill>
                      <p:spPr>
                        <a:xfrm>
                          <a:off x="10525584" y="5212733"/>
                          <a:ext cx="1292225" cy="6619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117582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7">
            <a:extLst>
              <a:ext uri="{FF2B5EF4-FFF2-40B4-BE49-F238E27FC236}">
                <a16:creationId xmlns:a16="http://schemas.microsoft.com/office/drawing/2014/main" id="{791735F6-B366-344F-723F-B20F8E78E583}"/>
              </a:ext>
            </a:extLst>
          </p:cNvPr>
          <p:cNvSpPr txBox="1"/>
          <p:nvPr/>
        </p:nvSpPr>
        <p:spPr>
          <a:xfrm>
            <a:off x="235085" y="111335"/>
            <a:ext cx="23848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3</a:t>
            </a:r>
          </a:p>
        </p:txBody>
      </p:sp>
      <p:grpSp>
        <p:nvGrpSpPr>
          <p:cNvPr id="187" name="Group 186">
            <a:extLst>
              <a:ext uri="{FF2B5EF4-FFF2-40B4-BE49-F238E27FC236}">
                <a16:creationId xmlns:a16="http://schemas.microsoft.com/office/drawing/2014/main" id="{99B131B9-FFCE-0C98-4E54-CDD40CB16D1D}"/>
              </a:ext>
            </a:extLst>
          </p:cNvPr>
          <p:cNvGrpSpPr/>
          <p:nvPr/>
        </p:nvGrpSpPr>
        <p:grpSpPr>
          <a:xfrm>
            <a:off x="798634" y="281547"/>
            <a:ext cx="11056542" cy="6372259"/>
            <a:chOff x="798634" y="281547"/>
            <a:chExt cx="11056542" cy="6372259"/>
          </a:xfrm>
        </p:grpSpPr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E5603186-7CD6-A0F0-6FBC-32481A89D088}"/>
                </a:ext>
              </a:extLst>
            </p:cNvPr>
            <p:cNvGrpSpPr/>
            <p:nvPr/>
          </p:nvGrpSpPr>
          <p:grpSpPr>
            <a:xfrm>
              <a:off x="798634" y="281547"/>
              <a:ext cx="11056542" cy="6372259"/>
              <a:chOff x="798634" y="281547"/>
              <a:chExt cx="11056542" cy="6372259"/>
            </a:xfrm>
          </p:grpSpPr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D742D388-ED3C-23CA-5783-E628CAE42702}"/>
                  </a:ext>
                </a:extLst>
              </p:cNvPr>
              <p:cNvGrpSpPr/>
              <p:nvPr/>
            </p:nvGrpSpPr>
            <p:grpSpPr>
              <a:xfrm>
                <a:off x="1164706" y="281547"/>
                <a:ext cx="10018392" cy="4417105"/>
                <a:chOff x="1164706" y="281547"/>
                <a:chExt cx="10018392" cy="4417105"/>
              </a:xfrm>
            </p:grpSpPr>
            <p:graphicFrame>
              <p:nvGraphicFramePr>
                <p:cNvPr id="69" name="Object 68">
                  <a:extLst>
                    <a:ext uri="{FF2B5EF4-FFF2-40B4-BE49-F238E27FC236}">
                      <a16:creationId xmlns:a16="http://schemas.microsoft.com/office/drawing/2014/main" id="{0F1840F8-385C-3DB3-3CA0-67C28D63CDE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649557942"/>
                    </p:ext>
                  </p:extLst>
                </p:nvPr>
              </p:nvGraphicFramePr>
              <p:xfrm>
                <a:off x="8893923" y="2365181"/>
                <a:ext cx="2289175" cy="230663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2288982" imgH="2305953" progId="SigmaPlotGraphicObject.12">
                        <p:embed/>
                      </p:oleObj>
                    </mc:Choice>
                    <mc:Fallback>
                      <p:oleObj name="SPW 13.0 Graph" r:id="rId2" imgW="2288982" imgH="2305953" progId="SigmaPlotGraphicObject.12">
                        <p:embed/>
                        <p:pic>
                          <p:nvPicPr>
                            <p:cNvPr id="69" name="Object 68">
                              <a:extLst>
                                <a:ext uri="{FF2B5EF4-FFF2-40B4-BE49-F238E27FC236}">
                                  <a16:creationId xmlns:a16="http://schemas.microsoft.com/office/drawing/2014/main" id="{0F1840F8-385C-3DB3-3CA0-67C28D63CDE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93923" y="2365181"/>
                              <a:ext cx="2289175" cy="230663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B6EB1992-A01A-6283-F755-179B80786160}"/>
                    </a:ext>
                  </a:extLst>
                </p:cNvPr>
                <p:cNvGrpSpPr/>
                <p:nvPr/>
              </p:nvGrpSpPr>
              <p:grpSpPr>
                <a:xfrm>
                  <a:off x="1164706" y="281547"/>
                  <a:ext cx="9727354" cy="4417105"/>
                  <a:chOff x="1164706" y="281547"/>
                  <a:chExt cx="9727354" cy="4417105"/>
                </a:xfrm>
              </p:grpSpPr>
              <p:grpSp>
                <p:nvGrpSpPr>
                  <p:cNvPr id="130" name="Group 129">
                    <a:extLst>
                      <a:ext uri="{FF2B5EF4-FFF2-40B4-BE49-F238E27FC236}">
                        <a16:creationId xmlns:a16="http://schemas.microsoft.com/office/drawing/2014/main" id="{11BE664C-78C3-BAD2-240B-65C0B3AF1F5C}"/>
                      </a:ext>
                    </a:extLst>
                  </p:cNvPr>
                  <p:cNvGrpSpPr/>
                  <p:nvPr/>
                </p:nvGrpSpPr>
                <p:grpSpPr>
                  <a:xfrm>
                    <a:off x="1199665" y="281547"/>
                    <a:ext cx="9692395" cy="2253610"/>
                    <a:chOff x="850027" y="790822"/>
                    <a:chExt cx="9692395" cy="2253610"/>
                  </a:xfrm>
                </p:grpSpPr>
                <p:sp>
                  <p:nvSpPr>
                    <p:cNvPr id="74" name="TextBox 73">
                      <a:extLst>
                        <a:ext uri="{FF2B5EF4-FFF2-40B4-BE49-F238E27FC236}">
                          <a16:creationId xmlns:a16="http://schemas.microsoft.com/office/drawing/2014/main" id="{09193D66-42FE-66E1-66BC-E71938DB815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0027" y="914568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542B7879-079F-1D13-322D-59FF0689A7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7154" y="914568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</p:txBody>
                </p:sp>
                <p:grpSp>
                  <p:nvGrpSpPr>
                    <p:cNvPr id="71" name="Group 70">
                      <a:extLst>
                        <a:ext uri="{FF2B5EF4-FFF2-40B4-BE49-F238E27FC236}">
                          <a16:creationId xmlns:a16="http://schemas.microsoft.com/office/drawing/2014/main" id="{7F7B2BCD-F5A3-9CAD-3467-E0403EAD125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20247" y="809232"/>
                      <a:ext cx="2065337" cy="2235200"/>
                      <a:chOff x="4856062" y="3548680"/>
                      <a:chExt cx="2065337" cy="2235200"/>
                    </a:xfrm>
                  </p:grpSpPr>
                  <p:graphicFrame>
                    <p:nvGraphicFrame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757D8FF-483F-1862-E63B-EC668A2FF41F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/>
                    </p:nvGraphicFramePr>
                    <p:xfrm>
                      <a:off x="4856062" y="3548680"/>
                      <a:ext cx="2065337" cy="2235200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4" imgW="2064954" imgH="2235770" progId="SigmaPlotGraphicObject.12">
                              <p:embed/>
                            </p:oleObj>
                          </mc:Choice>
                          <mc:Fallback>
                            <p:oleObj name="SPW 13.0 Graph" r:id="rId4" imgW="2064954" imgH="2235770" progId="SigmaPlotGraphicObject.12">
                              <p:embed/>
                              <p:pic>
                                <p:nvPicPr>
                                  <p:cNvPr id="2" name="Object 1">
                                    <a:extLst>
                                      <a:ext uri="{FF2B5EF4-FFF2-40B4-BE49-F238E27FC236}">
                                        <a16:creationId xmlns:a16="http://schemas.microsoft.com/office/drawing/2014/main" id="{7757D8FF-483F-1862-E63B-EC668A2FF41F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5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4856062" y="3548680"/>
                                    <a:ext cx="2065337" cy="22352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cxnSp>
                    <p:nvCxnSpPr>
                      <p:cNvPr id="20" name="Straight Arrow Connector 19">
                        <a:extLst>
                          <a:ext uri="{FF2B5EF4-FFF2-40B4-BE49-F238E27FC236}">
                            <a16:creationId xmlns:a16="http://schemas.microsoft.com/office/drawing/2014/main" id="{9E023E2A-A07B-A432-CCFD-0C997FC8AC3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5434475" y="3944277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" name="Straight Arrow Connector 20">
                        <a:extLst>
                          <a:ext uri="{FF2B5EF4-FFF2-40B4-BE49-F238E27FC236}">
                            <a16:creationId xmlns:a16="http://schemas.microsoft.com/office/drawing/2014/main" id="{9D96B8BE-D33D-0CC0-6BB4-F43E3FCAED7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5733786" y="4302395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" name="Straight Arrow Connector 29">
                        <a:extLst>
                          <a:ext uri="{FF2B5EF4-FFF2-40B4-BE49-F238E27FC236}">
                            <a16:creationId xmlns:a16="http://schemas.microsoft.com/office/drawing/2014/main" id="{34E55A0F-E819-F3B5-49F6-A5DD401D3BF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6005572" y="4529596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" name="Straight Arrow Connector 31">
                        <a:extLst>
                          <a:ext uri="{FF2B5EF4-FFF2-40B4-BE49-F238E27FC236}">
                            <a16:creationId xmlns:a16="http://schemas.microsoft.com/office/drawing/2014/main" id="{B9701D1B-53DF-751A-11D4-035E19041A1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6337694" y="4709400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8" name="TextBox 47">
                        <a:extLst>
                          <a:ext uri="{FF2B5EF4-FFF2-40B4-BE49-F238E27FC236}">
                            <a16:creationId xmlns:a16="http://schemas.microsoft.com/office/drawing/2014/main" id="{814D8EDC-BB53-B281-6A38-583A2A20362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210111" y="4788042"/>
                        <a:ext cx="596638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,4-NQ</a:t>
                        </a:r>
                      </a:p>
                    </p:txBody>
                  </p:sp>
                  <p:cxnSp>
                    <p:nvCxnSpPr>
                      <p:cNvPr id="54" name="Straight Arrow Connector 53">
                        <a:extLst>
                          <a:ext uri="{FF2B5EF4-FFF2-40B4-BE49-F238E27FC236}">
                            <a16:creationId xmlns:a16="http://schemas.microsoft.com/office/drawing/2014/main" id="{7A4DC1AB-9CF7-EDF8-B1D0-29A5EC3B3FD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5368156" y="4232709"/>
                        <a:ext cx="0" cy="58999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0" name="Group 9">
                      <a:extLst>
                        <a:ext uri="{FF2B5EF4-FFF2-40B4-BE49-F238E27FC236}">
                          <a16:creationId xmlns:a16="http://schemas.microsoft.com/office/drawing/2014/main" id="{702BEFE1-BC65-9A77-65C8-8C9D9AE1B2C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779252" y="803999"/>
                      <a:ext cx="2065337" cy="2235200"/>
                      <a:chOff x="939042" y="1038900"/>
                      <a:chExt cx="2065337" cy="2235200"/>
                    </a:xfrm>
                  </p:grpSpPr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0F02FC25-51F6-C743-B890-4EB0AC94CA5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04149" y="2092161"/>
                        <a:ext cx="38985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Jug</a:t>
                        </a:r>
                      </a:p>
                    </p:txBody>
                  </p:sp>
                  <p:cxnSp>
                    <p:nvCxnSpPr>
                      <p:cNvPr id="95" name="Straight Arrow Connector 94">
                        <a:extLst>
                          <a:ext uri="{FF2B5EF4-FFF2-40B4-BE49-F238E27FC236}">
                            <a16:creationId xmlns:a16="http://schemas.microsoft.com/office/drawing/2014/main" id="{619FEBFF-9B1F-C142-1378-CCB0DD4FFF7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1436659" y="1736538"/>
                        <a:ext cx="0" cy="400375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Straight Arrow Connector 98">
                        <a:extLst>
                          <a:ext uri="{FF2B5EF4-FFF2-40B4-BE49-F238E27FC236}">
                            <a16:creationId xmlns:a16="http://schemas.microsoft.com/office/drawing/2014/main" id="{667F147E-4BA9-6C11-096C-B933B5C9698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2048589" y="1944536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0" name="Straight Arrow Connector 99">
                        <a:extLst>
                          <a:ext uri="{FF2B5EF4-FFF2-40B4-BE49-F238E27FC236}">
                            <a16:creationId xmlns:a16="http://schemas.microsoft.com/office/drawing/2014/main" id="{172C1E1F-642A-FB0C-BE18-7CBCD24D879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2376741" y="2091419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1" name="Straight Arrow Connector 100">
                        <a:extLst>
                          <a:ext uri="{FF2B5EF4-FFF2-40B4-BE49-F238E27FC236}">
                            <a16:creationId xmlns:a16="http://schemas.microsoft.com/office/drawing/2014/main" id="{55F1F642-C9DF-ECC2-9D69-1428E64AC97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1721194" y="1770500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2" name="Straight Arrow Connector 101">
                        <a:extLst>
                          <a:ext uri="{FF2B5EF4-FFF2-40B4-BE49-F238E27FC236}">
                            <a16:creationId xmlns:a16="http://schemas.microsoft.com/office/drawing/2014/main" id="{D3AE0527-142D-1013-348F-179FC709D2B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1508922" y="1415024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aphicFrame>
                    <p:nvGraphicFramePr>
                      <p:cNvPr id="68" name="Object 67">
                        <a:extLst>
                          <a:ext uri="{FF2B5EF4-FFF2-40B4-BE49-F238E27FC236}">
                            <a16:creationId xmlns:a16="http://schemas.microsoft.com/office/drawing/2014/main" id="{BFE530E1-39F5-95AE-8F4E-1ACA07FC5F8F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164993489"/>
                          </p:ext>
                        </p:extLst>
                      </p:nvPr>
                    </p:nvGraphicFramePr>
                    <p:xfrm>
                      <a:off x="939042" y="1038900"/>
                      <a:ext cx="2065337" cy="2235200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6" imgW="2064954" imgH="2235770" progId="SigmaPlotGraphicObject.12">
                              <p:embed/>
                            </p:oleObj>
                          </mc:Choice>
                          <mc:Fallback>
                            <p:oleObj name="SPW 13.0 Graph" r:id="rId6" imgW="2064954" imgH="2235770" progId="SigmaPlotGraphicObject.12">
                              <p:embed/>
                              <p:pic>
                                <p:nvPicPr>
                                  <p:cNvPr id="68" name="Object 67">
                                    <a:extLst>
                                      <a:ext uri="{FF2B5EF4-FFF2-40B4-BE49-F238E27FC236}">
                                        <a16:creationId xmlns:a16="http://schemas.microsoft.com/office/drawing/2014/main" id="{BFE530E1-39F5-95AE-8F4E-1ACA07FC5F8F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7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939042" y="1038900"/>
                                    <a:ext cx="2065337" cy="22352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</p:grpSp>
                <p:grpSp>
                  <p:nvGrpSpPr>
                    <p:cNvPr id="98" name="Group 97">
                      <a:extLst>
                        <a:ext uri="{FF2B5EF4-FFF2-40B4-BE49-F238E27FC236}">
                          <a16:creationId xmlns:a16="http://schemas.microsoft.com/office/drawing/2014/main" id="{C309BCBB-DC89-103E-B98C-870A36FBD93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670529" y="804481"/>
                      <a:ext cx="2065337" cy="2235200"/>
                      <a:chOff x="8011389" y="1039382"/>
                      <a:chExt cx="2065337" cy="2235200"/>
                    </a:xfrm>
                  </p:grpSpPr>
                  <p:graphicFrame>
                    <p:nvGraphicFramePr>
                      <p:cNvPr id="96" name="Object 95">
                        <a:extLst>
                          <a:ext uri="{FF2B5EF4-FFF2-40B4-BE49-F238E27FC236}">
                            <a16:creationId xmlns:a16="http://schemas.microsoft.com/office/drawing/2014/main" id="{5C889143-A7DC-D156-1FCE-A2C766C5DE92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2376955060"/>
                          </p:ext>
                        </p:extLst>
                      </p:nvPr>
                    </p:nvGraphicFramePr>
                    <p:xfrm>
                      <a:off x="8011389" y="1039382"/>
                      <a:ext cx="2065337" cy="2235200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8" imgW="2064954" imgH="2235770" progId="SigmaPlotGraphicObject.12">
                              <p:embed/>
                            </p:oleObj>
                          </mc:Choice>
                          <mc:Fallback>
                            <p:oleObj name="SPW 13.0 Graph" r:id="rId8" imgW="2064954" imgH="2235770" progId="SigmaPlotGraphicObject.12">
                              <p:embed/>
                              <p:pic>
                                <p:nvPicPr>
                                  <p:cNvPr id="96" name="Object 95">
                                    <a:extLst>
                                      <a:ext uri="{FF2B5EF4-FFF2-40B4-BE49-F238E27FC236}">
                                        <a16:creationId xmlns:a16="http://schemas.microsoft.com/office/drawing/2014/main" id="{5C889143-A7DC-D156-1FCE-A2C766C5DE92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9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8011389" y="1039382"/>
                                    <a:ext cx="2065337" cy="22352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grpSp>
                    <p:nvGrpSpPr>
                      <p:cNvPr id="13" name="Group 12">
                        <a:extLst>
                          <a:ext uri="{FF2B5EF4-FFF2-40B4-BE49-F238E27FC236}">
                            <a16:creationId xmlns:a16="http://schemas.microsoft.com/office/drawing/2014/main" id="{2997C4AC-9FBB-8E0D-E4BC-F2F9CA1182A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79211" y="1434902"/>
                        <a:ext cx="1006331" cy="906793"/>
                        <a:chOff x="1304149" y="1431589"/>
                        <a:chExt cx="1006331" cy="906793"/>
                      </a:xfrm>
                    </p:grpSpPr>
                    <p:sp>
                      <p:nvSpPr>
                        <p:cNvPr id="14" name="TextBox 13">
                          <a:extLst>
                            <a:ext uri="{FF2B5EF4-FFF2-40B4-BE49-F238E27FC236}">
                              <a16:creationId xmlns:a16="http://schemas.microsoft.com/office/drawing/2014/main" id="{1B5C4F10-8540-A9FF-2AC0-3956F144F50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304149" y="2092161"/>
                          <a:ext cx="354584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B</a:t>
                          </a:r>
                        </a:p>
                      </p:txBody>
                    </p:sp>
                    <p:cxnSp>
                      <p:nvCxnSpPr>
                        <p:cNvPr id="15" name="Straight Arrow Connector 14">
                          <a:extLst>
                            <a:ext uri="{FF2B5EF4-FFF2-40B4-BE49-F238E27FC236}">
                              <a16:creationId xmlns:a16="http://schemas.microsoft.com/office/drawing/2014/main" id="{BDF54FF8-3947-9E72-4952-7095EAE091B9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1436659" y="1736538"/>
                          <a:ext cx="0" cy="400375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6" name="Straight Arrow Connector 15">
                          <a:extLst>
                            <a:ext uri="{FF2B5EF4-FFF2-40B4-BE49-F238E27FC236}">
                              <a16:creationId xmlns:a16="http://schemas.microsoft.com/office/drawing/2014/main" id="{61B4B444-5B3F-62E5-AE77-B612581D601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2048589" y="1944536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" name="Straight Arrow Connector 17">
                          <a:extLst>
                            <a:ext uri="{FF2B5EF4-FFF2-40B4-BE49-F238E27FC236}">
                              <a16:creationId xmlns:a16="http://schemas.microsoft.com/office/drawing/2014/main" id="{B8089F14-F7A7-A273-15A9-916137C5544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2310480" y="2157679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9" name="Straight Arrow Connector 18">
                          <a:extLst>
                            <a:ext uri="{FF2B5EF4-FFF2-40B4-BE49-F238E27FC236}">
                              <a16:creationId xmlns:a16="http://schemas.microsoft.com/office/drawing/2014/main" id="{9D2069E5-4FEC-BAA8-3628-CEE27459DD6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810646" y="1720804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4" name="Straight Arrow Connector 23">
                          <a:extLst>
                            <a:ext uri="{FF2B5EF4-FFF2-40B4-BE49-F238E27FC236}">
                              <a16:creationId xmlns:a16="http://schemas.microsoft.com/office/drawing/2014/main" id="{9EC92065-E0B1-C32C-B71D-BABF127A7D8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508922" y="1431589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97" name="Straight Arrow Connector 96">
                        <a:extLst>
                          <a:ext uri="{FF2B5EF4-FFF2-40B4-BE49-F238E27FC236}">
                            <a16:creationId xmlns:a16="http://schemas.microsoft.com/office/drawing/2014/main" id="{9E18B5A3-1221-5E66-1CF6-FB821CA9E57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10800000" flipV="1">
                        <a:off x="9551194" y="2346522"/>
                        <a:ext cx="0" cy="149453"/>
                      </a:xfrm>
                      <a:prstGeom prst="straightConnector1">
                        <a:avLst/>
                      </a:prstGeom>
                      <a:ln w="9525">
                        <a:solidFill>
                          <a:schemeClr val="tx1"/>
                        </a:solidFill>
                        <a:tailEnd type="stealth" w="sm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29" name="Group 128">
                      <a:extLst>
                        <a:ext uri="{FF2B5EF4-FFF2-40B4-BE49-F238E27FC236}">
                          <a16:creationId xmlns:a16="http://schemas.microsoft.com/office/drawing/2014/main" id="{5C810394-C3DA-C1E9-9A45-CCF51D1A29C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77085" y="798350"/>
                      <a:ext cx="2065337" cy="2235200"/>
                      <a:chOff x="6488894" y="806739"/>
                      <a:chExt cx="2065337" cy="2235200"/>
                    </a:xfrm>
                  </p:grpSpPr>
                  <p:grpSp>
                    <p:nvGrpSpPr>
                      <p:cNvPr id="72" name="Group 71">
                        <a:extLst>
                          <a:ext uri="{FF2B5EF4-FFF2-40B4-BE49-F238E27FC236}">
                            <a16:creationId xmlns:a16="http://schemas.microsoft.com/office/drawing/2014/main" id="{47BF4BAD-70D9-EC2E-2E91-E2983C0AF37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488894" y="806739"/>
                        <a:ext cx="2065337" cy="2235200"/>
                        <a:chOff x="570412" y="3551415"/>
                        <a:chExt cx="2065337" cy="2235200"/>
                      </a:xfrm>
                    </p:grpSpPr>
                    <p:graphicFrame>
                      <p:nvGraphicFramePr>
                        <p:cNvPr id="66" name="Object 65">
                          <a:extLst>
                            <a:ext uri="{FF2B5EF4-FFF2-40B4-BE49-F238E27FC236}">
                              <a16:creationId xmlns:a16="http://schemas.microsoft.com/office/drawing/2014/main" id="{5418477A-40F6-16FA-2996-2847505D5944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/>
                      </p:nvGraphicFramePr>
                      <p:xfrm>
                        <a:off x="570412" y="3551415"/>
                        <a:ext cx="2065337" cy="2235200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SPW 13.0 Graph" r:id="rId10" imgW="2064954" imgH="2235770" progId="SigmaPlotGraphicObject.12">
                                <p:embed/>
                              </p:oleObj>
                            </mc:Choice>
                            <mc:Fallback>
                              <p:oleObj name="SPW 13.0 Graph" r:id="rId10" imgW="2064954" imgH="2235770" progId="SigmaPlotGraphicObject.12">
                                <p:embed/>
                                <p:pic>
                                  <p:nvPicPr>
                                    <p:cNvPr id="66" name="Object 65">
                                      <a:extLst>
                                        <a:ext uri="{FF2B5EF4-FFF2-40B4-BE49-F238E27FC236}">
                                          <a16:creationId xmlns:a16="http://schemas.microsoft.com/office/drawing/2014/main" id="{5418477A-40F6-16FA-2996-2847505D5944}"/>
                                        </a:ext>
                                      </a:extLst>
                                    </p:cNvPr>
                                    <p:cNvPicPr/>
                                    <p:nvPr/>
                                  </p:nvPicPr>
                                  <p:blipFill>
                                    <a:blip r:embed="rId11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570412" y="3551415"/>
                                      <a:ext cx="2065337" cy="2235200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cxnSp>
                      <p:nvCxnSpPr>
                        <p:cNvPr id="37" name="Straight Arrow Connector 36">
                          <a:extLst>
                            <a:ext uri="{FF2B5EF4-FFF2-40B4-BE49-F238E27FC236}">
                              <a16:creationId xmlns:a16="http://schemas.microsoft.com/office/drawing/2014/main" id="{B0285356-1FF0-0DF7-9BF7-E2898320D06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365259" y="4104131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8" name="Straight Arrow Connector 37">
                          <a:extLst>
                            <a:ext uri="{FF2B5EF4-FFF2-40B4-BE49-F238E27FC236}">
                              <a16:creationId xmlns:a16="http://schemas.microsoft.com/office/drawing/2014/main" id="{3D4EBE52-8D13-719D-BA07-5220682029C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523775" y="4339098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0" name="Straight Arrow Connector 39">
                          <a:extLst>
                            <a:ext uri="{FF2B5EF4-FFF2-40B4-BE49-F238E27FC236}">
                              <a16:creationId xmlns:a16="http://schemas.microsoft.com/office/drawing/2014/main" id="{D2C97CE6-690D-0F70-8B78-B3C670685DC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706755" y="4589360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4" name="Straight Arrow Connector 43">
                          <a:extLst>
                            <a:ext uri="{FF2B5EF4-FFF2-40B4-BE49-F238E27FC236}">
                              <a16:creationId xmlns:a16="http://schemas.microsoft.com/office/drawing/2014/main" id="{9CBBCDEC-951F-9A2B-73BB-E8E97457E22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898912" y="4812103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5" name="Straight Arrow Connector 44">
                          <a:extLst>
                            <a:ext uri="{FF2B5EF4-FFF2-40B4-BE49-F238E27FC236}">
                              <a16:creationId xmlns:a16="http://schemas.microsoft.com/office/drawing/2014/main" id="{30636110-B093-98E8-0F8A-2CA46C5C3C8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2146115" y="5031782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6" name="TextBox 45">
                          <a:extLst>
                            <a:ext uri="{FF2B5EF4-FFF2-40B4-BE49-F238E27FC236}">
                              <a16:creationId xmlns:a16="http://schemas.microsoft.com/office/drawing/2014/main" id="{DA05D050-0F1E-1913-9953-EEE01DB430D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26084" y="4503291"/>
                          <a:ext cx="56297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DCNQ</a:t>
                          </a:r>
                        </a:p>
                      </p:txBody>
                    </p:sp>
                    <p:cxnSp>
                      <p:nvCxnSpPr>
                        <p:cNvPr id="47" name="Straight Arrow Connector 46">
                          <a:extLst>
                            <a:ext uri="{FF2B5EF4-FFF2-40B4-BE49-F238E27FC236}">
                              <a16:creationId xmlns:a16="http://schemas.microsoft.com/office/drawing/2014/main" id="{9F6612B9-08DC-8119-347E-55E8C3D4872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1168351" y="4234479"/>
                          <a:ext cx="0" cy="310694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53" name="TextBox 52">
                        <a:extLst>
                          <a:ext uri="{FF2B5EF4-FFF2-40B4-BE49-F238E27FC236}">
                            <a16:creationId xmlns:a16="http://schemas.microsoft.com/office/drawing/2014/main" id="{941D6CB8-953D-6518-E798-D963665FD13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285384" y="1137859"/>
                        <a:ext cx="56297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CNQ</a:t>
                        </a:r>
                      </a:p>
                    </p:txBody>
                  </p:sp>
                </p:grpSp>
                <p:sp>
                  <p:nvSpPr>
                    <p:cNvPr id="56" name="TextBox 55">
                      <a:extLst>
                        <a:ext uri="{FF2B5EF4-FFF2-40B4-BE49-F238E27FC236}">
                          <a16:creationId xmlns:a16="http://schemas.microsoft.com/office/drawing/2014/main" id="{D1417B31-8D69-786F-3147-F9C5FA5A03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16270" y="1137859"/>
                      <a:ext cx="83233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umbagin</a:t>
                      </a:r>
                    </a:p>
                  </p:txBody>
                </p:sp>
                <p:sp>
                  <p:nvSpPr>
                    <p:cNvPr id="60" name="TextBox 59">
                      <a:extLst>
                        <a:ext uri="{FF2B5EF4-FFF2-40B4-BE49-F238E27FC236}">
                          <a16:creationId xmlns:a16="http://schemas.microsoft.com/office/drawing/2014/main" id="{A3E92941-4A09-4760-1AF4-295D03D282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10661" y="1137859"/>
                      <a:ext cx="6378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glone</a:t>
                      </a:r>
                    </a:p>
                  </p:txBody>
                </p:sp>
                <p:sp>
                  <p:nvSpPr>
                    <p:cNvPr id="84" name="TextBox 83">
                      <a:extLst>
                        <a:ext uri="{FF2B5EF4-FFF2-40B4-BE49-F238E27FC236}">
                          <a16:creationId xmlns:a16="http://schemas.microsoft.com/office/drawing/2014/main" id="{8FFAF2ED-A823-30BC-83DA-7C509E34C59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67102" y="1137859"/>
                      <a:ext cx="64408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4-NQ</a:t>
                      </a:r>
                    </a:p>
                  </p:txBody>
                </p:sp>
                <p:sp>
                  <p:nvSpPr>
                    <p:cNvPr id="104" name="TextBox 103">
                      <a:extLst>
                        <a:ext uri="{FF2B5EF4-FFF2-40B4-BE49-F238E27FC236}">
                          <a16:creationId xmlns:a16="http://schemas.microsoft.com/office/drawing/2014/main" id="{C9C2AF76-E6A6-0FC9-ABB3-FDA53BD5F34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11794" y="914568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09" name="TextBox 108">
                      <a:extLst>
                        <a:ext uri="{FF2B5EF4-FFF2-40B4-BE49-F238E27FC236}">
                          <a16:creationId xmlns:a16="http://schemas.microsoft.com/office/drawing/2014/main" id="{983A478D-FA7F-4B2B-2634-7085A490D1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29962" y="914568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p:txBody>
                </p:sp>
                <p:sp>
                  <p:nvSpPr>
                    <p:cNvPr id="110" name="TextBox 109">
                      <a:extLst>
                        <a:ext uri="{FF2B5EF4-FFF2-40B4-BE49-F238E27FC236}">
                          <a16:creationId xmlns:a16="http://schemas.microsoft.com/office/drawing/2014/main" id="{5D52FE0A-7F12-58E4-BE4C-A2135D0EB8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83883" y="914568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p:txBody>
                </p:sp>
                <p:grpSp>
                  <p:nvGrpSpPr>
                    <p:cNvPr id="128" name="Group 127">
                      <a:extLst>
                        <a:ext uri="{FF2B5EF4-FFF2-40B4-BE49-F238E27FC236}">
                          <a16:creationId xmlns:a16="http://schemas.microsoft.com/office/drawing/2014/main" id="{8374D4DF-6D48-C9ED-E0E5-43E0B97A2AC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551520" y="790822"/>
                      <a:ext cx="2065337" cy="2235200"/>
                      <a:chOff x="8363542" y="799211"/>
                      <a:chExt cx="2065337" cy="2235200"/>
                    </a:xfrm>
                  </p:grpSpPr>
                  <p:sp>
                    <p:nvSpPr>
                      <p:cNvPr id="52" name="TextBox 51">
                        <a:extLst>
                          <a:ext uri="{FF2B5EF4-FFF2-40B4-BE49-F238E27FC236}">
                            <a16:creationId xmlns:a16="http://schemas.microsoft.com/office/drawing/2014/main" id="{02855BEA-A322-D0CA-81AE-1893F9BEE3A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193607" y="1137859"/>
                        <a:ext cx="57740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MNQ</a:t>
                        </a:r>
                      </a:p>
                    </p:txBody>
                  </p:sp>
                  <p:grpSp>
                    <p:nvGrpSpPr>
                      <p:cNvPr id="120" name="Group 119">
                        <a:extLst>
                          <a:ext uri="{FF2B5EF4-FFF2-40B4-BE49-F238E27FC236}">
                            <a16:creationId xmlns:a16="http://schemas.microsoft.com/office/drawing/2014/main" id="{7AC29A7A-38E5-6F60-BEA3-0F45BE97101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63542" y="799211"/>
                        <a:ext cx="2065337" cy="2235200"/>
                        <a:chOff x="918606" y="4471396"/>
                        <a:chExt cx="2065337" cy="2235200"/>
                      </a:xfrm>
                    </p:grpSpPr>
                    <p:graphicFrame>
                      <p:nvGraphicFramePr>
                        <p:cNvPr id="121" name="Object 120">
                          <a:extLst>
                            <a:ext uri="{FF2B5EF4-FFF2-40B4-BE49-F238E27FC236}">
                              <a16:creationId xmlns:a16="http://schemas.microsoft.com/office/drawing/2014/main" id="{3759F791-BF37-C52C-3222-98FBDEBBF540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1709997758"/>
                            </p:ext>
                          </p:extLst>
                        </p:nvPr>
                      </p:nvGraphicFramePr>
                      <p:xfrm>
                        <a:off x="918606" y="4471396"/>
                        <a:ext cx="2065337" cy="2235200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SPW 13.0 Graph" r:id="rId12" imgW="2064954" imgH="2235770" progId="SigmaPlotGraphicObject.12">
                                <p:embed/>
                              </p:oleObj>
                            </mc:Choice>
                            <mc:Fallback>
                              <p:oleObj name="SPW 13.0 Graph" r:id="rId12" imgW="2064954" imgH="2235770" progId="SigmaPlotGraphicObject.12">
                                <p:embed/>
                                <p:pic>
                                  <p:nvPicPr>
                                    <p:cNvPr id="121" name="Object 120">
                                      <a:extLst>
                                        <a:ext uri="{FF2B5EF4-FFF2-40B4-BE49-F238E27FC236}">
                                          <a16:creationId xmlns:a16="http://schemas.microsoft.com/office/drawing/2014/main" id="{3759F791-BF37-C52C-3222-98FBDEBBF540}"/>
                                        </a:ext>
                                      </a:extLst>
                                    </p:cNvPr>
                                    <p:cNvPicPr/>
                                    <p:nvPr/>
                                  </p:nvPicPr>
                                  <p:blipFill>
                                    <a:blip r:embed="rId13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918606" y="4471396"/>
                                      <a:ext cx="2065337" cy="2235200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cxnSp>
                      <p:nvCxnSpPr>
                        <p:cNvPr id="122" name="Straight Arrow Connector 121">
                          <a:extLst>
                            <a:ext uri="{FF2B5EF4-FFF2-40B4-BE49-F238E27FC236}">
                              <a16:creationId xmlns:a16="http://schemas.microsoft.com/office/drawing/2014/main" id="{E491C29F-F7EB-0C9C-B160-0035EA1B6E3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441037" y="4876155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3" name="Straight Arrow Connector 122">
                          <a:extLst>
                            <a:ext uri="{FF2B5EF4-FFF2-40B4-BE49-F238E27FC236}">
                              <a16:creationId xmlns:a16="http://schemas.microsoft.com/office/drawing/2014/main" id="{A6570DA7-0B74-D3AD-D904-07CEA2CFC87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1691196" y="5137597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4" name="Straight Arrow Connector 123">
                          <a:extLst>
                            <a:ext uri="{FF2B5EF4-FFF2-40B4-BE49-F238E27FC236}">
                              <a16:creationId xmlns:a16="http://schemas.microsoft.com/office/drawing/2014/main" id="{6598621D-2EC2-AC57-C976-EF220FABDDD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2033025" y="5304362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5" name="Straight Arrow Connector 124">
                          <a:extLst>
                            <a:ext uri="{FF2B5EF4-FFF2-40B4-BE49-F238E27FC236}">
                              <a16:creationId xmlns:a16="http://schemas.microsoft.com/office/drawing/2014/main" id="{8D791998-0D9C-C709-76FA-24130EDF91B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10800000" flipV="1">
                          <a:off x="2377922" y="5435462"/>
                          <a:ext cx="0" cy="149453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26" name="TextBox 125">
                          <a:extLst>
                            <a:ext uri="{FF2B5EF4-FFF2-40B4-BE49-F238E27FC236}">
                              <a16:creationId xmlns:a16="http://schemas.microsoft.com/office/drawing/2014/main" id="{2277814C-9EE1-E5E5-9ED2-251DE0BC868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4939" y="5472863"/>
                          <a:ext cx="57740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DMNQ</a:t>
                          </a:r>
                        </a:p>
                      </p:txBody>
                    </p:sp>
                    <p:cxnSp>
                      <p:nvCxnSpPr>
                        <p:cNvPr id="127" name="Straight Arrow Connector 126">
                          <a:extLst>
                            <a:ext uri="{FF2B5EF4-FFF2-40B4-BE49-F238E27FC236}">
                              <a16:creationId xmlns:a16="http://schemas.microsoft.com/office/drawing/2014/main" id="{FAAC732E-089F-9653-CC2C-B793251FC52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1405014" y="5179608"/>
                          <a:ext cx="0" cy="310694"/>
                        </a:xfrm>
                        <a:prstGeom prst="straightConnector1">
                          <a:avLst/>
                        </a:prstGeom>
                        <a:ln w="9525">
                          <a:solidFill>
                            <a:schemeClr val="tx1"/>
                          </a:solidFill>
                          <a:tailEnd type="stealth" w="sm" len="med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  <p:grpSp>
                <p:nvGrpSpPr>
                  <p:cNvPr id="49" name="Group 48">
                    <a:extLst>
                      <a:ext uri="{FF2B5EF4-FFF2-40B4-BE49-F238E27FC236}">
                        <a16:creationId xmlns:a16="http://schemas.microsoft.com/office/drawing/2014/main" id="{AF1B8CA1-4846-51EA-4C02-BC4D07C52F31}"/>
                      </a:ext>
                    </a:extLst>
                  </p:cNvPr>
                  <p:cNvGrpSpPr/>
                  <p:nvPr/>
                </p:nvGrpSpPr>
                <p:grpSpPr>
                  <a:xfrm>
                    <a:off x="1164706" y="2381536"/>
                    <a:ext cx="7807327" cy="2317116"/>
                    <a:chOff x="3904067" y="3585723"/>
                    <a:chExt cx="7807327" cy="2317116"/>
                  </a:xfrm>
                </p:grpSpPr>
                <p:grpSp>
                  <p:nvGrpSpPr>
                    <p:cNvPr id="43" name="Group 42">
                      <a:extLst>
                        <a:ext uri="{FF2B5EF4-FFF2-40B4-BE49-F238E27FC236}">
                          <a16:creationId xmlns:a16="http://schemas.microsoft.com/office/drawing/2014/main" id="{646A72C4-BCFA-69C8-03F5-E56AB54050D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190727" y="3596879"/>
                      <a:ext cx="2520667" cy="2273300"/>
                      <a:chOff x="1395275" y="3615353"/>
                      <a:chExt cx="2520667" cy="2273300"/>
                    </a:xfrm>
                  </p:grpSpPr>
                  <p:sp>
                    <p:nvSpPr>
                      <p:cNvPr id="28" name="TextBox 27">
                        <a:extLst>
                          <a:ext uri="{FF2B5EF4-FFF2-40B4-BE49-F238E27FC236}">
                            <a16:creationId xmlns:a16="http://schemas.microsoft.com/office/drawing/2014/main" id="{D74526D5-42FB-8E90-51A6-0D1B528EB4E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73495" y="3864156"/>
                        <a:ext cx="103746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CNQ var H</a:t>
                        </a:r>
                        <a:r>
                          <a:rPr lang="en-US" sz="1000" baseline="-25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</a:t>
                        </a:r>
                      </a:p>
                    </p:txBody>
                  </p:sp>
                  <p:graphicFrame>
                    <p:nvGraphicFramePr>
                      <p:cNvPr id="57" name="Object 56">
                        <a:extLst>
                          <a:ext uri="{FF2B5EF4-FFF2-40B4-BE49-F238E27FC236}">
                            <a16:creationId xmlns:a16="http://schemas.microsoft.com/office/drawing/2014/main" id="{C0C541B1-52B0-FB1E-76F1-9FD3CB2D4350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2191669075"/>
                          </p:ext>
                        </p:extLst>
                      </p:nvPr>
                    </p:nvGraphicFramePr>
                    <p:xfrm>
                      <a:off x="1395275" y="3615353"/>
                      <a:ext cx="2152650" cy="2273300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14" imgW="2153338" imgH="2273920" progId="SigmaPlotGraphicObject.12">
                              <p:embed/>
                            </p:oleObj>
                          </mc:Choice>
                          <mc:Fallback>
                            <p:oleObj name="SPW 13.0 Graph" r:id="rId14" imgW="2153338" imgH="2273920" progId="SigmaPlotGraphicObject.12">
                              <p:embed/>
                              <p:pic>
                                <p:nvPicPr>
                                  <p:cNvPr id="57" name="Object 56">
                                    <a:extLst>
                                      <a:ext uri="{FF2B5EF4-FFF2-40B4-BE49-F238E27FC236}">
                                        <a16:creationId xmlns:a16="http://schemas.microsoft.com/office/drawing/2014/main" id="{C0C541B1-52B0-FB1E-76F1-9FD3CB2D4350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15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1395275" y="3615353"/>
                                    <a:ext cx="2152650" cy="22733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grpSp>
                    <p:nvGrpSpPr>
                      <p:cNvPr id="51" name="Group 50">
                        <a:extLst>
                          <a:ext uri="{FF2B5EF4-FFF2-40B4-BE49-F238E27FC236}">
                            <a16:creationId xmlns:a16="http://schemas.microsoft.com/office/drawing/2014/main" id="{A5437BF5-5286-7FB9-A4BD-A4D0814B933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04749" y="3724767"/>
                        <a:ext cx="2511193" cy="1667446"/>
                        <a:chOff x="9120541" y="3670499"/>
                        <a:chExt cx="2511193" cy="1667446"/>
                      </a:xfrm>
                    </p:grpSpPr>
                    <p:grpSp>
                      <p:nvGrpSpPr>
                        <p:cNvPr id="41" name="Group 40">
                          <a:extLst>
                            <a:ext uri="{FF2B5EF4-FFF2-40B4-BE49-F238E27FC236}">
                              <a16:creationId xmlns:a16="http://schemas.microsoft.com/office/drawing/2014/main" id="{12A3CE0A-9769-DCB5-9075-1162777064A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9584363" y="4122106"/>
                          <a:ext cx="2047371" cy="1215839"/>
                          <a:chOff x="2354798" y="1290397"/>
                          <a:chExt cx="2047371" cy="1215839"/>
                        </a:xfrm>
                      </p:grpSpPr>
                      <p:sp>
                        <p:nvSpPr>
                          <p:cNvPr id="22" name="TextBox 21">
                            <a:extLst>
                              <a:ext uri="{FF2B5EF4-FFF2-40B4-BE49-F238E27FC236}">
                                <a16:creationId xmlns:a16="http://schemas.microsoft.com/office/drawing/2014/main" id="{0C9DEF3E-F887-0DBF-9552-85B74D269F3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54798" y="1566646"/>
                            <a:ext cx="562975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DCNQ</a:t>
                            </a:r>
                          </a:p>
                        </p:txBody>
                      </p:sp>
                      <p:cxnSp>
                        <p:nvCxnSpPr>
                          <p:cNvPr id="23" name="Straight Arrow Connector 22">
                            <a:extLst>
                              <a:ext uri="{FF2B5EF4-FFF2-40B4-BE49-F238E27FC236}">
                                <a16:creationId xmlns:a16="http://schemas.microsoft.com/office/drawing/2014/main" id="{98AFF594-79B1-22F6-F48B-28C28E2EECF2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10800000">
                            <a:off x="2624582" y="1460285"/>
                            <a:ext cx="0" cy="149453"/>
                          </a:xfrm>
                          <a:prstGeom prst="straightConnector1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  <a:tailEnd type="stealth" w="sm" len="med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5" name="Straight Arrow Connector 24">
                            <a:extLst>
                              <a:ext uri="{FF2B5EF4-FFF2-40B4-BE49-F238E27FC236}">
                                <a16:creationId xmlns:a16="http://schemas.microsoft.com/office/drawing/2014/main" id="{817B919E-3D1A-7FA2-264A-0E3CC39684B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V="1">
                            <a:off x="2857076" y="1547644"/>
                            <a:ext cx="0" cy="418044"/>
                          </a:xfrm>
                          <a:prstGeom prst="straightConnector1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  <a:tailEnd type="stealth" w="sm" len="med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26" name="TextBox 25">
                            <a:extLst>
                              <a:ext uri="{FF2B5EF4-FFF2-40B4-BE49-F238E27FC236}">
                                <a16:creationId xmlns:a16="http://schemas.microsoft.com/office/drawing/2014/main" id="{8B21FB80-DD55-BB7A-E431-7AA77148195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617809" y="1932762"/>
                            <a:ext cx="410690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H</a:t>
                            </a:r>
                            <a:r>
                              <a:rPr lang="en-US" sz="1000" baseline="-25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2</a:t>
                            </a:r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S</a:t>
                            </a:r>
                          </a:p>
                        </p:txBody>
                      </p:sp>
                      <p:sp>
                        <p:nvSpPr>
                          <p:cNvPr id="27" name="TextBox 26">
                            <a:extLst>
                              <a:ext uri="{FF2B5EF4-FFF2-40B4-BE49-F238E27FC236}">
                                <a16:creationId xmlns:a16="http://schemas.microsoft.com/office/drawing/2014/main" id="{E1620A40-7E13-6EEB-742A-8AD63EE95DA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821561" y="1551089"/>
                            <a:ext cx="580608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i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50-300</a:t>
                            </a:r>
                          </a:p>
                        </p:txBody>
                      </p:sp>
                      <p:sp>
                        <p:nvSpPr>
                          <p:cNvPr id="29" name="TextBox 28">
                            <a:extLst>
                              <a:ext uri="{FF2B5EF4-FFF2-40B4-BE49-F238E27FC236}">
                                <a16:creationId xmlns:a16="http://schemas.microsoft.com/office/drawing/2014/main" id="{3A4E3E38-0FA7-7E8C-58F8-A026F7724F5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93722" y="1290397"/>
                            <a:ext cx="325730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50</a:t>
                            </a:r>
                          </a:p>
                        </p:txBody>
                      </p:sp>
                      <p:sp>
                        <p:nvSpPr>
                          <p:cNvPr id="31" name="TextBox 30">
                            <a:extLst>
                              <a:ext uri="{FF2B5EF4-FFF2-40B4-BE49-F238E27FC236}">
                                <a16:creationId xmlns:a16="http://schemas.microsoft.com/office/drawing/2014/main" id="{E876CAA4-58BC-06AA-6051-4C768E7C96E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894282" y="1537624"/>
                            <a:ext cx="39626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00</a:t>
                            </a:r>
                          </a:p>
                        </p:txBody>
                      </p:sp>
                      <p:sp>
                        <p:nvSpPr>
                          <p:cNvPr id="33" name="TextBox 32">
                            <a:extLst>
                              <a:ext uri="{FF2B5EF4-FFF2-40B4-BE49-F238E27FC236}">
                                <a16:creationId xmlns:a16="http://schemas.microsoft.com/office/drawing/2014/main" id="{A551042C-23B3-3A0C-59CC-5732FEC319B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280362" y="1669704"/>
                            <a:ext cx="39626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50</a:t>
                            </a:r>
                          </a:p>
                        </p:txBody>
                      </p:sp>
                      <p:sp>
                        <p:nvSpPr>
                          <p:cNvPr id="34" name="TextBox 33">
                            <a:extLst>
                              <a:ext uri="{FF2B5EF4-FFF2-40B4-BE49-F238E27FC236}">
                                <a16:creationId xmlns:a16="http://schemas.microsoft.com/office/drawing/2014/main" id="{A96E4E65-1640-1758-55B7-A05556DD574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36738" y="1830939"/>
                            <a:ext cx="39626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200</a:t>
                            </a:r>
                          </a:p>
                        </p:txBody>
                      </p:sp>
                      <p:sp>
                        <p:nvSpPr>
                          <p:cNvPr id="36" name="TextBox 35">
                            <a:extLst>
                              <a:ext uri="{FF2B5EF4-FFF2-40B4-BE49-F238E27FC236}">
                                <a16:creationId xmlns:a16="http://schemas.microsoft.com/office/drawing/2014/main" id="{3F689B35-D7DA-D85F-6C42-3EC5E08FDF6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15681" y="2260015"/>
                            <a:ext cx="39626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300</a:t>
                            </a:r>
                          </a:p>
                        </p:txBody>
                      </p:sp>
                      <p:sp>
                        <p:nvSpPr>
                          <p:cNvPr id="39" name="Right Brace 38">
                            <a:extLst>
                              <a:ext uri="{FF2B5EF4-FFF2-40B4-BE49-F238E27FC236}">
                                <a16:creationId xmlns:a16="http://schemas.microsoft.com/office/drawing/2014/main" id="{5C894FBF-27E9-AF44-01E8-835D9A02268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802174" y="1498969"/>
                            <a:ext cx="77405" cy="346126"/>
                          </a:xfrm>
                          <a:prstGeom prst="rightBrace">
                            <a:avLst>
                              <a:gd name="adj1" fmla="val 39904"/>
                              <a:gd name="adj2" fmla="val 50000"/>
                            </a:avLst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50" name="TextBox 49">
                          <a:extLst>
                            <a:ext uri="{FF2B5EF4-FFF2-40B4-BE49-F238E27FC236}">
                              <a16:creationId xmlns:a16="http://schemas.microsoft.com/office/drawing/2014/main" id="{B047593D-F0DC-0CC5-B6E7-AB3A5B80F03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120541" y="3670499"/>
                          <a:ext cx="324292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H</a:t>
                          </a:r>
                        </a:p>
                      </p:txBody>
                    </p:sp>
                  </p:grpSp>
                </p:grpSp>
                <p:grpSp>
                  <p:nvGrpSpPr>
                    <p:cNvPr id="35" name="Group 34">
                      <a:extLst>
                        <a:ext uri="{FF2B5EF4-FFF2-40B4-BE49-F238E27FC236}">
                          <a16:creationId xmlns:a16="http://schemas.microsoft.com/office/drawing/2014/main" id="{1E01B9D2-AA0E-834E-0668-492ACA462A8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631398" y="3585723"/>
                      <a:ext cx="2616619" cy="2300287"/>
                      <a:chOff x="6631398" y="3585723"/>
                      <a:chExt cx="2616619" cy="2300287"/>
                    </a:xfrm>
                  </p:grpSpPr>
                  <p:sp>
                    <p:nvSpPr>
                      <p:cNvPr id="111" name="TextBox 110">
                        <a:extLst>
                          <a:ext uri="{FF2B5EF4-FFF2-40B4-BE49-F238E27FC236}">
                            <a16:creationId xmlns:a16="http://schemas.microsoft.com/office/drawing/2014/main" id="{CC96EF26-53A3-C3B9-E154-D6B025F4D12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31398" y="3712011"/>
                        <a:ext cx="324292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US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</a:t>
                        </a:r>
                      </a:p>
                    </p:txBody>
                  </p:sp>
                  <p:graphicFrame>
                    <p:nvGraphicFramePr>
                      <p:cNvPr id="112" name="Object 111">
                        <a:extLst>
                          <a:ext uri="{FF2B5EF4-FFF2-40B4-BE49-F238E27FC236}">
                            <a16:creationId xmlns:a16="http://schemas.microsoft.com/office/drawing/2014/main" id="{6D9DCE8C-815C-AE44-506F-6FDBEA89E0E3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955937572"/>
                          </p:ext>
                        </p:extLst>
                      </p:nvPr>
                    </p:nvGraphicFramePr>
                    <p:xfrm>
                      <a:off x="6758817" y="3585723"/>
                      <a:ext cx="2489200" cy="2300287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16" imgW="2488839" imgH="2299834" progId="SigmaPlotGraphicObject.12">
                              <p:embed/>
                            </p:oleObj>
                          </mc:Choice>
                          <mc:Fallback>
                            <p:oleObj name="SPW 13.0 Graph" r:id="rId16" imgW="2488839" imgH="2299834" progId="SigmaPlotGraphicObject.12">
                              <p:embed/>
                              <p:pic>
                                <p:nvPicPr>
                                  <p:cNvPr id="112" name="Object 111">
                                    <a:extLst>
                                      <a:ext uri="{FF2B5EF4-FFF2-40B4-BE49-F238E27FC236}">
                                        <a16:creationId xmlns:a16="http://schemas.microsoft.com/office/drawing/2014/main" id="{6D9DCE8C-815C-AE44-506F-6FDBEA89E0E3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17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6758817" y="3585723"/>
                                    <a:ext cx="2489200" cy="2300287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sp>
                    <p:nvSpPr>
                      <p:cNvPr id="119" name="TextBox 118">
                        <a:extLst>
                          <a:ext uri="{FF2B5EF4-FFF2-40B4-BE49-F238E27FC236}">
                            <a16:creationId xmlns:a16="http://schemas.microsoft.com/office/drawing/2014/main" id="{71411A39-48B3-AF64-DE0B-2C8B0C0E48A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461095" y="3869794"/>
                        <a:ext cx="128913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ate O</a:t>
                        </a:r>
                        <a:r>
                          <a:rPr lang="en-US" sz="1000" baseline="-25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Consumed</a:t>
                        </a:r>
                      </a:p>
                    </p:txBody>
                  </p:sp>
                </p:grpSp>
                <p:grpSp>
                  <p:nvGrpSpPr>
                    <p:cNvPr id="42" name="Group 41">
                      <a:extLst>
                        <a:ext uri="{FF2B5EF4-FFF2-40B4-BE49-F238E27FC236}">
                          <a16:creationId xmlns:a16="http://schemas.microsoft.com/office/drawing/2014/main" id="{DD129E1B-70CE-06C8-82BC-0EB4756C398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904067" y="3594614"/>
                      <a:ext cx="2948250" cy="2308225"/>
                      <a:chOff x="3904067" y="3594614"/>
                      <a:chExt cx="2948250" cy="2308225"/>
                    </a:xfrm>
                  </p:grpSpPr>
                  <p:sp>
                    <p:nvSpPr>
                      <p:cNvPr id="108" name="TextBox 107">
                        <a:extLst>
                          <a:ext uri="{FF2B5EF4-FFF2-40B4-BE49-F238E27FC236}">
                            <a16:creationId xmlns:a16="http://schemas.microsoft.com/office/drawing/2014/main" id="{8E84A4AB-011E-67F2-0E0F-7432C18FC3F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04067" y="3715056"/>
                        <a:ext cx="324292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US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</a:t>
                        </a:r>
                      </a:p>
                    </p:txBody>
                  </p:sp>
                  <p:sp>
                    <p:nvSpPr>
                      <p:cNvPr id="118" name="TextBox 117">
                        <a:extLst>
                          <a:ext uri="{FF2B5EF4-FFF2-40B4-BE49-F238E27FC236}">
                            <a16:creationId xmlns:a16="http://schemas.microsoft.com/office/drawing/2014/main" id="{0F4228A9-80BD-2A9F-C8CC-68FC47F616F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97334" y="3869794"/>
                        <a:ext cx="98456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O</a:t>
                        </a:r>
                        <a:r>
                          <a:rPr lang="en-US" sz="1000" baseline="-25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Consumed</a:t>
                        </a:r>
                      </a:p>
                    </p:txBody>
                  </p:sp>
                  <p:graphicFrame>
                    <p:nvGraphicFrame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F981EBC-8B98-9365-E9D2-CE3614C5FC51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264884775"/>
                          </p:ext>
                        </p:extLst>
                      </p:nvPr>
                    </p:nvGraphicFramePr>
                    <p:xfrm>
                      <a:off x="3958304" y="3594614"/>
                      <a:ext cx="2894013" cy="2308225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18" imgW="2893966" imgH="2308832" progId="SigmaPlotGraphicObject.12">
                              <p:embed/>
                            </p:oleObj>
                          </mc:Choice>
                          <mc:Fallback>
                            <p:oleObj name="SPW 13.0 Graph" r:id="rId18" imgW="2893966" imgH="2308832" progId="SigmaPlotGraphicObject.12">
                              <p:embed/>
                              <p:pic>
                                <p:nvPicPr>
                                  <p:cNvPr id="8" name="Object 7">
                                    <a:extLst>
                                      <a:ext uri="{FF2B5EF4-FFF2-40B4-BE49-F238E27FC236}">
                                        <a16:creationId xmlns:a16="http://schemas.microsoft.com/office/drawing/2014/main" id="{9F981EBC-8B98-9365-E9D2-CE3614C5FC51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19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3958304" y="3594614"/>
                                    <a:ext cx="2894013" cy="2308225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</p:grpSp>
              </p:grpSp>
              <p:grpSp>
                <p:nvGrpSpPr>
                  <p:cNvPr id="64" name="Group 63">
                    <a:extLst>
                      <a:ext uri="{FF2B5EF4-FFF2-40B4-BE49-F238E27FC236}">
                        <a16:creationId xmlns:a16="http://schemas.microsoft.com/office/drawing/2014/main" id="{8F60C7EB-E352-4E74-276C-134634214216}"/>
                      </a:ext>
                    </a:extLst>
                  </p:cNvPr>
                  <p:cNvGrpSpPr/>
                  <p:nvPr/>
                </p:nvGrpSpPr>
                <p:grpSpPr>
                  <a:xfrm>
                    <a:off x="8928595" y="2499316"/>
                    <a:ext cx="1343050" cy="1129267"/>
                    <a:chOff x="9164901" y="3648082"/>
                    <a:chExt cx="1343050" cy="1129267"/>
                  </a:xfrm>
                </p:grpSpPr>
                <p:sp>
                  <p:nvSpPr>
                    <p:cNvPr id="9" name="TextBox 8">
                      <a:extLst>
                        <a:ext uri="{FF2B5EF4-FFF2-40B4-BE49-F238E27FC236}">
                          <a16:creationId xmlns:a16="http://schemas.microsoft.com/office/drawing/2014/main" id="{52B64F65-630B-9845-D21E-80987C95F9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553665" y="4531128"/>
                      <a:ext cx="56297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NQ</a:t>
                      </a:r>
                    </a:p>
                  </p:txBody>
                </p:sp>
                <p:cxnSp>
                  <p:nvCxnSpPr>
                    <p:cNvPr id="11" name="Straight Arrow Connector 10">
                      <a:extLst>
                        <a:ext uri="{FF2B5EF4-FFF2-40B4-BE49-F238E27FC236}">
                          <a16:creationId xmlns:a16="http://schemas.microsoft.com/office/drawing/2014/main" id="{C56148FF-D0A0-65CD-B28D-C713DC5175F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9957226" y="4110605"/>
                      <a:ext cx="185064" cy="45715"/>
                    </a:xfrm>
                    <a:prstGeom prst="straightConnector1">
                      <a:avLst/>
                    </a:prstGeom>
                    <a:ln w="9525">
                      <a:solidFill>
                        <a:schemeClr val="tx1"/>
                      </a:solidFill>
                      <a:tailEnd type="stealth" w="sm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" name="TextBox 11">
                      <a:extLst>
                        <a:ext uri="{FF2B5EF4-FFF2-40B4-BE49-F238E27FC236}">
                          <a16:creationId xmlns:a16="http://schemas.microsoft.com/office/drawing/2014/main" id="{B5303672-233D-3C5E-8C3B-4DD4E8B7C12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097261" y="3978650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10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p:txBody>
                </p:sp>
                <p:cxnSp>
                  <p:nvCxnSpPr>
                    <p:cNvPr id="17" name="Straight Arrow Connector 16">
                      <a:extLst>
                        <a:ext uri="{FF2B5EF4-FFF2-40B4-BE49-F238E27FC236}">
                          <a16:creationId xmlns:a16="http://schemas.microsoft.com/office/drawing/2014/main" id="{DA2EB88B-3E12-122D-6D7F-F803717806B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9820614" y="4172371"/>
                      <a:ext cx="0" cy="418044"/>
                    </a:xfrm>
                    <a:prstGeom prst="straightConnector1">
                      <a:avLst/>
                    </a:prstGeom>
                    <a:ln w="9525">
                      <a:solidFill>
                        <a:schemeClr val="tx1"/>
                      </a:solidFill>
                      <a:tailEnd type="stealth" w="sm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00407546-3BA8-53DA-FD8D-A5196AFF47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164901" y="3648082"/>
                      <a:ext cx="3242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p:txBody>
                </p:sp>
              </p:grpSp>
            </p:grpSp>
          </p:grpSp>
          <p:grpSp>
            <p:nvGrpSpPr>
              <p:cNvPr id="147" name="Group 146">
                <a:extLst>
                  <a:ext uri="{FF2B5EF4-FFF2-40B4-BE49-F238E27FC236}">
                    <a16:creationId xmlns:a16="http://schemas.microsoft.com/office/drawing/2014/main" id="{009F0176-5B7E-75D2-8899-9704DA4D53B5}"/>
                  </a:ext>
                </a:extLst>
              </p:cNvPr>
              <p:cNvGrpSpPr/>
              <p:nvPr/>
            </p:nvGrpSpPr>
            <p:grpSpPr>
              <a:xfrm>
                <a:off x="798634" y="4403789"/>
                <a:ext cx="11056542" cy="2250017"/>
                <a:chOff x="798634" y="4403789"/>
                <a:chExt cx="11056542" cy="2250017"/>
              </a:xfrm>
            </p:grpSpPr>
            <p:grpSp>
              <p:nvGrpSpPr>
                <p:cNvPr id="135" name="Group 134">
                  <a:extLst>
                    <a:ext uri="{FF2B5EF4-FFF2-40B4-BE49-F238E27FC236}">
                      <a16:creationId xmlns:a16="http://schemas.microsoft.com/office/drawing/2014/main" id="{4479966F-7D3C-DB3F-D265-FA540B07A69A}"/>
                    </a:ext>
                  </a:extLst>
                </p:cNvPr>
                <p:cNvGrpSpPr/>
                <p:nvPr/>
              </p:nvGrpSpPr>
              <p:grpSpPr>
                <a:xfrm>
                  <a:off x="798634" y="4418606"/>
                  <a:ext cx="2138813" cy="2235200"/>
                  <a:chOff x="1373991" y="4622800"/>
                  <a:chExt cx="2138813" cy="2235200"/>
                </a:xfrm>
              </p:grpSpPr>
              <p:grpSp>
                <p:nvGrpSpPr>
                  <p:cNvPr id="106" name="Group 105">
                    <a:extLst>
                      <a:ext uri="{FF2B5EF4-FFF2-40B4-BE49-F238E27FC236}">
                        <a16:creationId xmlns:a16="http://schemas.microsoft.com/office/drawing/2014/main" id="{CB17208E-34C4-6943-C010-B480E9F8CCA0}"/>
                      </a:ext>
                    </a:extLst>
                  </p:cNvPr>
                  <p:cNvGrpSpPr/>
                  <p:nvPr/>
                </p:nvGrpSpPr>
                <p:grpSpPr>
                  <a:xfrm>
                    <a:off x="1447467" y="4622800"/>
                    <a:ext cx="2065337" cy="2235200"/>
                    <a:chOff x="1447467" y="4622800"/>
                    <a:chExt cx="2065337" cy="2235200"/>
                  </a:xfrm>
                </p:grpSpPr>
                <p:grpSp>
                  <p:nvGrpSpPr>
                    <p:cNvPr id="92" name="Group 91">
                      <a:extLst>
                        <a:ext uri="{FF2B5EF4-FFF2-40B4-BE49-F238E27FC236}">
                          <a16:creationId xmlns:a16="http://schemas.microsoft.com/office/drawing/2014/main" id="{0BBD3728-83A6-FAA3-81AB-9B2AD8E887B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47467" y="4622800"/>
                      <a:ext cx="2065337" cy="2235200"/>
                      <a:chOff x="1447467" y="4622800"/>
                      <a:chExt cx="2065337" cy="2235200"/>
                    </a:xfrm>
                  </p:grpSpPr>
                  <p:graphicFrame>
                    <p:nvGraphicFrame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82DEF068-9A90-8C82-AE8E-5C0BEE1308BD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994259143"/>
                          </p:ext>
                        </p:extLst>
                      </p:nvPr>
                    </p:nvGraphicFramePr>
                    <p:xfrm>
                      <a:off x="1447467" y="4622800"/>
                      <a:ext cx="2065337" cy="2235200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SPW 13.0 Graph" r:id="rId20" imgW="2064954" imgH="2235770" progId="SigmaPlotGraphicObject.12">
                              <p:embed/>
                            </p:oleObj>
                          </mc:Choice>
                          <mc:Fallback>
                            <p:oleObj name="SPW 13.0 Graph" r:id="rId20" imgW="2064954" imgH="2235770" progId="SigmaPlotGraphicObject.12">
                              <p:embed/>
                              <p:pic>
                                <p:nvPicPr>
                                  <p:cNvPr id="62" name="Object 61">
                                    <a:extLst>
                                      <a:ext uri="{FF2B5EF4-FFF2-40B4-BE49-F238E27FC236}">
                                        <a16:creationId xmlns:a16="http://schemas.microsoft.com/office/drawing/2014/main" id="{82DEF068-9A90-8C82-AE8E-5C0BEE1308BD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21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1447467" y="4622800"/>
                                    <a:ext cx="2065337" cy="2235200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sp>
                    <p:nvSpPr>
                      <p:cNvPr id="5" name="TextBox 4">
                        <a:extLst>
                          <a:ext uri="{FF2B5EF4-FFF2-40B4-BE49-F238E27FC236}">
                            <a16:creationId xmlns:a16="http://schemas.microsoft.com/office/drawing/2014/main" id="{C2EA243E-D6E6-664D-55C2-57B924C4B46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35220" y="4952413"/>
                        <a:ext cx="64408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,4-NQ</a:t>
                        </a:r>
                      </a:p>
                    </p:txBody>
                  </p:sp>
                  <p:sp>
                    <p:nvSpPr>
                      <p:cNvPr id="67" name="TextBox 66">
                        <a:extLst>
                          <a:ext uri="{FF2B5EF4-FFF2-40B4-BE49-F238E27FC236}">
                            <a16:creationId xmlns:a16="http://schemas.microsoft.com/office/drawing/2014/main" id="{FA77E361-AD50-55D5-4E98-4C88F3051AF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64794" y="5316218"/>
                        <a:ext cx="64408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MSO</a:t>
                        </a:r>
                      </a:p>
                    </p:txBody>
                  </p:sp>
                </p:grpSp>
                <p:cxnSp>
                  <p:nvCxnSpPr>
                    <p:cNvPr id="93" name="Straight Arrow Connector 92">
                      <a:extLst>
                        <a:ext uri="{FF2B5EF4-FFF2-40B4-BE49-F238E27FC236}">
                          <a16:creationId xmlns:a16="http://schemas.microsoft.com/office/drawing/2014/main" id="{91072F24-35EB-D8C0-B090-4E71E4C584B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51681" y="5506626"/>
                      <a:ext cx="0" cy="155699"/>
                    </a:xfrm>
                    <a:prstGeom prst="straightConnector1">
                      <a:avLst/>
                    </a:prstGeom>
                    <a:ln w="9525">
                      <a:solidFill>
                        <a:schemeClr val="tx1"/>
                      </a:solidFill>
                      <a:tailEnd type="stealth" w="sm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974DBCC3-0C1C-9053-62F2-D1A659C262F0}"/>
                      </a:ext>
                    </a:extLst>
                  </p:cNvPr>
                  <p:cNvSpPr txBox="1"/>
                  <p:nvPr/>
                </p:nvSpPr>
                <p:spPr>
                  <a:xfrm>
                    <a:off x="1373991" y="4812308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</a:t>
                    </a:r>
                  </a:p>
                </p:txBody>
              </p:sp>
            </p:grpSp>
            <p:grpSp>
              <p:nvGrpSpPr>
                <p:cNvPr id="136" name="Group 135">
                  <a:extLst>
                    <a:ext uri="{FF2B5EF4-FFF2-40B4-BE49-F238E27FC236}">
                      <a16:creationId xmlns:a16="http://schemas.microsoft.com/office/drawing/2014/main" id="{A2671E23-D4A8-67F4-9701-6F1869FC6F20}"/>
                    </a:ext>
                  </a:extLst>
                </p:cNvPr>
                <p:cNvGrpSpPr/>
                <p:nvPr/>
              </p:nvGrpSpPr>
              <p:grpSpPr>
                <a:xfrm>
                  <a:off x="2691638" y="4418606"/>
                  <a:ext cx="2132375" cy="2235200"/>
                  <a:chOff x="3338019" y="4622800"/>
                  <a:chExt cx="2132375" cy="2235200"/>
                </a:xfrm>
              </p:grpSpPr>
              <p:grpSp>
                <p:nvGrpSpPr>
                  <p:cNvPr id="90" name="Group 89">
                    <a:extLst>
                      <a:ext uri="{FF2B5EF4-FFF2-40B4-BE49-F238E27FC236}">
                        <a16:creationId xmlns:a16="http://schemas.microsoft.com/office/drawing/2014/main" id="{5E81CC4B-378D-6419-4B66-59413AD5230F}"/>
                      </a:ext>
                    </a:extLst>
                  </p:cNvPr>
                  <p:cNvGrpSpPr/>
                  <p:nvPr/>
                </p:nvGrpSpPr>
                <p:grpSpPr>
                  <a:xfrm>
                    <a:off x="3405057" y="4622800"/>
                    <a:ext cx="2065337" cy="2235200"/>
                    <a:chOff x="3708659" y="4622800"/>
                    <a:chExt cx="2065337" cy="2235200"/>
                  </a:xfrm>
                </p:grpSpPr>
                <p:graphicFrame>
                  <p:nvGraphicFramePr>
                    <p:cNvPr id="73" name="Object 72">
                      <a:extLst>
                        <a:ext uri="{FF2B5EF4-FFF2-40B4-BE49-F238E27FC236}">
                          <a16:creationId xmlns:a16="http://schemas.microsoft.com/office/drawing/2014/main" id="{A5C6C54A-A386-9E30-6D65-B8D3DDD513F6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620766748"/>
                        </p:ext>
                      </p:extLst>
                    </p:nvPr>
                  </p:nvGraphicFramePr>
                  <p:xfrm>
                    <a:off x="3708659" y="4622800"/>
                    <a:ext cx="2065337" cy="2235200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22" imgW="2064954" imgH="2235770" progId="SigmaPlotGraphicObject.12">
                            <p:embed/>
                          </p:oleObj>
                        </mc:Choice>
                        <mc:Fallback>
                          <p:oleObj name="SPW 13.0 Graph" r:id="rId22" imgW="2064954" imgH="2235770" progId="SigmaPlotGraphicObject.12">
                            <p:embed/>
                            <p:pic>
                              <p:nvPicPr>
                                <p:cNvPr id="73" name="Object 72">
                                  <a:extLst>
                                    <a:ext uri="{FF2B5EF4-FFF2-40B4-BE49-F238E27FC236}">
                                      <a16:creationId xmlns:a16="http://schemas.microsoft.com/office/drawing/2014/main" id="{A5C6C54A-A386-9E30-6D65-B8D3DDD513F6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23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3708659" y="4622800"/>
                                  <a:ext cx="2065337" cy="2235200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F2643E98-D78D-60C2-9135-803CB408584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30528" y="4952413"/>
                      <a:ext cx="64408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glone</a:t>
                      </a:r>
                    </a:p>
                  </p:txBody>
                </p:sp>
              </p:grp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3539260A-CFAE-990E-A567-5C16BDBEB891}"/>
                      </a:ext>
                    </a:extLst>
                  </p:cNvPr>
                  <p:cNvSpPr txBox="1"/>
                  <p:nvPr/>
                </p:nvSpPr>
                <p:spPr>
                  <a:xfrm>
                    <a:off x="3338019" y="4814456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</a:p>
                </p:txBody>
              </p:sp>
            </p:grpSp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98520181-CB44-6FFF-9F81-C98B0BB10356}"/>
                    </a:ext>
                  </a:extLst>
                </p:cNvPr>
                <p:cNvGrpSpPr/>
                <p:nvPr/>
              </p:nvGrpSpPr>
              <p:grpSpPr>
                <a:xfrm>
                  <a:off x="4401875" y="4403789"/>
                  <a:ext cx="2126144" cy="2235200"/>
                  <a:chOff x="4919435" y="4403789"/>
                  <a:chExt cx="2126144" cy="2235200"/>
                </a:xfrm>
              </p:grpSpPr>
              <p:graphicFrame>
                <p:nvGraphicFramePr>
                  <p:cNvPr id="142" name="Object 141">
                    <a:extLst>
                      <a:ext uri="{FF2B5EF4-FFF2-40B4-BE49-F238E27FC236}">
                        <a16:creationId xmlns:a16="http://schemas.microsoft.com/office/drawing/2014/main" id="{577F570D-822F-281D-68A6-346C97FA9AC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780581669"/>
                      </p:ext>
                    </p:extLst>
                  </p:nvPr>
                </p:nvGraphicFramePr>
                <p:xfrm>
                  <a:off x="4980242" y="4403789"/>
                  <a:ext cx="2065337" cy="22352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4" imgW="2064954" imgH="2235770" progId="SigmaPlotGraphicObject.12">
                          <p:embed/>
                        </p:oleObj>
                      </mc:Choice>
                      <mc:Fallback>
                        <p:oleObj name="SPW 13.0 Graph" r:id="rId24" imgW="2064954" imgH="2235770" progId="SigmaPlotGraphicObject.12">
                          <p:embed/>
                          <p:pic>
                            <p:nvPicPr>
                              <p:cNvPr id="142" name="Object 141">
                                <a:extLst>
                                  <a:ext uri="{FF2B5EF4-FFF2-40B4-BE49-F238E27FC236}">
                                    <a16:creationId xmlns:a16="http://schemas.microsoft.com/office/drawing/2014/main" id="{577F570D-822F-281D-68A6-346C97FA9AC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980242" y="4403789"/>
                                <a:ext cx="2065337" cy="22352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6AC1ED3D-236D-E9E4-7ADF-B907AABF79E3}"/>
                      </a:ext>
                    </a:extLst>
                  </p:cNvPr>
                  <p:cNvSpPr txBox="1"/>
                  <p:nvPr/>
                </p:nvSpPr>
                <p:spPr>
                  <a:xfrm>
                    <a:off x="5690967" y="4753965"/>
                    <a:ext cx="86446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umbagin</a:t>
                    </a:r>
                  </a:p>
                </p:txBody>
              </p:sp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AFDA175C-C430-73AF-7C87-B2FB4908F697}"/>
                      </a:ext>
                    </a:extLst>
                  </p:cNvPr>
                  <p:cNvSpPr txBox="1"/>
                  <p:nvPr/>
                </p:nvSpPr>
                <p:spPr>
                  <a:xfrm>
                    <a:off x="4919435" y="4617099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137" name="Group 136">
                  <a:extLst>
                    <a:ext uri="{FF2B5EF4-FFF2-40B4-BE49-F238E27FC236}">
                      <a16:creationId xmlns:a16="http://schemas.microsoft.com/office/drawing/2014/main" id="{5BCDF5E7-23D5-88AB-965C-1E4A286AFBC6}"/>
                    </a:ext>
                  </a:extLst>
                </p:cNvPr>
                <p:cNvGrpSpPr/>
                <p:nvPr/>
              </p:nvGrpSpPr>
              <p:grpSpPr>
                <a:xfrm>
                  <a:off x="6221016" y="4418606"/>
                  <a:ext cx="2134153" cy="2235200"/>
                  <a:chOff x="7385546" y="4622800"/>
                  <a:chExt cx="2134153" cy="2235200"/>
                </a:xfrm>
              </p:grpSpPr>
              <p:grpSp>
                <p:nvGrpSpPr>
                  <p:cNvPr id="86" name="Group 85">
                    <a:extLst>
                      <a:ext uri="{FF2B5EF4-FFF2-40B4-BE49-F238E27FC236}">
                        <a16:creationId xmlns:a16="http://schemas.microsoft.com/office/drawing/2014/main" id="{7EE8BF73-60EE-3AF9-2F82-CA7B8AF25B98}"/>
                      </a:ext>
                    </a:extLst>
                  </p:cNvPr>
                  <p:cNvGrpSpPr/>
                  <p:nvPr/>
                </p:nvGrpSpPr>
                <p:grpSpPr>
                  <a:xfrm>
                    <a:off x="7454362" y="4622800"/>
                    <a:ext cx="2065337" cy="2235200"/>
                    <a:chOff x="7945110" y="4622800"/>
                    <a:chExt cx="2065337" cy="2235200"/>
                  </a:xfrm>
                </p:grpSpPr>
                <p:graphicFrame>
                  <p:nvGraphicFramePr>
                    <p:cNvPr id="7" name="Object 6">
                      <a:extLst>
                        <a:ext uri="{FF2B5EF4-FFF2-40B4-BE49-F238E27FC236}">
                          <a16:creationId xmlns:a16="http://schemas.microsoft.com/office/drawing/2014/main" id="{3808BB29-DE4F-2CCF-99D2-D4CCA3898384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596694653"/>
                        </p:ext>
                      </p:extLst>
                    </p:nvPr>
                  </p:nvGraphicFramePr>
                  <p:xfrm>
                    <a:off x="7945110" y="4622800"/>
                    <a:ext cx="2065337" cy="2235200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26" imgW="2064954" imgH="2235770" progId="SigmaPlotGraphicObject.12">
                            <p:embed/>
                          </p:oleObj>
                        </mc:Choice>
                        <mc:Fallback>
                          <p:oleObj name="SPW 13.0 Graph" r:id="rId26" imgW="2064954" imgH="2235770" progId="SigmaPlotGraphicObject.12">
                            <p:embed/>
                            <p:pic>
                              <p:nvPicPr>
                                <p:cNvPr id="7" name="Object 6">
                                  <a:extLst>
                                    <a:ext uri="{FF2B5EF4-FFF2-40B4-BE49-F238E27FC236}">
                                      <a16:creationId xmlns:a16="http://schemas.microsoft.com/office/drawing/2014/main" id="{3808BB29-DE4F-2CCF-99D2-D4CCA3898384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2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7945110" y="4622800"/>
                                  <a:ext cx="2065337" cy="2235200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61" name="TextBox 60">
                      <a:extLst>
                        <a:ext uri="{FF2B5EF4-FFF2-40B4-BE49-F238E27FC236}">
                          <a16:creationId xmlns:a16="http://schemas.microsoft.com/office/drawing/2014/main" id="{51B7B7D1-DE37-7055-198D-2AF3696424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772167" y="4952413"/>
                      <a:ext cx="64408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NQ</a:t>
                      </a:r>
                    </a:p>
                  </p:txBody>
                </p:sp>
              </p:grpSp>
              <p:sp>
                <p:nvSpPr>
                  <p:cNvPr id="131" name="TextBox 130">
                    <a:extLst>
                      <a:ext uri="{FF2B5EF4-FFF2-40B4-BE49-F238E27FC236}">
                        <a16:creationId xmlns:a16="http://schemas.microsoft.com/office/drawing/2014/main" id="{B9471228-4526-0FBF-23BE-229D80E3B699}"/>
                      </a:ext>
                    </a:extLst>
                  </p:cNvPr>
                  <p:cNvSpPr txBox="1"/>
                  <p:nvPr/>
                </p:nvSpPr>
                <p:spPr>
                  <a:xfrm>
                    <a:off x="7385546" y="4820531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</a:p>
                </p:txBody>
              </p:sp>
            </p:grpSp>
            <p:grpSp>
              <p:nvGrpSpPr>
                <p:cNvPr id="138" name="Group 137">
                  <a:extLst>
                    <a:ext uri="{FF2B5EF4-FFF2-40B4-BE49-F238E27FC236}">
                      <a16:creationId xmlns:a16="http://schemas.microsoft.com/office/drawing/2014/main" id="{BAF35ECE-7465-21F2-797D-E0A22E59EB8C}"/>
                    </a:ext>
                  </a:extLst>
                </p:cNvPr>
                <p:cNvGrpSpPr/>
                <p:nvPr/>
              </p:nvGrpSpPr>
              <p:grpSpPr>
                <a:xfrm>
                  <a:off x="8064399" y="4418606"/>
                  <a:ext cx="2134017" cy="2235200"/>
                  <a:chOff x="9219042" y="4418606"/>
                  <a:chExt cx="2134017" cy="2235200"/>
                </a:xfrm>
              </p:grpSpPr>
              <p:grpSp>
                <p:nvGrpSpPr>
                  <p:cNvPr id="88" name="Group 87">
                    <a:extLst>
                      <a:ext uri="{FF2B5EF4-FFF2-40B4-BE49-F238E27FC236}">
                        <a16:creationId xmlns:a16="http://schemas.microsoft.com/office/drawing/2014/main" id="{7A53EE93-DD03-416B-2298-D961E2530402}"/>
                      </a:ext>
                    </a:extLst>
                  </p:cNvPr>
                  <p:cNvGrpSpPr/>
                  <p:nvPr/>
                </p:nvGrpSpPr>
                <p:grpSpPr>
                  <a:xfrm>
                    <a:off x="9287722" y="4418606"/>
                    <a:ext cx="2065337" cy="2235200"/>
                    <a:chOff x="5551636" y="4622800"/>
                    <a:chExt cx="2065337" cy="2235200"/>
                  </a:xfrm>
                </p:grpSpPr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145647E0-3120-F07F-7491-919CA7B415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69970" y="4952413"/>
                      <a:ext cx="64408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NQ</a:t>
                      </a:r>
                    </a:p>
                  </p:txBody>
                </p:sp>
                <p:graphicFrame>
                  <p:nvGraphicFramePr>
                    <p:cNvPr id="80" name="Object 79">
                      <a:extLst>
                        <a:ext uri="{FF2B5EF4-FFF2-40B4-BE49-F238E27FC236}">
                          <a16:creationId xmlns:a16="http://schemas.microsoft.com/office/drawing/2014/main" id="{CC7B070A-5BCC-66AB-01C8-88F65346E99B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1581325004"/>
                        </p:ext>
                      </p:extLst>
                    </p:nvPr>
                  </p:nvGraphicFramePr>
                  <p:xfrm>
                    <a:off x="5551636" y="4622800"/>
                    <a:ext cx="2065337" cy="2235200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SPW 13.0 Graph" r:id="rId28" imgW="2064954" imgH="2235770" progId="SigmaPlotGraphicObject.12">
                            <p:embed/>
                          </p:oleObj>
                        </mc:Choice>
                        <mc:Fallback>
                          <p:oleObj name="SPW 13.0 Graph" r:id="rId28" imgW="2064954" imgH="2235770" progId="SigmaPlotGraphicObject.12">
                            <p:embed/>
                            <p:pic>
                              <p:nvPicPr>
                                <p:cNvPr id="80" name="Object 79">
                                  <a:extLst>
                                    <a:ext uri="{FF2B5EF4-FFF2-40B4-BE49-F238E27FC236}">
                                      <a16:creationId xmlns:a16="http://schemas.microsoft.com/office/drawing/2014/main" id="{CC7B070A-5BCC-66AB-01C8-88F65346E99B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29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5551636" y="4622800"/>
                                  <a:ext cx="2065337" cy="2235200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</p:grpSp>
              <p:sp>
                <p:nvSpPr>
                  <p:cNvPr id="132" name="TextBox 131">
                    <a:extLst>
                      <a:ext uri="{FF2B5EF4-FFF2-40B4-BE49-F238E27FC236}">
                        <a16:creationId xmlns:a16="http://schemas.microsoft.com/office/drawing/2014/main" id="{24141357-C554-0D9B-DD77-FA8DF8E4ACDB}"/>
                      </a:ext>
                    </a:extLst>
                  </p:cNvPr>
                  <p:cNvSpPr txBox="1"/>
                  <p:nvPr/>
                </p:nvSpPr>
                <p:spPr>
                  <a:xfrm>
                    <a:off x="9219042" y="4618491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</p:grp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D60C02CF-7B41-46B0-BEAB-40260059BCB3}"/>
                    </a:ext>
                  </a:extLst>
                </p:cNvPr>
                <p:cNvGrpSpPr/>
                <p:nvPr/>
              </p:nvGrpSpPr>
              <p:grpSpPr>
                <a:xfrm>
                  <a:off x="9722847" y="4406032"/>
                  <a:ext cx="2132329" cy="2235200"/>
                  <a:chOff x="10257659" y="4406032"/>
                  <a:chExt cx="2132329" cy="2235200"/>
                </a:xfrm>
              </p:grpSpPr>
              <p:graphicFrame>
                <p:nvGraphicFramePr>
                  <p:cNvPr id="145" name="Object 144">
                    <a:extLst>
                      <a:ext uri="{FF2B5EF4-FFF2-40B4-BE49-F238E27FC236}">
                        <a16:creationId xmlns:a16="http://schemas.microsoft.com/office/drawing/2014/main" id="{031679E2-FB9B-9F4B-EC79-1EFD0DFCB533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991842782"/>
                      </p:ext>
                    </p:extLst>
                  </p:nvPr>
                </p:nvGraphicFramePr>
                <p:xfrm>
                  <a:off x="10324651" y="4406032"/>
                  <a:ext cx="2065337" cy="22352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30" imgW="2064954" imgH="2235770" progId="SigmaPlotGraphicObject.12">
                          <p:embed/>
                        </p:oleObj>
                      </mc:Choice>
                      <mc:Fallback>
                        <p:oleObj name="SPW 13.0 Graph" r:id="rId30" imgW="2064954" imgH="2235770" progId="SigmaPlotGraphicObject.12">
                          <p:embed/>
                          <p:pic>
                            <p:nvPicPr>
                              <p:cNvPr id="145" name="Object 144">
                                <a:extLst>
                                  <a:ext uri="{FF2B5EF4-FFF2-40B4-BE49-F238E27FC236}">
                                    <a16:creationId xmlns:a16="http://schemas.microsoft.com/office/drawing/2014/main" id="{031679E2-FB9B-9F4B-EC79-1EFD0DFCB53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0324651" y="4406032"/>
                                <a:ext cx="2065337" cy="22352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33" name="TextBox 132">
                    <a:extLst>
                      <a:ext uri="{FF2B5EF4-FFF2-40B4-BE49-F238E27FC236}">
                        <a16:creationId xmlns:a16="http://schemas.microsoft.com/office/drawing/2014/main" id="{3F937FDC-7075-E027-BB0F-E0CB62A75F5F}"/>
                      </a:ext>
                    </a:extLst>
                  </p:cNvPr>
                  <p:cNvSpPr txBox="1"/>
                  <p:nvPr/>
                </p:nvSpPr>
                <p:spPr>
                  <a:xfrm>
                    <a:off x="10257659" y="4616618"/>
                    <a:ext cx="32429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340BCD0A-F729-51D6-E586-0BE825AC58F9}"/>
                      </a:ext>
                    </a:extLst>
                  </p:cNvPr>
                  <p:cNvSpPr txBox="1"/>
                  <p:nvPr/>
                </p:nvSpPr>
                <p:spPr>
                  <a:xfrm>
                    <a:off x="10924315" y="4751094"/>
                    <a:ext cx="86446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nadione</a:t>
                    </a:r>
                  </a:p>
                </p:txBody>
              </p:sp>
            </p:grpSp>
          </p:grp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55E1ACAE-A395-C00F-25C2-4FBCCF36886A}"/>
                </a:ext>
              </a:extLst>
            </p:cNvPr>
            <p:cNvGrpSpPr/>
            <p:nvPr/>
          </p:nvGrpSpPr>
          <p:grpSpPr>
            <a:xfrm>
              <a:off x="10988611" y="5247502"/>
              <a:ext cx="557655" cy="246221"/>
              <a:chOff x="10988611" y="5247502"/>
              <a:chExt cx="557655" cy="246221"/>
            </a:xfrm>
          </p:grpSpPr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72E1BE5E-88FA-8F2F-95A3-E172E1DCFC72}"/>
                  </a:ext>
                </a:extLst>
              </p:cNvPr>
              <p:cNvSpPr txBox="1"/>
              <p:nvPr/>
            </p:nvSpPr>
            <p:spPr>
              <a:xfrm>
                <a:off x="11135576" y="5247502"/>
                <a:ext cx="410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152" name="Straight Arrow Connector 151">
                <a:extLst>
                  <a:ext uri="{FF2B5EF4-FFF2-40B4-BE49-F238E27FC236}">
                    <a16:creationId xmlns:a16="http://schemas.microsoft.com/office/drawing/2014/main" id="{DC8AEA1C-F7E7-BD72-07CB-C1199E61FE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988611" y="5376682"/>
                <a:ext cx="192007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16F8A24B-22B3-9D77-A4F0-2A40A1CF339B}"/>
                </a:ext>
              </a:extLst>
            </p:cNvPr>
            <p:cNvGrpSpPr/>
            <p:nvPr/>
          </p:nvGrpSpPr>
          <p:grpSpPr>
            <a:xfrm>
              <a:off x="2087065" y="4901138"/>
              <a:ext cx="557655" cy="246221"/>
              <a:chOff x="10988611" y="5247502"/>
              <a:chExt cx="557655" cy="246221"/>
            </a:xfrm>
          </p:grpSpPr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B2DD5308-0E63-D4C1-2312-4B9420095C4A}"/>
                  </a:ext>
                </a:extLst>
              </p:cNvPr>
              <p:cNvSpPr txBox="1"/>
              <p:nvPr/>
            </p:nvSpPr>
            <p:spPr>
              <a:xfrm>
                <a:off x="11135576" y="5247502"/>
                <a:ext cx="410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157" name="Straight Arrow Connector 156">
                <a:extLst>
                  <a:ext uri="{FF2B5EF4-FFF2-40B4-BE49-F238E27FC236}">
                    <a16:creationId xmlns:a16="http://schemas.microsoft.com/office/drawing/2014/main" id="{A8957F9B-68FC-3886-E89C-031E4D8D107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988611" y="5376682"/>
                <a:ext cx="192007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2542B582-E7DA-D485-45DA-E4EFC2ADBB6C}"/>
                </a:ext>
              </a:extLst>
            </p:cNvPr>
            <p:cNvGrpSpPr/>
            <p:nvPr/>
          </p:nvGrpSpPr>
          <p:grpSpPr>
            <a:xfrm>
              <a:off x="3943574" y="5199011"/>
              <a:ext cx="557655" cy="246221"/>
              <a:chOff x="10988611" y="5247502"/>
              <a:chExt cx="557655" cy="246221"/>
            </a:xfrm>
          </p:grpSpPr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E9DD5D12-C25D-F54B-07F6-42DD5066EFDC}"/>
                  </a:ext>
                </a:extLst>
              </p:cNvPr>
              <p:cNvSpPr txBox="1"/>
              <p:nvPr/>
            </p:nvSpPr>
            <p:spPr>
              <a:xfrm>
                <a:off x="11135576" y="5247502"/>
                <a:ext cx="410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160" name="Straight Arrow Connector 159">
                <a:extLst>
                  <a:ext uri="{FF2B5EF4-FFF2-40B4-BE49-F238E27FC236}">
                    <a16:creationId xmlns:a16="http://schemas.microsoft.com/office/drawing/2014/main" id="{74795D99-16C5-3B5D-4C41-336158DCF5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988611" y="5376682"/>
                <a:ext cx="192007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Group 160">
              <a:extLst>
                <a:ext uri="{FF2B5EF4-FFF2-40B4-BE49-F238E27FC236}">
                  <a16:creationId xmlns:a16="http://schemas.microsoft.com/office/drawing/2014/main" id="{6ABDA284-16F4-4DEB-B94F-05FEA30DB4BF}"/>
                </a:ext>
              </a:extLst>
            </p:cNvPr>
            <p:cNvGrpSpPr/>
            <p:nvPr/>
          </p:nvGrpSpPr>
          <p:grpSpPr>
            <a:xfrm>
              <a:off x="7497265" y="5046611"/>
              <a:ext cx="557655" cy="246221"/>
              <a:chOff x="10988611" y="5247502"/>
              <a:chExt cx="557655" cy="246221"/>
            </a:xfrm>
          </p:grpSpPr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19CCEB4A-CFDC-1D8F-BDF5-17D69B59230B}"/>
                  </a:ext>
                </a:extLst>
              </p:cNvPr>
              <p:cNvSpPr txBox="1"/>
              <p:nvPr/>
            </p:nvSpPr>
            <p:spPr>
              <a:xfrm>
                <a:off x="11135576" y="5247502"/>
                <a:ext cx="410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163" name="Straight Arrow Connector 162">
                <a:extLst>
                  <a:ext uri="{FF2B5EF4-FFF2-40B4-BE49-F238E27FC236}">
                    <a16:creationId xmlns:a16="http://schemas.microsoft.com/office/drawing/2014/main" id="{810AF234-6721-E31A-F850-25395687666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988611" y="5376682"/>
                <a:ext cx="192007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B29955FE-6CCE-B0ED-A467-4708204EBE57}"/>
                </a:ext>
              </a:extLst>
            </p:cNvPr>
            <p:cNvGrpSpPr/>
            <p:nvPr/>
          </p:nvGrpSpPr>
          <p:grpSpPr>
            <a:xfrm>
              <a:off x="9441873" y="5150520"/>
              <a:ext cx="538829" cy="246221"/>
              <a:chOff x="11007437" y="5247502"/>
              <a:chExt cx="538829" cy="246221"/>
            </a:xfrm>
          </p:grpSpPr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F5693E81-EBB4-008A-2CB3-A31DEE91A3CF}"/>
                  </a:ext>
                </a:extLst>
              </p:cNvPr>
              <p:cNvSpPr txBox="1"/>
              <p:nvPr/>
            </p:nvSpPr>
            <p:spPr>
              <a:xfrm>
                <a:off x="11135576" y="5247502"/>
                <a:ext cx="410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166" name="Straight Arrow Connector 165">
                <a:extLst>
                  <a:ext uri="{FF2B5EF4-FFF2-40B4-BE49-F238E27FC236}">
                    <a16:creationId xmlns:a16="http://schemas.microsoft.com/office/drawing/2014/main" id="{E7D17E0B-83D0-B206-C5CE-69F1340AAFF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007437" y="5376682"/>
                <a:ext cx="173181" cy="889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A512D385-DD85-F1C9-CBB5-2DCE391BC51B}"/>
                </a:ext>
              </a:extLst>
            </p:cNvPr>
            <p:cNvGrpSpPr/>
            <p:nvPr/>
          </p:nvGrpSpPr>
          <p:grpSpPr>
            <a:xfrm>
              <a:off x="1284994" y="5334000"/>
              <a:ext cx="377026" cy="429887"/>
              <a:chOff x="10809995" y="5376682"/>
              <a:chExt cx="377026" cy="428769"/>
            </a:xfrm>
          </p:grpSpPr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D37149BE-AFED-29AE-D4BE-1EBD5DF51305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70" name="Straight Arrow Connector 169">
                <a:extLst>
                  <a:ext uri="{FF2B5EF4-FFF2-40B4-BE49-F238E27FC236}">
                    <a16:creationId xmlns:a16="http://schemas.microsoft.com/office/drawing/2014/main" id="{743B9B43-2C6A-FAAE-0D5D-64160CB4508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2" name="Group 171">
              <a:extLst>
                <a:ext uri="{FF2B5EF4-FFF2-40B4-BE49-F238E27FC236}">
                  <a16:creationId xmlns:a16="http://schemas.microsoft.com/office/drawing/2014/main" id="{C3B1B774-E32A-2E64-E3C2-A069BAE76776}"/>
                </a:ext>
              </a:extLst>
            </p:cNvPr>
            <p:cNvGrpSpPr/>
            <p:nvPr/>
          </p:nvGrpSpPr>
          <p:grpSpPr>
            <a:xfrm>
              <a:off x="3148430" y="5472546"/>
              <a:ext cx="377026" cy="429887"/>
              <a:chOff x="10809995" y="5376682"/>
              <a:chExt cx="377026" cy="428769"/>
            </a:xfrm>
          </p:grpSpPr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AF00DE79-8F8E-DD47-5055-844CABE61C8A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74" name="Straight Arrow Connector 173">
                <a:extLst>
                  <a:ext uri="{FF2B5EF4-FFF2-40B4-BE49-F238E27FC236}">
                    <a16:creationId xmlns:a16="http://schemas.microsoft.com/office/drawing/2014/main" id="{5D9248FA-0D93-EA7E-3FBD-8E0401237C1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5" name="Group 174">
              <a:extLst>
                <a:ext uri="{FF2B5EF4-FFF2-40B4-BE49-F238E27FC236}">
                  <a16:creationId xmlns:a16="http://schemas.microsoft.com/office/drawing/2014/main" id="{0A0ADA32-D85D-B640-CB0C-454916C4E43F}"/>
                </a:ext>
              </a:extLst>
            </p:cNvPr>
            <p:cNvGrpSpPr/>
            <p:nvPr/>
          </p:nvGrpSpPr>
          <p:grpSpPr>
            <a:xfrm>
              <a:off x="4880249" y="5334001"/>
              <a:ext cx="377026" cy="429887"/>
              <a:chOff x="10809995" y="5376682"/>
              <a:chExt cx="377026" cy="428769"/>
            </a:xfrm>
          </p:grpSpPr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674AA9BF-A3B3-CFCE-771B-4005C31A462E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77" name="Straight Arrow Connector 176">
                <a:extLst>
                  <a:ext uri="{FF2B5EF4-FFF2-40B4-BE49-F238E27FC236}">
                    <a16:creationId xmlns:a16="http://schemas.microsoft.com/office/drawing/2014/main" id="{F4A16D3F-0AB5-C1DE-89CA-CE6AE5F4CFD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8" name="Group 177">
              <a:extLst>
                <a:ext uri="{FF2B5EF4-FFF2-40B4-BE49-F238E27FC236}">
                  <a16:creationId xmlns:a16="http://schemas.microsoft.com/office/drawing/2014/main" id="{4421A66F-067E-F5ED-948B-4433983EDEE4}"/>
                </a:ext>
              </a:extLst>
            </p:cNvPr>
            <p:cNvGrpSpPr/>
            <p:nvPr/>
          </p:nvGrpSpPr>
          <p:grpSpPr>
            <a:xfrm>
              <a:off x="6681340" y="5299365"/>
              <a:ext cx="377026" cy="429887"/>
              <a:chOff x="10809995" y="5376682"/>
              <a:chExt cx="377026" cy="428769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1B6F1C76-73A5-29E0-0E85-7300EFB934C9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80" name="Straight Arrow Connector 179">
                <a:extLst>
                  <a:ext uri="{FF2B5EF4-FFF2-40B4-BE49-F238E27FC236}">
                    <a16:creationId xmlns:a16="http://schemas.microsoft.com/office/drawing/2014/main" id="{EB0DCB72-12E0-3A45-5F93-DF70649905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577F7A3B-0F71-8F99-99D0-B65327D4ADAF}"/>
                </a:ext>
              </a:extLst>
            </p:cNvPr>
            <p:cNvGrpSpPr/>
            <p:nvPr/>
          </p:nvGrpSpPr>
          <p:grpSpPr>
            <a:xfrm>
              <a:off x="8614049" y="5458692"/>
              <a:ext cx="377026" cy="429887"/>
              <a:chOff x="10809995" y="5376682"/>
              <a:chExt cx="377026" cy="428769"/>
            </a:xfrm>
          </p:grpSpPr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964FC156-D14F-D9AD-C0C0-7B46691A85D0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83" name="Straight Arrow Connector 182">
                <a:extLst>
                  <a:ext uri="{FF2B5EF4-FFF2-40B4-BE49-F238E27FC236}">
                    <a16:creationId xmlns:a16="http://schemas.microsoft.com/office/drawing/2014/main" id="{2F0CEDD7-E32A-8BED-578C-EA13F50F97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5722732B-70A7-1A81-2538-2A59C502D714}"/>
                </a:ext>
              </a:extLst>
            </p:cNvPr>
            <p:cNvGrpSpPr/>
            <p:nvPr/>
          </p:nvGrpSpPr>
          <p:grpSpPr>
            <a:xfrm>
              <a:off x="10172685" y="5597237"/>
              <a:ext cx="377026" cy="429887"/>
              <a:chOff x="10809995" y="5376682"/>
              <a:chExt cx="377026" cy="428769"/>
            </a:xfrm>
          </p:grpSpPr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CF2D158A-398F-F33E-C2D0-F64CC87ACD43}"/>
                  </a:ext>
                </a:extLst>
              </p:cNvPr>
              <p:cNvSpPr txBox="1"/>
              <p:nvPr/>
            </p:nvSpPr>
            <p:spPr>
              <a:xfrm>
                <a:off x="10809995" y="555923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Q</a:t>
                </a:r>
              </a:p>
            </p:txBody>
          </p:sp>
          <p:cxnSp>
            <p:nvCxnSpPr>
              <p:cNvPr id="186" name="Straight Arrow Connector 185">
                <a:extLst>
                  <a:ext uri="{FF2B5EF4-FFF2-40B4-BE49-F238E27FC236}">
                    <a16:creationId xmlns:a16="http://schemas.microsoft.com/office/drawing/2014/main" id="{C367FA5D-8937-E788-74ED-53C3F73E05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40120" y="5376682"/>
                <a:ext cx="0" cy="19284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550017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C556CAA3-A516-9531-DA37-FB857386C62A}"/>
              </a:ext>
            </a:extLst>
          </p:cNvPr>
          <p:cNvSpPr txBox="1"/>
          <p:nvPr/>
        </p:nvSpPr>
        <p:spPr>
          <a:xfrm>
            <a:off x="202035" y="263994"/>
            <a:ext cx="22427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4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AF353DEE-073C-F0AF-9CC4-1E0423AB6E6B}"/>
              </a:ext>
            </a:extLst>
          </p:cNvPr>
          <p:cNvGrpSpPr/>
          <p:nvPr/>
        </p:nvGrpSpPr>
        <p:grpSpPr>
          <a:xfrm>
            <a:off x="669432" y="1110402"/>
            <a:ext cx="10885140" cy="4429616"/>
            <a:chOff x="669432" y="1110402"/>
            <a:chExt cx="10885140" cy="4429616"/>
          </a:xfrm>
        </p:grpSpPr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id="{ECC048B5-6386-0F8C-DF07-69C285F1E80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69432" y="1113514"/>
            <a:ext cx="283686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2836245" imgH="2282918" progId="SigmaPlotGraphicObject.12">
                    <p:embed/>
                  </p:oleObj>
                </mc:Choice>
                <mc:Fallback>
                  <p:oleObj name="SPW 13.0 Graph" r:id="rId2" imgW="2836245" imgH="2282918" progId="SigmaPlotGraphicObject.12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ECC048B5-6386-0F8C-DF07-69C285F1E80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69432" y="1113514"/>
                          <a:ext cx="283686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6EF9DED8-CB9F-219C-6CFB-C8BB13706B6B}"/>
                </a:ext>
              </a:extLst>
            </p:cNvPr>
            <p:cNvGrpSpPr/>
            <p:nvPr/>
          </p:nvGrpSpPr>
          <p:grpSpPr>
            <a:xfrm>
              <a:off x="3383743" y="3257193"/>
              <a:ext cx="2835275" cy="2282825"/>
              <a:chOff x="3383743" y="3257193"/>
              <a:chExt cx="2835275" cy="2282825"/>
            </a:xfrm>
          </p:grpSpPr>
          <p:graphicFrame>
            <p:nvGraphicFramePr>
              <p:cNvPr id="27" name="Object 26">
                <a:extLst>
                  <a:ext uri="{FF2B5EF4-FFF2-40B4-BE49-F238E27FC236}">
                    <a16:creationId xmlns:a16="http://schemas.microsoft.com/office/drawing/2014/main" id="{1C8A12FE-B0CC-1127-6916-EE7172301E8C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3383743" y="3257193"/>
              <a:ext cx="2835275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4" imgW="2834802" imgH="2282918" progId="SigmaPlotGraphicObject.12">
                      <p:embed/>
                    </p:oleObj>
                  </mc:Choice>
                  <mc:Fallback>
                    <p:oleObj name="SPW 13.0 Graph" r:id="rId4" imgW="2834802" imgH="2282918" progId="SigmaPlotGraphicObject.12">
                      <p:embed/>
                      <p:pic>
                        <p:nvPicPr>
                          <p:cNvPr id="27" name="Object 26">
                            <a:extLst>
                              <a:ext uri="{FF2B5EF4-FFF2-40B4-BE49-F238E27FC236}">
                                <a16:creationId xmlns:a16="http://schemas.microsoft.com/office/drawing/2014/main" id="{1C8A12FE-B0CC-1127-6916-EE7172301E8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383743" y="3257193"/>
                            <a:ext cx="2835275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8E70C14-3407-ACBC-6753-6836B58B5D57}"/>
                  </a:ext>
                </a:extLst>
              </p:cNvPr>
              <p:cNvSpPr txBox="1"/>
              <p:nvPr/>
            </p:nvSpPr>
            <p:spPr>
              <a:xfrm>
                <a:off x="4159685" y="3553331"/>
                <a:ext cx="107510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-MNQ (3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371CC70F-34B4-7C5C-44AF-212AA6039BFB}"/>
                </a:ext>
              </a:extLst>
            </p:cNvPr>
            <p:cNvGrpSpPr/>
            <p:nvPr/>
          </p:nvGrpSpPr>
          <p:grpSpPr>
            <a:xfrm>
              <a:off x="6077460" y="3257193"/>
              <a:ext cx="2820987" cy="2282825"/>
              <a:chOff x="6077460" y="3257193"/>
              <a:chExt cx="2820987" cy="2282825"/>
            </a:xfrm>
          </p:grpSpPr>
          <p:graphicFrame>
            <p:nvGraphicFramePr>
              <p:cNvPr id="31" name="Object 30">
                <a:extLst>
                  <a:ext uri="{FF2B5EF4-FFF2-40B4-BE49-F238E27FC236}">
                    <a16:creationId xmlns:a16="http://schemas.microsoft.com/office/drawing/2014/main" id="{F652F31D-A6E7-0035-B6EB-C30C16965256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077460" y="3257193"/>
              <a:ext cx="2820987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6" imgW="2821093" imgH="2282918" progId="SigmaPlotGraphicObject.12">
                      <p:embed/>
                    </p:oleObj>
                  </mc:Choice>
                  <mc:Fallback>
                    <p:oleObj name="SPW 13.0 Graph" r:id="rId6" imgW="2821093" imgH="2282918" progId="SigmaPlotGraphicObject.12">
                      <p:embed/>
                      <p:pic>
                        <p:nvPicPr>
                          <p:cNvPr id="31" name="Object 30">
                            <a:extLst>
                              <a:ext uri="{FF2B5EF4-FFF2-40B4-BE49-F238E27FC236}">
                                <a16:creationId xmlns:a16="http://schemas.microsoft.com/office/drawing/2014/main" id="{F652F31D-A6E7-0035-B6EB-C30C1696525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6077460" y="3257193"/>
                            <a:ext cx="2820987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0F16BA9-153D-33D2-9090-074D397B1F76}"/>
                  </a:ext>
                </a:extLst>
              </p:cNvPr>
              <p:cNvSpPr txBox="1"/>
              <p:nvPr/>
            </p:nvSpPr>
            <p:spPr>
              <a:xfrm>
                <a:off x="6870099" y="3553331"/>
                <a:ext cx="107106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MNQ (3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7CB8541A-F725-98BC-FD85-3E464689FCE0}"/>
                </a:ext>
              </a:extLst>
            </p:cNvPr>
            <p:cNvGrpSpPr/>
            <p:nvPr/>
          </p:nvGrpSpPr>
          <p:grpSpPr>
            <a:xfrm>
              <a:off x="8741522" y="3257193"/>
              <a:ext cx="2813050" cy="2282825"/>
              <a:chOff x="8741522" y="3257193"/>
              <a:chExt cx="2813050" cy="2282825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C4BE0D2-1F3A-098F-4340-CD9D627DEFBF}"/>
                  </a:ext>
                </a:extLst>
              </p:cNvPr>
              <p:cNvSpPr txBox="1"/>
              <p:nvPr/>
            </p:nvSpPr>
            <p:spPr>
              <a:xfrm>
                <a:off x="9384228" y="3553331"/>
                <a:ext cx="104444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CNQ (1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aphicFrame>
            <p:nvGraphicFramePr>
              <p:cNvPr id="32" name="Object 31">
                <a:extLst>
                  <a:ext uri="{FF2B5EF4-FFF2-40B4-BE49-F238E27FC236}">
                    <a16:creationId xmlns:a16="http://schemas.microsoft.com/office/drawing/2014/main" id="{00860FED-90C4-8987-9BF7-27AC6BBA210C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741522" y="3257193"/>
              <a:ext cx="2813050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8" imgW="2813157" imgH="2282918" progId="SigmaPlotGraphicObject.12">
                      <p:embed/>
                    </p:oleObj>
                  </mc:Choice>
                  <mc:Fallback>
                    <p:oleObj name="SPW 13.0 Graph" r:id="rId8" imgW="2813157" imgH="2282918" progId="SigmaPlotGraphicObject.12">
                      <p:embed/>
                      <p:pic>
                        <p:nvPicPr>
                          <p:cNvPr id="32" name="Object 31">
                            <a:extLst>
                              <a:ext uri="{FF2B5EF4-FFF2-40B4-BE49-F238E27FC236}">
                                <a16:creationId xmlns:a16="http://schemas.microsoft.com/office/drawing/2014/main" id="{00860FED-90C4-8987-9BF7-27AC6BBA210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8741522" y="3257193"/>
                            <a:ext cx="2813050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A40F8DE-7935-3595-06B5-484EBCE8418D}"/>
                </a:ext>
              </a:extLst>
            </p:cNvPr>
            <p:cNvSpPr txBox="1"/>
            <p:nvPr/>
          </p:nvSpPr>
          <p:spPr>
            <a:xfrm>
              <a:off x="1370096" y="1425617"/>
              <a:ext cx="112157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,4-NQ (3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B173561-15AA-59A1-EE88-5F460AB5F5FE}"/>
                </a:ext>
              </a:extLst>
            </p:cNvPr>
            <p:cNvSpPr txBox="1"/>
            <p:nvPr/>
          </p:nvSpPr>
          <p:spPr>
            <a:xfrm>
              <a:off x="6893847" y="1425617"/>
              <a:ext cx="107227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Juglone (1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18CAAFC5-1A9F-A509-447C-53FEAC9A99C5}"/>
                </a:ext>
              </a:extLst>
            </p:cNvPr>
            <p:cNvGrpSpPr/>
            <p:nvPr/>
          </p:nvGrpSpPr>
          <p:grpSpPr>
            <a:xfrm>
              <a:off x="8741480" y="1113514"/>
              <a:ext cx="2671763" cy="2282825"/>
              <a:chOff x="8741480" y="1113514"/>
              <a:chExt cx="2671763" cy="2282825"/>
            </a:xfrm>
          </p:grpSpPr>
          <p:graphicFrame>
            <p:nvGraphicFramePr>
              <p:cNvPr id="26" name="Object 25">
                <a:extLst>
                  <a:ext uri="{FF2B5EF4-FFF2-40B4-BE49-F238E27FC236}">
                    <a16:creationId xmlns:a16="http://schemas.microsoft.com/office/drawing/2014/main" id="{3FA7B3BA-9D0C-95A4-F198-8560E2C015C0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741480" y="1113514"/>
              <a:ext cx="2671763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0" imgW="2671741" imgH="2282918" progId="SigmaPlotGraphicObject.12">
                      <p:embed/>
                    </p:oleObj>
                  </mc:Choice>
                  <mc:Fallback>
                    <p:oleObj name="SPW 13.0 Graph" r:id="rId10" imgW="2671741" imgH="2282918" progId="SigmaPlotGraphicObject.12">
                      <p:embed/>
                      <p:pic>
                        <p:nvPicPr>
                          <p:cNvPr id="26" name="Object 25">
                            <a:extLst>
                              <a:ext uri="{FF2B5EF4-FFF2-40B4-BE49-F238E27FC236}">
                                <a16:creationId xmlns:a16="http://schemas.microsoft.com/office/drawing/2014/main" id="{3FA7B3BA-9D0C-95A4-F198-8560E2C015C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741480" y="1113514"/>
                            <a:ext cx="2671763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5E2311C-F77A-7F48-1DF3-B743F7607CD4}"/>
                  </a:ext>
                </a:extLst>
              </p:cNvPr>
              <p:cNvSpPr txBox="1"/>
              <p:nvPr/>
            </p:nvSpPr>
            <p:spPr>
              <a:xfrm>
                <a:off x="9378907" y="1425617"/>
                <a:ext cx="120643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umbagin (3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CE01CC9B-D355-9455-5E5F-E56EB9B8A9D1}"/>
                </a:ext>
              </a:extLst>
            </p:cNvPr>
            <p:cNvGrpSpPr/>
            <p:nvPr/>
          </p:nvGrpSpPr>
          <p:grpSpPr>
            <a:xfrm>
              <a:off x="670806" y="3257193"/>
              <a:ext cx="2770187" cy="2282825"/>
              <a:chOff x="670806" y="3257193"/>
              <a:chExt cx="2770187" cy="2282825"/>
            </a:xfrm>
          </p:grpSpPr>
          <p:graphicFrame>
            <p:nvGraphicFramePr>
              <p:cNvPr id="38" name="Object 37">
                <a:extLst>
                  <a:ext uri="{FF2B5EF4-FFF2-40B4-BE49-F238E27FC236}">
                    <a16:creationId xmlns:a16="http://schemas.microsoft.com/office/drawing/2014/main" id="{D3E8A68B-B52D-AC3B-D2B2-9C17827967DC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70806" y="3257193"/>
              <a:ext cx="2770187" cy="2282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2" imgW="2770588" imgH="2282918" progId="SigmaPlotGraphicObject.12">
                      <p:embed/>
                    </p:oleObj>
                  </mc:Choice>
                  <mc:Fallback>
                    <p:oleObj name="SPW 13.0 Graph" r:id="rId12" imgW="2770588" imgH="2282918" progId="SigmaPlotGraphicObject.12">
                      <p:embed/>
                      <p:pic>
                        <p:nvPicPr>
                          <p:cNvPr id="38" name="Object 37">
                            <a:extLst>
                              <a:ext uri="{FF2B5EF4-FFF2-40B4-BE49-F238E27FC236}">
                                <a16:creationId xmlns:a16="http://schemas.microsoft.com/office/drawing/2014/main" id="{D3E8A68B-B52D-AC3B-D2B2-9C17827967D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670806" y="3257193"/>
                            <a:ext cx="2770187" cy="2282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49E3058-87C8-373D-C0B1-4B6EA12077D6}"/>
                  </a:ext>
                </a:extLst>
              </p:cNvPr>
              <p:cNvSpPr txBox="1"/>
              <p:nvPr/>
            </p:nvSpPr>
            <p:spPr>
              <a:xfrm>
                <a:off x="1206478" y="3506069"/>
                <a:ext cx="134033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nadione (1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DAE9ED4-C8F6-1E39-BC12-B070BC1CA4D3}"/>
                </a:ext>
              </a:extLst>
            </p:cNvPr>
            <p:cNvSpPr txBox="1"/>
            <p:nvPr/>
          </p:nvSpPr>
          <p:spPr>
            <a:xfrm>
              <a:off x="4156642" y="1427015"/>
              <a:ext cx="112157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,4-NQ (1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EE8E9654-10EA-F350-212D-7575A0973CE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073819" y="1110402"/>
            <a:ext cx="2693987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4" imgW="2694469" imgH="2282918" progId="SigmaPlotGraphicObject.12">
                    <p:embed/>
                  </p:oleObj>
                </mc:Choice>
                <mc:Fallback>
                  <p:oleObj name="SPW 13.0 Graph" r:id="rId14" imgW="2694469" imgH="2282918" progId="SigmaPlotGraphicObject.12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EE8E9654-10EA-F350-212D-7575A0973CE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6073819" y="1110402"/>
                          <a:ext cx="2693987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D511C430-7B70-D95A-C8CB-B3B62CC476A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385015" y="1110402"/>
            <a:ext cx="283686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6" imgW="2836245" imgH="2282918" progId="SigmaPlotGraphicObject.12">
                    <p:embed/>
                  </p:oleObj>
                </mc:Choice>
                <mc:Fallback>
                  <p:oleObj name="SPW 13.0 Graph" r:id="rId16" imgW="2836245" imgH="2282918" progId="SigmaPlotGraphicObject.12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D511C430-7B70-D95A-C8CB-B3B62CC476A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385015" y="1110402"/>
                          <a:ext cx="283686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0900319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0E75099-3D23-06AF-597A-6480A0C4E1EA}"/>
              </a:ext>
            </a:extLst>
          </p:cNvPr>
          <p:cNvGrpSpPr/>
          <p:nvPr/>
        </p:nvGrpSpPr>
        <p:grpSpPr>
          <a:xfrm>
            <a:off x="495044" y="631418"/>
            <a:ext cx="11082375" cy="5771023"/>
            <a:chOff x="495044" y="631418"/>
            <a:chExt cx="11082375" cy="577102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D6C45A8-66F4-63BF-2B16-ED8536803368}"/>
                </a:ext>
              </a:extLst>
            </p:cNvPr>
            <p:cNvSpPr txBox="1"/>
            <p:nvPr/>
          </p:nvSpPr>
          <p:spPr>
            <a:xfrm>
              <a:off x="4608732" y="845360"/>
              <a:ext cx="950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 </a:t>
              </a:r>
              <a:r>
                <a:rPr lang="en-US" sz="1000" dirty="0" err="1"/>
                <a:t>uM</a:t>
              </a:r>
              <a:r>
                <a:rPr lang="en-US" sz="1000" dirty="0"/>
                <a:t> 1,4-NQ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45BF3DD-1EEA-71C0-6FD7-1D693BAE451D}"/>
                </a:ext>
              </a:extLst>
            </p:cNvPr>
            <p:cNvSpPr txBox="1"/>
            <p:nvPr/>
          </p:nvSpPr>
          <p:spPr>
            <a:xfrm>
              <a:off x="1872451" y="845360"/>
              <a:ext cx="909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 </a:t>
              </a:r>
              <a:r>
                <a:rPr lang="en-US" sz="1000" dirty="0" err="1"/>
                <a:t>uM</a:t>
              </a:r>
              <a:r>
                <a:rPr lang="en-US" sz="1000" dirty="0"/>
                <a:t> 1,4-NQ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01F6DC6-C335-B5DE-62A1-52CD6E68D245}"/>
                </a:ext>
              </a:extLst>
            </p:cNvPr>
            <p:cNvSpPr txBox="1"/>
            <p:nvPr/>
          </p:nvSpPr>
          <p:spPr>
            <a:xfrm>
              <a:off x="7310993" y="845360"/>
              <a:ext cx="1007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0 </a:t>
              </a:r>
              <a:r>
                <a:rPr lang="en-US" sz="1000" dirty="0" err="1"/>
                <a:t>uM</a:t>
              </a:r>
              <a:r>
                <a:rPr lang="en-US" sz="1000" dirty="0"/>
                <a:t> 1,4-NQ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BE83118-987D-3AA5-709A-61641D84A35D}"/>
                </a:ext>
              </a:extLst>
            </p:cNvPr>
            <p:cNvSpPr txBox="1"/>
            <p:nvPr/>
          </p:nvSpPr>
          <p:spPr>
            <a:xfrm>
              <a:off x="495044" y="1539809"/>
              <a:ext cx="830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:1 NQ:P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46B89F9-3BDB-EB90-14B9-1F78445E72B1}"/>
                </a:ext>
              </a:extLst>
            </p:cNvPr>
            <p:cNvSpPr txBox="1"/>
            <p:nvPr/>
          </p:nvSpPr>
          <p:spPr>
            <a:xfrm>
              <a:off x="525934" y="3276704"/>
              <a:ext cx="830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:5 NQ:P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BF9F809-3CA8-94ED-960C-13D9E7E2C95D}"/>
                </a:ext>
              </a:extLst>
            </p:cNvPr>
            <p:cNvSpPr txBox="1"/>
            <p:nvPr/>
          </p:nvSpPr>
          <p:spPr>
            <a:xfrm>
              <a:off x="992361" y="684625"/>
              <a:ext cx="300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12D4318-A190-7B22-26F6-3704E12BCB58}"/>
                </a:ext>
              </a:extLst>
            </p:cNvPr>
            <p:cNvSpPr txBox="1"/>
            <p:nvPr/>
          </p:nvSpPr>
          <p:spPr>
            <a:xfrm>
              <a:off x="1954954" y="4680786"/>
              <a:ext cx="7783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 </a:t>
              </a:r>
              <a:r>
                <a:rPr lang="en-US" sz="1000" dirty="0" err="1"/>
                <a:t>uM</a:t>
              </a:r>
              <a:r>
                <a:rPr lang="en-US" sz="1000" dirty="0"/>
                <a:t> Ju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34F2E17-C2BC-1C13-4999-6B8352332B4D}"/>
                </a:ext>
              </a:extLst>
            </p:cNvPr>
            <p:cNvSpPr txBox="1"/>
            <p:nvPr/>
          </p:nvSpPr>
          <p:spPr>
            <a:xfrm>
              <a:off x="4328959" y="4680786"/>
              <a:ext cx="9422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 </a:t>
              </a:r>
              <a:r>
                <a:rPr lang="en-US" sz="1000" dirty="0" err="1"/>
                <a:t>uM</a:t>
              </a:r>
              <a:r>
                <a:rPr lang="en-US" sz="1000" dirty="0"/>
                <a:t> Men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34755BE-2BF0-05FC-F818-87CAE3DCA271}"/>
                </a:ext>
              </a:extLst>
            </p:cNvPr>
            <p:cNvSpPr txBox="1"/>
            <p:nvPr/>
          </p:nvSpPr>
          <p:spPr>
            <a:xfrm>
              <a:off x="9581829" y="4680786"/>
              <a:ext cx="9890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 </a:t>
              </a:r>
              <a:r>
                <a:rPr lang="en-US" sz="1000" dirty="0" err="1"/>
                <a:t>uM</a:t>
              </a:r>
              <a:r>
                <a:rPr lang="en-US" sz="1000" dirty="0"/>
                <a:t> DMNQ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0C6606A-CAA9-B7D9-2718-0D1AFE0D7C24}"/>
                </a:ext>
              </a:extLst>
            </p:cNvPr>
            <p:cNvSpPr txBox="1"/>
            <p:nvPr/>
          </p:nvSpPr>
          <p:spPr>
            <a:xfrm>
              <a:off x="7187422" y="4680786"/>
              <a:ext cx="9303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 </a:t>
              </a:r>
              <a:r>
                <a:rPr lang="en-US" sz="1000" dirty="0" err="1"/>
                <a:t>uM</a:t>
              </a:r>
              <a:r>
                <a:rPr lang="en-US" sz="1000" dirty="0"/>
                <a:t> Plum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0527456-63A6-1CA4-BDF2-22AE69504360}"/>
                </a:ext>
              </a:extLst>
            </p:cNvPr>
            <p:cNvSpPr txBox="1"/>
            <p:nvPr/>
          </p:nvSpPr>
          <p:spPr>
            <a:xfrm>
              <a:off x="987108" y="2535212"/>
              <a:ext cx="300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10A636C9-4E75-3801-D6C3-B5DEE1C1FC7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574208" y="631418"/>
            <a:ext cx="2686808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2923187" imgH="2282918" progId="SigmaPlotGraphicObject.12">
                    <p:embed/>
                  </p:oleObj>
                </mc:Choice>
                <mc:Fallback>
                  <p:oleObj name="SPW 13.0 Graph" r:id="rId2" imgW="2923187" imgH="2282918" progId="SigmaPlotGraphicObject.12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10A636C9-4E75-3801-D6C3-B5DEE1C1FC7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574208" y="631418"/>
                          <a:ext cx="2686808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72E7FDD7-548C-82E4-DC92-5B82E084F69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916330" y="631418"/>
            <a:ext cx="2686808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2923187" imgH="2282918" progId="SigmaPlotGraphicObject.12">
                    <p:embed/>
                  </p:oleObj>
                </mc:Choice>
                <mc:Fallback>
                  <p:oleObj name="SPW 13.0 Graph" r:id="rId4" imgW="2923187" imgH="2282918" progId="SigmaPlotGraphicObject.12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72E7FDD7-548C-82E4-DC92-5B82E084F69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916330" y="631418"/>
                          <a:ext cx="2686808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EB71ACCC-DDAE-5A35-48D2-3A0B21B6BB0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258451" y="631418"/>
            <a:ext cx="2686808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2923187" imgH="2282918" progId="SigmaPlotGraphicObject.12">
                    <p:embed/>
                  </p:oleObj>
                </mc:Choice>
                <mc:Fallback>
                  <p:oleObj name="SPW 13.0 Graph" r:id="rId6" imgW="2923187" imgH="2282918" progId="SigmaPlotGraphicObject.12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EB71ACCC-DDAE-5A35-48D2-3A0B21B6BB0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258451" y="631418"/>
                          <a:ext cx="2686808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F7F9440A-C5A8-C69C-1E0B-C65898E0B98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284265" y="2383164"/>
            <a:ext cx="2685349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8" imgW="2921383" imgH="2282918" progId="SigmaPlotGraphicObject.12">
                    <p:embed/>
                  </p:oleObj>
                </mc:Choice>
                <mc:Fallback>
                  <p:oleObj name="SPW 13.0 Graph" r:id="rId8" imgW="2921383" imgH="2282918" progId="SigmaPlotGraphicObject.12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F7F9440A-C5A8-C69C-1E0B-C65898E0B98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284265" y="2383164"/>
                          <a:ext cx="2685349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BD25F0C4-CCFD-59B2-F1C2-3A41FC227C6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860392" y="2383164"/>
            <a:ext cx="2685349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2921383" imgH="2282918" progId="SigmaPlotGraphicObject.12">
                    <p:embed/>
                  </p:oleObj>
                </mc:Choice>
                <mc:Fallback>
                  <p:oleObj name="SPW 13.0 Graph" r:id="rId10" imgW="2921383" imgH="2282918" progId="SigmaPlotGraphicObject.12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BD25F0C4-CCFD-59B2-F1C2-3A41FC227C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860392" y="2383164"/>
                          <a:ext cx="2685349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AA77FEC5-77EB-0456-A170-36C6C76E037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563227" y="2356531"/>
            <a:ext cx="2685349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2" imgW="2921383" imgH="2282918" progId="SigmaPlotGraphicObject.12">
                    <p:embed/>
                  </p:oleObj>
                </mc:Choice>
                <mc:Fallback>
                  <p:oleObj name="SPW 13.0 Graph" r:id="rId12" imgW="2921383" imgH="2282918" progId="SigmaPlotGraphicObject.12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AA77FEC5-77EB-0456-A170-36C6C76E03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563227" y="2356531"/>
                          <a:ext cx="2685349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B44D78A5-0D19-A9DB-50D1-9679466A7F8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5728412"/>
                </p:ext>
              </p:extLst>
            </p:nvPr>
          </p:nvGraphicFramePr>
          <p:xfrm>
            <a:off x="6432932" y="4303782"/>
            <a:ext cx="2615297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4" imgW="2845264" imgH="2282918" progId="SigmaPlotGraphicObject.12">
                    <p:embed/>
                  </p:oleObj>
                </mc:Choice>
                <mc:Fallback>
                  <p:oleObj name="SPW 13.0 Graph" r:id="rId14" imgW="2845264" imgH="2282918" progId="SigmaPlotGraphicObject.12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B44D78A5-0D19-A9DB-50D1-9679466A7F8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6432932" y="4303782"/>
                          <a:ext cx="2615297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3E6E2742-384F-0C9B-52EF-D8C38735E9D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6471342"/>
                </p:ext>
              </p:extLst>
            </p:nvPr>
          </p:nvGraphicFramePr>
          <p:xfrm>
            <a:off x="8900826" y="4303782"/>
            <a:ext cx="2676593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6" imgW="2910921" imgH="2282918" progId="SigmaPlotGraphicObject.12">
                    <p:embed/>
                  </p:oleObj>
                </mc:Choice>
                <mc:Fallback>
                  <p:oleObj name="SPW 13.0 Graph" r:id="rId16" imgW="2910921" imgH="2282918" progId="SigmaPlotGraphicObject.12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3E6E2742-384F-0C9B-52EF-D8C38735E9D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8900826" y="4303782"/>
                          <a:ext cx="2676593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6EF3597-7A47-37A0-1F14-077C9421D861}"/>
                </a:ext>
              </a:extLst>
            </p:cNvPr>
            <p:cNvSpPr txBox="1"/>
            <p:nvPr/>
          </p:nvSpPr>
          <p:spPr>
            <a:xfrm>
              <a:off x="1066800" y="4570202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DEC220A-A070-8A03-A14A-E1C23BFBEAA2}"/>
                </a:ext>
              </a:extLst>
            </p:cNvPr>
            <p:cNvSpPr txBox="1"/>
            <p:nvPr/>
          </p:nvSpPr>
          <p:spPr>
            <a:xfrm>
              <a:off x="3550020" y="4570202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AEF43D5-9D3D-BD1F-4BAF-D4FC56AF9AF6}"/>
                </a:ext>
              </a:extLst>
            </p:cNvPr>
            <p:cNvSpPr txBox="1"/>
            <p:nvPr/>
          </p:nvSpPr>
          <p:spPr>
            <a:xfrm>
              <a:off x="6252165" y="4570202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DA6A229-91B2-CE5A-D1E6-48B4AA9836E3}"/>
                </a:ext>
              </a:extLst>
            </p:cNvPr>
            <p:cNvSpPr txBox="1"/>
            <p:nvPr/>
          </p:nvSpPr>
          <p:spPr>
            <a:xfrm>
              <a:off x="8717456" y="4570202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6AEEF16-6749-40B0-3111-763F28AF0E7A}"/>
                </a:ext>
              </a:extLst>
            </p:cNvPr>
            <p:cNvSpPr txBox="1"/>
            <p:nvPr/>
          </p:nvSpPr>
          <p:spPr>
            <a:xfrm>
              <a:off x="570015" y="5267949"/>
              <a:ext cx="8308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:1 NQ:PA</a:t>
              </a:r>
            </a:p>
          </p:txBody>
        </p:sp>
        <p:graphicFrame>
          <p:nvGraphicFramePr>
            <p:cNvPr id="50" name="Object 49">
              <a:extLst>
                <a:ext uri="{FF2B5EF4-FFF2-40B4-BE49-F238E27FC236}">
                  <a16:creationId xmlns:a16="http://schemas.microsoft.com/office/drawing/2014/main" id="{26AB31EF-ED57-FEDD-34BE-BBB3FC0F4CB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274208" y="4303782"/>
            <a:ext cx="2559838" cy="2098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8" imgW="2784296" imgH="2282918" progId="SigmaPlotGraphicObject.12">
                    <p:embed/>
                  </p:oleObj>
                </mc:Choice>
                <mc:Fallback>
                  <p:oleObj name="SPW 13.0 Graph" r:id="rId18" imgW="2784296" imgH="2282918" progId="SigmaPlotGraphicObject.12">
                    <p:embed/>
                    <p:pic>
                      <p:nvPicPr>
                        <p:cNvPr id="50" name="Object 49">
                          <a:extLst>
                            <a:ext uri="{FF2B5EF4-FFF2-40B4-BE49-F238E27FC236}">
                              <a16:creationId xmlns:a16="http://schemas.microsoft.com/office/drawing/2014/main" id="{26AB31EF-ED57-FEDD-34BE-BBB3FC0F4CB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1274208" y="4303782"/>
                          <a:ext cx="2559838" cy="2098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9E9D23CA-B196-E90B-79E9-E2CCCF6E4D8B}"/>
                </a:ext>
              </a:extLst>
            </p:cNvPr>
            <p:cNvGrpSpPr/>
            <p:nvPr/>
          </p:nvGrpSpPr>
          <p:grpSpPr>
            <a:xfrm>
              <a:off x="9126430" y="718824"/>
              <a:ext cx="2291887" cy="2002979"/>
              <a:chOff x="805037" y="4161200"/>
              <a:chExt cx="2573951" cy="2249487"/>
            </a:xfrm>
          </p:grpSpPr>
          <p:graphicFrame>
            <p:nvGraphicFramePr>
              <p:cNvPr id="18" name="Object 17">
                <a:extLst>
                  <a:ext uri="{FF2B5EF4-FFF2-40B4-BE49-F238E27FC236}">
                    <a16:creationId xmlns:a16="http://schemas.microsoft.com/office/drawing/2014/main" id="{6EA88B15-5F8A-B48D-8D76-D513281D8803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05037" y="4161200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0" imgW="2092371" imgH="2249446" progId="SigmaPlotGraphicObject.12">
                      <p:embed/>
                    </p:oleObj>
                  </mc:Choice>
                  <mc:Fallback>
                    <p:oleObj name="SPW 13.0 Graph" r:id="rId20" imgW="2092371" imgH="2249446" progId="SigmaPlotGraphicObject.12">
                      <p:embed/>
                      <p:pic>
                        <p:nvPicPr>
                          <p:cNvPr id="18" name="Object 17">
                            <a:extLst>
                              <a:ext uri="{FF2B5EF4-FFF2-40B4-BE49-F238E27FC236}">
                                <a16:creationId xmlns:a16="http://schemas.microsoft.com/office/drawing/2014/main" id="{6EA88B15-5F8A-B48D-8D76-D513281D880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805037" y="4161200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A74622E-537A-A3D5-34EC-AFE16A27EC95}"/>
                  </a:ext>
                </a:extLst>
              </p:cNvPr>
              <p:cNvSpPr txBox="1"/>
              <p:nvPr/>
            </p:nvSpPr>
            <p:spPr>
              <a:xfrm>
                <a:off x="2753389" y="5212494"/>
                <a:ext cx="4748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670547D-E6AF-BBCC-74BF-3935FA87BA3F}"/>
                  </a:ext>
                </a:extLst>
              </p:cNvPr>
              <p:cNvSpPr txBox="1"/>
              <p:nvPr/>
            </p:nvSpPr>
            <p:spPr>
              <a:xfrm>
                <a:off x="2763114" y="4965672"/>
                <a:ext cx="61587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,4NQ+PA</a:t>
                </a:r>
              </a:p>
            </p:txBody>
          </p: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CB598F75-F9D2-37C6-5B43-7655D4257F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00529" y="5067185"/>
                <a:ext cx="11964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A88B148E-4828-66F0-2F3D-6FDAD6C26997}"/>
                  </a:ext>
                </a:extLst>
              </p:cNvPr>
              <p:cNvSpPr txBox="1"/>
              <p:nvPr/>
            </p:nvSpPr>
            <p:spPr>
              <a:xfrm>
                <a:off x="1314619" y="5235645"/>
                <a:ext cx="4488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3BAEDAC4-6CB5-0D85-896A-99CA9CFC79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15920" y="4713251"/>
                <a:ext cx="0" cy="523767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971CC2C3-DB07-EC2D-BB65-15D6F4375F3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692830" y="5321187"/>
                <a:ext cx="11964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7B2B4824-DCB9-2422-AE1B-D0697B117203}"/>
                </a:ext>
              </a:extLst>
            </p:cNvPr>
            <p:cNvGrpSpPr/>
            <p:nvPr/>
          </p:nvGrpSpPr>
          <p:grpSpPr>
            <a:xfrm>
              <a:off x="9130356" y="2402214"/>
              <a:ext cx="2143743" cy="2002979"/>
              <a:chOff x="8491770" y="4450039"/>
              <a:chExt cx="2407575" cy="2249487"/>
            </a:xfrm>
          </p:grpSpPr>
          <p:graphicFrame>
            <p:nvGraphicFramePr>
              <p:cNvPr id="52" name="Object 51">
                <a:extLst>
                  <a:ext uri="{FF2B5EF4-FFF2-40B4-BE49-F238E27FC236}">
                    <a16:creationId xmlns:a16="http://schemas.microsoft.com/office/drawing/2014/main" id="{324DA7FD-477D-6A6A-45A5-DA6A3A7C8C4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491770" y="4450039"/>
              <a:ext cx="2092325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2" imgW="2092371" imgH="2249446" progId="SigmaPlotGraphicObject.12">
                      <p:embed/>
                    </p:oleObj>
                  </mc:Choice>
                  <mc:Fallback>
                    <p:oleObj name="SPW 13.0 Graph" r:id="rId22" imgW="2092371" imgH="2249446" progId="SigmaPlotGraphicObject.12">
                      <p:embed/>
                      <p:pic>
                        <p:nvPicPr>
                          <p:cNvPr id="52" name="Object 51">
                            <a:extLst>
                              <a:ext uri="{FF2B5EF4-FFF2-40B4-BE49-F238E27FC236}">
                                <a16:creationId xmlns:a16="http://schemas.microsoft.com/office/drawing/2014/main" id="{324DA7FD-477D-6A6A-45A5-DA6A3A7C8C4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8491770" y="4450039"/>
                            <a:ext cx="2092325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FD04D64-6D70-BE44-B7EC-56F771ABA16E}"/>
                  </a:ext>
                </a:extLst>
              </p:cNvPr>
              <p:cNvSpPr txBox="1"/>
              <p:nvPr/>
            </p:nvSpPr>
            <p:spPr>
              <a:xfrm>
                <a:off x="10283471" y="5340341"/>
                <a:ext cx="61587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,4NQ+PA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4EBF4A7-11B6-6956-10FE-3F939242DC38}"/>
                  </a:ext>
                </a:extLst>
              </p:cNvPr>
              <p:cNvSpPr txBox="1"/>
              <p:nvPr/>
            </p:nvSpPr>
            <p:spPr>
              <a:xfrm>
                <a:off x="10273162" y="5667226"/>
                <a:ext cx="4443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,4NQ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D11704D2-2E2A-82EC-5EC0-5F0698271A1B}"/>
                  </a:ext>
                </a:extLst>
              </p:cNvPr>
              <p:cNvSpPr txBox="1"/>
              <p:nvPr/>
            </p:nvSpPr>
            <p:spPr>
              <a:xfrm>
                <a:off x="8858686" y="5746548"/>
                <a:ext cx="4315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GSH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F0715508-DDBB-B3D8-7598-C2449BA7D2F2}"/>
                  </a:ext>
                </a:extLst>
              </p:cNvPr>
              <p:cNvSpPr txBox="1"/>
              <p:nvPr/>
            </p:nvSpPr>
            <p:spPr>
              <a:xfrm>
                <a:off x="9368465" y="5832212"/>
                <a:ext cx="4488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+H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44742D7F-56F3-0D44-5F10-044EF7596153}"/>
                  </a:ext>
                </a:extLst>
              </p:cNvPr>
              <p:cNvCxnSpPr/>
              <p:nvPr/>
            </p:nvCxnSpPr>
            <p:spPr>
              <a:xfrm>
                <a:off x="9065010" y="4924870"/>
                <a:ext cx="0" cy="79958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26B2A293-E1B3-7127-CA28-3F37099D9E2F}"/>
                  </a:ext>
                </a:extLst>
              </p:cNvPr>
              <p:cNvCxnSpPr/>
              <p:nvPr/>
            </p:nvCxnSpPr>
            <p:spPr>
              <a:xfrm>
                <a:off x="9590547" y="4991164"/>
                <a:ext cx="0" cy="79958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Arrow Connector 58">
                <a:extLst>
                  <a:ext uri="{FF2B5EF4-FFF2-40B4-BE49-F238E27FC236}">
                    <a16:creationId xmlns:a16="http://schemas.microsoft.com/office/drawing/2014/main" id="{F5FCC391-4597-99C0-DE46-265B4A08DAE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223474" y="5441727"/>
                <a:ext cx="11964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>
                <a:extLst>
                  <a:ext uri="{FF2B5EF4-FFF2-40B4-BE49-F238E27FC236}">
                    <a16:creationId xmlns:a16="http://schemas.microsoft.com/office/drawing/2014/main" id="{3A97E826-38D6-B59A-5D3F-D963DB39C86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213145" y="5769771"/>
                <a:ext cx="11964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2A626C1-9A0F-13D8-F34E-97BCC5A0A76B}"/>
                </a:ext>
              </a:extLst>
            </p:cNvPr>
            <p:cNvSpPr txBox="1"/>
            <p:nvPr/>
          </p:nvSpPr>
          <p:spPr>
            <a:xfrm>
              <a:off x="8979674" y="684625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56EF578-3413-F3E6-B9AD-033BF5249807}"/>
                </a:ext>
              </a:extLst>
            </p:cNvPr>
            <p:cNvSpPr txBox="1"/>
            <p:nvPr/>
          </p:nvSpPr>
          <p:spPr>
            <a:xfrm>
              <a:off x="8980818" y="2576449"/>
              <a:ext cx="2544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22FE0AE3-0B84-A16E-2DC1-AA8D6F7007AD}"/>
              </a:ext>
            </a:extLst>
          </p:cNvPr>
          <p:cNvSpPr txBox="1"/>
          <p:nvPr/>
        </p:nvSpPr>
        <p:spPr>
          <a:xfrm>
            <a:off x="235085" y="241960"/>
            <a:ext cx="216906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5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BC532ECD-29ED-D6C3-5DF2-3F53AC0EF8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9222107"/>
              </p:ext>
            </p:extLst>
          </p:nvPr>
        </p:nvGraphicFramePr>
        <p:xfrm>
          <a:off x="3722129" y="4152480"/>
          <a:ext cx="2859087" cy="2282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3.0 Graph" r:id="rId24" imgW="2858972" imgH="2282918" progId="SigmaPlotGraphicObject.12">
                  <p:embed/>
                </p:oleObj>
              </mc:Choice>
              <mc:Fallback>
                <p:oleObj name="SPW 13.0 Graph" r:id="rId24" imgW="2858972" imgH="2282918" progId="SigmaPlotGraphicObject.12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BC532ECD-29ED-D6C3-5DF2-3F53AC0EF8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722129" y="4152480"/>
                        <a:ext cx="2859087" cy="2282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768340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235E44D1-CF14-7A61-E609-863D2E77DB11}"/>
              </a:ext>
            </a:extLst>
          </p:cNvPr>
          <p:cNvGrpSpPr/>
          <p:nvPr/>
        </p:nvGrpSpPr>
        <p:grpSpPr>
          <a:xfrm>
            <a:off x="212562" y="436422"/>
            <a:ext cx="11780941" cy="6306507"/>
            <a:chOff x="212562" y="436422"/>
            <a:chExt cx="11780941" cy="6306507"/>
          </a:xfrm>
        </p:grpSpPr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4536DF5A-0B4B-4417-9E74-70A6E71AAD7E}"/>
                </a:ext>
              </a:extLst>
            </p:cNvPr>
            <p:cNvGrpSpPr/>
            <p:nvPr/>
          </p:nvGrpSpPr>
          <p:grpSpPr>
            <a:xfrm>
              <a:off x="212562" y="447410"/>
              <a:ext cx="11780941" cy="6295519"/>
              <a:chOff x="202171" y="440482"/>
              <a:chExt cx="11780941" cy="6295519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B5CBE3F-88C1-EDF6-10AB-8F21B530302F}"/>
                  </a:ext>
                </a:extLst>
              </p:cNvPr>
              <p:cNvSpPr txBox="1"/>
              <p:nvPr/>
            </p:nvSpPr>
            <p:spPr>
              <a:xfrm>
                <a:off x="263131" y="1469704"/>
                <a:ext cx="97451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30B4942-ACDC-61F0-8A63-72DACF000EE3}"/>
                  </a:ext>
                </a:extLst>
              </p:cNvPr>
              <p:cNvSpPr txBox="1"/>
              <p:nvPr/>
            </p:nvSpPr>
            <p:spPr>
              <a:xfrm>
                <a:off x="202171" y="3448628"/>
                <a:ext cx="97451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6F936A3-5BE0-7267-51B6-A520D2C4546A}"/>
                  </a:ext>
                </a:extLst>
              </p:cNvPr>
              <p:cNvSpPr txBox="1"/>
              <p:nvPr/>
            </p:nvSpPr>
            <p:spPr>
              <a:xfrm>
                <a:off x="202171" y="5427552"/>
                <a:ext cx="97451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B2E08117-B12D-C526-6101-6B9553FF906B}"/>
                  </a:ext>
                </a:extLst>
              </p:cNvPr>
              <p:cNvGrpSpPr/>
              <p:nvPr/>
            </p:nvGrpSpPr>
            <p:grpSpPr>
              <a:xfrm>
                <a:off x="6513671" y="440482"/>
                <a:ext cx="5469441" cy="6290451"/>
                <a:chOff x="979777" y="440482"/>
                <a:chExt cx="5469441" cy="6290451"/>
              </a:xfrm>
            </p:grpSpPr>
            <p:graphicFrame>
              <p:nvGraphicFramePr>
                <p:cNvPr id="4" name="Object 3">
                  <a:extLst>
                    <a:ext uri="{FF2B5EF4-FFF2-40B4-BE49-F238E27FC236}">
                      <a16:creationId xmlns:a16="http://schemas.microsoft.com/office/drawing/2014/main" id="{FFCA1CDB-EE98-8B0F-3544-07D0BA7E463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979777" y="440482"/>
                <a:ext cx="3135313" cy="22828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2" imgW="3134949" imgH="2282918" progId="SigmaPlotGraphicObject.12">
                        <p:embed/>
                      </p:oleObj>
                    </mc:Choice>
                    <mc:Fallback>
                      <p:oleObj name="SPW 13.0 Graph" r:id="rId2" imgW="3134949" imgH="2282918" progId="SigmaPlotGraphicObject.12">
                        <p:embed/>
                        <p:pic>
                          <p:nvPicPr>
                            <p:cNvPr id="4" name="Object 3">
                              <a:extLst>
                                <a:ext uri="{FF2B5EF4-FFF2-40B4-BE49-F238E27FC236}">
                                  <a16:creationId xmlns:a16="http://schemas.microsoft.com/office/drawing/2014/main" id="{FFCA1CDB-EE98-8B0F-3544-07D0BA7E463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79777" y="440482"/>
                              <a:ext cx="3135313" cy="22828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1D80D378-3A7E-A4FB-8546-4F99B7EEBE5E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979777" y="4448108"/>
                <a:ext cx="3154363" cy="22828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3154790" imgH="2282918" progId="SigmaPlotGraphicObject.12">
                        <p:embed/>
                      </p:oleObj>
                    </mc:Choice>
                    <mc:Fallback>
                      <p:oleObj name="SPW 13.0 Graph" r:id="rId4" imgW="3154790" imgH="2282918" progId="SigmaPlotGraphicObject.12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1D80D378-3A7E-A4FB-8546-4F99B7EEBE5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79777" y="4448108"/>
                              <a:ext cx="3154363" cy="22828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E431F8F3-6C0B-CC3E-F8A4-70B2A422D71C}"/>
                    </a:ext>
                  </a:extLst>
                </p:cNvPr>
                <p:cNvGrpSpPr/>
                <p:nvPr/>
              </p:nvGrpSpPr>
              <p:grpSpPr>
                <a:xfrm>
                  <a:off x="4056313" y="464967"/>
                  <a:ext cx="2382331" cy="2209800"/>
                  <a:chOff x="2770165" y="398390"/>
                  <a:chExt cx="2382331" cy="2209800"/>
                </a:xfrm>
              </p:grpSpPr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9D6519FF-46C9-D4EC-9177-C71494DFF00E}"/>
                      </a:ext>
                    </a:extLst>
                  </p:cNvPr>
                  <p:cNvSpPr txBox="1"/>
                  <p:nvPr/>
                </p:nvSpPr>
                <p:spPr>
                  <a:xfrm>
                    <a:off x="3937190" y="1717734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7AC8F677-4E56-1DD7-3AC4-3F2875DCCF82}"/>
                      </a:ext>
                    </a:extLst>
                  </p:cNvPr>
                  <p:cNvSpPr txBox="1"/>
                  <p:nvPr/>
                </p:nvSpPr>
                <p:spPr>
                  <a:xfrm>
                    <a:off x="3393545" y="847187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graphicFrame>
                <p:nvGraphicFramePr>
                  <p:cNvPr id="24" name="Object 23">
                    <a:extLst>
                      <a:ext uri="{FF2B5EF4-FFF2-40B4-BE49-F238E27FC236}">
                        <a16:creationId xmlns:a16="http://schemas.microsoft.com/office/drawing/2014/main" id="{17B4B0F7-2A8C-B8F4-2DF2-30D705AF9496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2770165" y="398390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6" imgW="1466103" imgH="2209856" progId="SigmaPlotGraphicObject.12">
                          <p:embed/>
                        </p:oleObj>
                      </mc:Choice>
                      <mc:Fallback>
                        <p:oleObj name="SPW 13.0 Graph" r:id="rId6" imgW="1466103" imgH="2209856" progId="SigmaPlotGraphicObject.12">
                          <p:embed/>
                          <p:pic>
                            <p:nvPicPr>
                              <p:cNvPr id="24" name="Object 23">
                                <a:extLst>
                                  <a:ext uri="{FF2B5EF4-FFF2-40B4-BE49-F238E27FC236}">
                                    <a16:creationId xmlns:a16="http://schemas.microsoft.com/office/drawing/2014/main" id="{17B4B0F7-2A8C-B8F4-2DF2-30D705AF9496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770165" y="398390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3EA9264B-0F89-054A-A102-8B85AFEF6657}"/>
                      </a:ext>
                    </a:extLst>
                  </p:cNvPr>
                  <p:cNvSpPr txBox="1"/>
                  <p:nvPr/>
                </p:nvSpPr>
                <p:spPr>
                  <a:xfrm>
                    <a:off x="3760632" y="983683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E8707813-2471-28FD-F7E9-64D199E97E81}"/>
                    </a:ext>
                  </a:extLst>
                </p:cNvPr>
                <p:cNvGrpSpPr/>
                <p:nvPr/>
              </p:nvGrpSpPr>
              <p:grpSpPr>
                <a:xfrm>
                  <a:off x="4056313" y="2452536"/>
                  <a:ext cx="2383371" cy="2209800"/>
                  <a:chOff x="5394380" y="394322"/>
                  <a:chExt cx="2383371" cy="2209800"/>
                </a:xfrm>
              </p:grpSpPr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CF81F5CA-158A-DDE3-D4EB-6AC4EC669AEA}"/>
                      </a:ext>
                    </a:extLst>
                  </p:cNvPr>
                  <p:cNvSpPr txBox="1"/>
                  <p:nvPr/>
                </p:nvSpPr>
                <p:spPr>
                  <a:xfrm>
                    <a:off x="6562445" y="1715083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E56037B3-B049-3A03-C824-804A230B1A5E}"/>
                      </a:ext>
                    </a:extLst>
                  </p:cNvPr>
                  <p:cNvSpPr txBox="1"/>
                  <p:nvPr/>
                </p:nvSpPr>
                <p:spPr>
                  <a:xfrm>
                    <a:off x="6018800" y="912123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A9F0D4EA-947C-F5D7-0F34-294720A62D90}"/>
                      </a:ext>
                    </a:extLst>
                  </p:cNvPr>
                  <p:cNvSpPr txBox="1"/>
                  <p:nvPr/>
                </p:nvSpPr>
                <p:spPr>
                  <a:xfrm>
                    <a:off x="6373959" y="738515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graphicFrame>
                <p:nvGraphicFramePr>
                  <p:cNvPr id="21" name="Object 20">
                    <a:extLst>
                      <a:ext uri="{FF2B5EF4-FFF2-40B4-BE49-F238E27FC236}">
                        <a16:creationId xmlns:a16="http://schemas.microsoft.com/office/drawing/2014/main" id="{B93F69B8-271F-94F6-C4FE-4298EBAB5EA1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5394380" y="394322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8" imgW="1466103" imgH="2209856" progId="SigmaPlotGraphicObject.12">
                          <p:embed/>
                        </p:oleObj>
                      </mc:Choice>
                      <mc:Fallback>
                        <p:oleObj name="SPW 13.0 Graph" r:id="rId8" imgW="1466103" imgH="2209856" progId="SigmaPlotGraphicObject.12">
                          <p:embed/>
                          <p:pic>
                            <p:nvPicPr>
                              <p:cNvPr id="21" name="Object 20">
                                <a:extLst>
                                  <a:ext uri="{FF2B5EF4-FFF2-40B4-BE49-F238E27FC236}">
                                    <a16:creationId xmlns:a16="http://schemas.microsoft.com/office/drawing/2014/main" id="{B93F69B8-271F-94F6-C4FE-4298EBAB5EA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394380" y="394322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C07F4CE5-D1D8-0E32-2217-DBFD4EFA6514}"/>
                    </a:ext>
                  </a:extLst>
                </p:cNvPr>
                <p:cNvGrpSpPr/>
                <p:nvPr/>
              </p:nvGrpSpPr>
              <p:grpSpPr>
                <a:xfrm>
                  <a:off x="4056313" y="4475630"/>
                  <a:ext cx="2392905" cy="2209800"/>
                  <a:chOff x="8411687" y="546036"/>
                  <a:chExt cx="2392905" cy="2209800"/>
                </a:xfrm>
              </p:grpSpPr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36734D05-985D-9A89-D679-9DFCF88C4EEE}"/>
                      </a:ext>
                    </a:extLst>
                  </p:cNvPr>
                  <p:cNvSpPr txBox="1"/>
                  <p:nvPr/>
                </p:nvSpPr>
                <p:spPr>
                  <a:xfrm>
                    <a:off x="9589286" y="1843628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M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MNQ)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4EE92402-E7EC-7FCE-B252-D22CA3668A74}"/>
                      </a:ext>
                    </a:extLst>
                  </p:cNvPr>
                  <p:cNvSpPr txBox="1"/>
                  <p:nvPr/>
                </p:nvSpPr>
                <p:spPr>
                  <a:xfrm>
                    <a:off x="9037693" y="1024767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1607C1B2-0E76-92A2-AA65-6682AF5C649D}"/>
                      </a:ext>
                    </a:extLst>
                  </p:cNvPr>
                  <p:cNvSpPr txBox="1"/>
                  <p:nvPr/>
                </p:nvSpPr>
                <p:spPr>
                  <a:xfrm>
                    <a:off x="9404780" y="882966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graphicFrame>
                <p:nvGraphicFramePr>
                  <p:cNvPr id="17" name="Object 16">
                    <a:extLst>
                      <a:ext uri="{FF2B5EF4-FFF2-40B4-BE49-F238E27FC236}">
                        <a16:creationId xmlns:a16="http://schemas.microsoft.com/office/drawing/2014/main" id="{69B83E89-B5D6-055B-D39B-D4B497954950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8411687" y="546036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10" imgW="1466103" imgH="2209856" progId="SigmaPlotGraphicObject.12">
                          <p:embed/>
                        </p:oleObj>
                      </mc:Choice>
                      <mc:Fallback>
                        <p:oleObj name="SPW 13.0 Graph" r:id="rId10" imgW="1466103" imgH="2209856" progId="SigmaPlotGraphicObject.12">
                          <p:embed/>
                          <p:pic>
                            <p:nvPicPr>
                              <p:cNvPr id="17" name="Object 16">
                                <a:extLst>
                                  <a:ext uri="{FF2B5EF4-FFF2-40B4-BE49-F238E27FC236}">
                                    <a16:creationId xmlns:a16="http://schemas.microsoft.com/office/drawing/2014/main" id="{69B83E89-B5D6-055B-D39B-D4B497954950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8411687" y="546036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graphicFrame>
              <p:nvGraphicFramePr>
                <p:cNvPr id="31" name="Object 30">
                  <a:extLst>
                    <a:ext uri="{FF2B5EF4-FFF2-40B4-BE49-F238E27FC236}">
                      <a16:creationId xmlns:a16="http://schemas.microsoft.com/office/drawing/2014/main" id="{63AC4713-4830-FE9B-E848-13E37FAAA0F7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982353" y="2442784"/>
                <a:ext cx="3184525" cy="22828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3185094" imgH="2282918" progId="SigmaPlotGraphicObject.12">
                        <p:embed/>
                      </p:oleObj>
                    </mc:Choice>
                    <mc:Fallback>
                      <p:oleObj name="SPW 13.0 Graph" r:id="rId12" imgW="3185094" imgH="2282918" progId="SigmaPlotGraphicObject.12">
                        <p:embed/>
                        <p:pic>
                          <p:nvPicPr>
                            <p:cNvPr id="31" name="Object 30">
                              <a:extLst>
                                <a:ext uri="{FF2B5EF4-FFF2-40B4-BE49-F238E27FC236}">
                                  <a16:creationId xmlns:a16="http://schemas.microsoft.com/office/drawing/2014/main" id="{63AC4713-4830-FE9B-E848-13E37FAAA0F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82353" y="2442784"/>
                              <a:ext cx="3184525" cy="22828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D9F48338-4393-E23E-5E73-7EE901CC863C}"/>
                  </a:ext>
                </a:extLst>
              </p:cNvPr>
              <p:cNvGrpSpPr/>
              <p:nvPr/>
            </p:nvGrpSpPr>
            <p:grpSpPr>
              <a:xfrm>
                <a:off x="1031023" y="448372"/>
                <a:ext cx="5498077" cy="6287629"/>
                <a:chOff x="6481786" y="448372"/>
                <a:chExt cx="5498077" cy="6287629"/>
              </a:xfrm>
            </p:grpSpPr>
            <p:graphicFrame>
              <p:nvGraphicFramePr>
                <p:cNvPr id="33" name="Object 32">
                  <a:extLst>
                    <a:ext uri="{FF2B5EF4-FFF2-40B4-BE49-F238E27FC236}">
                      <a16:creationId xmlns:a16="http://schemas.microsoft.com/office/drawing/2014/main" id="{FA6567CF-A762-A069-CA07-512013669176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6481786" y="2437631"/>
                <a:ext cx="3081337" cy="22828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4" imgW="3081557" imgH="2282918" progId="SigmaPlotGraphicObject.12">
                        <p:embed/>
                      </p:oleObj>
                    </mc:Choice>
                    <mc:Fallback>
                      <p:oleObj name="SPW 13.0 Graph" r:id="rId14" imgW="3081557" imgH="2282918" progId="SigmaPlotGraphicObject.12">
                        <p:embed/>
                        <p:pic>
                          <p:nvPicPr>
                            <p:cNvPr id="33" name="Object 32">
                              <a:extLst>
                                <a:ext uri="{FF2B5EF4-FFF2-40B4-BE49-F238E27FC236}">
                                  <a16:creationId xmlns:a16="http://schemas.microsoft.com/office/drawing/2014/main" id="{FA6567CF-A762-A069-CA07-51201366917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481786" y="2437631"/>
                              <a:ext cx="3081337" cy="22828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4" name="Object 33">
                  <a:extLst>
                    <a:ext uri="{FF2B5EF4-FFF2-40B4-BE49-F238E27FC236}">
                      <a16:creationId xmlns:a16="http://schemas.microsoft.com/office/drawing/2014/main" id="{2CA81401-590D-14AD-4313-7E943C96327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6481786" y="4453176"/>
                <a:ext cx="3114675" cy="22828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6" imgW="3115108" imgH="2282918" progId="SigmaPlotGraphicObject.12">
                        <p:embed/>
                      </p:oleObj>
                    </mc:Choice>
                    <mc:Fallback>
                      <p:oleObj name="SPW 13.0 Graph" r:id="rId16" imgW="3115108" imgH="2282918" progId="SigmaPlotGraphicObject.12">
                        <p:embed/>
                        <p:pic>
                          <p:nvPicPr>
                            <p:cNvPr id="34" name="Object 33">
                              <a:extLst>
                                <a:ext uri="{FF2B5EF4-FFF2-40B4-BE49-F238E27FC236}">
                                  <a16:creationId xmlns:a16="http://schemas.microsoft.com/office/drawing/2014/main" id="{2CA81401-590D-14AD-4313-7E943C96327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481786" y="4453176"/>
                              <a:ext cx="3114675" cy="22828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41B945A0-5585-FDC2-3559-D743D3002A00}"/>
                    </a:ext>
                  </a:extLst>
                </p:cNvPr>
                <p:cNvGrpSpPr/>
                <p:nvPr/>
              </p:nvGrpSpPr>
              <p:grpSpPr>
                <a:xfrm>
                  <a:off x="9583398" y="448372"/>
                  <a:ext cx="2396465" cy="2209800"/>
                  <a:chOff x="2533422" y="2947180"/>
                  <a:chExt cx="2396465" cy="2209800"/>
                </a:xfrm>
              </p:grpSpPr>
              <p:graphicFrame>
                <p:nvGraphicFramePr>
                  <p:cNvPr id="49" name="Object 48">
                    <a:extLst>
                      <a:ext uri="{FF2B5EF4-FFF2-40B4-BE49-F238E27FC236}">
                        <a16:creationId xmlns:a16="http://schemas.microsoft.com/office/drawing/2014/main" id="{1D8F2875-CA91-E4D0-4EC7-4EF05063257E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2533422" y="2947180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18" imgW="1466103" imgH="2209856" progId="SigmaPlotGraphicObject.12">
                          <p:embed/>
                        </p:oleObj>
                      </mc:Choice>
                      <mc:Fallback>
                        <p:oleObj name="SPW 13.0 Graph" r:id="rId18" imgW="1466103" imgH="2209856" progId="SigmaPlotGraphicObject.12">
                          <p:embed/>
                          <p:pic>
                            <p:nvPicPr>
                              <p:cNvPr id="49" name="Object 48">
                                <a:extLst>
                                  <a:ext uri="{FF2B5EF4-FFF2-40B4-BE49-F238E27FC236}">
                                    <a16:creationId xmlns:a16="http://schemas.microsoft.com/office/drawing/2014/main" id="{1D8F2875-CA91-E4D0-4EC7-4EF05063257E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533422" y="2947180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732DD5B0-8027-312C-AFE1-A035FC5AC069}"/>
                      </a:ext>
                    </a:extLst>
                  </p:cNvPr>
                  <p:cNvSpPr txBox="1"/>
                  <p:nvPr/>
                </p:nvSpPr>
                <p:spPr>
                  <a:xfrm>
                    <a:off x="3714581" y="4266904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87EA5270-0C24-024A-AD48-8E8596AB5277}"/>
                      </a:ext>
                    </a:extLst>
                  </p:cNvPr>
                  <p:cNvSpPr txBox="1"/>
                  <p:nvPr/>
                </p:nvSpPr>
                <p:spPr>
                  <a:xfrm>
                    <a:off x="3148786" y="4095245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241B1A9F-B67E-CDF5-9382-8FF370BDA9D0}"/>
                      </a:ext>
                    </a:extLst>
                  </p:cNvPr>
                  <p:cNvSpPr txBox="1"/>
                  <p:nvPr/>
                </p:nvSpPr>
                <p:spPr>
                  <a:xfrm>
                    <a:off x="3518813" y="3997546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39E67B1F-1848-49ED-B5BF-C5D318E5DE5E}"/>
                    </a:ext>
                  </a:extLst>
                </p:cNvPr>
                <p:cNvGrpSpPr/>
                <p:nvPr/>
              </p:nvGrpSpPr>
              <p:grpSpPr>
                <a:xfrm>
                  <a:off x="9583398" y="2453867"/>
                  <a:ext cx="2372254" cy="2209800"/>
                  <a:chOff x="5189581" y="3039205"/>
                  <a:chExt cx="2372254" cy="2209800"/>
                </a:xfrm>
              </p:grpSpPr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E58C20E0-27BE-3614-9971-E89446442DB1}"/>
                      </a:ext>
                    </a:extLst>
                  </p:cNvPr>
                  <p:cNvSpPr txBox="1"/>
                  <p:nvPr/>
                </p:nvSpPr>
                <p:spPr>
                  <a:xfrm>
                    <a:off x="6346529" y="4361733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7958BBAE-15A9-6851-BE75-BB54DCD3EC4C}"/>
                      </a:ext>
                    </a:extLst>
                  </p:cNvPr>
                  <p:cNvSpPr txBox="1"/>
                  <p:nvPr/>
                </p:nvSpPr>
                <p:spPr>
                  <a:xfrm>
                    <a:off x="5824759" y="3831085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391C9477-E3EB-51E6-345E-811B30B46B36}"/>
                      </a:ext>
                    </a:extLst>
                  </p:cNvPr>
                  <p:cNvSpPr txBox="1"/>
                  <p:nvPr/>
                </p:nvSpPr>
                <p:spPr>
                  <a:xfrm>
                    <a:off x="6204947" y="3706291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graphicFrame>
                <p:nvGraphicFramePr>
                  <p:cNvPr id="48" name="Object 47">
                    <a:extLst>
                      <a:ext uri="{FF2B5EF4-FFF2-40B4-BE49-F238E27FC236}">
                        <a16:creationId xmlns:a16="http://schemas.microsoft.com/office/drawing/2014/main" id="{41392358-1C9E-4247-040C-7E3A3ACB280C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5189581" y="3039205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0" imgW="1466103" imgH="2209856" progId="SigmaPlotGraphicObject.12">
                          <p:embed/>
                        </p:oleObj>
                      </mc:Choice>
                      <mc:Fallback>
                        <p:oleObj name="SPW 13.0 Graph" r:id="rId20" imgW="1466103" imgH="2209856" progId="SigmaPlotGraphicObject.12">
                          <p:embed/>
                          <p:pic>
                            <p:nvPicPr>
                              <p:cNvPr id="48" name="Object 47">
                                <a:extLst>
                                  <a:ext uri="{FF2B5EF4-FFF2-40B4-BE49-F238E27FC236}">
                                    <a16:creationId xmlns:a16="http://schemas.microsoft.com/office/drawing/2014/main" id="{41392358-1C9E-4247-040C-7E3A3ACB280C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189581" y="3039205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2FE23865-1BC3-434B-D673-CA6072F8C39D}"/>
                    </a:ext>
                  </a:extLst>
                </p:cNvPr>
                <p:cNvGrpSpPr/>
                <p:nvPr/>
              </p:nvGrpSpPr>
              <p:grpSpPr>
                <a:xfrm>
                  <a:off x="9583398" y="4468196"/>
                  <a:ext cx="2385535" cy="2209800"/>
                  <a:chOff x="7316696" y="2434273"/>
                  <a:chExt cx="2385535" cy="2209800"/>
                </a:xfrm>
              </p:grpSpPr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9E9643E4-935A-D9C2-4061-225C1477FDD8}"/>
                      </a:ext>
                    </a:extLst>
                  </p:cNvPr>
                  <p:cNvSpPr txBox="1"/>
                  <p:nvPr/>
                </p:nvSpPr>
                <p:spPr>
                  <a:xfrm>
                    <a:off x="8486925" y="3752132"/>
                    <a:ext cx="1215306" cy="52322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 +1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CNQ</a:t>
                    </a:r>
                  </a:p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 +30 </a:t>
                    </a:r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M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H</a:t>
                    </a:r>
                    <a:r>
                      <a:rPr lang="en-US" sz="7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+DCNQ)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3B959163-0718-14DE-3D43-4FFC2CD15D6B}"/>
                      </a:ext>
                    </a:extLst>
                  </p:cNvPr>
                  <p:cNvSpPr txBox="1"/>
                  <p:nvPr/>
                </p:nvSpPr>
                <p:spPr>
                  <a:xfrm>
                    <a:off x="7934675" y="3302766"/>
                    <a:ext cx="289339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graphicFrame>
                <p:nvGraphicFramePr>
                  <p:cNvPr id="44" name="Object 43">
                    <a:extLst>
                      <a:ext uri="{FF2B5EF4-FFF2-40B4-BE49-F238E27FC236}">
                        <a16:creationId xmlns:a16="http://schemas.microsoft.com/office/drawing/2014/main" id="{BB098E61-C365-B4F5-E987-92298AE9E0C0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7316696" y="2434273"/>
                  <a:ext cx="1466850" cy="22098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SPW 13.0 Graph" r:id="rId22" imgW="1466103" imgH="2209856" progId="SigmaPlotGraphicObject.12">
                          <p:embed/>
                        </p:oleObj>
                      </mc:Choice>
                      <mc:Fallback>
                        <p:oleObj name="SPW 13.0 Graph" r:id="rId22" imgW="1466103" imgH="2209856" progId="SigmaPlotGraphicObject.12">
                          <p:embed/>
                          <p:pic>
                            <p:nvPicPr>
                              <p:cNvPr id="44" name="Object 43">
                                <a:extLst>
                                  <a:ext uri="{FF2B5EF4-FFF2-40B4-BE49-F238E27FC236}">
                                    <a16:creationId xmlns:a16="http://schemas.microsoft.com/office/drawing/2014/main" id="{BB098E61-C365-B4F5-E987-92298AE9E0C0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7316696" y="2434273"/>
                                <a:ext cx="1466850" cy="22098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</p:grp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A4D06417-8F30-03D7-A98C-9B11037646B0}"/>
                  </a:ext>
                </a:extLst>
              </p:cNvPr>
              <p:cNvSpPr txBox="1"/>
              <p:nvPr/>
            </p:nvSpPr>
            <p:spPr>
              <a:xfrm>
                <a:off x="828086" y="696778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04B3787B-B65E-4EE4-3321-A7F30EE45A2E}"/>
                  </a:ext>
                </a:extLst>
              </p:cNvPr>
              <p:cNvSpPr txBox="1"/>
              <p:nvPr/>
            </p:nvSpPr>
            <p:spPr>
              <a:xfrm>
                <a:off x="6310770" y="696778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533F4DD-6FA5-B7AB-4514-66596F348908}"/>
                  </a:ext>
                </a:extLst>
              </p:cNvPr>
              <p:cNvSpPr txBox="1"/>
              <p:nvPr/>
            </p:nvSpPr>
            <p:spPr>
              <a:xfrm>
                <a:off x="802067" y="2733734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49B710D-54DA-ABAE-2C62-2450EEC86289}"/>
                  </a:ext>
                </a:extLst>
              </p:cNvPr>
              <p:cNvSpPr txBox="1"/>
              <p:nvPr/>
            </p:nvSpPr>
            <p:spPr>
              <a:xfrm>
                <a:off x="6284751" y="2733734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BE27CE7-0FD7-0421-F884-DF09766166DE}"/>
                  </a:ext>
                </a:extLst>
              </p:cNvPr>
              <p:cNvSpPr txBox="1"/>
              <p:nvPr/>
            </p:nvSpPr>
            <p:spPr>
              <a:xfrm>
                <a:off x="831803" y="4737237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03E2296E-F8FB-0F19-30EA-E0CA0D86AF60}"/>
                  </a:ext>
                </a:extLst>
              </p:cNvPr>
              <p:cNvSpPr txBox="1"/>
              <p:nvPr/>
            </p:nvSpPr>
            <p:spPr>
              <a:xfrm>
                <a:off x="6314487" y="4737237"/>
                <a:ext cx="2954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</p:grpSp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5CA54444-866C-7AEE-65A6-F70CB1514A9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31440" y="436422"/>
            <a:ext cx="3146425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4" imgW="3147215" imgH="2282918" progId="SigmaPlotGraphicObject.12">
                    <p:embed/>
                  </p:oleObj>
                </mc:Choice>
                <mc:Fallback>
                  <p:oleObj name="SPW 13.0 Graph" r:id="rId24" imgW="3147215" imgH="2282918" progId="SigmaPlotGraphicObject.12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5CA54444-866C-7AEE-65A6-F70CB1514A9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1031440" y="436422"/>
                          <a:ext cx="3146425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9C120E75-1F40-8FF0-7E2A-ECBE795DC60D}"/>
              </a:ext>
            </a:extLst>
          </p:cNvPr>
          <p:cNvSpPr txBox="1"/>
          <p:nvPr/>
        </p:nvSpPr>
        <p:spPr>
          <a:xfrm>
            <a:off x="235085" y="241960"/>
            <a:ext cx="216906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6</a:t>
            </a:r>
          </a:p>
        </p:txBody>
      </p:sp>
    </p:spTree>
    <p:extLst>
      <p:ext uri="{BB962C8B-B14F-4D97-AF65-F5344CB8AC3E}">
        <p14:creationId xmlns:p14="http://schemas.microsoft.com/office/powerpoint/2010/main" val="18555600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D952902-58DA-A7B1-852E-5472E74CA842}"/>
              </a:ext>
            </a:extLst>
          </p:cNvPr>
          <p:cNvSpPr txBox="1"/>
          <p:nvPr/>
        </p:nvSpPr>
        <p:spPr>
          <a:xfrm>
            <a:off x="315051" y="202349"/>
            <a:ext cx="20993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7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27DA63A-5A25-E24F-D487-CDC905FBDA3B}"/>
              </a:ext>
            </a:extLst>
          </p:cNvPr>
          <p:cNvGrpSpPr/>
          <p:nvPr/>
        </p:nvGrpSpPr>
        <p:grpSpPr>
          <a:xfrm>
            <a:off x="826239" y="1071475"/>
            <a:ext cx="10698835" cy="4379023"/>
            <a:chOff x="720835" y="125089"/>
            <a:chExt cx="10698835" cy="4379023"/>
          </a:xfrm>
        </p:grpSpPr>
        <p:graphicFrame>
          <p:nvGraphicFramePr>
            <p:cNvPr id="453" name="Object 452">
              <a:extLst>
                <a:ext uri="{FF2B5EF4-FFF2-40B4-BE49-F238E27FC236}">
                  <a16:creationId xmlns:a16="http://schemas.microsoft.com/office/drawing/2014/main" id="{76A833E3-C6FF-CF9C-18E2-B25453BF7ED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55048" y="2221334"/>
            <a:ext cx="2092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2092371" imgH="2249446" progId="SigmaPlotGraphicObject.12">
                    <p:embed/>
                  </p:oleObj>
                </mc:Choice>
                <mc:Fallback>
                  <p:oleObj name="SPW 13.0 Graph" r:id="rId2" imgW="2092371" imgH="2249446" progId="SigmaPlotGraphicObject.12">
                    <p:embed/>
                    <p:pic>
                      <p:nvPicPr>
                        <p:cNvPr id="453" name="Object 452">
                          <a:extLst>
                            <a:ext uri="{FF2B5EF4-FFF2-40B4-BE49-F238E27FC236}">
                              <a16:creationId xmlns:a16="http://schemas.microsoft.com/office/drawing/2014/main" id="{76A833E3-C6FF-CF9C-18E2-B25453BF7E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555048" y="2221334"/>
                          <a:ext cx="2092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54" name="Group 353">
              <a:extLst>
                <a:ext uri="{FF2B5EF4-FFF2-40B4-BE49-F238E27FC236}">
                  <a16:creationId xmlns:a16="http://schemas.microsoft.com/office/drawing/2014/main" id="{BEDB92F4-3DF6-189D-3D71-6D72952752AA}"/>
                </a:ext>
              </a:extLst>
            </p:cNvPr>
            <p:cNvGrpSpPr/>
            <p:nvPr/>
          </p:nvGrpSpPr>
          <p:grpSpPr>
            <a:xfrm>
              <a:off x="785301" y="125089"/>
              <a:ext cx="10581583" cy="2255279"/>
              <a:chOff x="831618" y="-370270"/>
              <a:chExt cx="10581583" cy="2255279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92C1170-98FE-6A75-36C1-7BB6295CC1E7}"/>
                  </a:ext>
                </a:extLst>
              </p:cNvPr>
              <p:cNvSpPr txBox="1"/>
              <p:nvPr/>
            </p:nvSpPr>
            <p:spPr>
              <a:xfrm>
                <a:off x="831618" y="655355"/>
                <a:ext cx="603876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rolox</a:t>
                </a:r>
              </a:p>
            </p:txBody>
          </p:sp>
          <p:grpSp>
            <p:nvGrpSpPr>
              <p:cNvPr id="352" name="Group 351">
                <a:extLst>
                  <a:ext uri="{FF2B5EF4-FFF2-40B4-BE49-F238E27FC236}">
                    <a16:creationId xmlns:a16="http://schemas.microsoft.com/office/drawing/2014/main" id="{E42636F7-D6FD-5005-B97A-02742F962D50}"/>
                  </a:ext>
                </a:extLst>
              </p:cNvPr>
              <p:cNvGrpSpPr/>
              <p:nvPr/>
            </p:nvGrpSpPr>
            <p:grpSpPr>
              <a:xfrm>
                <a:off x="1355794" y="-120403"/>
                <a:ext cx="6818421" cy="276999"/>
                <a:chOff x="1355794" y="-120403"/>
                <a:chExt cx="6818421" cy="276999"/>
              </a:xfrm>
            </p:grpSpPr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4BF32FF0-9675-4F71-E944-CFBED70239CC}"/>
                    </a:ext>
                  </a:extLst>
                </p:cNvPr>
                <p:cNvSpPr txBox="1"/>
                <p:nvPr/>
              </p:nvSpPr>
              <p:spPr>
                <a:xfrm>
                  <a:off x="1355794" y="-120403"/>
                  <a:ext cx="27512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EEFBFA2E-FCBF-3490-06F4-26D37F190B97}"/>
                    </a:ext>
                  </a:extLst>
                </p:cNvPr>
                <p:cNvSpPr txBox="1"/>
                <p:nvPr/>
              </p:nvSpPr>
              <p:spPr>
                <a:xfrm>
                  <a:off x="3518304" y="-120403"/>
                  <a:ext cx="27512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6DDBF5D3-272C-D22A-2960-7256DA85E97E}"/>
                    </a:ext>
                  </a:extLst>
                </p:cNvPr>
                <p:cNvSpPr txBox="1"/>
                <p:nvPr/>
              </p:nvSpPr>
              <p:spPr>
                <a:xfrm>
                  <a:off x="5698417" y="-120403"/>
                  <a:ext cx="27512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2618A90-7826-FD84-76D5-519A011E8FD2}"/>
                    </a:ext>
                  </a:extLst>
                </p:cNvPr>
                <p:cNvSpPr txBox="1"/>
                <p:nvPr/>
              </p:nvSpPr>
              <p:spPr>
                <a:xfrm>
                  <a:off x="7899091" y="-120403"/>
                  <a:ext cx="27512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62C8D1C-D5F3-F0E5-9EF1-749E6E7BA32B}"/>
                  </a:ext>
                </a:extLst>
              </p:cNvPr>
              <p:cNvSpPr txBox="1"/>
              <p:nvPr/>
            </p:nvSpPr>
            <p:spPr>
              <a:xfrm>
                <a:off x="6640337" y="-19088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MNQ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B1F55C1-354F-1337-618D-A14F04A65708}"/>
                  </a:ext>
                </a:extLst>
              </p:cNvPr>
              <p:cNvSpPr txBox="1"/>
              <p:nvPr/>
            </p:nvSpPr>
            <p:spPr>
              <a:xfrm>
                <a:off x="4499553" y="-19088"/>
                <a:ext cx="78739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umbagin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3CFE2F7-00AD-6365-F4EA-87294204E156}"/>
                  </a:ext>
                </a:extLst>
              </p:cNvPr>
              <p:cNvSpPr txBox="1"/>
              <p:nvPr/>
            </p:nvSpPr>
            <p:spPr>
              <a:xfrm>
                <a:off x="2197572" y="-19088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DC3C066-A994-6952-2E59-4547E1CDDF67}"/>
                  </a:ext>
                </a:extLst>
              </p:cNvPr>
              <p:cNvSpPr txBox="1"/>
              <p:nvPr/>
            </p:nvSpPr>
            <p:spPr>
              <a:xfrm>
                <a:off x="8821768" y="-20640"/>
                <a:ext cx="5629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CNQ</a:t>
                </a:r>
              </a:p>
            </p:txBody>
          </p: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D020E92F-6C7E-973E-4248-84A0C1B1D0AE}"/>
                  </a:ext>
                </a:extLst>
              </p:cNvPr>
              <p:cNvGrpSpPr/>
              <p:nvPr/>
            </p:nvGrpSpPr>
            <p:grpSpPr>
              <a:xfrm>
                <a:off x="9960918" y="672052"/>
                <a:ext cx="1452283" cy="732743"/>
                <a:chOff x="10093219" y="827491"/>
                <a:chExt cx="1452283" cy="732743"/>
              </a:xfrm>
            </p:grpSpPr>
            <p:grpSp>
              <p:nvGrpSpPr>
                <p:cNvPr id="252" name="Group 251">
                  <a:extLst>
                    <a:ext uri="{FF2B5EF4-FFF2-40B4-BE49-F238E27FC236}">
                      <a16:creationId xmlns:a16="http://schemas.microsoft.com/office/drawing/2014/main" id="{63EF911C-A155-496E-832B-5C1973674A23}"/>
                    </a:ext>
                  </a:extLst>
                </p:cNvPr>
                <p:cNvGrpSpPr/>
                <p:nvPr/>
              </p:nvGrpSpPr>
              <p:grpSpPr>
                <a:xfrm>
                  <a:off x="10312264" y="954310"/>
                  <a:ext cx="149713" cy="479802"/>
                  <a:chOff x="10312264" y="954310"/>
                  <a:chExt cx="149713" cy="479802"/>
                </a:xfrm>
              </p:grpSpPr>
              <p:cxnSp>
                <p:nvCxnSpPr>
                  <p:cNvPr id="295" name="Straight Connector 294">
                    <a:extLst>
                      <a:ext uri="{FF2B5EF4-FFF2-40B4-BE49-F238E27FC236}">
                        <a16:creationId xmlns:a16="http://schemas.microsoft.com/office/drawing/2014/main" id="{A4402356-E236-EF51-5766-C730690F5AD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954310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6" name="Straight Connector 295">
                    <a:extLst>
                      <a:ext uri="{FF2B5EF4-FFF2-40B4-BE49-F238E27FC236}">
                        <a16:creationId xmlns:a16="http://schemas.microsoft.com/office/drawing/2014/main" id="{6AD71FE8-FDB7-2F02-76CC-4EE37A7142E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114244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009E47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7" name="Straight Connector 296">
                    <a:extLst>
                      <a:ext uri="{FF2B5EF4-FFF2-40B4-BE49-F238E27FC236}">
                        <a16:creationId xmlns:a16="http://schemas.microsoft.com/office/drawing/2014/main" id="{BF88489F-42D2-EB0F-EE7C-1F1D0967F4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274178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048EEC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8" name="Straight Connector 297">
                    <a:extLst>
                      <a:ext uri="{FF2B5EF4-FFF2-40B4-BE49-F238E27FC236}">
                        <a16:creationId xmlns:a16="http://schemas.microsoft.com/office/drawing/2014/main" id="{D3701EDC-C4A4-C936-AAB9-4CB4601827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434112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EE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54" name="Group 253">
                  <a:extLst>
                    <a:ext uri="{FF2B5EF4-FFF2-40B4-BE49-F238E27FC236}">
                      <a16:creationId xmlns:a16="http://schemas.microsoft.com/office/drawing/2014/main" id="{3B515011-A4DD-47F0-09B3-BA131D0A98AA}"/>
                    </a:ext>
                  </a:extLst>
                </p:cNvPr>
                <p:cNvGrpSpPr/>
                <p:nvPr/>
              </p:nvGrpSpPr>
              <p:grpSpPr>
                <a:xfrm>
                  <a:off x="10093219" y="827491"/>
                  <a:ext cx="290464" cy="732743"/>
                  <a:chOff x="10093219" y="827491"/>
                  <a:chExt cx="290464" cy="732743"/>
                </a:xfrm>
              </p:grpSpPr>
              <p:sp>
                <p:nvSpPr>
                  <p:cNvPr id="289" name="TextBox 288">
                    <a:extLst>
                      <a:ext uri="{FF2B5EF4-FFF2-40B4-BE49-F238E27FC236}">
                        <a16:creationId xmlns:a16="http://schemas.microsoft.com/office/drawing/2014/main" id="{0C0323A7-7E0A-DFF0-B376-7132CF1924B8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827491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</a:t>
                    </a:r>
                  </a:p>
                </p:txBody>
              </p:sp>
              <p:sp>
                <p:nvSpPr>
                  <p:cNvPr id="290" name="TextBox 289">
                    <a:extLst>
                      <a:ext uri="{FF2B5EF4-FFF2-40B4-BE49-F238E27FC236}">
                        <a16:creationId xmlns:a16="http://schemas.microsoft.com/office/drawing/2014/main" id="{62829EAC-0BAA-15AD-33DD-238085CB50C9}"/>
                      </a:ext>
                    </a:extLst>
                  </p:cNvPr>
                  <p:cNvSpPr txBox="1"/>
                  <p:nvPr/>
                </p:nvSpPr>
                <p:spPr>
                  <a:xfrm>
                    <a:off x="10198952" y="946637"/>
                    <a:ext cx="18473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1" name="TextBox 290">
                    <a:extLst>
                      <a:ext uri="{FF2B5EF4-FFF2-40B4-BE49-F238E27FC236}">
                        <a16:creationId xmlns:a16="http://schemas.microsoft.com/office/drawing/2014/main" id="{5C66CFF7-894C-35FE-5BC8-A43A0B28272F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1148486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</a:t>
                    </a:r>
                  </a:p>
                </p:txBody>
              </p:sp>
              <p:sp>
                <p:nvSpPr>
                  <p:cNvPr id="292" name="TextBox 291">
                    <a:extLst>
                      <a:ext uri="{FF2B5EF4-FFF2-40B4-BE49-F238E27FC236}">
                        <a16:creationId xmlns:a16="http://schemas.microsoft.com/office/drawing/2014/main" id="{B24B0955-45A1-3F3B-E47F-F8F708324988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1314013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</a:t>
                    </a:r>
                  </a:p>
                </p:txBody>
              </p:sp>
              <p:sp>
                <p:nvSpPr>
                  <p:cNvPr id="293" name="TextBox 292">
                    <a:extLst>
                      <a:ext uri="{FF2B5EF4-FFF2-40B4-BE49-F238E27FC236}">
                        <a16:creationId xmlns:a16="http://schemas.microsoft.com/office/drawing/2014/main" id="{3AB24CCE-0877-003C-EF29-150E3A51D9BF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989584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</a:t>
                    </a:r>
                  </a:p>
                </p:txBody>
              </p:sp>
            </p:grp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40071712-D6A2-03A8-E904-BB7C8F3D4C5A}"/>
                    </a:ext>
                  </a:extLst>
                </p:cNvPr>
                <p:cNvSpPr txBox="1"/>
                <p:nvPr/>
              </p:nvSpPr>
              <p:spPr>
                <a:xfrm>
                  <a:off x="10429491" y="829148"/>
                  <a:ext cx="4106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C11C9B7F-A05A-9FC2-A325-3F3388D85D3E}"/>
                    </a:ext>
                  </a:extLst>
                </p:cNvPr>
                <p:cNvSpPr txBox="1"/>
                <p:nvPr/>
              </p:nvSpPr>
              <p:spPr>
                <a:xfrm>
                  <a:off x="10429491" y="986418"/>
                  <a:ext cx="8418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Trolox</a:t>
                  </a:r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7EFFDA44-1161-3C61-11CC-C18DDF81F0B2}"/>
                    </a:ext>
                  </a:extLst>
                </p:cNvPr>
                <p:cNvSpPr txBox="1"/>
                <p:nvPr/>
              </p:nvSpPr>
              <p:spPr>
                <a:xfrm>
                  <a:off x="10429491" y="1147066"/>
                  <a:ext cx="6783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NQ</a:t>
                  </a:r>
                </a:p>
              </p:txBody>
            </p:sp>
            <p:sp>
              <p:nvSpPr>
                <p:cNvPr id="286" name="TextBox 285">
                  <a:extLst>
                    <a:ext uri="{FF2B5EF4-FFF2-40B4-BE49-F238E27FC236}">
                      <a16:creationId xmlns:a16="http://schemas.microsoft.com/office/drawing/2014/main" id="{D939C33E-A5BA-C95C-975B-70294F047F6F}"/>
                    </a:ext>
                  </a:extLst>
                </p:cNvPr>
                <p:cNvSpPr txBox="1"/>
                <p:nvPr/>
              </p:nvSpPr>
              <p:spPr>
                <a:xfrm>
                  <a:off x="10429491" y="1307714"/>
                  <a:ext cx="11160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NQ+Trolox</a:t>
                  </a:r>
                </a:p>
              </p:txBody>
            </p:sp>
          </p:grpSp>
          <p:grpSp>
            <p:nvGrpSpPr>
              <p:cNvPr id="343" name="Group 342">
                <a:extLst>
                  <a:ext uri="{FF2B5EF4-FFF2-40B4-BE49-F238E27FC236}">
                    <a16:creationId xmlns:a16="http://schemas.microsoft.com/office/drawing/2014/main" id="{5663BC06-B3C0-206F-874A-0659B139C9A3}"/>
                  </a:ext>
                </a:extLst>
              </p:cNvPr>
              <p:cNvGrpSpPr/>
              <p:nvPr/>
            </p:nvGrpSpPr>
            <p:grpSpPr>
              <a:xfrm>
                <a:off x="7936690" y="-364478"/>
                <a:ext cx="2122196" cy="2249487"/>
                <a:chOff x="7923990" y="-508000"/>
                <a:chExt cx="2122196" cy="2249487"/>
              </a:xfrm>
            </p:grpSpPr>
            <p:graphicFrame>
              <p:nvGraphicFramePr>
                <p:cNvPr id="326" name="Object 325">
                  <a:extLst>
                    <a:ext uri="{FF2B5EF4-FFF2-40B4-BE49-F238E27FC236}">
                      <a16:creationId xmlns:a16="http://schemas.microsoft.com/office/drawing/2014/main" id="{ABAA4C3A-383C-32CE-9821-1D95ED3404B4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7923990" y="-508000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4" imgW="2092371" imgH="2249446" progId="SigmaPlotGraphicObject.12">
                        <p:embed/>
                      </p:oleObj>
                    </mc:Choice>
                    <mc:Fallback>
                      <p:oleObj name="SPW 13.0 Graph" r:id="rId4" imgW="2092371" imgH="2249446" progId="SigmaPlotGraphicObject.12">
                        <p:embed/>
                        <p:pic>
                          <p:nvPicPr>
                            <p:cNvPr id="326" name="Object 325">
                              <a:extLst>
                                <a:ext uri="{FF2B5EF4-FFF2-40B4-BE49-F238E27FC236}">
                                  <a16:creationId xmlns:a16="http://schemas.microsoft.com/office/drawing/2014/main" id="{ABAA4C3A-383C-32CE-9821-1D95ED3404B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23990" y="-508000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70" name="Group 169">
                  <a:extLst>
                    <a:ext uri="{FF2B5EF4-FFF2-40B4-BE49-F238E27FC236}">
                      <a16:creationId xmlns:a16="http://schemas.microsoft.com/office/drawing/2014/main" id="{2577525F-0F7D-8AD1-2C63-565D4B2AE2C1}"/>
                    </a:ext>
                  </a:extLst>
                </p:cNvPr>
                <p:cNvGrpSpPr/>
                <p:nvPr/>
              </p:nvGrpSpPr>
              <p:grpSpPr>
                <a:xfrm>
                  <a:off x="8379565" y="311167"/>
                  <a:ext cx="791784" cy="692153"/>
                  <a:chOff x="8252185" y="2686000"/>
                  <a:chExt cx="791784" cy="692153"/>
                </a:xfrm>
              </p:grpSpPr>
              <p:sp>
                <p:nvSpPr>
                  <p:cNvPr id="171" name="TextBox 170">
                    <a:extLst>
                      <a:ext uri="{FF2B5EF4-FFF2-40B4-BE49-F238E27FC236}">
                        <a16:creationId xmlns:a16="http://schemas.microsoft.com/office/drawing/2014/main" id="{28C1834E-5B5B-CC77-E550-A7B465D5B0E2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172" name="Straight Arrow Connector 171">
                    <a:extLst>
                      <a:ext uri="{FF2B5EF4-FFF2-40B4-BE49-F238E27FC236}">
                        <a16:creationId xmlns:a16="http://schemas.microsoft.com/office/drawing/2014/main" id="{41A7F631-8291-24D0-2518-95428368BF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3" name="TextBox 172">
                    <a:extLst>
                      <a:ext uri="{FF2B5EF4-FFF2-40B4-BE49-F238E27FC236}">
                        <a16:creationId xmlns:a16="http://schemas.microsoft.com/office/drawing/2014/main" id="{C3D34807-5808-494A-77E8-CCF0F3DEE8E6}"/>
                      </a:ext>
                    </a:extLst>
                  </p:cNvPr>
                  <p:cNvSpPr txBox="1"/>
                  <p:nvPr/>
                </p:nvSpPr>
                <p:spPr>
                  <a:xfrm>
                    <a:off x="8480994" y="3131932"/>
                    <a:ext cx="56297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CNQ</a:t>
                    </a:r>
                  </a:p>
                </p:txBody>
              </p:sp>
              <p:sp>
                <p:nvSpPr>
                  <p:cNvPr id="174" name="TextBox 173">
                    <a:extLst>
                      <a:ext uri="{FF2B5EF4-FFF2-40B4-BE49-F238E27FC236}">
                        <a16:creationId xmlns:a16="http://schemas.microsoft.com/office/drawing/2014/main" id="{28350828-DC1F-AE19-9D18-8503675E87F9}"/>
                      </a:ext>
                    </a:extLst>
                  </p:cNvPr>
                  <p:cNvSpPr txBox="1"/>
                  <p:nvPr/>
                </p:nvSpPr>
                <p:spPr>
                  <a:xfrm>
                    <a:off x="8408280" y="2963918"/>
                    <a:ext cx="37702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o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75" name="Straight Arrow Connector 174">
                    <a:extLst>
                      <a:ext uri="{FF2B5EF4-FFF2-40B4-BE49-F238E27FC236}">
                        <a16:creationId xmlns:a16="http://schemas.microsoft.com/office/drawing/2014/main" id="{5B707A28-67D9-7676-5208-04C954D93A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6" name="Straight Arrow Connector 175">
                    <a:extLst>
                      <a:ext uri="{FF2B5EF4-FFF2-40B4-BE49-F238E27FC236}">
                        <a16:creationId xmlns:a16="http://schemas.microsoft.com/office/drawing/2014/main" id="{1B500885-CC5B-2413-E756-0821259515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52239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6AED3418-18CC-FBEC-EDA4-8D1BEA8FB29D}"/>
                    </a:ext>
                  </a:extLst>
                </p:cNvPr>
                <p:cNvSpPr txBox="1"/>
                <p:nvPr/>
              </p:nvSpPr>
              <p:spPr>
                <a:xfrm>
                  <a:off x="9755722" y="342181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DEC621E0-8FFB-45E3-FF20-2E09C0E81651}"/>
                    </a:ext>
                  </a:extLst>
                </p:cNvPr>
                <p:cNvSpPr txBox="1"/>
                <p:nvPr/>
              </p:nvSpPr>
              <p:spPr>
                <a:xfrm>
                  <a:off x="9755722" y="582120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B2B451BB-67BB-7E94-CB6F-E132F302253F}"/>
                    </a:ext>
                  </a:extLst>
                </p:cNvPr>
                <p:cNvSpPr txBox="1"/>
                <p:nvPr/>
              </p:nvSpPr>
              <p:spPr>
                <a:xfrm>
                  <a:off x="9755722" y="718464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F9D3B6DB-F75E-4EFB-87E8-8506AF5AA090}"/>
                    </a:ext>
                  </a:extLst>
                </p:cNvPr>
                <p:cNvSpPr txBox="1"/>
                <p:nvPr/>
              </p:nvSpPr>
              <p:spPr>
                <a:xfrm>
                  <a:off x="9755722" y="212447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  <p:grpSp>
            <p:nvGrpSpPr>
              <p:cNvPr id="344" name="Group 343">
                <a:extLst>
                  <a:ext uri="{FF2B5EF4-FFF2-40B4-BE49-F238E27FC236}">
                    <a16:creationId xmlns:a16="http://schemas.microsoft.com/office/drawing/2014/main" id="{7BFAC56A-4D16-E759-5954-7F6A4B140A15}"/>
                  </a:ext>
                </a:extLst>
              </p:cNvPr>
              <p:cNvGrpSpPr/>
              <p:nvPr/>
            </p:nvGrpSpPr>
            <p:grpSpPr>
              <a:xfrm>
                <a:off x="5739951" y="-364478"/>
                <a:ext cx="2098295" cy="2249487"/>
                <a:chOff x="5714551" y="-508000"/>
                <a:chExt cx="2098295" cy="2249487"/>
              </a:xfrm>
            </p:grpSpPr>
            <p:graphicFrame>
              <p:nvGraphicFramePr>
                <p:cNvPr id="325" name="Object 324">
                  <a:extLst>
                    <a:ext uri="{FF2B5EF4-FFF2-40B4-BE49-F238E27FC236}">
                      <a16:creationId xmlns:a16="http://schemas.microsoft.com/office/drawing/2014/main" id="{FAA5C791-47FA-272D-09D9-77435E461F12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714551" y="-508000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6" imgW="2092371" imgH="2249446" progId="SigmaPlotGraphicObject.12">
                        <p:embed/>
                      </p:oleObj>
                    </mc:Choice>
                    <mc:Fallback>
                      <p:oleObj name="SPW 13.0 Graph" r:id="rId6" imgW="2092371" imgH="2249446" progId="SigmaPlotGraphicObject.12">
                        <p:embed/>
                        <p:pic>
                          <p:nvPicPr>
                            <p:cNvPr id="325" name="Object 324">
                              <a:extLst>
                                <a:ext uri="{FF2B5EF4-FFF2-40B4-BE49-F238E27FC236}">
                                  <a16:creationId xmlns:a16="http://schemas.microsoft.com/office/drawing/2014/main" id="{FAA5C791-47FA-272D-09D9-77435E461F1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714551" y="-508000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40" name="Group 139">
                  <a:extLst>
                    <a:ext uri="{FF2B5EF4-FFF2-40B4-BE49-F238E27FC236}">
                      <a16:creationId xmlns:a16="http://schemas.microsoft.com/office/drawing/2014/main" id="{1BC44123-18D3-7182-C283-B633B1D014A5}"/>
                    </a:ext>
                  </a:extLst>
                </p:cNvPr>
                <p:cNvGrpSpPr/>
                <p:nvPr/>
              </p:nvGrpSpPr>
              <p:grpSpPr>
                <a:xfrm>
                  <a:off x="6112908" y="204202"/>
                  <a:ext cx="768272" cy="692153"/>
                  <a:chOff x="8290124" y="2686000"/>
                  <a:chExt cx="768272" cy="692153"/>
                </a:xfrm>
              </p:grpSpPr>
              <p:sp>
                <p:nvSpPr>
                  <p:cNvPr id="141" name="TextBox 140">
                    <a:extLst>
                      <a:ext uri="{FF2B5EF4-FFF2-40B4-BE49-F238E27FC236}">
                        <a16:creationId xmlns:a16="http://schemas.microsoft.com/office/drawing/2014/main" id="{21BD38C5-6422-6451-737A-710DA35583E4}"/>
                      </a:ext>
                    </a:extLst>
                  </p:cNvPr>
                  <p:cNvSpPr txBox="1"/>
                  <p:nvPr/>
                </p:nvSpPr>
                <p:spPr>
                  <a:xfrm>
                    <a:off x="8290124" y="2828298"/>
                    <a:ext cx="45828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142" name="Straight Arrow Connector 141">
                    <a:extLst>
                      <a:ext uri="{FF2B5EF4-FFF2-40B4-BE49-F238E27FC236}">
                        <a16:creationId xmlns:a16="http://schemas.microsoft.com/office/drawing/2014/main" id="{D9245E3A-B205-9390-FE16-89B517083D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DA7A6548-EA0B-0F0D-8955-7570CDF69B0B}"/>
                      </a:ext>
                    </a:extLst>
                  </p:cNvPr>
                  <p:cNvSpPr txBox="1"/>
                  <p:nvPr/>
                </p:nvSpPr>
                <p:spPr>
                  <a:xfrm>
                    <a:off x="8480994" y="3131932"/>
                    <a:ext cx="57740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MNQ</a:t>
                    </a:r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FE8EA841-DCF6-509B-51CB-76001B761AAC}"/>
                      </a:ext>
                    </a:extLst>
                  </p:cNvPr>
                  <p:cNvSpPr txBox="1"/>
                  <p:nvPr/>
                </p:nvSpPr>
                <p:spPr>
                  <a:xfrm>
                    <a:off x="8438632" y="2963918"/>
                    <a:ext cx="37702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o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45" name="Straight Arrow Connector 144">
                    <a:extLst>
                      <a:ext uri="{FF2B5EF4-FFF2-40B4-BE49-F238E27FC236}">
                        <a16:creationId xmlns:a16="http://schemas.microsoft.com/office/drawing/2014/main" id="{6A34F5CF-425E-F2A2-60FC-6992AF79A1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Straight Arrow Connector 145">
                    <a:extLst>
                      <a:ext uri="{FF2B5EF4-FFF2-40B4-BE49-F238E27FC236}">
                        <a16:creationId xmlns:a16="http://schemas.microsoft.com/office/drawing/2014/main" id="{DE873545-7DAD-7795-3468-2202A09886A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E51D250E-8D0D-48CB-25D6-C8CA3544669F}"/>
                    </a:ext>
                  </a:extLst>
                </p:cNvPr>
                <p:cNvSpPr txBox="1"/>
                <p:nvPr/>
              </p:nvSpPr>
              <p:spPr>
                <a:xfrm>
                  <a:off x="7522382" y="319476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620EBCFD-CB9A-3E10-F85C-43AD3F6C7CED}"/>
                    </a:ext>
                  </a:extLst>
                </p:cNvPr>
                <p:cNvSpPr txBox="1"/>
                <p:nvPr/>
              </p:nvSpPr>
              <p:spPr>
                <a:xfrm>
                  <a:off x="7522382" y="575630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8129CFCE-76FF-348F-06D6-A8E70E1BF6BF}"/>
                    </a:ext>
                  </a:extLst>
                </p:cNvPr>
                <p:cNvSpPr txBox="1"/>
                <p:nvPr/>
              </p:nvSpPr>
              <p:spPr>
                <a:xfrm>
                  <a:off x="7522382" y="439593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C2EF76FB-1D4F-DB27-B5FD-8E52C4A5BFD8}"/>
                    </a:ext>
                  </a:extLst>
                </p:cNvPr>
                <p:cNvSpPr txBox="1"/>
                <p:nvPr/>
              </p:nvSpPr>
              <p:spPr>
                <a:xfrm>
                  <a:off x="7522382" y="18974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  <p:grpSp>
            <p:nvGrpSpPr>
              <p:cNvPr id="342" name="Group 341">
                <a:extLst>
                  <a:ext uri="{FF2B5EF4-FFF2-40B4-BE49-F238E27FC236}">
                    <a16:creationId xmlns:a16="http://schemas.microsoft.com/office/drawing/2014/main" id="{1DC922A2-ECB1-D90B-844E-B2DFB382636C}"/>
                  </a:ext>
                </a:extLst>
              </p:cNvPr>
              <p:cNvGrpSpPr/>
              <p:nvPr/>
            </p:nvGrpSpPr>
            <p:grpSpPr>
              <a:xfrm>
                <a:off x="3551560" y="-370270"/>
                <a:ext cx="2114724" cy="2249487"/>
                <a:chOff x="3522338" y="-352514"/>
                <a:chExt cx="2114724" cy="2249487"/>
              </a:xfrm>
            </p:grpSpPr>
            <p:graphicFrame>
              <p:nvGraphicFramePr>
                <p:cNvPr id="323" name="Object 322">
                  <a:extLst>
                    <a:ext uri="{FF2B5EF4-FFF2-40B4-BE49-F238E27FC236}">
                      <a16:creationId xmlns:a16="http://schemas.microsoft.com/office/drawing/2014/main" id="{D51670E0-013E-07C5-34FE-D4FC042E1835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3522338" y="-352514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8" imgW="2092371" imgH="2249446" progId="SigmaPlotGraphicObject.12">
                        <p:embed/>
                      </p:oleObj>
                    </mc:Choice>
                    <mc:Fallback>
                      <p:oleObj name="SPW 13.0 Graph" r:id="rId8" imgW="2092371" imgH="2249446" progId="SigmaPlotGraphicObject.12">
                        <p:embed/>
                        <p:pic>
                          <p:nvPicPr>
                            <p:cNvPr id="323" name="Object 322">
                              <a:extLst>
                                <a:ext uri="{FF2B5EF4-FFF2-40B4-BE49-F238E27FC236}">
                                  <a16:creationId xmlns:a16="http://schemas.microsoft.com/office/drawing/2014/main" id="{D51670E0-013E-07C5-34FE-D4FC042E183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522338" y="-352514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62" name="Group 161">
                  <a:extLst>
                    <a:ext uri="{FF2B5EF4-FFF2-40B4-BE49-F238E27FC236}">
                      <a16:creationId xmlns:a16="http://schemas.microsoft.com/office/drawing/2014/main" id="{CA19025A-6421-67FE-4553-AEF4C9A7D19A}"/>
                    </a:ext>
                  </a:extLst>
                </p:cNvPr>
                <p:cNvGrpSpPr/>
                <p:nvPr/>
              </p:nvGrpSpPr>
              <p:grpSpPr>
                <a:xfrm>
                  <a:off x="3940081" y="360193"/>
                  <a:ext cx="685273" cy="692153"/>
                  <a:chOff x="8252185" y="2686000"/>
                  <a:chExt cx="685273" cy="692153"/>
                </a:xfrm>
              </p:grpSpPr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1763AB19-D57D-0FF0-E2BC-C3F471583C1F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164" name="Straight Arrow Connector 163">
                    <a:extLst>
                      <a:ext uri="{FF2B5EF4-FFF2-40B4-BE49-F238E27FC236}">
                        <a16:creationId xmlns:a16="http://schemas.microsoft.com/office/drawing/2014/main" id="{7732A112-1C11-E366-E7D6-12D2F10D53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7F1ECD2D-CE73-F40A-F466-288CA474628D}"/>
                      </a:ext>
                    </a:extLst>
                  </p:cNvPr>
                  <p:cNvSpPr txBox="1"/>
                  <p:nvPr/>
                </p:nvSpPr>
                <p:spPr>
                  <a:xfrm>
                    <a:off x="8582874" y="3131932"/>
                    <a:ext cx="35458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</a:t>
                    </a:r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76B3C106-2172-2C6C-872F-518E024404C2}"/>
                      </a:ext>
                    </a:extLst>
                  </p:cNvPr>
                  <p:cNvSpPr txBox="1"/>
                  <p:nvPr/>
                </p:nvSpPr>
                <p:spPr>
                  <a:xfrm>
                    <a:off x="8408280" y="2963918"/>
                    <a:ext cx="37702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o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67" name="Straight Arrow Connector 166">
                    <a:extLst>
                      <a:ext uri="{FF2B5EF4-FFF2-40B4-BE49-F238E27FC236}">
                        <a16:creationId xmlns:a16="http://schemas.microsoft.com/office/drawing/2014/main" id="{0AD40E7C-1FAE-9947-0F69-7CD9ED081ED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8" name="Straight Arrow Connector 167">
                    <a:extLst>
                      <a:ext uri="{FF2B5EF4-FFF2-40B4-BE49-F238E27FC236}">
                        <a16:creationId xmlns:a16="http://schemas.microsoft.com/office/drawing/2014/main" id="{AF4C2BC0-AB7D-E5EF-E481-D26530C0453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2143FE76-6367-B879-2A36-56AF661065F5}"/>
                    </a:ext>
                  </a:extLst>
                </p:cNvPr>
                <p:cNvSpPr txBox="1"/>
                <p:nvPr/>
              </p:nvSpPr>
              <p:spPr>
                <a:xfrm>
                  <a:off x="5346598" y="478366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71D818AE-D8F8-ED39-56CD-2A831AB83D00}"/>
                    </a:ext>
                  </a:extLst>
                </p:cNvPr>
                <p:cNvSpPr txBox="1"/>
                <p:nvPr/>
              </p:nvSpPr>
              <p:spPr>
                <a:xfrm>
                  <a:off x="5346598" y="598326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D2A826F8-41AA-08B1-8CE1-4D979A9BBCFF}"/>
                    </a:ext>
                  </a:extLst>
                </p:cNvPr>
                <p:cNvSpPr txBox="1"/>
                <p:nvPr/>
              </p:nvSpPr>
              <p:spPr>
                <a:xfrm>
                  <a:off x="5346598" y="734670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EA8C3614-0A38-1A41-29D4-B90407E2906D}"/>
                    </a:ext>
                  </a:extLst>
                </p:cNvPr>
                <p:cNvSpPr txBox="1"/>
                <p:nvPr/>
              </p:nvSpPr>
              <p:spPr>
                <a:xfrm>
                  <a:off x="5346598" y="34863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  <p:grpSp>
            <p:nvGrpSpPr>
              <p:cNvPr id="341" name="Group 340">
                <a:extLst>
                  <a:ext uri="{FF2B5EF4-FFF2-40B4-BE49-F238E27FC236}">
                    <a16:creationId xmlns:a16="http://schemas.microsoft.com/office/drawing/2014/main" id="{A7A7096B-45E3-EF3B-2DBD-1027E9035007}"/>
                  </a:ext>
                </a:extLst>
              </p:cNvPr>
              <p:cNvGrpSpPr/>
              <p:nvPr/>
            </p:nvGrpSpPr>
            <p:grpSpPr>
              <a:xfrm>
                <a:off x="1383132" y="-369771"/>
                <a:ext cx="2096525" cy="2249487"/>
                <a:chOff x="1332332" y="-369771"/>
                <a:chExt cx="2096525" cy="2249487"/>
              </a:xfrm>
            </p:grpSpPr>
            <p:graphicFrame>
              <p:nvGraphicFramePr>
                <p:cNvPr id="324" name="Object 323">
                  <a:extLst>
                    <a:ext uri="{FF2B5EF4-FFF2-40B4-BE49-F238E27FC236}">
                      <a16:creationId xmlns:a16="http://schemas.microsoft.com/office/drawing/2014/main" id="{84A23520-9792-A4B3-A637-04B91BE3682E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1332332" y="-369771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0" imgW="2092371" imgH="2249446" progId="SigmaPlotGraphicObject.12">
                        <p:embed/>
                      </p:oleObj>
                    </mc:Choice>
                    <mc:Fallback>
                      <p:oleObj name="SPW 13.0 Graph" r:id="rId10" imgW="2092371" imgH="2249446" progId="SigmaPlotGraphicObject.12">
                        <p:embed/>
                        <p:pic>
                          <p:nvPicPr>
                            <p:cNvPr id="324" name="Object 323">
                              <a:extLst>
                                <a:ext uri="{FF2B5EF4-FFF2-40B4-BE49-F238E27FC236}">
                                  <a16:creationId xmlns:a16="http://schemas.microsoft.com/office/drawing/2014/main" id="{84A23520-9792-A4B3-A637-04B91BE3682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32332" y="-369771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48" name="Group 147">
                  <a:extLst>
                    <a:ext uri="{FF2B5EF4-FFF2-40B4-BE49-F238E27FC236}">
                      <a16:creationId xmlns:a16="http://schemas.microsoft.com/office/drawing/2014/main" id="{1AD74220-8673-ED4F-91BF-A7AC2D59ED61}"/>
                    </a:ext>
                  </a:extLst>
                </p:cNvPr>
                <p:cNvGrpSpPr/>
                <p:nvPr/>
              </p:nvGrpSpPr>
              <p:grpSpPr>
                <a:xfrm>
                  <a:off x="1754622" y="405800"/>
                  <a:ext cx="810542" cy="709547"/>
                  <a:chOff x="8252185" y="2686000"/>
                  <a:chExt cx="810542" cy="709547"/>
                </a:xfrm>
              </p:grpSpPr>
              <p:sp>
                <p:nvSpPr>
                  <p:cNvPr id="149" name="TextBox 148">
                    <a:extLst>
                      <a:ext uri="{FF2B5EF4-FFF2-40B4-BE49-F238E27FC236}">
                        <a16:creationId xmlns:a16="http://schemas.microsoft.com/office/drawing/2014/main" id="{7CD553A7-0A58-C206-2D33-DF3470839093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150" name="Straight Arrow Connector 149">
                    <a:extLst>
                      <a:ext uri="{FF2B5EF4-FFF2-40B4-BE49-F238E27FC236}">
                        <a16:creationId xmlns:a16="http://schemas.microsoft.com/office/drawing/2014/main" id="{38DE4870-977B-4E60-3EA9-228AE87650D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1" name="TextBox 150">
                    <a:extLst>
                      <a:ext uri="{FF2B5EF4-FFF2-40B4-BE49-F238E27FC236}">
                        <a16:creationId xmlns:a16="http://schemas.microsoft.com/office/drawing/2014/main" id="{F5BBC2A0-6E63-BAB8-0FC2-79C2AF11D390}"/>
                      </a:ext>
                    </a:extLst>
                  </p:cNvPr>
                  <p:cNvSpPr txBox="1"/>
                  <p:nvPr/>
                </p:nvSpPr>
                <p:spPr>
                  <a:xfrm>
                    <a:off x="8466089" y="3149326"/>
                    <a:ext cx="59663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,4-NQ</a:t>
                    </a:r>
                  </a:p>
                </p:txBody>
              </p:sp>
              <p:sp>
                <p:nvSpPr>
                  <p:cNvPr id="152" name="TextBox 151">
                    <a:extLst>
                      <a:ext uri="{FF2B5EF4-FFF2-40B4-BE49-F238E27FC236}">
                        <a16:creationId xmlns:a16="http://schemas.microsoft.com/office/drawing/2014/main" id="{35E38805-89B0-C70C-7179-A5C308E5A3D9}"/>
                      </a:ext>
                    </a:extLst>
                  </p:cNvPr>
                  <p:cNvSpPr txBox="1"/>
                  <p:nvPr/>
                </p:nvSpPr>
                <p:spPr>
                  <a:xfrm>
                    <a:off x="8415735" y="2981312"/>
                    <a:ext cx="37702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o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53" name="Straight Arrow Connector 152">
                    <a:extLst>
                      <a:ext uri="{FF2B5EF4-FFF2-40B4-BE49-F238E27FC236}">
                        <a16:creationId xmlns:a16="http://schemas.microsoft.com/office/drawing/2014/main" id="{5A85706B-BC8D-BD8A-56BA-CA7E31BD780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4" name="Straight Arrow Connector 153">
                    <a:extLst>
                      <a:ext uri="{FF2B5EF4-FFF2-40B4-BE49-F238E27FC236}">
                        <a16:creationId xmlns:a16="http://schemas.microsoft.com/office/drawing/2014/main" id="{DBFEF92F-C302-1A30-2899-FD81856BF3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F4F60921-7F18-F338-E003-337BDB972393}"/>
                    </a:ext>
                  </a:extLst>
                </p:cNvPr>
                <p:cNvSpPr txBox="1"/>
                <p:nvPr/>
              </p:nvSpPr>
              <p:spPr>
                <a:xfrm>
                  <a:off x="3138393" y="465388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3CE9F1CF-5617-3CEE-4FB6-10F89B886ADF}"/>
                    </a:ext>
                  </a:extLst>
                </p:cNvPr>
                <p:cNvSpPr txBox="1"/>
                <p:nvPr/>
              </p:nvSpPr>
              <p:spPr>
                <a:xfrm>
                  <a:off x="3138393" y="692358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942DDF43-E2C9-FA49-F580-D4312EBB6FF9}"/>
                    </a:ext>
                  </a:extLst>
                </p:cNvPr>
                <p:cNvSpPr txBox="1"/>
                <p:nvPr/>
              </p:nvSpPr>
              <p:spPr>
                <a:xfrm>
                  <a:off x="3138393" y="82870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BC652958-2D50-0D56-3A7F-D295B27BE820}"/>
                    </a:ext>
                  </a:extLst>
                </p:cNvPr>
                <p:cNvSpPr txBox="1"/>
                <p:nvPr/>
              </p:nvSpPr>
              <p:spPr>
                <a:xfrm>
                  <a:off x="3138393" y="335654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</p:grpSp>
        <p:grpSp>
          <p:nvGrpSpPr>
            <p:cNvPr id="353" name="Group 352">
              <a:extLst>
                <a:ext uri="{FF2B5EF4-FFF2-40B4-BE49-F238E27FC236}">
                  <a16:creationId xmlns:a16="http://schemas.microsoft.com/office/drawing/2014/main" id="{3A92648E-1008-0AFB-C949-DB140BE19DED}"/>
                </a:ext>
              </a:extLst>
            </p:cNvPr>
            <p:cNvGrpSpPr/>
            <p:nvPr/>
          </p:nvGrpSpPr>
          <p:grpSpPr>
            <a:xfrm>
              <a:off x="720835" y="2199132"/>
              <a:ext cx="10698835" cy="2304980"/>
              <a:chOff x="742100" y="1866611"/>
              <a:chExt cx="10698835" cy="2304980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92500D60-F8EB-5050-AC14-4B5A237B5F10}"/>
                  </a:ext>
                </a:extLst>
              </p:cNvPr>
              <p:cNvSpPr txBox="1"/>
              <p:nvPr/>
            </p:nvSpPr>
            <p:spPr>
              <a:xfrm>
                <a:off x="6624456" y="2222304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MNQ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F90AFBDB-AEE4-6A4F-9DD1-03A47A51C778}"/>
                  </a:ext>
                </a:extLst>
              </p:cNvPr>
              <p:cNvSpPr txBox="1"/>
              <p:nvPr/>
            </p:nvSpPr>
            <p:spPr>
              <a:xfrm>
                <a:off x="2193825" y="2222304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7A9D4C7-82EF-8134-9B53-D7A237FB8074}"/>
                  </a:ext>
                </a:extLst>
              </p:cNvPr>
              <p:cNvSpPr txBox="1"/>
              <p:nvPr/>
            </p:nvSpPr>
            <p:spPr>
              <a:xfrm>
                <a:off x="8765684" y="2220752"/>
                <a:ext cx="5629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CNQ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B06DE440-C4FF-82E3-FA97-736ADC6DB08A}"/>
                  </a:ext>
                </a:extLst>
              </p:cNvPr>
              <p:cNvSpPr txBox="1"/>
              <p:nvPr/>
            </p:nvSpPr>
            <p:spPr>
              <a:xfrm>
                <a:off x="742100" y="2938301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mpol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D7979C3-380B-C0ED-1646-209BEE52E831}"/>
                  </a:ext>
                </a:extLst>
              </p:cNvPr>
              <p:cNvSpPr txBox="1"/>
              <p:nvPr/>
            </p:nvSpPr>
            <p:spPr>
              <a:xfrm>
                <a:off x="1290748" y="2051025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A144D92-D85C-7A40-9162-F2E6FE0569E2}"/>
                  </a:ext>
                </a:extLst>
              </p:cNvPr>
              <p:cNvSpPr txBox="1"/>
              <p:nvPr/>
            </p:nvSpPr>
            <p:spPr>
              <a:xfrm>
                <a:off x="3515887" y="2051025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459ACE9-0A8A-92F7-38F1-D1ED70B4008B}"/>
                  </a:ext>
                </a:extLst>
              </p:cNvPr>
              <p:cNvSpPr txBox="1"/>
              <p:nvPr/>
            </p:nvSpPr>
            <p:spPr>
              <a:xfrm>
                <a:off x="5584361" y="2051025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6F58A6D-D20D-02F5-610E-F3F104DB4683}"/>
                  </a:ext>
                </a:extLst>
              </p:cNvPr>
              <p:cNvSpPr txBox="1"/>
              <p:nvPr/>
            </p:nvSpPr>
            <p:spPr>
              <a:xfrm>
                <a:off x="7892451" y="2051025"/>
                <a:ext cx="27512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8291066C-85F1-6895-2DFB-5B67126985E6}"/>
                  </a:ext>
                </a:extLst>
              </p:cNvPr>
              <p:cNvSpPr txBox="1"/>
              <p:nvPr/>
            </p:nvSpPr>
            <p:spPr>
              <a:xfrm>
                <a:off x="4366479" y="2222304"/>
                <a:ext cx="78739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umbagin</a:t>
                </a:r>
              </a:p>
            </p:txBody>
          </p: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CC09EF40-E280-DFAF-8A49-25E71CD099A2}"/>
                  </a:ext>
                </a:extLst>
              </p:cNvPr>
              <p:cNvGrpSpPr/>
              <p:nvPr/>
            </p:nvGrpSpPr>
            <p:grpSpPr>
              <a:xfrm>
                <a:off x="9924532" y="2943983"/>
                <a:ext cx="1516403" cy="732743"/>
                <a:chOff x="10093219" y="827491"/>
                <a:chExt cx="1516403" cy="732743"/>
              </a:xfrm>
            </p:grpSpPr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370C81A0-72F2-552C-D3FC-D9E19B6A9DA0}"/>
                    </a:ext>
                  </a:extLst>
                </p:cNvPr>
                <p:cNvGrpSpPr/>
                <p:nvPr/>
              </p:nvGrpSpPr>
              <p:grpSpPr>
                <a:xfrm>
                  <a:off x="10312264" y="954310"/>
                  <a:ext cx="149713" cy="479802"/>
                  <a:chOff x="10312264" y="954310"/>
                  <a:chExt cx="149713" cy="479802"/>
                </a:xfrm>
              </p:grpSpPr>
              <p:cxnSp>
                <p:nvCxnSpPr>
                  <p:cNvPr id="331" name="Straight Connector 330">
                    <a:extLst>
                      <a:ext uri="{FF2B5EF4-FFF2-40B4-BE49-F238E27FC236}">
                        <a16:creationId xmlns:a16="http://schemas.microsoft.com/office/drawing/2014/main" id="{E6098646-B63F-46CB-E07B-1BF9251BAA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954310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2" name="Straight Connector 331">
                    <a:extLst>
                      <a:ext uri="{FF2B5EF4-FFF2-40B4-BE49-F238E27FC236}">
                        <a16:creationId xmlns:a16="http://schemas.microsoft.com/office/drawing/2014/main" id="{5E36A108-141C-6461-C4F7-E9930B9CA3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114244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009E47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3" name="Straight Connector 332">
                    <a:extLst>
                      <a:ext uri="{FF2B5EF4-FFF2-40B4-BE49-F238E27FC236}">
                        <a16:creationId xmlns:a16="http://schemas.microsoft.com/office/drawing/2014/main" id="{0A8C30BD-B2F9-5782-23BF-38805A475F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274178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048EEC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4" name="Straight Connector 333">
                    <a:extLst>
                      <a:ext uri="{FF2B5EF4-FFF2-40B4-BE49-F238E27FC236}">
                        <a16:creationId xmlns:a16="http://schemas.microsoft.com/office/drawing/2014/main" id="{C2BE883C-CE97-E383-42D1-95F1AA3114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312264" y="1434112"/>
                    <a:ext cx="149713" cy="0"/>
                  </a:xfrm>
                  <a:prstGeom prst="line">
                    <a:avLst/>
                  </a:prstGeom>
                  <a:ln w="28575">
                    <a:solidFill>
                      <a:srgbClr val="EE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0" name="Group 89">
                  <a:extLst>
                    <a:ext uri="{FF2B5EF4-FFF2-40B4-BE49-F238E27FC236}">
                      <a16:creationId xmlns:a16="http://schemas.microsoft.com/office/drawing/2014/main" id="{C6125298-7309-7EDB-A744-2C5019EFAF37}"/>
                    </a:ext>
                  </a:extLst>
                </p:cNvPr>
                <p:cNvGrpSpPr/>
                <p:nvPr/>
              </p:nvGrpSpPr>
              <p:grpSpPr>
                <a:xfrm>
                  <a:off x="10093219" y="827491"/>
                  <a:ext cx="290464" cy="732743"/>
                  <a:chOff x="10093219" y="827491"/>
                  <a:chExt cx="290464" cy="732743"/>
                </a:xfrm>
              </p:grpSpPr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BDFEF49C-B785-5020-24B6-B9CE082BE584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827491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</a:t>
                    </a:r>
                  </a:p>
                </p:txBody>
              </p:sp>
              <p:sp>
                <p:nvSpPr>
                  <p:cNvPr id="327" name="TextBox 326">
                    <a:extLst>
                      <a:ext uri="{FF2B5EF4-FFF2-40B4-BE49-F238E27FC236}">
                        <a16:creationId xmlns:a16="http://schemas.microsoft.com/office/drawing/2014/main" id="{7483A986-3592-F13B-1C0C-07F42ACC0B4B}"/>
                      </a:ext>
                    </a:extLst>
                  </p:cNvPr>
                  <p:cNvSpPr txBox="1"/>
                  <p:nvPr/>
                </p:nvSpPr>
                <p:spPr>
                  <a:xfrm>
                    <a:off x="10198952" y="946637"/>
                    <a:ext cx="18473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8" name="TextBox 327">
                    <a:extLst>
                      <a:ext uri="{FF2B5EF4-FFF2-40B4-BE49-F238E27FC236}">
                        <a16:creationId xmlns:a16="http://schemas.microsoft.com/office/drawing/2014/main" id="{696D7CFA-FEAB-AC33-32F8-1911A879D84F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1148486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</a:t>
                    </a:r>
                  </a:p>
                </p:txBody>
              </p:sp>
              <p:sp>
                <p:nvSpPr>
                  <p:cNvPr id="329" name="TextBox 328">
                    <a:extLst>
                      <a:ext uri="{FF2B5EF4-FFF2-40B4-BE49-F238E27FC236}">
                        <a16:creationId xmlns:a16="http://schemas.microsoft.com/office/drawing/2014/main" id="{0D7111A2-1376-2FD9-7F75-84388B623E20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1314013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</a:t>
                    </a:r>
                  </a:p>
                </p:txBody>
              </p:sp>
              <p:sp>
                <p:nvSpPr>
                  <p:cNvPr id="330" name="TextBox 329">
                    <a:extLst>
                      <a:ext uri="{FF2B5EF4-FFF2-40B4-BE49-F238E27FC236}">
                        <a16:creationId xmlns:a16="http://schemas.microsoft.com/office/drawing/2014/main" id="{994E99AA-A091-8CE4-E836-57EAF20CD45E}"/>
                      </a:ext>
                    </a:extLst>
                  </p:cNvPr>
                  <p:cNvSpPr txBox="1"/>
                  <p:nvPr/>
                </p:nvSpPr>
                <p:spPr>
                  <a:xfrm>
                    <a:off x="10093219" y="989584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</a:t>
                    </a:r>
                  </a:p>
                </p:txBody>
              </p:sp>
            </p:grp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929E95E2-11CA-E38F-D7AA-DB2FEC010B4F}"/>
                    </a:ext>
                  </a:extLst>
                </p:cNvPr>
                <p:cNvSpPr txBox="1"/>
                <p:nvPr/>
              </p:nvSpPr>
              <p:spPr>
                <a:xfrm>
                  <a:off x="10429491" y="829148"/>
                  <a:ext cx="4106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AE24C9FB-5924-9045-9700-91387E92E515}"/>
                    </a:ext>
                  </a:extLst>
                </p:cNvPr>
                <p:cNvSpPr txBox="1"/>
                <p:nvPr/>
              </p:nvSpPr>
              <p:spPr>
                <a:xfrm>
                  <a:off x="10429491" y="986418"/>
                  <a:ext cx="91242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Tempol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6E10C140-CC66-BCD2-062B-40BA6FFE81D3}"/>
                    </a:ext>
                  </a:extLst>
                </p:cNvPr>
                <p:cNvSpPr txBox="1"/>
                <p:nvPr/>
              </p:nvSpPr>
              <p:spPr>
                <a:xfrm>
                  <a:off x="10429491" y="1147066"/>
                  <a:ext cx="6783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NQ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90EB3409-6C8C-DEB6-64C7-6CF28B7B81C7}"/>
                    </a:ext>
                  </a:extLst>
                </p:cNvPr>
                <p:cNvSpPr txBox="1"/>
                <p:nvPr/>
              </p:nvSpPr>
              <p:spPr>
                <a:xfrm>
                  <a:off x="10429491" y="1307714"/>
                  <a:ext cx="11801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sz="10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+NQ+Tempol</a:t>
                  </a:r>
                </a:p>
              </p:txBody>
            </p:sp>
          </p:grpSp>
          <p:grpSp>
            <p:nvGrpSpPr>
              <p:cNvPr id="349" name="Group 348">
                <a:extLst>
                  <a:ext uri="{FF2B5EF4-FFF2-40B4-BE49-F238E27FC236}">
                    <a16:creationId xmlns:a16="http://schemas.microsoft.com/office/drawing/2014/main" id="{94FDB624-2B40-374F-502F-B15028FB444A}"/>
                  </a:ext>
                </a:extLst>
              </p:cNvPr>
              <p:cNvGrpSpPr/>
              <p:nvPr/>
            </p:nvGrpSpPr>
            <p:grpSpPr>
              <a:xfrm>
                <a:off x="7925134" y="1866611"/>
                <a:ext cx="2092325" cy="2249487"/>
                <a:chOff x="7925134" y="1866611"/>
                <a:chExt cx="2092325" cy="2249487"/>
              </a:xfrm>
            </p:grpSpPr>
            <p:graphicFrame>
              <p:nvGraphicFramePr>
                <p:cNvPr id="11" name="Object 10">
                  <a:extLst>
                    <a:ext uri="{FF2B5EF4-FFF2-40B4-BE49-F238E27FC236}">
                      <a16:creationId xmlns:a16="http://schemas.microsoft.com/office/drawing/2014/main" id="{BEAA25AC-1AC8-50C6-7C7B-2369EDFFFC02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7925134" y="1866611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2" imgW="2092371" imgH="2249446" progId="SigmaPlotGraphicObject.12">
                        <p:embed/>
                      </p:oleObj>
                    </mc:Choice>
                    <mc:Fallback>
                      <p:oleObj name="SPW 13.0 Graph" r:id="rId12" imgW="2092371" imgH="2249446" progId="SigmaPlotGraphicObject.12">
                        <p:embed/>
                        <p:pic>
                          <p:nvPicPr>
                            <p:cNvPr id="11" name="Object 10">
                              <a:extLst>
                                <a:ext uri="{FF2B5EF4-FFF2-40B4-BE49-F238E27FC236}">
                                  <a16:creationId xmlns:a16="http://schemas.microsoft.com/office/drawing/2014/main" id="{BEAA25AC-1AC8-50C6-7C7B-2369EDFFFC0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25134" y="1866611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26" name="Group 125">
                  <a:extLst>
                    <a:ext uri="{FF2B5EF4-FFF2-40B4-BE49-F238E27FC236}">
                      <a16:creationId xmlns:a16="http://schemas.microsoft.com/office/drawing/2014/main" id="{CA60F073-B792-9A38-A5E2-19D081594B71}"/>
                    </a:ext>
                  </a:extLst>
                </p:cNvPr>
                <p:cNvGrpSpPr/>
                <p:nvPr/>
              </p:nvGrpSpPr>
              <p:grpSpPr>
                <a:xfrm>
                  <a:off x="8378684" y="2626319"/>
                  <a:ext cx="791784" cy="692153"/>
                  <a:chOff x="8252185" y="2686000"/>
                  <a:chExt cx="791784" cy="692153"/>
                </a:xfrm>
              </p:grpSpPr>
              <p:sp>
                <p:nvSpPr>
                  <p:cNvPr id="127" name="TextBox 126">
                    <a:extLst>
                      <a:ext uri="{FF2B5EF4-FFF2-40B4-BE49-F238E27FC236}">
                        <a16:creationId xmlns:a16="http://schemas.microsoft.com/office/drawing/2014/main" id="{931F53A7-B434-A595-D56E-A3675616A0D6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128" name="Straight Arrow Connector 127">
                    <a:extLst>
                      <a:ext uri="{FF2B5EF4-FFF2-40B4-BE49-F238E27FC236}">
                        <a16:creationId xmlns:a16="http://schemas.microsoft.com/office/drawing/2014/main" id="{3C50443A-73B0-E7E4-87D8-43114235DEB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9" name="TextBox 128">
                    <a:extLst>
                      <a:ext uri="{FF2B5EF4-FFF2-40B4-BE49-F238E27FC236}">
                        <a16:creationId xmlns:a16="http://schemas.microsoft.com/office/drawing/2014/main" id="{8FC44439-3ACD-D2A5-FE9E-9E9AAEFF5498}"/>
                      </a:ext>
                    </a:extLst>
                  </p:cNvPr>
                  <p:cNvSpPr txBox="1"/>
                  <p:nvPr/>
                </p:nvSpPr>
                <p:spPr>
                  <a:xfrm>
                    <a:off x="8480994" y="3131932"/>
                    <a:ext cx="56297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CNQ</a:t>
                    </a:r>
                  </a:p>
                </p:txBody>
              </p:sp>
              <p:sp>
                <p:nvSpPr>
                  <p:cNvPr id="130" name="TextBox 129">
                    <a:extLst>
                      <a:ext uri="{FF2B5EF4-FFF2-40B4-BE49-F238E27FC236}">
                        <a16:creationId xmlns:a16="http://schemas.microsoft.com/office/drawing/2014/main" id="{CEAE2DAF-4450-13C9-C5CC-54B17C99FDEE}"/>
                      </a:ext>
                    </a:extLst>
                  </p:cNvPr>
                  <p:cNvSpPr txBox="1"/>
                  <p:nvPr/>
                </p:nvSpPr>
                <p:spPr>
                  <a:xfrm>
                    <a:off x="8376221" y="2963918"/>
                    <a:ext cx="44114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31" name="Straight Arrow Connector 130">
                    <a:extLst>
                      <a:ext uri="{FF2B5EF4-FFF2-40B4-BE49-F238E27FC236}">
                        <a16:creationId xmlns:a16="http://schemas.microsoft.com/office/drawing/2014/main" id="{95059036-990F-7203-CBF6-F306A4A5CD7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2" name="Straight Arrow Connector 131">
                    <a:extLst>
                      <a:ext uri="{FF2B5EF4-FFF2-40B4-BE49-F238E27FC236}">
                        <a16:creationId xmlns:a16="http://schemas.microsoft.com/office/drawing/2014/main" id="{A936AE11-035B-B43A-55A7-632A82260D6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35" name="TextBox 334">
                  <a:extLst>
                    <a:ext uri="{FF2B5EF4-FFF2-40B4-BE49-F238E27FC236}">
                      <a16:creationId xmlns:a16="http://schemas.microsoft.com/office/drawing/2014/main" id="{8E76DE9F-0F1B-D08A-71DA-3DFE2D894FCF}"/>
                    </a:ext>
                  </a:extLst>
                </p:cNvPr>
                <p:cNvSpPr txBox="1"/>
                <p:nvPr/>
              </p:nvSpPr>
              <p:spPr>
                <a:xfrm>
                  <a:off x="9725036" y="249132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336" name="TextBox 335">
                  <a:extLst>
                    <a:ext uri="{FF2B5EF4-FFF2-40B4-BE49-F238E27FC236}">
                      <a16:creationId xmlns:a16="http://schemas.microsoft.com/office/drawing/2014/main" id="{2F7166B8-5EA0-72A1-BA96-777C93D03969}"/>
                    </a:ext>
                  </a:extLst>
                </p:cNvPr>
                <p:cNvSpPr txBox="1"/>
                <p:nvPr/>
              </p:nvSpPr>
              <p:spPr>
                <a:xfrm>
                  <a:off x="9725036" y="284556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337" name="TextBox 336">
                  <a:extLst>
                    <a:ext uri="{FF2B5EF4-FFF2-40B4-BE49-F238E27FC236}">
                      <a16:creationId xmlns:a16="http://schemas.microsoft.com/office/drawing/2014/main" id="{0153A891-6527-494C-AC5C-D60FD69A1A07}"/>
                    </a:ext>
                  </a:extLst>
                </p:cNvPr>
                <p:cNvSpPr txBox="1"/>
                <p:nvPr/>
              </p:nvSpPr>
              <p:spPr>
                <a:xfrm>
                  <a:off x="9725036" y="2981906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338" name="TextBox 337">
                  <a:extLst>
                    <a:ext uri="{FF2B5EF4-FFF2-40B4-BE49-F238E27FC236}">
                      <a16:creationId xmlns:a16="http://schemas.microsoft.com/office/drawing/2014/main" id="{5AD9975B-7283-469A-82B7-8F5F71F5D78E}"/>
                    </a:ext>
                  </a:extLst>
                </p:cNvPr>
                <p:cNvSpPr txBox="1"/>
                <p:nvPr/>
              </p:nvSpPr>
              <p:spPr>
                <a:xfrm>
                  <a:off x="9725036" y="2639173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  <p:grpSp>
            <p:nvGrpSpPr>
              <p:cNvPr id="351" name="Group 350">
                <a:extLst>
                  <a:ext uri="{FF2B5EF4-FFF2-40B4-BE49-F238E27FC236}">
                    <a16:creationId xmlns:a16="http://schemas.microsoft.com/office/drawing/2014/main" id="{24F3C76B-4E94-058E-44E4-0AEF065320CD}"/>
                  </a:ext>
                </a:extLst>
              </p:cNvPr>
              <p:cNvGrpSpPr/>
              <p:nvPr/>
            </p:nvGrpSpPr>
            <p:grpSpPr>
              <a:xfrm>
                <a:off x="5743063" y="1922104"/>
                <a:ext cx="2107253" cy="2249487"/>
                <a:chOff x="5743063" y="1922104"/>
                <a:chExt cx="2107253" cy="2249487"/>
              </a:xfrm>
            </p:grpSpPr>
            <p:graphicFrame>
              <p:nvGraphicFramePr>
                <p:cNvPr id="48" name="Object 47">
                  <a:extLst>
                    <a:ext uri="{FF2B5EF4-FFF2-40B4-BE49-F238E27FC236}">
                      <a16:creationId xmlns:a16="http://schemas.microsoft.com/office/drawing/2014/main" id="{D367C60D-3F4D-F479-84C3-0FC052165BF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743063" y="1922104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4" imgW="2092371" imgH="2249446" progId="SigmaPlotGraphicObject.12">
                        <p:embed/>
                      </p:oleObj>
                    </mc:Choice>
                    <mc:Fallback>
                      <p:oleObj name="SPW 13.0 Graph" r:id="rId14" imgW="2092371" imgH="2249446" progId="SigmaPlotGraphicObject.12">
                        <p:embed/>
                        <p:pic>
                          <p:nvPicPr>
                            <p:cNvPr id="48" name="Object 47">
                              <a:extLst>
                                <a:ext uri="{FF2B5EF4-FFF2-40B4-BE49-F238E27FC236}">
                                  <a16:creationId xmlns:a16="http://schemas.microsoft.com/office/drawing/2014/main" id="{D367C60D-3F4D-F479-84C3-0FC052165BF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743063" y="1922104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58" name="Group 57">
                  <a:extLst>
                    <a:ext uri="{FF2B5EF4-FFF2-40B4-BE49-F238E27FC236}">
                      <a16:creationId xmlns:a16="http://schemas.microsoft.com/office/drawing/2014/main" id="{CE2C85C0-9F53-7FE3-3467-68A760AFAFC9}"/>
                    </a:ext>
                  </a:extLst>
                </p:cNvPr>
                <p:cNvGrpSpPr/>
                <p:nvPr/>
              </p:nvGrpSpPr>
              <p:grpSpPr>
                <a:xfrm>
                  <a:off x="6152822" y="2666584"/>
                  <a:ext cx="806211" cy="692153"/>
                  <a:chOff x="8252185" y="2686000"/>
                  <a:chExt cx="806211" cy="692153"/>
                </a:xfrm>
              </p:grpSpPr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E563CD73-0DD7-965A-5DF6-CDBF0E56A578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60" name="Straight Arrow Connector 59">
                    <a:extLst>
                      <a:ext uri="{FF2B5EF4-FFF2-40B4-BE49-F238E27FC236}">
                        <a16:creationId xmlns:a16="http://schemas.microsoft.com/office/drawing/2014/main" id="{185A59AB-7B44-B2A0-8D77-6A6937A9EC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FB5919BD-F998-6615-8D1C-B734574882D1}"/>
                      </a:ext>
                    </a:extLst>
                  </p:cNvPr>
                  <p:cNvSpPr txBox="1"/>
                  <p:nvPr/>
                </p:nvSpPr>
                <p:spPr>
                  <a:xfrm>
                    <a:off x="8480994" y="3131932"/>
                    <a:ext cx="57740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MNQ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36A02FC0-3C1F-A227-91F7-4556C9B5BE18}"/>
                      </a:ext>
                    </a:extLst>
                  </p:cNvPr>
                  <p:cNvSpPr txBox="1"/>
                  <p:nvPr/>
                </p:nvSpPr>
                <p:spPr>
                  <a:xfrm>
                    <a:off x="8376221" y="2963918"/>
                    <a:ext cx="44114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3" name="Straight Arrow Connector 62">
                    <a:extLst>
                      <a:ext uri="{FF2B5EF4-FFF2-40B4-BE49-F238E27FC236}">
                        <a16:creationId xmlns:a16="http://schemas.microsoft.com/office/drawing/2014/main" id="{A82B0163-8556-5E38-C0C3-CC81B442D2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Straight Arrow Connector 63">
                    <a:extLst>
                      <a:ext uri="{FF2B5EF4-FFF2-40B4-BE49-F238E27FC236}">
                        <a16:creationId xmlns:a16="http://schemas.microsoft.com/office/drawing/2014/main" id="{DED7ECD8-EA8E-1567-341F-8E1AA68883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50" name="Group 349">
                  <a:extLst>
                    <a:ext uri="{FF2B5EF4-FFF2-40B4-BE49-F238E27FC236}">
                      <a16:creationId xmlns:a16="http://schemas.microsoft.com/office/drawing/2014/main" id="{DB07424A-F78A-F54B-2D28-32BB74E8391D}"/>
                    </a:ext>
                  </a:extLst>
                </p:cNvPr>
                <p:cNvGrpSpPr/>
                <p:nvPr/>
              </p:nvGrpSpPr>
              <p:grpSpPr>
                <a:xfrm>
                  <a:off x="7559852" y="2643722"/>
                  <a:ext cx="290464" cy="672584"/>
                  <a:chOff x="7587373" y="2643722"/>
                  <a:chExt cx="290464" cy="672584"/>
                </a:xfrm>
              </p:grpSpPr>
              <p:sp>
                <p:nvSpPr>
                  <p:cNvPr id="345" name="TextBox 344">
                    <a:extLst>
                      <a:ext uri="{FF2B5EF4-FFF2-40B4-BE49-F238E27FC236}">
                        <a16:creationId xmlns:a16="http://schemas.microsoft.com/office/drawing/2014/main" id="{DC7A9943-C29E-AEBA-B6DC-2DE37623DE3E}"/>
                      </a:ext>
                    </a:extLst>
                  </p:cNvPr>
                  <p:cNvSpPr txBox="1"/>
                  <p:nvPr/>
                </p:nvSpPr>
                <p:spPr>
                  <a:xfrm>
                    <a:off x="7587373" y="2643722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</a:t>
                    </a:r>
                  </a:p>
                </p:txBody>
              </p:sp>
              <p:sp>
                <p:nvSpPr>
                  <p:cNvPr id="346" name="TextBox 345">
                    <a:extLst>
                      <a:ext uri="{FF2B5EF4-FFF2-40B4-BE49-F238E27FC236}">
                        <a16:creationId xmlns:a16="http://schemas.microsoft.com/office/drawing/2014/main" id="{8F68823F-2C60-8AD2-1C9A-2816C4132AE3}"/>
                      </a:ext>
                    </a:extLst>
                  </p:cNvPr>
                  <p:cNvSpPr txBox="1"/>
                  <p:nvPr/>
                </p:nvSpPr>
                <p:spPr>
                  <a:xfrm>
                    <a:off x="7587373" y="2826704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</a:t>
                    </a:r>
                  </a:p>
                </p:txBody>
              </p:sp>
              <p:sp>
                <p:nvSpPr>
                  <p:cNvPr id="347" name="TextBox 346">
                    <a:extLst>
                      <a:ext uri="{FF2B5EF4-FFF2-40B4-BE49-F238E27FC236}">
                        <a16:creationId xmlns:a16="http://schemas.microsoft.com/office/drawing/2014/main" id="{2EEF57AC-C26D-85AA-9D29-D8E8A9F1B1DB}"/>
                      </a:ext>
                    </a:extLst>
                  </p:cNvPr>
                  <p:cNvSpPr txBox="1"/>
                  <p:nvPr/>
                </p:nvSpPr>
                <p:spPr>
                  <a:xfrm>
                    <a:off x="7587373" y="3070085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</a:t>
                    </a:r>
                  </a:p>
                </p:txBody>
              </p:sp>
              <p:sp>
                <p:nvSpPr>
                  <p:cNvPr id="348" name="TextBox 347">
                    <a:extLst>
                      <a:ext uri="{FF2B5EF4-FFF2-40B4-BE49-F238E27FC236}">
                        <a16:creationId xmlns:a16="http://schemas.microsoft.com/office/drawing/2014/main" id="{15BF9EA4-BFE0-62C1-CA76-60B8EE691E31}"/>
                      </a:ext>
                    </a:extLst>
                  </p:cNvPr>
                  <p:cNvSpPr txBox="1"/>
                  <p:nvPr/>
                </p:nvSpPr>
                <p:spPr>
                  <a:xfrm>
                    <a:off x="7587373" y="2932248"/>
                    <a:ext cx="29046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</a:t>
                    </a:r>
                  </a:p>
                </p:txBody>
              </p:sp>
            </p:grpSp>
          </p:grpSp>
          <p:grpSp>
            <p:nvGrpSpPr>
              <p:cNvPr id="100" name="Group 99">
                <a:extLst>
                  <a:ext uri="{FF2B5EF4-FFF2-40B4-BE49-F238E27FC236}">
                    <a16:creationId xmlns:a16="http://schemas.microsoft.com/office/drawing/2014/main" id="{2F6F80C0-D0FD-4D5F-04B9-10BB14686CA4}"/>
                  </a:ext>
                </a:extLst>
              </p:cNvPr>
              <p:cNvGrpSpPr/>
              <p:nvPr/>
            </p:nvGrpSpPr>
            <p:grpSpPr>
              <a:xfrm>
                <a:off x="3955894" y="2643722"/>
                <a:ext cx="1685875" cy="726737"/>
                <a:chOff x="3955894" y="2643722"/>
                <a:chExt cx="1685875" cy="726737"/>
              </a:xfrm>
            </p:grpSpPr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D435DB42-E5B4-A2E1-7DBD-0C3CA5B8C8F8}"/>
                    </a:ext>
                  </a:extLst>
                </p:cNvPr>
                <p:cNvGrpSpPr/>
                <p:nvPr/>
              </p:nvGrpSpPr>
              <p:grpSpPr>
                <a:xfrm>
                  <a:off x="3955894" y="2652197"/>
                  <a:ext cx="685273" cy="692153"/>
                  <a:chOff x="8252185" y="2686000"/>
                  <a:chExt cx="685273" cy="692153"/>
                </a:xfrm>
              </p:grpSpPr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EE20345D-E83A-F0EB-F708-B20C1F585401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53" name="Straight Arrow Connector 52">
                    <a:extLst>
                      <a:ext uri="{FF2B5EF4-FFF2-40B4-BE49-F238E27FC236}">
                        <a16:creationId xmlns:a16="http://schemas.microsoft.com/office/drawing/2014/main" id="{49714411-40EE-ECAF-C5A2-81EA8673B08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54FE8551-FB93-ED33-86DA-1640E652D008}"/>
                      </a:ext>
                    </a:extLst>
                  </p:cNvPr>
                  <p:cNvSpPr txBox="1"/>
                  <p:nvPr/>
                </p:nvSpPr>
                <p:spPr>
                  <a:xfrm>
                    <a:off x="8582874" y="3131932"/>
                    <a:ext cx="35458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65341F98-994E-1365-1C49-7D5EDB425B62}"/>
                      </a:ext>
                    </a:extLst>
                  </p:cNvPr>
                  <p:cNvSpPr txBox="1"/>
                  <p:nvPr/>
                </p:nvSpPr>
                <p:spPr>
                  <a:xfrm>
                    <a:off x="8376221" y="2963918"/>
                    <a:ext cx="44114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6" name="Straight Arrow Connector 55">
                    <a:extLst>
                      <a:ext uri="{FF2B5EF4-FFF2-40B4-BE49-F238E27FC236}">
                        <a16:creationId xmlns:a16="http://schemas.microsoft.com/office/drawing/2014/main" id="{D0CD8509-64EF-2D29-45FA-7592957DE1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Straight Arrow Connector 56">
                    <a:extLst>
                      <a:ext uri="{FF2B5EF4-FFF2-40B4-BE49-F238E27FC236}">
                        <a16:creationId xmlns:a16="http://schemas.microsoft.com/office/drawing/2014/main" id="{217B7A56-7FF1-54C0-8094-B3D6423D4B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F251F343-57C4-31CC-AFD9-393E96350A64}"/>
                    </a:ext>
                  </a:extLst>
                </p:cNvPr>
                <p:cNvSpPr txBox="1"/>
                <p:nvPr/>
              </p:nvSpPr>
              <p:spPr>
                <a:xfrm>
                  <a:off x="5351305" y="264372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156A4F59-D463-2701-7647-CD6A40F01E32}"/>
                    </a:ext>
                  </a:extLst>
                </p:cNvPr>
                <p:cNvSpPr txBox="1"/>
                <p:nvPr/>
              </p:nvSpPr>
              <p:spPr>
                <a:xfrm>
                  <a:off x="5348247" y="2860340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8CA166BA-F699-A8D3-022D-1E9F77ADEADD}"/>
                    </a:ext>
                  </a:extLst>
                </p:cNvPr>
                <p:cNvSpPr txBox="1"/>
                <p:nvPr/>
              </p:nvSpPr>
              <p:spPr>
                <a:xfrm>
                  <a:off x="5348076" y="3124238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270B84E4-544E-D413-314A-3F331B06133F}"/>
                    </a:ext>
                  </a:extLst>
                </p:cNvPr>
                <p:cNvSpPr txBox="1"/>
                <p:nvPr/>
              </p:nvSpPr>
              <p:spPr>
                <a:xfrm>
                  <a:off x="5351305" y="2987297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  <p:grpSp>
            <p:nvGrpSpPr>
              <p:cNvPr id="177" name="Group 176">
                <a:extLst>
                  <a:ext uri="{FF2B5EF4-FFF2-40B4-BE49-F238E27FC236}">
                    <a16:creationId xmlns:a16="http://schemas.microsoft.com/office/drawing/2014/main" id="{73AB9D85-E6C1-18C3-21A0-FC5A2F47E144}"/>
                  </a:ext>
                </a:extLst>
              </p:cNvPr>
              <p:cNvGrpSpPr/>
              <p:nvPr/>
            </p:nvGrpSpPr>
            <p:grpSpPr>
              <a:xfrm>
                <a:off x="1356476" y="1917606"/>
                <a:ext cx="2092325" cy="2249487"/>
                <a:chOff x="1356476" y="1917606"/>
                <a:chExt cx="2092325" cy="2249487"/>
              </a:xfrm>
            </p:grpSpPr>
            <p:graphicFrame>
              <p:nvGraphicFramePr>
                <p:cNvPr id="24" name="Object 23">
                  <a:extLst>
                    <a:ext uri="{FF2B5EF4-FFF2-40B4-BE49-F238E27FC236}">
                      <a16:creationId xmlns:a16="http://schemas.microsoft.com/office/drawing/2014/main" id="{52038157-33B7-A032-B7A9-76E39819BC92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1356476" y="1917606"/>
                <a:ext cx="2092325" cy="22494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SPW 13.0 Graph" r:id="rId16" imgW="2092371" imgH="2249446" progId="SigmaPlotGraphicObject.12">
                        <p:embed/>
                      </p:oleObj>
                    </mc:Choice>
                    <mc:Fallback>
                      <p:oleObj name="SPW 13.0 Graph" r:id="rId16" imgW="2092371" imgH="2249446" progId="SigmaPlotGraphicObject.12">
                        <p:embed/>
                        <p:pic>
                          <p:nvPicPr>
                            <p:cNvPr id="24" name="Object 23">
                              <a:extLst>
                                <a:ext uri="{FF2B5EF4-FFF2-40B4-BE49-F238E27FC236}">
                                  <a16:creationId xmlns:a16="http://schemas.microsoft.com/office/drawing/2014/main" id="{52038157-33B7-A032-B7A9-76E39819BC9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56476" y="1917606"/>
                              <a:ext cx="2092325" cy="22494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5A7F5FD8-36FE-19C2-3D5C-794D81ADF8AB}"/>
                    </a:ext>
                  </a:extLst>
                </p:cNvPr>
                <p:cNvGrpSpPr/>
                <p:nvPr/>
              </p:nvGrpSpPr>
              <p:grpSpPr>
                <a:xfrm>
                  <a:off x="1804033" y="2612722"/>
                  <a:ext cx="810542" cy="709547"/>
                  <a:chOff x="8252185" y="2686000"/>
                  <a:chExt cx="810542" cy="709547"/>
                </a:xfrm>
              </p:grpSpPr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4CDA54EA-49F0-2B97-CB67-69017F6684BC}"/>
                      </a:ext>
                    </a:extLst>
                  </p:cNvPr>
                  <p:cNvSpPr txBox="1"/>
                  <p:nvPr/>
                </p:nvSpPr>
                <p:spPr>
                  <a:xfrm>
                    <a:off x="8252185" y="2828298"/>
                    <a:ext cx="4106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</a:p>
                </p:txBody>
              </p:sp>
              <p:cxnSp>
                <p:nvCxnSpPr>
                  <p:cNvPr id="42" name="Straight Arrow Connector 41">
                    <a:extLst>
                      <a:ext uri="{FF2B5EF4-FFF2-40B4-BE49-F238E27FC236}">
                        <a16:creationId xmlns:a16="http://schemas.microsoft.com/office/drawing/2014/main" id="{B38A44FA-9785-4422-1EBC-75A9987A17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523320" y="2686000"/>
                    <a:ext cx="0" cy="195399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31862ECE-DF01-D97D-A04D-E87566ED5857}"/>
                      </a:ext>
                    </a:extLst>
                  </p:cNvPr>
                  <p:cNvSpPr txBox="1"/>
                  <p:nvPr/>
                </p:nvSpPr>
                <p:spPr>
                  <a:xfrm>
                    <a:off x="8466089" y="3149326"/>
                    <a:ext cx="59663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,4-NQ</a:t>
                    </a: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16766A3F-3051-3D89-0B41-D0D89AF094E7}"/>
                      </a:ext>
                    </a:extLst>
                  </p:cNvPr>
                  <p:cNvSpPr txBox="1"/>
                  <p:nvPr/>
                </p:nvSpPr>
                <p:spPr>
                  <a:xfrm>
                    <a:off x="8383676" y="2981312"/>
                    <a:ext cx="44114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45" name="Straight Arrow Connector 44">
                    <a:extLst>
                      <a:ext uri="{FF2B5EF4-FFF2-40B4-BE49-F238E27FC236}">
                        <a16:creationId xmlns:a16="http://schemas.microsoft.com/office/drawing/2014/main" id="{6DA02ED7-25AE-7407-93B8-32B785701AC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632129" y="2709461"/>
                    <a:ext cx="0" cy="2966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Arrow Connector 45">
                    <a:extLst>
                      <a:ext uri="{FF2B5EF4-FFF2-40B4-BE49-F238E27FC236}">
                        <a16:creationId xmlns:a16="http://schemas.microsoft.com/office/drawing/2014/main" id="{9FE2A430-DE0D-0BE3-EB0D-0D49C06D1CD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67415" y="2742060"/>
                    <a:ext cx="0" cy="424111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07AF1435-97F4-0629-EC2E-F78DB8D640AD}"/>
                    </a:ext>
                  </a:extLst>
                </p:cNvPr>
                <p:cNvSpPr txBox="1"/>
                <p:nvPr/>
              </p:nvSpPr>
              <p:spPr>
                <a:xfrm>
                  <a:off x="3152453" y="2530571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</a:t>
                  </a:r>
                </a:p>
              </p:txBody>
            </p: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B73C1997-4880-6570-128A-8CF85150BF78}"/>
                    </a:ext>
                  </a:extLst>
                </p:cNvPr>
                <p:cNvSpPr txBox="1"/>
                <p:nvPr/>
              </p:nvSpPr>
              <p:spPr>
                <a:xfrm>
                  <a:off x="3152453" y="2884811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2C972FC5-20A4-1DB9-2BF5-893FC811C4DA}"/>
                    </a:ext>
                  </a:extLst>
                </p:cNvPr>
                <p:cNvSpPr txBox="1"/>
                <p:nvPr/>
              </p:nvSpPr>
              <p:spPr>
                <a:xfrm>
                  <a:off x="3152453" y="3021155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59CF287C-C80B-5A95-233A-71BE7250D88E}"/>
                    </a:ext>
                  </a:extLst>
                </p:cNvPr>
                <p:cNvSpPr txBox="1"/>
                <p:nvPr/>
              </p:nvSpPr>
              <p:spPr>
                <a:xfrm>
                  <a:off x="3152453" y="2678422"/>
                  <a:ext cx="2904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4771875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6F1F6CDC-3737-9FCF-8CD4-17A62C1BA1AC}"/>
              </a:ext>
            </a:extLst>
          </p:cNvPr>
          <p:cNvGrpSpPr/>
          <p:nvPr/>
        </p:nvGrpSpPr>
        <p:grpSpPr>
          <a:xfrm>
            <a:off x="157200" y="989404"/>
            <a:ext cx="12034800" cy="4428907"/>
            <a:chOff x="84358" y="931652"/>
            <a:chExt cx="12034800" cy="4428907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8D112976-4FEF-2E83-E0B3-1902787B8A9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421365" y="934278"/>
            <a:ext cx="27797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" imgW="2779607" imgH="2282918" progId="SigmaPlotGraphicObject.12">
                    <p:embed/>
                  </p:oleObj>
                </mc:Choice>
                <mc:Fallback>
                  <p:oleObj name="SPW 13.0 Graph" r:id="rId2" imgW="2779607" imgH="2282918" progId="SigmaPlotGraphicObject.12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8D112976-4FEF-2E83-E0B3-1902787B8A9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421365" y="934278"/>
                          <a:ext cx="27797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0A8B3CEF-873C-3329-B0CB-9AEAB85C871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837196" y="934278"/>
            <a:ext cx="27797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4" imgW="2779607" imgH="2282918" progId="SigmaPlotGraphicObject.12">
                    <p:embed/>
                  </p:oleObj>
                </mc:Choice>
                <mc:Fallback>
                  <p:oleObj name="SPW 13.0 Graph" r:id="rId4" imgW="2779607" imgH="2282918" progId="SigmaPlotGraphicObject.12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0A8B3CEF-873C-3329-B0CB-9AEAB85C871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837196" y="934278"/>
                          <a:ext cx="27797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C9CFEB2-0D12-F4EE-C216-68A6780F72A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029638" y="934278"/>
            <a:ext cx="27797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6" imgW="2779607" imgH="2282918" progId="SigmaPlotGraphicObject.12">
                    <p:embed/>
                  </p:oleObj>
                </mc:Choice>
                <mc:Fallback>
                  <p:oleObj name="SPW 13.0 Graph" r:id="rId6" imgW="2779607" imgH="2282918" progId="SigmaPlotGraphicObject.12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5C9CFEB2-0D12-F4EE-C216-68A6780F72A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029638" y="934278"/>
                          <a:ext cx="27797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52AE366-4812-85BC-60CE-D20070498011}"/>
                </a:ext>
              </a:extLst>
            </p:cNvPr>
            <p:cNvSpPr txBox="1"/>
            <p:nvPr/>
          </p:nvSpPr>
          <p:spPr>
            <a:xfrm>
              <a:off x="743241" y="1182807"/>
              <a:ext cx="119501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,4-NQ (0.3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9BBD120-D61C-CAEA-1E17-C75BF36DC978}"/>
                </a:ext>
              </a:extLst>
            </p:cNvPr>
            <p:cNvSpPr txBox="1"/>
            <p:nvPr/>
          </p:nvSpPr>
          <p:spPr>
            <a:xfrm>
              <a:off x="3339730" y="1182807"/>
              <a:ext cx="119501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Juglone (0.3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80768FE-D274-5E8B-5CEC-CD1F3FDF4700}"/>
                </a:ext>
              </a:extLst>
            </p:cNvPr>
            <p:cNvSpPr txBox="1"/>
            <p:nvPr/>
          </p:nvSpPr>
          <p:spPr>
            <a:xfrm>
              <a:off x="5912874" y="1182807"/>
              <a:ext cx="119501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lumbagin (3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85489DE-20A0-C133-7575-9AB7CE97EB21}"/>
                </a:ext>
              </a:extLst>
            </p:cNvPr>
            <p:cNvSpPr txBox="1"/>
            <p:nvPr/>
          </p:nvSpPr>
          <p:spPr>
            <a:xfrm>
              <a:off x="8448239" y="1182807"/>
              <a:ext cx="136323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enadione (1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87874723-E1EF-85D4-903A-768B6CDC0B1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839236" y="3077734"/>
            <a:ext cx="27797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8" imgW="2781144" imgH="2286208" progId="SigmaPlotGraphicObject.12">
                    <p:embed/>
                  </p:oleObj>
                </mc:Choice>
                <mc:Fallback>
                  <p:oleObj name="SPW 13.0 Graph" r:id="rId8" imgW="2781144" imgH="2286208" progId="SigmaPlotGraphicObject.12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87874723-E1EF-85D4-903A-768B6CDC0B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839236" y="3077734"/>
                          <a:ext cx="27797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29BBA950-1CF6-6291-FF8D-3C853CB055E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433350" y="3077734"/>
            <a:ext cx="27797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0" imgW="2779607" imgH="2282918" progId="SigmaPlotGraphicObject.12">
                    <p:embed/>
                  </p:oleObj>
                </mc:Choice>
                <mc:Fallback>
                  <p:oleObj name="SPW 13.0 Graph" r:id="rId10" imgW="2779607" imgH="2282918" progId="SigmaPlotGraphicObject.12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29BBA950-1CF6-6291-FF8D-3C853CB055E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433350" y="3077734"/>
                          <a:ext cx="27797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7B0279F-A780-358B-36F7-3F0CCA40EEFF}"/>
                </a:ext>
              </a:extLst>
            </p:cNvPr>
            <p:cNvSpPr txBox="1"/>
            <p:nvPr/>
          </p:nvSpPr>
          <p:spPr>
            <a:xfrm>
              <a:off x="811240" y="3301539"/>
              <a:ext cx="104171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-MNQ (1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1517517-04A7-C0F7-2CD8-E1437FC18CAE}"/>
                </a:ext>
              </a:extLst>
            </p:cNvPr>
            <p:cNvSpPr txBox="1"/>
            <p:nvPr/>
          </p:nvSpPr>
          <p:spPr>
            <a:xfrm>
              <a:off x="3398435" y="3301539"/>
              <a:ext cx="98595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NQ (1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8CFCAEF-6939-3044-5210-118552A2AECE}"/>
                </a:ext>
              </a:extLst>
            </p:cNvPr>
            <p:cNvSpPr txBox="1"/>
            <p:nvPr/>
          </p:nvSpPr>
          <p:spPr>
            <a:xfrm>
              <a:off x="5926979" y="3301539"/>
              <a:ext cx="109560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CNQ (0.3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B3944C4A-9993-4C19-B7C1-E774FE0E57D1}"/>
                </a:ext>
              </a:extLst>
            </p:cNvPr>
            <p:cNvGrpSpPr/>
            <p:nvPr/>
          </p:nvGrpSpPr>
          <p:grpSpPr>
            <a:xfrm>
              <a:off x="11343762" y="4012773"/>
              <a:ext cx="775396" cy="962025"/>
              <a:chOff x="5959661" y="5528236"/>
              <a:chExt cx="775396" cy="962025"/>
            </a:xfrm>
          </p:grpSpPr>
          <p:graphicFrame>
            <p:nvGraphicFramePr>
              <p:cNvPr id="30" name="Object 29">
                <a:extLst>
                  <a:ext uri="{FF2B5EF4-FFF2-40B4-BE49-F238E27FC236}">
                    <a16:creationId xmlns:a16="http://schemas.microsoft.com/office/drawing/2014/main" id="{B7A8168D-D482-6A5D-AC71-7DC115A61E54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959661" y="5528236"/>
              <a:ext cx="468313" cy="9620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2" imgW="467897" imgH="961683" progId="SigmaPlotGraphicObject.12">
                      <p:embed/>
                    </p:oleObj>
                  </mc:Choice>
                  <mc:Fallback>
                    <p:oleObj name="SPW 13.0 Graph" r:id="rId12" imgW="467897" imgH="961683" progId="SigmaPlotGraphicObject.12">
                      <p:embed/>
                      <p:pic>
                        <p:nvPicPr>
                          <p:cNvPr id="30" name="Object 29">
                            <a:extLst>
                              <a:ext uri="{FF2B5EF4-FFF2-40B4-BE49-F238E27FC236}">
                                <a16:creationId xmlns:a16="http://schemas.microsoft.com/office/drawing/2014/main" id="{B7A8168D-D482-6A5D-AC71-7DC115A61E5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5959661" y="5528236"/>
                            <a:ext cx="468313" cy="9620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2B1D558-03A6-BFA9-5B56-B404C4644AB4}"/>
                  </a:ext>
                </a:extLst>
              </p:cNvPr>
              <p:cNvSpPr txBox="1"/>
              <p:nvPr/>
            </p:nvSpPr>
            <p:spPr>
              <a:xfrm>
                <a:off x="6111887" y="6002483"/>
                <a:ext cx="62317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-MNQ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A599E8BB-5BE7-8138-B795-A5D3F3D423B5}"/>
                  </a:ext>
                </a:extLst>
              </p:cNvPr>
              <p:cNvSpPr txBox="1"/>
              <p:nvPr/>
            </p:nvSpPr>
            <p:spPr>
              <a:xfrm>
                <a:off x="6111887" y="5569615"/>
                <a:ext cx="62317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66E4434-97F4-FB18-4BCD-8FAFD9128300}"/>
                  </a:ext>
                </a:extLst>
              </p:cNvPr>
              <p:cNvSpPr txBox="1"/>
              <p:nvPr/>
            </p:nvSpPr>
            <p:spPr>
              <a:xfrm>
                <a:off x="6111887" y="5677832"/>
                <a:ext cx="62317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Jug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83AEF8B-B9F8-500F-C431-AC6C4B6911B6}"/>
                  </a:ext>
                </a:extLst>
              </p:cNvPr>
              <p:cNvSpPr txBox="1"/>
              <p:nvPr/>
            </p:nvSpPr>
            <p:spPr>
              <a:xfrm>
                <a:off x="6111887" y="5786049"/>
                <a:ext cx="4041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46E382F9-23C7-7DB3-D162-FB2E9CD66135}"/>
                  </a:ext>
                </a:extLst>
              </p:cNvPr>
              <p:cNvSpPr txBox="1"/>
              <p:nvPr/>
            </p:nvSpPr>
            <p:spPr>
              <a:xfrm>
                <a:off x="6111887" y="5894266"/>
                <a:ext cx="543769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ena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A5DC5BD-211D-2274-B40D-F7B7D143CB0D}"/>
                  </a:ext>
                </a:extLst>
              </p:cNvPr>
              <p:cNvSpPr txBox="1"/>
              <p:nvPr/>
            </p:nvSpPr>
            <p:spPr>
              <a:xfrm>
                <a:off x="6111887" y="6110700"/>
                <a:ext cx="59115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MNQ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ED58529-D97C-1D28-F859-559FBA3D2BA8}"/>
                  </a:ext>
                </a:extLst>
              </p:cNvPr>
              <p:cNvSpPr txBox="1"/>
              <p:nvPr/>
            </p:nvSpPr>
            <p:spPr>
              <a:xfrm>
                <a:off x="6111887" y="6218915"/>
                <a:ext cx="59115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CNQ</a:t>
                </a:r>
              </a:p>
            </p:txBody>
          </p: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C84683A-EA4F-E1C9-8A00-9C60705BD9BE}"/>
                </a:ext>
              </a:extLst>
            </p:cNvPr>
            <p:cNvSpPr txBox="1"/>
            <p:nvPr/>
          </p:nvSpPr>
          <p:spPr>
            <a:xfrm>
              <a:off x="8827027" y="3310676"/>
              <a:ext cx="59115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0 min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393197B-3FD9-5472-A97E-A93991B474C3}"/>
                </a:ext>
              </a:extLst>
            </p:cNvPr>
            <p:cNvSpPr txBox="1"/>
            <p:nvPr/>
          </p:nvSpPr>
          <p:spPr>
            <a:xfrm>
              <a:off x="10492761" y="3303258"/>
              <a:ext cx="66979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0 mi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20037DB-06F7-59F6-DF92-60F88AFC916C}"/>
                </a:ext>
              </a:extLst>
            </p:cNvPr>
            <p:cNvSpPr txBox="1"/>
            <p:nvPr/>
          </p:nvSpPr>
          <p:spPr>
            <a:xfrm>
              <a:off x="222134" y="1043928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817A74E-180D-4BE4-9D74-61EAAF09D532}"/>
                </a:ext>
              </a:extLst>
            </p:cNvPr>
            <p:cNvSpPr txBox="1"/>
            <p:nvPr/>
          </p:nvSpPr>
          <p:spPr>
            <a:xfrm>
              <a:off x="2848251" y="1043928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2D01BC5-7D60-FFA6-6AB8-6ABFD7083D1D}"/>
                </a:ext>
              </a:extLst>
            </p:cNvPr>
            <p:cNvSpPr txBox="1"/>
            <p:nvPr/>
          </p:nvSpPr>
          <p:spPr>
            <a:xfrm>
              <a:off x="5421122" y="1043928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2BBFE8E-8557-798B-07E2-44B10E3A43A4}"/>
                </a:ext>
              </a:extLst>
            </p:cNvPr>
            <p:cNvSpPr txBox="1"/>
            <p:nvPr/>
          </p:nvSpPr>
          <p:spPr>
            <a:xfrm>
              <a:off x="8010294" y="1043928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D3F53F7-E7BE-CB9E-B285-ABB5D54989C8}"/>
                </a:ext>
              </a:extLst>
            </p:cNvPr>
            <p:cNvSpPr txBox="1"/>
            <p:nvPr/>
          </p:nvSpPr>
          <p:spPr>
            <a:xfrm>
              <a:off x="204205" y="3186489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20C7655-51C4-6782-E478-48B2F4929634}"/>
                </a:ext>
              </a:extLst>
            </p:cNvPr>
            <p:cNvSpPr txBox="1"/>
            <p:nvPr/>
          </p:nvSpPr>
          <p:spPr>
            <a:xfrm>
              <a:off x="2866181" y="3186489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A7B0178-B7A2-8435-1984-372F73941CEF}"/>
                </a:ext>
              </a:extLst>
            </p:cNvPr>
            <p:cNvSpPr txBox="1"/>
            <p:nvPr/>
          </p:nvSpPr>
          <p:spPr>
            <a:xfrm>
              <a:off x="5448017" y="3186489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DAB0777-34FA-8CF5-A5F5-87A5164674EE}"/>
                </a:ext>
              </a:extLst>
            </p:cNvPr>
            <p:cNvSpPr txBox="1"/>
            <p:nvPr/>
          </p:nvSpPr>
          <p:spPr>
            <a:xfrm>
              <a:off x="8028223" y="3186489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CE823F7-5B9C-D773-2B42-EA1C29D09E3B}"/>
                </a:ext>
              </a:extLst>
            </p:cNvPr>
            <p:cNvSpPr txBox="1"/>
            <p:nvPr/>
          </p:nvSpPr>
          <p:spPr>
            <a:xfrm>
              <a:off x="9713588" y="3186489"/>
              <a:ext cx="26413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graphicFrame>
          <p:nvGraphicFramePr>
            <p:cNvPr id="58" name="Object 57">
              <a:extLst>
                <a:ext uri="{FF2B5EF4-FFF2-40B4-BE49-F238E27FC236}">
                  <a16:creationId xmlns:a16="http://schemas.microsoft.com/office/drawing/2014/main" id="{90F5D97D-DDF5-60F7-AE51-0E9EE232BCD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765272" y="3090931"/>
            <a:ext cx="1889125" cy="2093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4" imgW="1889627" imgH="2093965" progId="SigmaPlotGraphicObject.12">
                    <p:embed/>
                  </p:oleObj>
                </mc:Choice>
                <mc:Fallback>
                  <p:oleObj name="SPW 13.0 Graph" r:id="rId14" imgW="1889627" imgH="2093965" progId="SigmaPlotGraphicObject.12">
                    <p:embed/>
                    <p:pic>
                      <p:nvPicPr>
                        <p:cNvPr id="58" name="Object 57">
                          <a:extLst>
                            <a:ext uri="{FF2B5EF4-FFF2-40B4-BE49-F238E27FC236}">
                              <a16:creationId xmlns:a16="http://schemas.microsoft.com/office/drawing/2014/main" id="{90F5D97D-DDF5-60F7-AE51-0E9EE232BCD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9765272" y="3090931"/>
                          <a:ext cx="1889125" cy="2093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0" name="Object 59">
              <a:extLst>
                <a:ext uri="{FF2B5EF4-FFF2-40B4-BE49-F238E27FC236}">
                  <a16:creationId xmlns:a16="http://schemas.microsoft.com/office/drawing/2014/main" id="{24449337-C674-1A1C-C033-C048472C671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110818" y="3090739"/>
            <a:ext cx="1863725" cy="2093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6" imgW="1864014" imgH="2093965" progId="SigmaPlotGraphicObject.12">
                    <p:embed/>
                  </p:oleObj>
                </mc:Choice>
                <mc:Fallback>
                  <p:oleObj name="SPW 13.0 Graph" r:id="rId16" imgW="1864014" imgH="2093965" progId="SigmaPlotGraphicObject.12">
                    <p:embed/>
                    <p:pic>
                      <p:nvPicPr>
                        <p:cNvPr id="60" name="Object 59">
                          <a:extLst>
                            <a:ext uri="{FF2B5EF4-FFF2-40B4-BE49-F238E27FC236}">
                              <a16:creationId xmlns:a16="http://schemas.microsoft.com/office/drawing/2014/main" id="{24449337-C674-1A1C-C033-C048472C67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8110818" y="3090739"/>
                          <a:ext cx="1863725" cy="2093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bject 20">
              <a:extLst>
                <a:ext uri="{FF2B5EF4-FFF2-40B4-BE49-F238E27FC236}">
                  <a16:creationId xmlns:a16="http://schemas.microsoft.com/office/drawing/2014/main" id="{53D4A8B8-DCCD-E69F-6035-DC9FEBA2FD8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4358" y="931652"/>
            <a:ext cx="2917825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18" imgW="2918497" imgH="2282918" progId="SigmaPlotGraphicObject.12">
                    <p:embed/>
                  </p:oleObj>
                </mc:Choice>
                <mc:Fallback>
                  <p:oleObj name="SPW 13.0 Graph" r:id="rId18" imgW="2918497" imgH="2282918" progId="SigmaPlotGraphicObject.12">
                    <p:embed/>
                    <p:pic>
                      <p:nvPicPr>
                        <p:cNvPr id="21" name="Object 20">
                          <a:extLst>
                            <a:ext uri="{FF2B5EF4-FFF2-40B4-BE49-F238E27FC236}">
                              <a16:creationId xmlns:a16="http://schemas.microsoft.com/office/drawing/2014/main" id="{53D4A8B8-DCCD-E69F-6035-DC9FEBA2FD8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84358" y="931652"/>
                          <a:ext cx="2917825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F9A50DE1-7425-27C5-2645-554B5E9DB48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4730" y="3077517"/>
            <a:ext cx="294481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3.0 Graph" r:id="rId20" imgW="2944471" imgH="2282918" progId="SigmaPlotGraphicObject.12">
                    <p:embed/>
                  </p:oleObj>
                </mc:Choice>
                <mc:Fallback>
                  <p:oleObj name="SPW 13.0 Graph" r:id="rId20" imgW="2944471" imgH="2282918" progId="SigmaPlotGraphicObject.12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F9A50DE1-7425-27C5-2645-554B5E9DB48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84730" y="3077517"/>
                          <a:ext cx="294481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0DB10F6-E1FB-BEC4-6C94-31B11C8F628D}"/>
              </a:ext>
            </a:extLst>
          </p:cNvPr>
          <p:cNvSpPr txBox="1"/>
          <p:nvPr/>
        </p:nvSpPr>
        <p:spPr>
          <a:xfrm>
            <a:off x="235085" y="241960"/>
            <a:ext cx="216906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8</a:t>
            </a:r>
          </a:p>
        </p:txBody>
      </p:sp>
    </p:spTree>
    <p:extLst>
      <p:ext uri="{BB962C8B-B14F-4D97-AF65-F5344CB8AC3E}">
        <p14:creationId xmlns:p14="http://schemas.microsoft.com/office/powerpoint/2010/main" val="31590913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A849F45-B3F0-9518-84DF-64752D6FF2E9}"/>
              </a:ext>
            </a:extLst>
          </p:cNvPr>
          <p:cNvSpPr txBox="1"/>
          <p:nvPr/>
        </p:nvSpPr>
        <p:spPr>
          <a:xfrm>
            <a:off x="493276" y="241812"/>
            <a:ext cx="21107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9</a:t>
            </a:r>
          </a:p>
        </p:txBody>
      </p: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73BE2E9E-B473-D255-F9C3-A8A75736943B}"/>
              </a:ext>
            </a:extLst>
          </p:cNvPr>
          <p:cNvGrpSpPr/>
          <p:nvPr/>
        </p:nvGrpSpPr>
        <p:grpSpPr>
          <a:xfrm>
            <a:off x="2035300" y="600917"/>
            <a:ext cx="8378164" cy="5614546"/>
            <a:chOff x="2117186" y="246075"/>
            <a:chExt cx="8378164" cy="561454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AE25BBD-B11C-9330-0676-EB06B9FB68EC}"/>
                </a:ext>
              </a:extLst>
            </p:cNvPr>
            <p:cNvSpPr txBox="1"/>
            <p:nvPr/>
          </p:nvSpPr>
          <p:spPr>
            <a:xfrm>
              <a:off x="2605644" y="1089732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535F1B1-FDA6-9796-2D6A-1850FCB94875}"/>
                </a:ext>
              </a:extLst>
            </p:cNvPr>
            <p:cNvSpPr txBox="1"/>
            <p:nvPr/>
          </p:nvSpPr>
          <p:spPr>
            <a:xfrm>
              <a:off x="2577432" y="3613439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23424BA-E704-6218-7813-BD7AFE0493A4}"/>
                </a:ext>
              </a:extLst>
            </p:cNvPr>
            <p:cNvSpPr txBox="1"/>
            <p:nvPr/>
          </p:nvSpPr>
          <p:spPr>
            <a:xfrm>
              <a:off x="2577432" y="4882118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4B0710-4B50-D899-553B-7B7F8AA8CB75}"/>
                </a:ext>
              </a:extLst>
            </p:cNvPr>
            <p:cNvSpPr txBox="1"/>
            <p:nvPr/>
          </p:nvSpPr>
          <p:spPr>
            <a:xfrm>
              <a:off x="2117186" y="3021738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E647834-9607-DA01-870C-4A16309EC7A5}"/>
                </a:ext>
              </a:extLst>
            </p:cNvPr>
            <p:cNvSpPr txBox="1"/>
            <p:nvPr/>
          </p:nvSpPr>
          <p:spPr>
            <a:xfrm>
              <a:off x="2577432" y="2365256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8F15E8F7-0ED2-3A0C-42C3-919003796F4F}"/>
                </a:ext>
              </a:extLst>
            </p:cNvPr>
            <p:cNvGrpSpPr/>
            <p:nvPr/>
          </p:nvGrpSpPr>
          <p:grpSpPr>
            <a:xfrm>
              <a:off x="4518418" y="254168"/>
              <a:ext cx="1624013" cy="1754187"/>
              <a:chOff x="5590556" y="570924"/>
              <a:chExt cx="1624013" cy="1754187"/>
            </a:xfrm>
          </p:grpSpPr>
          <p:graphicFrame>
            <p:nvGraphicFramePr>
              <p:cNvPr id="15" name="Object 14">
                <a:extLst>
                  <a:ext uri="{FF2B5EF4-FFF2-40B4-BE49-F238E27FC236}">
                    <a16:creationId xmlns:a16="http://schemas.microsoft.com/office/drawing/2014/main" id="{A712BE5D-9257-A8E5-C877-B8DF57A3D81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02293439"/>
                  </p:ext>
                </p:extLst>
              </p:nvPr>
            </p:nvGraphicFramePr>
            <p:xfrm>
              <a:off x="5590556" y="570924"/>
              <a:ext cx="1624013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3" imgW="1624474" imgH="1754208" progId="SigmaPlotGraphicObject.12">
                      <p:embed/>
                    </p:oleObj>
                  </mc:Choice>
                  <mc:Fallback>
                    <p:oleObj name="SPW 13.0 Graph" r:id="rId3" imgW="162447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5590556" y="570924"/>
                            <a:ext cx="1624013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EF2B31E-5C53-CC83-8615-7655C8232488}"/>
                  </a:ext>
                </a:extLst>
              </p:cNvPr>
              <p:cNvSpPr txBox="1"/>
              <p:nvPr/>
            </p:nvSpPr>
            <p:spPr>
              <a:xfrm>
                <a:off x="6329264" y="1769625"/>
                <a:ext cx="311544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†</a:t>
                </a:r>
                <a:endParaRPr lang="en-US" sz="500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40FF2A2-BB5D-8D2D-85D7-1BBC125A81B2}"/>
                  </a:ext>
                </a:extLst>
              </p:cNvPr>
              <p:cNvSpPr txBox="1"/>
              <p:nvPr/>
            </p:nvSpPr>
            <p:spPr>
              <a:xfrm>
                <a:off x="6215996" y="1012413"/>
                <a:ext cx="30078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912D79D-5AC7-2FC3-7F74-A1D94D098380}"/>
                  </a:ext>
                </a:extLst>
              </p:cNvPr>
              <p:cNvSpPr txBox="1"/>
              <p:nvPr/>
            </p:nvSpPr>
            <p:spPr>
              <a:xfrm>
                <a:off x="6229039" y="958949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x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F6A3E942-CD9F-7BCD-5748-DD3A0FF59C32}"/>
                  </a:ext>
                </a:extLst>
              </p:cNvPr>
              <p:cNvSpPr txBox="1"/>
              <p:nvPr/>
            </p:nvSpPr>
            <p:spPr>
              <a:xfrm>
                <a:off x="6813437" y="1706241"/>
                <a:ext cx="311544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</a:t>
                </a:r>
                <a:endParaRPr lang="en-US" sz="500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0BA421D-65AC-C82D-D125-77650A4CA3E3}"/>
                  </a:ext>
                </a:extLst>
              </p:cNvPr>
              <p:cNvSpPr txBox="1"/>
              <p:nvPr/>
            </p:nvSpPr>
            <p:spPr>
              <a:xfrm>
                <a:off x="6683984" y="1229549"/>
                <a:ext cx="30078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621205D0-0C6D-4EFA-58C5-77830DAD27A5}"/>
                </a:ext>
              </a:extLst>
            </p:cNvPr>
            <p:cNvGrpSpPr/>
            <p:nvPr/>
          </p:nvGrpSpPr>
          <p:grpSpPr>
            <a:xfrm>
              <a:off x="3037010" y="253010"/>
              <a:ext cx="1624013" cy="1754187"/>
              <a:chOff x="2016469" y="539170"/>
              <a:chExt cx="1624013" cy="1754187"/>
            </a:xfrm>
          </p:grpSpPr>
          <p:graphicFrame>
            <p:nvGraphicFramePr>
              <p:cNvPr id="4" name="Object 3">
                <a:extLst>
                  <a:ext uri="{FF2B5EF4-FFF2-40B4-BE49-F238E27FC236}">
                    <a16:creationId xmlns:a16="http://schemas.microsoft.com/office/drawing/2014/main" id="{70F7B230-A0C0-545E-A9E8-39180842593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31169111"/>
                  </p:ext>
                </p:extLst>
              </p:nvPr>
            </p:nvGraphicFramePr>
            <p:xfrm>
              <a:off x="2016469" y="539170"/>
              <a:ext cx="1624013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5" imgW="1624474" imgH="1754208" progId="SigmaPlotGraphicObject.12">
                      <p:embed/>
                    </p:oleObj>
                  </mc:Choice>
                  <mc:Fallback>
                    <p:oleObj name="SPW 13.0 Graph" r:id="rId5" imgW="162447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016469" y="539170"/>
                            <a:ext cx="1624013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CA6540CB-A665-E020-A90D-D4132BA7C577}"/>
                  </a:ext>
                </a:extLst>
              </p:cNvPr>
              <p:cNvSpPr txBox="1"/>
              <p:nvPr/>
            </p:nvSpPr>
            <p:spPr>
              <a:xfrm>
                <a:off x="2640668" y="973302"/>
                <a:ext cx="2760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EDE5BCD5-F80B-9CA9-510A-8D31DC17222E}"/>
                  </a:ext>
                </a:extLst>
              </p:cNvPr>
              <p:cNvSpPr txBox="1"/>
              <p:nvPr/>
            </p:nvSpPr>
            <p:spPr>
              <a:xfrm>
                <a:off x="3124621" y="1167260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5289253-4D8D-C403-2BDA-080D247D1F2F}"/>
                  </a:ext>
                </a:extLst>
              </p:cNvPr>
              <p:cNvSpPr txBox="1"/>
              <p:nvPr/>
            </p:nvSpPr>
            <p:spPr>
              <a:xfrm>
                <a:off x="2656462" y="930628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x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4DD5EE0-80EA-0A63-C2C9-398FA596B4D8}"/>
                  </a:ext>
                </a:extLst>
              </p:cNvPr>
              <p:cNvSpPr txBox="1"/>
              <p:nvPr/>
            </p:nvSpPr>
            <p:spPr>
              <a:xfrm>
                <a:off x="2752641" y="1661736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†</a:t>
                </a:r>
                <a:endParaRPr lang="en-US" sz="500" dirty="0"/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DDD35B64-0A51-929B-F6CC-FB0BD8A248F2}"/>
                </a:ext>
              </a:extLst>
            </p:cNvPr>
            <p:cNvGrpSpPr/>
            <p:nvPr/>
          </p:nvGrpSpPr>
          <p:grpSpPr>
            <a:xfrm>
              <a:off x="3146519" y="1536341"/>
              <a:ext cx="1519237" cy="1754187"/>
              <a:chOff x="2063579" y="1967219"/>
              <a:chExt cx="1519237" cy="1754187"/>
            </a:xfrm>
          </p:grpSpPr>
          <p:graphicFrame>
            <p:nvGraphicFramePr>
              <p:cNvPr id="19" name="Object 18">
                <a:extLst>
                  <a:ext uri="{FF2B5EF4-FFF2-40B4-BE49-F238E27FC236}">
                    <a16:creationId xmlns:a16="http://schemas.microsoft.com/office/drawing/2014/main" id="{D3A5ABDD-4E45-C3D2-5D02-0FC5834699E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71447274"/>
                  </p:ext>
                </p:extLst>
              </p:nvPr>
            </p:nvGraphicFramePr>
            <p:xfrm>
              <a:off x="2063579" y="1967219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7" imgW="1519494" imgH="1754208" progId="SigmaPlotGraphicObject.12">
                      <p:embed/>
                    </p:oleObj>
                  </mc:Choice>
                  <mc:Fallback>
                    <p:oleObj name="SPW 13.0 Graph" r:id="rId7" imgW="151949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063579" y="1967219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0735F5E-88C7-1FCF-4A26-3C5E0DB661C8}"/>
                  </a:ext>
                </a:extLst>
              </p:cNvPr>
              <p:cNvSpPr txBox="1"/>
              <p:nvPr/>
            </p:nvSpPr>
            <p:spPr>
              <a:xfrm>
                <a:off x="2609650" y="2495921"/>
                <a:ext cx="2151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23D66974-2FF0-45D3-8F2C-E51C8685F77E}"/>
                  </a:ext>
                </a:extLst>
              </p:cNvPr>
              <p:cNvSpPr txBox="1"/>
              <p:nvPr/>
            </p:nvSpPr>
            <p:spPr>
              <a:xfrm>
                <a:off x="3165336" y="3126361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</a:t>
                </a:r>
                <a:endParaRPr lang="en-US" sz="500" dirty="0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A4F0076-E9DA-3409-E98C-7F3C82D532E0}"/>
                  </a:ext>
                </a:extLst>
              </p:cNvPr>
              <p:cNvSpPr txBox="1"/>
              <p:nvPr/>
            </p:nvSpPr>
            <p:spPr>
              <a:xfrm>
                <a:off x="2954690" y="2996028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8B9C9215-8B4C-3F30-87CC-1AE9FA6B7C75}"/>
                  </a:ext>
                </a:extLst>
              </p:cNvPr>
              <p:cNvSpPr txBox="1"/>
              <p:nvPr/>
            </p:nvSpPr>
            <p:spPr>
              <a:xfrm>
                <a:off x="3069158" y="2540910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72DEE30B-2F17-04D3-CB60-DDDED121F895}"/>
                  </a:ext>
                </a:extLst>
              </p:cNvPr>
              <p:cNvSpPr txBox="1"/>
              <p:nvPr/>
            </p:nvSpPr>
            <p:spPr>
              <a:xfrm>
                <a:off x="3054713" y="2587630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B3A31554-5F33-2313-D6BE-6F668A59222E}"/>
                </a:ext>
              </a:extLst>
            </p:cNvPr>
            <p:cNvGrpSpPr/>
            <p:nvPr/>
          </p:nvGrpSpPr>
          <p:grpSpPr>
            <a:xfrm>
              <a:off x="4518418" y="1540413"/>
              <a:ext cx="1624013" cy="1754187"/>
              <a:chOff x="5354917" y="2075984"/>
              <a:chExt cx="1624013" cy="1754187"/>
            </a:xfrm>
          </p:grpSpPr>
          <p:graphicFrame>
            <p:nvGraphicFramePr>
              <p:cNvPr id="22" name="Object 21">
                <a:extLst>
                  <a:ext uri="{FF2B5EF4-FFF2-40B4-BE49-F238E27FC236}">
                    <a16:creationId xmlns:a16="http://schemas.microsoft.com/office/drawing/2014/main" id="{24C995E2-8332-1F32-A468-108A0879CD4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60531247"/>
                  </p:ext>
                </p:extLst>
              </p:nvPr>
            </p:nvGraphicFramePr>
            <p:xfrm>
              <a:off x="5354917" y="2075984"/>
              <a:ext cx="1624013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9" imgW="1624474" imgH="1754208" progId="SigmaPlotGraphicObject.12">
                      <p:embed/>
                    </p:oleObj>
                  </mc:Choice>
                  <mc:Fallback>
                    <p:oleObj name="SPW 13.0 Graph" r:id="rId9" imgW="162447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5354917" y="2075984"/>
                            <a:ext cx="1624013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813491DC-C172-44E1-46D2-B58164455CDF}"/>
                  </a:ext>
                </a:extLst>
              </p:cNvPr>
              <p:cNvSpPr txBox="1"/>
              <p:nvPr/>
            </p:nvSpPr>
            <p:spPr>
              <a:xfrm>
                <a:off x="6550394" y="3196496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†</a:t>
                </a:r>
                <a:endParaRPr lang="en-US" sz="500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EA6F634-2C90-AD97-402D-364189BA54EE}"/>
                  </a:ext>
                </a:extLst>
              </p:cNvPr>
              <p:cNvSpPr txBox="1"/>
              <p:nvPr/>
            </p:nvSpPr>
            <p:spPr>
              <a:xfrm>
                <a:off x="6564806" y="3255709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xx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CB712A2F-EAF7-62B6-53ED-0286D2FB72BD}"/>
                  </a:ext>
                </a:extLst>
              </p:cNvPr>
              <p:cNvSpPr txBox="1"/>
              <p:nvPr/>
            </p:nvSpPr>
            <p:spPr>
              <a:xfrm>
                <a:off x="6450562" y="2649671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96EB5EC0-BC3E-1D10-3594-2723E061C9B5}"/>
                  </a:ext>
                </a:extLst>
              </p:cNvPr>
              <p:cNvSpPr txBox="1"/>
              <p:nvPr/>
            </p:nvSpPr>
            <p:spPr>
              <a:xfrm>
                <a:off x="6353237" y="3117411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75059EC6-2026-5432-DCF7-CAA754A0DB38}"/>
                </a:ext>
              </a:extLst>
            </p:cNvPr>
            <p:cNvGrpSpPr/>
            <p:nvPr/>
          </p:nvGrpSpPr>
          <p:grpSpPr>
            <a:xfrm>
              <a:off x="3072601" y="2825187"/>
              <a:ext cx="1589087" cy="1754187"/>
              <a:chOff x="2026521" y="3318029"/>
              <a:chExt cx="1589087" cy="1754187"/>
            </a:xfrm>
          </p:grpSpPr>
          <p:graphicFrame>
            <p:nvGraphicFramePr>
              <p:cNvPr id="25" name="Object 24">
                <a:extLst>
                  <a:ext uri="{FF2B5EF4-FFF2-40B4-BE49-F238E27FC236}">
                    <a16:creationId xmlns:a16="http://schemas.microsoft.com/office/drawing/2014/main" id="{6395527A-5292-48A6-560F-A620818D97E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12223251"/>
                  </p:ext>
                </p:extLst>
              </p:nvPr>
            </p:nvGraphicFramePr>
            <p:xfrm>
              <a:off x="2026521" y="3318029"/>
              <a:ext cx="158908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1" imgW="1589480" imgH="1754208" progId="SigmaPlotGraphicObject.12">
                      <p:embed/>
                    </p:oleObj>
                  </mc:Choice>
                  <mc:Fallback>
                    <p:oleObj name="SPW 13.0 Graph" r:id="rId11" imgW="1589480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2026521" y="3318029"/>
                            <a:ext cx="158908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93C0C4D3-4FF3-2849-69FC-6F55F0ABEEE5}"/>
                  </a:ext>
                </a:extLst>
              </p:cNvPr>
              <p:cNvSpPr txBox="1"/>
              <p:nvPr/>
            </p:nvSpPr>
            <p:spPr>
              <a:xfrm>
                <a:off x="2871071" y="4457989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54FABA5A-C63E-C092-853A-9ECFFC8B03C7}"/>
                  </a:ext>
                </a:extLst>
              </p:cNvPr>
              <p:cNvSpPr txBox="1"/>
              <p:nvPr/>
            </p:nvSpPr>
            <p:spPr>
              <a:xfrm>
                <a:off x="3097870" y="4100840"/>
                <a:ext cx="2151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6CC9E420-7364-9277-E2EC-0A611ECE3566}"/>
                </a:ext>
              </a:extLst>
            </p:cNvPr>
            <p:cNvGrpSpPr/>
            <p:nvPr/>
          </p:nvGrpSpPr>
          <p:grpSpPr>
            <a:xfrm>
              <a:off x="4518420" y="2820719"/>
              <a:ext cx="1624013" cy="1754187"/>
              <a:chOff x="5211111" y="3370658"/>
              <a:chExt cx="1624013" cy="1754187"/>
            </a:xfrm>
          </p:grpSpPr>
          <p:graphicFrame>
            <p:nvGraphicFramePr>
              <p:cNvPr id="28" name="Object 27">
                <a:extLst>
                  <a:ext uri="{FF2B5EF4-FFF2-40B4-BE49-F238E27FC236}">
                    <a16:creationId xmlns:a16="http://schemas.microsoft.com/office/drawing/2014/main" id="{3AC4FDA6-D981-D7CA-D5DF-A662F342319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08560409"/>
                  </p:ext>
                </p:extLst>
              </p:nvPr>
            </p:nvGraphicFramePr>
            <p:xfrm>
              <a:off x="5211111" y="3370658"/>
              <a:ext cx="1624013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3" imgW="1624474" imgH="1754208" progId="SigmaPlotGraphicObject.12">
                      <p:embed/>
                    </p:oleObj>
                  </mc:Choice>
                  <mc:Fallback>
                    <p:oleObj name="SPW 13.0 Graph" r:id="rId13" imgW="162447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5211111" y="3370658"/>
                            <a:ext cx="1624013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25202584-339D-56D9-5623-3F36AB6B7BBD}"/>
                  </a:ext>
                </a:extLst>
              </p:cNvPr>
              <p:cNvSpPr txBox="1"/>
              <p:nvPr/>
            </p:nvSpPr>
            <p:spPr>
              <a:xfrm>
                <a:off x="6207578" y="4352795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3BDB4C0F-679C-CC06-701D-6123760665A7}"/>
                  </a:ext>
                </a:extLst>
              </p:cNvPr>
              <p:cNvSpPr txBox="1"/>
              <p:nvPr/>
            </p:nvSpPr>
            <p:spPr>
              <a:xfrm>
                <a:off x="6322439" y="3996978"/>
                <a:ext cx="2151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01F12B54-8402-789B-C55A-4E5E936733AD}"/>
                  </a:ext>
                </a:extLst>
              </p:cNvPr>
              <p:cNvSpPr txBox="1"/>
              <p:nvPr/>
            </p:nvSpPr>
            <p:spPr>
              <a:xfrm>
                <a:off x="6433167" y="4481778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</a:t>
                </a:r>
                <a:endParaRPr lang="en-US" sz="500" dirty="0"/>
              </a:p>
            </p:txBody>
          </p: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D36B0923-72A3-87B4-731D-B98FD4A682F7}"/>
                </a:ext>
              </a:extLst>
            </p:cNvPr>
            <p:cNvGrpSpPr/>
            <p:nvPr/>
          </p:nvGrpSpPr>
          <p:grpSpPr>
            <a:xfrm>
              <a:off x="3072601" y="4104723"/>
              <a:ext cx="1589087" cy="1754187"/>
              <a:chOff x="1981391" y="4681665"/>
              <a:chExt cx="1589087" cy="1754187"/>
            </a:xfrm>
          </p:grpSpPr>
          <p:graphicFrame>
            <p:nvGraphicFramePr>
              <p:cNvPr id="33" name="Object 32">
                <a:extLst>
                  <a:ext uri="{FF2B5EF4-FFF2-40B4-BE49-F238E27FC236}">
                    <a16:creationId xmlns:a16="http://schemas.microsoft.com/office/drawing/2014/main" id="{36063E2E-613E-9A44-BFCF-B001F560E82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40724179"/>
                  </p:ext>
                </p:extLst>
              </p:nvPr>
            </p:nvGraphicFramePr>
            <p:xfrm>
              <a:off x="1981391" y="4681665"/>
              <a:ext cx="158908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5" imgW="1589480" imgH="1754208" progId="SigmaPlotGraphicObject.12">
                      <p:embed/>
                    </p:oleObj>
                  </mc:Choice>
                  <mc:Fallback>
                    <p:oleObj name="SPW 13.0 Graph" r:id="rId15" imgW="1589480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981391" y="4681665"/>
                            <a:ext cx="158908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DF6048A-9136-8297-4826-ABBA623AA88E}"/>
                  </a:ext>
                </a:extLst>
              </p:cNvPr>
              <p:cNvSpPr txBox="1"/>
              <p:nvPr/>
            </p:nvSpPr>
            <p:spPr>
              <a:xfrm>
                <a:off x="3142407" y="5603874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†</a:t>
                </a:r>
                <a:endParaRPr lang="en-US" sz="500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BA59F8DE-3667-F2DB-E932-BE6D3E9C9813}"/>
                  </a:ext>
                </a:extLst>
              </p:cNvPr>
              <p:cNvSpPr txBox="1"/>
              <p:nvPr/>
            </p:nvSpPr>
            <p:spPr>
              <a:xfrm>
                <a:off x="3171824" y="5662355"/>
                <a:ext cx="21352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86279F83-F97B-A849-E5B4-EAF5D7E489DE}"/>
                  </a:ext>
                </a:extLst>
              </p:cNvPr>
              <p:cNvSpPr txBox="1"/>
              <p:nvPr/>
            </p:nvSpPr>
            <p:spPr>
              <a:xfrm>
                <a:off x="3025041" y="5260700"/>
                <a:ext cx="2760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365D93B1-51DA-7E62-0EC4-4259EE7E7856}"/>
                  </a:ext>
                </a:extLst>
              </p:cNvPr>
              <p:cNvSpPr txBox="1"/>
              <p:nvPr/>
            </p:nvSpPr>
            <p:spPr>
              <a:xfrm>
                <a:off x="2586723" y="5121786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5DE8F4BA-C3C9-4BBE-EBF8-96BB17F4239B}"/>
                  </a:ext>
                </a:extLst>
              </p:cNvPr>
              <p:cNvSpPr txBox="1"/>
              <p:nvPr/>
            </p:nvSpPr>
            <p:spPr>
              <a:xfrm>
                <a:off x="2698700" y="5335491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</a:t>
                </a:r>
                <a:endParaRPr lang="en-US" sz="500" dirty="0"/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0BC9D473-47ED-B27E-0291-C8E4F51877EC}"/>
                </a:ext>
              </a:extLst>
            </p:cNvPr>
            <p:cNvGrpSpPr/>
            <p:nvPr/>
          </p:nvGrpSpPr>
          <p:grpSpPr>
            <a:xfrm>
              <a:off x="4625190" y="4106434"/>
              <a:ext cx="1519237" cy="1754187"/>
              <a:chOff x="5313816" y="4837113"/>
              <a:chExt cx="1519237" cy="1754187"/>
            </a:xfrm>
          </p:grpSpPr>
          <p:graphicFrame>
            <p:nvGraphicFramePr>
              <p:cNvPr id="36" name="Object 35">
                <a:extLst>
                  <a:ext uri="{FF2B5EF4-FFF2-40B4-BE49-F238E27FC236}">
                    <a16:creationId xmlns:a16="http://schemas.microsoft.com/office/drawing/2014/main" id="{E0FAAC3F-6506-7A14-107C-DD92EA0FB43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43639249"/>
                  </p:ext>
                </p:extLst>
              </p:nvPr>
            </p:nvGraphicFramePr>
            <p:xfrm>
              <a:off x="5313816" y="4837113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7" imgW="1519494" imgH="1754208" progId="SigmaPlotGraphicObject.12">
                      <p:embed/>
                    </p:oleObj>
                  </mc:Choice>
                  <mc:Fallback>
                    <p:oleObj name="SPW 13.0 Graph" r:id="rId17" imgW="1519494" imgH="1754208" progId="SigmaPlotGraphicObjec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5313816" y="4837113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742133B0-5589-4E9C-1C9A-A6D0A48A6B1E}"/>
                  </a:ext>
                </a:extLst>
              </p:cNvPr>
              <p:cNvSpPr txBox="1"/>
              <p:nvPr/>
            </p:nvSpPr>
            <p:spPr>
              <a:xfrm>
                <a:off x="5831515" y="5302509"/>
                <a:ext cx="2760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B6156EF-795F-4138-651C-ABE0FDC1E991}"/>
                  </a:ext>
                </a:extLst>
              </p:cNvPr>
              <p:cNvSpPr txBox="1"/>
              <p:nvPr/>
            </p:nvSpPr>
            <p:spPr>
              <a:xfrm>
                <a:off x="6424711" y="5967154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#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7C34D638-9B5E-7861-95F1-8AE9CD00A126}"/>
                  </a:ext>
                </a:extLst>
              </p:cNvPr>
              <p:cNvSpPr txBox="1"/>
              <p:nvPr/>
            </p:nvSpPr>
            <p:spPr>
              <a:xfrm>
                <a:off x="5746549" y="5530435"/>
                <a:ext cx="2151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992DD6AF-A222-75F8-B3C4-1B0BD4C0F70B}"/>
                  </a:ext>
                </a:extLst>
              </p:cNvPr>
              <p:cNvSpPr txBox="1"/>
              <p:nvPr/>
            </p:nvSpPr>
            <p:spPr>
              <a:xfrm>
                <a:off x="6303549" y="5502115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0A8B99AA-51AA-ED69-6EFF-0014DCDB4283}"/>
                  </a:ext>
                </a:extLst>
              </p:cNvPr>
              <p:cNvSpPr txBox="1"/>
              <p:nvPr/>
            </p:nvSpPr>
            <p:spPr>
              <a:xfrm>
                <a:off x="6422330" y="5900583"/>
                <a:ext cx="288616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b="1" i="0" u="none" strike="noStrike" baseline="0" dirty="0"/>
                  <a:t>††</a:t>
                </a:r>
                <a:endParaRPr lang="en-US" sz="500" dirty="0"/>
              </a:p>
            </p:txBody>
          </p:sp>
        </p:grp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5B273969-2C18-87D1-DB64-3195B5E2284B}"/>
                </a:ext>
              </a:extLst>
            </p:cNvPr>
            <p:cNvGrpSpPr/>
            <p:nvPr/>
          </p:nvGrpSpPr>
          <p:grpSpPr>
            <a:xfrm>
              <a:off x="5901712" y="825222"/>
              <a:ext cx="628698" cy="4708599"/>
              <a:chOff x="7321798" y="572212"/>
              <a:chExt cx="628698" cy="4708599"/>
            </a:xfrm>
          </p:grpSpPr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59898132-B65D-5F2B-CA21-656A36D472EB}"/>
                  </a:ext>
                </a:extLst>
              </p:cNvPr>
              <p:cNvGrpSpPr/>
              <p:nvPr/>
            </p:nvGrpSpPr>
            <p:grpSpPr>
              <a:xfrm>
                <a:off x="7321798" y="4444156"/>
                <a:ext cx="628698" cy="836655"/>
                <a:chOff x="7499847" y="4881069"/>
                <a:chExt cx="628698" cy="836655"/>
              </a:xfrm>
            </p:grpSpPr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4C8FCF60-9103-1803-7462-0548D7413660}"/>
                    </a:ext>
                  </a:extLst>
                </p:cNvPr>
                <p:cNvSpPr txBox="1"/>
                <p:nvPr/>
              </p:nvSpPr>
              <p:spPr>
                <a:xfrm>
                  <a:off x="7499847" y="5194504"/>
                  <a:ext cx="62869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: Control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: +1,4-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: +DC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: +DMNQ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3190513C-ED0D-2A5F-3F82-5058CF40D204}"/>
                    </a:ext>
                  </a:extLst>
                </p:cNvPr>
                <p:cNvSpPr txBox="1"/>
                <p:nvPr/>
              </p:nvSpPr>
              <p:spPr>
                <a:xfrm>
                  <a:off x="7617918" y="4881069"/>
                  <a:ext cx="4940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CAD95E9B-450A-CB9A-D64A-95E0BCCB70FB}"/>
                    </a:ext>
                  </a:extLst>
                </p:cNvPr>
                <p:cNvSpPr txBox="1"/>
                <p:nvPr/>
              </p:nvSpPr>
              <p:spPr>
                <a:xfrm>
                  <a:off x="7614710" y="5022391"/>
                  <a:ext cx="4972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lt;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2" name="Rectangle 111">
                  <a:extLst>
                    <a:ext uri="{FF2B5EF4-FFF2-40B4-BE49-F238E27FC236}">
                      <a16:creationId xmlns:a16="http://schemas.microsoft.com/office/drawing/2014/main" id="{52269D74-52DA-4EF4-19CF-BEC85C29092C}"/>
                    </a:ext>
                  </a:extLst>
                </p:cNvPr>
                <p:cNvSpPr/>
                <p:nvPr/>
              </p:nvSpPr>
              <p:spPr>
                <a:xfrm>
                  <a:off x="7560330" y="4930631"/>
                  <a:ext cx="103361" cy="103361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13" name="Rectangle 112">
                  <a:extLst>
                    <a:ext uri="{FF2B5EF4-FFF2-40B4-BE49-F238E27FC236}">
                      <a16:creationId xmlns:a16="http://schemas.microsoft.com/office/drawing/2014/main" id="{55D117FB-5E4C-BD02-8E90-4171CF0A25E8}"/>
                    </a:ext>
                  </a:extLst>
                </p:cNvPr>
                <p:cNvSpPr/>
                <p:nvPr/>
              </p:nvSpPr>
              <p:spPr>
                <a:xfrm>
                  <a:off x="7562282" y="5071849"/>
                  <a:ext cx="103361" cy="103361"/>
                </a:xfrm>
                <a:prstGeom prst="rect">
                  <a:avLst/>
                </a:prstGeom>
                <a:solidFill>
                  <a:srgbClr val="0A04EC"/>
                </a:solidFill>
                <a:ln w="3175">
                  <a:solidFill>
                    <a:srgbClr val="0A04EC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  <p:grpSp>
            <p:nvGrpSpPr>
              <p:cNvPr id="115" name="Group 114">
                <a:extLst>
                  <a:ext uri="{FF2B5EF4-FFF2-40B4-BE49-F238E27FC236}">
                    <a16:creationId xmlns:a16="http://schemas.microsoft.com/office/drawing/2014/main" id="{6EAD7F9F-EDB4-5C01-68AB-CD6DBF71FE9E}"/>
                  </a:ext>
                </a:extLst>
              </p:cNvPr>
              <p:cNvGrpSpPr/>
              <p:nvPr/>
            </p:nvGrpSpPr>
            <p:grpSpPr>
              <a:xfrm>
                <a:off x="7321798" y="1862860"/>
                <a:ext cx="628698" cy="836655"/>
                <a:chOff x="7499847" y="4881069"/>
                <a:chExt cx="628698" cy="836655"/>
              </a:xfrm>
            </p:grpSpPr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D0734DF0-7A13-3861-304E-DA10E4F8DABC}"/>
                    </a:ext>
                  </a:extLst>
                </p:cNvPr>
                <p:cNvSpPr txBox="1"/>
                <p:nvPr/>
              </p:nvSpPr>
              <p:spPr>
                <a:xfrm>
                  <a:off x="7499847" y="5194504"/>
                  <a:ext cx="62869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: Control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: +1,4-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: +DC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: +DMNQ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4DD0FC8C-9644-409F-0876-6373D6403C0E}"/>
                    </a:ext>
                  </a:extLst>
                </p:cNvPr>
                <p:cNvSpPr txBox="1"/>
                <p:nvPr/>
              </p:nvSpPr>
              <p:spPr>
                <a:xfrm>
                  <a:off x="7617918" y="4881069"/>
                  <a:ext cx="4940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EF1AAB13-1608-06E1-8032-4974352CC437}"/>
                    </a:ext>
                  </a:extLst>
                </p:cNvPr>
                <p:cNvSpPr txBox="1"/>
                <p:nvPr/>
              </p:nvSpPr>
              <p:spPr>
                <a:xfrm>
                  <a:off x="7614710" y="5022391"/>
                  <a:ext cx="4972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lt;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19" name="Rectangle 118">
                  <a:extLst>
                    <a:ext uri="{FF2B5EF4-FFF2-40B4-BE49-F238E27FC236}">
                      <a16:creationId xmlns:a16="http://schemas.microsoft.com/office/drawing/2014/main" id="{5CCB1A20-C08F-72FF-F74B-0E00788A6771}"/>
                    </a:ext>
                  </a:extLst>
                </p:cNvPr>
                <p:cNvSpPr/>
                <p:nvPr/>
              </p:nvSpPr>
              <p:spPr>
                <a:xfrm>
                  <a:off x="7560330" y="4930631"/>
                  <a:ext cx="103361" cy="103361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20" name="Rectangle 119">
                  <a:extLst>
                    <a:ext uri="{FF2B5EF4-FFF2-40B4-BE49-F238E27FC236}">
                      <a16:creationId xmlns:a16="http://schemas.microsoft.com/office/drawing/2014/main" id="{F5912299-B506-FA31-0456-EA538E431E1C}"/>
                    </a:ext>
                  </a:extLst>
                </p:cNvPr>
                <p:cNvSpPr/>
                <p:nvPr/>
              </p:nvSpPr>
              <p:spPr>
                <a:xfrm>
                  <a:off x="7562282" y="5071849"/>
                  <a:ext cx="103361" cy="103361"/>
                </a:xfrm>
                <a:prstGeom prst="rect">
                  <a:avLst/>
                </a:prstGeom>
                <a:solidFill>
                  <a:srgbClr val="0A04EC"/>
                </a:solidFill>
                <a:ln w="3175">
                  <a:solidFill>
                    <a:srgbClr val="0A04EC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AE5D7D03-88D8-233A-6933-29CD40120A45}"/>
                  </a:ext>
                </a:extLst>
              </p:cNvPr>
              <p:cNvGrpSpPr/>
              <p:nvPr/>
            </p:nvGrpSpPr>
            <p:grpSpPr>
              <a:xfrm>
                <a:off x="7321798" y="572212"/>
                <a:ext cx="628698" cy="836655"/>
                <a:chOff x="7499847" y="4881069"/>
                <a:chExt cx="628698" cy="836655"/>
              </a:xfrm>
            </p:grpSpPr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27AA9F31-32AF-C19D-833C-21887325A1A2}"/>
                    </a:ext>
                  </a:extLst>
                </p:cNvPr>
                <p:cNvSpPr txBox="1"/>
                <p:nvPr/>
              </p:nvSpPr>
              <p:spPr>
                <a:xfrm>
                  <a:off x="7499847" y="5194504"/>
                  <a:ext cx="62869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: Control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: +1,4-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: +DC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: +DMNQ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49D45E4F-54E8-A242-40FD-2BC6C3344E83}"/>
                    </a:ext>
                  </a:extLst>
                </p:cNvPr>
                <p:cNvSpPr txBox="1"/>
                <p:nvPr/>
              </p:nvSpPr>
              <p:spPr>
                <a:xfrm>
                  <a:off x="7617918" y="4881069"/>
                  <a:ext cx="4940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6C9EEB40-447B-E791-B337-9A3CF7C3F2C8}"/>
                    </a:ext>
                  </a:extLst>
                </p:cNvPr>
                <p:cNvSpPr txBox="1"/>
                <p:nvPr/>
              </p:nvSpPr>
              <p:spPr>
                <a:xfrm>
                  <a:off x="7614710" y="5022391"/>
                  <a:ext cx="4972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lt;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25" name="Rectangle 124">
                  <a:extLst>
                    <a:ext uri="{FF2B5EF4-FFF2-40B4-BE49-F238E27FC236}">
                      <a16:creationId xmlns:a16="http://schemas.microsoft.com/office/drawing/2014/main" id="{491184C7-8A78-3551-DA52-C4B05002BE4E}"/>
                    </a:ext>
                  </a:extLst>
                </p:cNvPr>
                <p:cNvSpPr/>
                <p:nvPr/>
              </p:nvSpPr>
              <p:spPr>
                <a:xfrm>
                  <a:off x="7560330" y="4930631"/>
                  <a:ext cx="103361" cy="103361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26" name="Rectangle 125">
                  <a:extLst>
                    <a:ext uri="{FF2B5EF4-FFF2-40B4-BE49-F238E27FC236}">
                      <a16:creationId xmlns:a16="http://schemas.microsoft.com/office/drawing/2014/main" id="{1053B36E-F10B-8956-ABBB-1FEAEC3F73A2}"/>
                    </a:ext>
                  </a:extLst>
                </p:cNvPr>
                <p:cNvSpPr/>
                <p:nvPr/>
              </p:nvSpPr>
              <p:spPr>
                <a:xfrm>
                  <a:off x="7562282" y="5071849"/>
                  <a:ext cx="103361" cy="103361"/>
                </a:xfrm>
                <a:prstGeom prst="rect">
                  <a:avLst/>
                </a:prstGeom>
                <a:solidFill>
                  <a:srgbClr val="0A04EC"/>
                </a:solidFill>
                <a:ln w="3175">
                  <a:solidFill>
                    <a:srgbClr val="0A04EC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AF99908D-7BCC-5A6D-E12B-4151AF40D8D3}"/>
                  </a:ext>
                </a:extLst>
              </p:cNvPr>
              <p:cNvGrpSpPr/>
              <p:nvPr/>
            </p:nvGrpSpPr>
            <p:grpSpPr>
              <a:xfrm>
                <a:off x="7321798" y="3153508"/>
                <a:ext cx="628698" cy="836655"/>
                <a:chOff x="7499847" y="4881069"/>
                <a:chExt cx="628698" cy="836655"/>
              </a:xfrm>
            </p:grpSpPr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16C355F0-33E8-00B0-A316-8BD05E7FBA20}"/>
                    </a:ext>
                  </a:extLst>
                </p:cNvPr>
                <p:cNvSpPr txBox="1"/>
                <p:nvPr/>
              </p:nvSpPr>
              <p:spPr>
                <a:xfrm>
                  <a:off x="7499847" y="5194504"/>
                  <a:ext cx="628698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: Control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: +1,4-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: +DCNQ</a:t>
                  </a:r>
                </a:p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: +DMNQ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6A4C3461-F5FF-ED6D-8931-5B256351B28B}"/>
                    </a:ext>
                  </a:extLst>
                </p:cNvPr>
                <p:cNvSpPr txBox="1"/>
                <p:nvPr/>
              </p:nvSpPr>
              <p:spPr>
                <a:xfrm>
                  <a:off x="7617918" y="4881069"/>
                  <a:ext cx="4940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90D3A985-EF55-D181-87F9-6226A530D47F}"/>
                    </a:ext>
                  </a:extLst>
                </p:cNvPr>
                <p:cNvSpPr txBox="1"/>
                <p:nvPr/>
              </p:nvSpPr>
              <p:spPr>
                <a:xfrm>
                  <a:off x="7614710" y="5022391"/>
                  <a:ext cx="4972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lt;1% O</a:t>
                  </a:r>
                  <a:r>
                    <a:rPr lang="en-US" sz="7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31" name="Rectangle 130">
                  <a:extLst>
                    <a:ext uri="{FF2B5EF4-FFF2-40B4-BE49-F238E27FC236}">
                      <a16:creationId xmlns:a16="http://schemas.microsoft.com/office/drawing/2014/main" id="{18B8688E-71B5-27FD-8A31-C805EE3602AD}"/>
                    </a:ext>
                  </a:extLst>
                </p:cNvPr>
                <p:cNvSpPr/>
                <p:nvPr/>
              </p:nvSpPr>
              <p:spPr>
                <a:xfrm>
                  <a:off x="7560330" y="4930631"/>
                  <a:ext cx="103361" cy="103361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132" name="Rectangle 131">
                  <a:extLst>
                    <a:ext uri="{FF2B5EF4-FFF2-40B4-BE49-F238E27FC236}">
                      <a16:creationId xmlns:a16="http://schemas.microsoft.com/office/drawing/2014/main" id="{7E13FFB8-F439-13AA-D82A-B5DAA0A49F7B}"/>
                    </a:ext>
                  </a:extLst>
                </p:cNvPr>
                <p:cNvSpPr/>
                <p:nvPr/>
              </p:nvSpPr>
              <p:spPr>
                <a:xfrm>
                  <a:off x="7562282" y="5071849"/>
                  <a:ext cx="103361" cy="103361"/>
                </a:xfrm>
                <a:prstGeom prst="rect">
                  <a:avLst/>
                </a:prstGeom>
                <a:solidFill>
                  <a:srgbClr val="0A04EC"/>
                </a:solidFill>
                <a:ln w="3175">
                  <a:solidFill>
                    <a:srgbClr val="0A04EC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</p:grp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544822C-6CFF-227B-7045-E45C93A3276B}"/>
                </a:ext>
              </a:extLst>
            </p:cNvPr>
            <p:cNvSpPr txBox="1"/>
            <p:nvPr/>
          </p:nvSpPr>
          <p:spPr>
            <a:xfrm>
              <a:off x="2706066" y="439722"/>
              <a:ext cx="34492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9DB4B78B-1759-B1DB-82CD-2A8E30910DC8}"/>
                </a:ext>
              </a:extLst>
            </p:cNvPr>
            <p:cNvGrpSpPr/>
            <p:nvPr/>
          </p:nvGrpSpPr>
          <p:grpSpPr>
            <a:xfrm>
              <a:off x="9875672" y="785207"/>
              <a:ext cx="612117" cy="922372"/>
              <a:chOff x="7499847" y="4881069"/>
              <a:chExt cx="612117" cy="922372"/>
            </a:xfrm>
          </p:grpSpPr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40D296B8-96FB-9359-1F2E-592B71DA7D75}"/>
                  </a:ext>
                </a:extLst>
              </p:cNvPr>
              <p:cNvSpPr txBox="1"/>
              <p:nvPr/>
            </p:nvSpPr>
            <p:spPr>
              <a:xfrm>
                <a:off x="7499847" y="5172499"/>
                <a:ext cx="526106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Source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D24C8EBD-A8F9-A897-7AC9-10BFD29AB371}"/>
                  </a:ext>
                </a:extLst>
              </p:cNvPr>
              <p:cNvSpPr txBox="1"/>
              <p:nvPr/>
            </p:nvSpPr>
            <p:spPr>
              <a:xfrm>
                <a:off x="7617918" y="4881069"/>
                <a:ext cx="4940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99DF5FB6-FBA1-6C3A-D0CD-D49362368A3B}"/>
                  </a:ext>
                </a:extLst>
              </p:cNvPr>
              <p:cNvSpPr txBox="1"/>
              <p:nvPr/>
            </p:nvSpPr>
            <p:spPr>
              <a:xfrm>
                <a:off x="7614710" y="5022391"/>
                <a:ext cx="4972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42" name="Rectangle 141">
                <a:extLst>
                  <a:ext uri="{FF2B5EF4-FFF2-40B4-BE49-F238E27FC236}">
                    <a16:creationId xmlns:a16="http://schemas.microsoft.com/office/drawing/2014/main" id="{1053E6FC-F920-B415-AD44-7BC03692CE15}"/>
                  </a:ext>
                </a:extLst>
              </p:cNvPr>
              <p:cNvSpPr/>
              <p:nvPr/>
            </p:nvSpPr>
            <p:spPr>
              <a:xfrm>
                <a:off x="7560330" y="4930631"/>
                <a:ext cx="103361" cy="103361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43" name="Rectangle 142">
                <a:extLst>
                  <a:ext uri="{FF2B5EF4-FFF2-40B4-BE49-F238E27FC236}">
                    <a16:creationId xmlns:a16="http://schemas.microsoft.com/office/drawing/2014/main" id="{8EC055C9-EDDD-A9A3-C507-F79A45499A94}"/>
                  </a:ext>
                </a:extLst>
              </p:cNvPr>
              <p:cNvSpPr/>
              <p:nvPr/>
            </p:nvSpPr>
            <p:spPr>
              <a:xfrm>
                <a:off x="7562282" y="5071849"/>
                <a:ext cx="103361" cy="103361"/>
              </a:xfrm>
              <a:prstGeom prst="rect">
                <a:avLst/>
              </a:prstGeom>
              <a:solidFill>
                <a:srgbClr val="0A04EC"/>
              </a:solidFill>
              <a:ln w="3175">
                <a:solidFill>
                  <a:srgbClr val="0A04E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78FD4FD6-F0B0-65E8-27FE-C16FE42288BF}"/>
                </a:ext>
              </a:extLst>
            </p:cNvPr>
            <p:cNvSpPr txBox="1"/>
            <p:nvPr/>
          </p:nvSpPr>
          <p:spPr>
            <a:xfrm>
              <a:off x="6753505" y="446834"/>
              <a:ext cx="34492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FF003C8F-4D78-920E-1A8F-371D1606BFC7}"/>
                </a:ext>
              </a:extLst>
            </p:cNvPr>
            <p:cNvGrpSpPr/>
            <p:nvPr/>
          </p:nvGrpSpPr>
          <p:grpSpPr>
            <a:xfrm>
              <a:off x="6638640" y="1052609"/>
              <a:ext cx="594488" cy="4102016"/>
              <a:chOff x="6333840" y="1183237"/>
              <a:chExt cx="594488" cy="4102016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012C7A3-502F-07BE-395B-BCE8C26B2F24}"/>
                  </a:ext>
                </a:extLst>
              </p:cNvPr>
              <p:cNvSpPr txBox="1"/>
              <p:nvPr/>
            </p:nvSpPr>
            <p:spPr>
              <a:xfrm>
                <a:off x="6333840" y="1183237"/>
                <a:ext cx="5944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D80ADC5-2A0B-CFEA-16F3-B7FF73865BB2}"/>
                  </a:ext>
                </a:extLst>
              </p:cNvPr>
              <p:cNvSpPr txBox="1"/>
              <p:nvPr/>
            </p:nvSpPr>
            <p:spPr>
              <a:xfrm>
                <a:off x="6333840" y="2475169"/>
                <a:ext cx="5944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,4-NQ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DF3846A-6ACA-A292-C8E0-5A8C0521AFE3}"/>
                  </a:ext>
                </a:extLst>
              </p:cNvPr>
              <p:cNvSpPr txBox="1"/>
              <p:nvPr/>
            </p:nvSpPr>
            <p:spPr>
              <a:xfrm>
                <a:off x="6333840" y="3757148"/>
                <a:ext cx="5944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CNQ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E107338-BA24-1F1B-9C17-CC9C720AA7C7}"/>
                  </a:ext>
                </a:extLst>
              </p:cNvPr>
              <p:cNvSpPr txBox="1"/>
              <p:nvPr/>
            </p:nvSpPr>
            <p:spPr>
              <a:xfrm>
                <a:off x="6333840" y="5039032"/>
                <a:ext cx="5944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MNQ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20F6A716-1BBD-7BC1-5A2A-511E905884F5}"/>
                </a:ext>
              </a:extLst>
            </p:cNvPr>
            <p:cNvGrpSpPr/>
            <p:nvPr/>
          </p:nvGrpSpPr>
          <p:grpSpPr>
            <a:xfrm>
              <a:off x="7131767" y="249281"/>
              <a:ext cx="1591408" cy="5610220"/>
              <a:chOff x="6826967" y="379909"/>
              <a:chExt cx="1591408" cy="5610220"/>
            </a:xfrm>
          </p:grpSpPr>
          <p:graphicFrame>
            <p:nvGraphicFramePr>
              <p:cNvPr id="23" name="Object 22">
                <a:extLst>
                  <a:ext uri="{FF2B5EF4-FFF2-40B4-BE49-F238E27FC236}">
                    <a16:creationId xmlns:a16="http://schemas.microsoft.com/office/drawing/2014/main" id="{C758B19E-2E10-F62A-888A-74ED1FDFBF2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80255382"/>
                  </p:ext>
                </p:extLst>
              </p:nvPr>
            </p:nvGraphicFramePr>
            <p:xfrm>
              <a:off x="6899138" y="379909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19" imgW="1519494" imgH="1754208" progId="SigmaPlotGraphicObject.12">
                      <p:embed/>
                    </p:oleObj>
                  </mc:Choice>
                  <mc:Fallback>
                    <p:oleObj name="SPW 13.0 Graph" r:id="rId19" imgW="1519494" imgH="1754208" progId="SigmaPlotGraphicObject.12">
                      <p:embed/>
                      <p:pic>
                        <p:nvPicPr>
                          <p:cNvPr id="4" name="Object 3">
                            <a:extLst>
                              <a:ext uri="{FF2B5EF4-FFF2-40B4-BE49-F238E27FC236}">
                                <a16:creationId xmlns:a16="http://schemas.microsoft.com/office/drawing/2014/main" id="{1BF02652-394D-9F82-41DE-B3627975556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6899138" y="379909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4" name="Object 23">
                <a:extLst>
                  <a:ext uri="{FF2B5EF4-FFF2-40B4-BE49-F238E27FC236}">
                    <a16:creationId xmlns:a16="http://schemas.microsoft.com/office/drawing/2014/main" id="{ED4898D4-A6A4-99BC-796D-E867D277587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43923138"/>
                  </p:ext>
                </p:extLst>
              </p:nvPr>
            </p:nvGraphicFramePr>
            <p:xfrm>
              <a:off x="6827914" y="1665469"/>
              <a:ext cx="158908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1" imgW="1589480" imgH="1754208" progId="SigmaPlotGraphicObject.12">
                      <p:embed/>
                    </p:oleObj>
                  </mc:Choice>
                  <mc:Fallback>
                    <p:oleObj name="SPW 13.0 Graph" r:id="rId21" imgW="1589480" imgH="1754208" progId="SigmaPlotGraphicObject.12">
                      <p:embed/>
                      <p:pic>
                        <p:nvPicPr>
                          <p:cNvPr id="5" name="Object 4">
                            <a:extLst>
                              <a:ext uri="{FF2B5EF4-FFF2-40B4-BE49-F238E27FC236}">
                                <a16:creationId xmlns:a16="http://schemas.microsoft.com/office/drawing/2014/main" id="{F9314CC4-0918-0352-D6E1-DCD0758404D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6827914" y="1665469"/>
                            <a:ext cx="158908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1" name="Object 30">
                <a:extLst>
                  <a:ext uri="{FF2B5EF4-FFF2-40B4-BE49-F238E27FC236}">
                    <a16:creationId xmlns:a16="http://schemas.microsoft.com/office/drawing/2014/main" id="{B615DB47-71A0-EF36-ED85-12C9DE3EACB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76687941"/>
                  </p:ext>
                </p:extLst>
              </p:nvPr>
            </p:nvGraphicFramePr>
            <p:xfrm>
              <a:off x="6828260" y="2953561"/>
              <a:ext cx="158908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3" imgW="1589480" imgH="1754208" progId="SigmaPlotGraphicObject.12">
                      <p:embed/>
                    </p:oleObj>
                  </mc:Choice>
                  <mc:Fallback>
                    <p:oleObj name="SPW 13.0 Graph" r:id="rId23" imgW="1589480" imgH="1754208" progId="SigmaPlotGraphicObject.12">
                      <p:embed/>
                      <p:pic>
                        <p:nvPicPr>
                          <p:cNvPr id="15" name="Object 14">
                            <a:extLst>
                              <a:ext uri="{FF2B5EF4-FFF2-40B4-BE49-F238E27FC236}">
                                <a16:creationId xmlns:a16="http://schemas.microsoft.com/office/drawing/2014/main" id="{34A1767A-128D-F520-145C-B9DBF7534B1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6828260" y="2953561"/>
                            <a:ext cx="158908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2" name="Object 31">
                <a:extLst>
                  <a:ext uri="{FF2B5EF4-FFF2-40B4-BE49-F238E27FC236}">
                    <a16:creationId xmlns:a16="http://schemas.microsoft.com/office/drawing/2014/main" id="{F98433D6-A399-6699-A458-E2C9F7D8DD0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21103592"/>
                  </p:ext>
                </p:extLst>
              </p:nvPr>
            </p:nvGraphicFramePr>
            <p:xfrm>
              <a:off x="6826967" y="4235942"/>
              <a:ext cx="158908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5" imgW="1589480" imgH="1754208" progId="SigmaPlotGraphicObject.12">
                      <p:embed/>
                    </p:oleObj>
                  </mc:Choice>
                  <mc:Fallback>
                    <p:oleObj name="SPW 13.0 Graph" r:id="rId25" imgW="1589480" imgH="1754208" progId="SigmaPlotGraphicObject.12">
                      <p:embed/>
                      <p:pic>
                        <p:nvPicPr>
                          <p:cNvPr id="16" name="Object 15">
                            <a:extLst>
                              <a:ext uri="{FF2B5EF4-FFF2-40B4-BE49-F238E27FC236}">
                                <a16:creationId xmlns:a16="http://schemas.microsoft.com/office/drawing/2014/main" id="{277A6C29-57B1-DDB7-2402-2335F84576E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6"/>
                          <a:stretch>
                            <a:fillRect/>
                          </a:stretch>
                        </p:blipFill>
                        <p:spPr>
                          <a:xfrm>
                            <a:off x="6826967" y="4235942"/>
                            <a:ext cx="158908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4D4223FE-54E3-26E6-8D04-09E2633D05A6}"/>
                </a:ext>
              </a:extLst>
            </p:cNvPr>
            <p:cNvGrpSpPr/>
            <p:nvPr/>
          </p:nvGrpSpPr>
          <p:grpSpPr>
            <a:xfrm>
              <a:off x="8596366" y="246075"/>
              <a:ext cx="1520987" cy="5611538"/>
              <a:chOff x="8291566" y="376703"/>
              <a:chExt cx="1520987" cy="5611538"/>
            </a:xfrm>
          </p:grpSpPr>
          <p:graphicFrame>
            <p:nvGraphicFramePr>
              <p:cNvPr id="40" name="Object 39">
                <a:extLst>
                  <a:ext uri="{FF2B5EF4-FFF2-40B4-BE49-F238E27FC236}">
                    <a16:creationId xmlns:a16="http://schemas.microsoft.com/office/drawing/2014/main" id="{0134E4E1-19C1-5E63-B54B-3DC27BB1A3C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83703074"/>
                  </p:ext>
                </p:extLst>
              </p:nvPr>
            </p:nvGraphicFramePr>
            <p:xfrm>
              <a:off x="8293299" y="376703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7" imgW="1519494" imgH="1754208" progId="SigmaPlotGraphicObject.12">
                      <p:embed/>
                    </p:oleObj>
                  </mc:Choice>
                  <mc:Fallback>
                    <p:oleObj name="SPW 13.0 Graph" r:id="rId27" imgW="1519494" imgH="1754208" progId="SigmaPlotGraphicObject.12">
                      <p:embed/>
                      <p:pic>
                        <p:nvPicPr>
                          <p:cNvPr id="17" name="Object 16">
                            <a:extLst>
                              <a:ext uri="{FF2B5EF4-FFF2-40B4-BE49-F238E27FC236}">
                                <a16:creationId xmlns:a16="http://schemas.microsoft.com/office/drawing/2014/main" id="{AA436A20-A7EC-D76E-3989-B8C8C06EAE2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8"/>
                          <a:stretch>
                            <a:fillRect/>
                          </a:stretch>
                        </p:blipFill>
                        <p:spPr>
                          <a:xfrm>
                            <a:off x="8293299" y="376703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2" name="Object 41">
                <a:extLst>
                  <a:ext uri="{FF2B5EF4-FFF2-40B4-BE49-F238E27FC236}">
                    <a16:creationId xmlns:a16="http://schemas.microsoft.com/office/drawing/2014/main" id="{6E6F4391-5BAD-DF73-5C68-71C206826BD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05173310"/>
                  </p:ext>
                </p:extLst>
              </p:nvPr>
            </p:nvGraphicFramePr>
            <p:xfrm>
              <a:off x="8293316" y="1660765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29" imgW="1519494" imgH="1754208" progId="SigmaPlotGraphicObject.12">
                      <p:embed/>
                    </p:oleObj>
                  </mc:Choice>
                  <mc:Fallback>
                    <p:oleObj name="SPW 13.0 Graph" r:id="rId29" imgW="1519494" imgH="1754208" progId="SigmaPlotGraphicObject.12">
                      <p:embed/>
                      <p:pic>
                        <p:nvPicPr>
                          <p:cNvPr id="18" name="Object 17">
                            <a:extLst>
                              <a:ext uri="{FF2B5EF4-FFF2-40B4-BE49-F238E27FC236}">
                                <a16:creationId xmlns:a16="http://schemas.microsoft.com/office/drawing/2014/main" id="{CB17FD0C-5FEE-8159-5395-9B7B9B6ED7A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8293316" y="1660765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3" name="Object 42">
                <a:extLst>
                  <a:ext uri="{FF2B5EF4-FFF2-40B4-BE49-F238E27FC236}">
                    <a16:creationId xmlns:a16="http://schemas.microsoft.com/office/drawing/2014/main" id="{0396282C-04FC-F5FB-F744-002E076D3C0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4673498"/>
                  </p:ext>
                </p:extLst>
              </p:nvPr>
            </p:nvGraphicFramePr>
            <p:xfrm>
              <a:off x="8291566" y="2953684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31" imgW="1519494" imgH="1754208" progId="SigmaPlotGraphicObject.12">
                      <p:embed/>
                    </p:oleObj>
                  </mc:Choice>
                  <mc:Fallback>
                    <p:oleObj name="SPW 13.0 Graph" r:id="rId31" imgW="1519494" imgH="1754208" progId="SigmaPlotGraphicObject.12">
                      <p:embed/>
                      <p:pic>
                        <p:nvPicPr>
                          <p:cNvPr id="19" name="Object 18">
                            <a:extLst>
                              <a:ext uri="{FF2B5EF4-FFF2-40B4-BE49-F238E27FC236}">
                                <a16:creationId xmlns:a16="http://schemas.microsoft.com/office/drawing/2014/main" id="{CB2FBA61-1D5A-7E18-2713-DCA43DD152B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8291566" y="2953684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6" name="Object 45">
                <a:extLst>
                  <a:ext uri="{FF2B5EF4-FFF2-40B4-BE49-F238E27FC236}">
                    <a16:creationId xmlns:a16="http://schemas.microsoft.com/office/drawing/2014/main" id="{EBD8B807-E409-5CA5-0A67-5F547ABC524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83018147"/>
                  </p:ext>
                </p:extLst>
              </p:nvPr>
            </p:nvGraphicFramePr>
            <p:xfrm>
              <a:off x="8293091" y="4234054"/>
              <a:ext cx="1519237" cy="1754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SPW 13.0 Graph" r:id="rId33" imgW="1519494" imgH="1754208" progId="SigmaPlotGraphicObject.12">
                      <p:embed/>
                    </p:oleObj>
                  </mc:Choice>
                  <mc:Fallback>
                    <p:oleObj name="SPW 13.0 Graph" r:id="rId33" imgW="1519494" imgH="1754208" progId="SigmaPlotGraphicObject.12">
                      <p:embed/>
                      <p:pic>
                        <p:nvPicPr>
                          <p:cNvPr id="20" name="Object 19">
                            <a:extLst>
                              <a:ext uri="{FF2B5EF4-FFF2-40B4-BE49-F238E27FC236}">
                                <a16:creationId xmlns:a16="http://schemas.microsoft.com/office/drawing/2014/main" id="{7AC24C70-F4DA-59FD-EAB8-936F36191A8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"/>
                          <a:stretch>
                            <a:fillRect/>
                          </a:stretch>
                        </p:blipFill>
                        <p:spPr>
                          <a:xfrm>
                            <a:off x="8293091" y="4234054"/>
                            <a:ext cx="1519237" cy="1754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533BFED1-AB3C-54AA-FAB2-99B2E61BA7FC}"/>
                </a:ext>
              </a:extLst>
            </p:cNvPr>
            <p:cNvGrpSpPr/>
            <p:nvPr/>
          </p:nvGrpSpPr>
          <p:grpSpPr>
            <a:xfrm>
              <a:off x="9876049" y="2076645"/>
              <a:ext cx="612117" cy="922372"/>
              <a:chOff x="7499847" y="4881069"/>
              <a:chExt cx="612117" cy="922372"/>
            </a:xfrm>
          </p:grpSpPr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775DDABC-AA49-F083-AC38-56B790434917}"/>
                  </a:ext>
                </a:extLst>
              </p:cNvPr>
              <p:cNvSpPr txBox="1"/>
              <p:nvPr/>
            </p:nvSpPr>
            <p:spPr>
              <a:xfrm>
                <a:off x="7499847" y="5172499"/>
                <a:ext cx="526106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Source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BF778A7C-1E44-279E-411E-A81F55695097}"/>
                  </a:ext>
                </a:extLst>
              </p:cNvPr>
              <p:cNvSpPr txBox="1"/>
              <p:nvPr/>
            </p:nvSpPr>
            <p:spPr>
              <a:xfrm>
                <a:off x="7617918" y="4881069"/>
                <a:ext cx="4940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0280E179-92F8-00C8-4624-85DEBE8453DB}"/>
                  </a:ext>
                </a:extLst>
              </p:cNvPr>
              <p:cNvSpPr txBox="1"/>
              <p:nvPr/>
            </p:nvSpPr>
            <p:spPr>
              <a:xfrm>
                <a:off x="7614710" y="5022391"/>
                <a:ext cx="4972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EAB7B0AD-8782-C143-65BC-BA37EB6C4C41}"/>
                  </a:ext>
                </a:extLst>
              </p:cNvPr>
              <p:cNvSpPr/>
              <p:nvPr/>
            </p:nvSpPr>
            <p:spPr>
              <a:xfrm>
                <a:off x="7560330" y="4930631"/>
                <a:ext cx="103361" cy="103361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78" name="Rectangle 77">
                <a:extLst>
                  <a:ext uri="{FF2B5EF4-FFF2-40B4-BE49-F238E27FC236}">
                    <a16:creationId xmlns:a16="http://schemas.microsoft.com/office/drawing/2014/main" id="{53AAACE8-F8F9-10B4-345D-28566E85EA52}"/>
                  </a:ext>
                </a:extLst>
              </p:cNvPr>
              <p:cNvSpPr/>
              <p:nvPr/>
            </p:nvSpPr>
            <p:spPr>
              <a:xfrm>
                <a:off x="7562282" y="5071849"/>
                <a:ext cx="103361" cy="103361"/>
              </a:xfrm>
              <a:prstGeom prst="rect">
                <a:avLst/>
              </a:prstGeom>
              <a:solidFill>
                <a:srgbClr val="0A04EC"/>
              </a:solidFill>
              <a:ln w="3175">
                <a:solidFill>
                  <a:srgbClr val="0A04E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392D8FDA-263F-F114-6FB2-1F87CB3A226D}"/>
                </a:ext>
              </a:extLst>
            </p:cNvPr>
            <p:cNvGrpSpPr/>
            <p:nvPr/>
          </p:nvGrpSpPr>
          <p:grpSpPr>
            <a:xfrm>
              <a:off x="9883233" y="3354469"/>
              <a:ext cx="612117" cy="922372"/>
              <a:chOff x="7499847" y="4881069"/>
              <a:chExt cx="612117" cy="922372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F2D97722-0AEB-1332-6311-F2CF9A085A51}"/>
                  </a:ext>
                </a:extLst>
              </p:cNvPr>
              <p:cNvSpPr txBox="1"/>
              <p:nvPr/>
            </p:nvSpPr>
            <p:spPr>
              <a:xfrm>
                <a:off x="7499847" y="5172499"/>
                <a:ext cx="526106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Source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4B2AE92-4158-1074-D480-06EC8192FAA4}"/>
                  </a:ext>
                </a:extLst>
              </p:cNvPr>
              <p:cNvSpPr txBox="1"/>
              <p:nvPr/>
            </p:nvSpPr>
            <p:spPr>
              <a:xfrm>
                <a:off x="7617918" y="4881069"/>
                <a:ext cx="4940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081FDE1-A283-D28D-12CF-01EB78210D55}"/>
                  </a:ext>
                </a:extLst>
              </p:cNvPr>
              <p:cNvSpPr txBox="1"/>
              <p:nvPr/>
            </p:nvSpPr>
            <p:spPr>
              <a:xfrm>
                <a:off x="7614710" y="5022391"/>
                <a:ext cx="4972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AAD4F036-8A22-4ABD-DEE7-010A794D731C}"/>
                  </a:ext>
                </a:extLst>
              </p:cNvPr>
              <p:cNvSpPr/>
              <p:nvPr/>
            </p:nvSpPr>
            <p:spPr>
              <a:xfrm>
                <a:off x="7560330" y="4930631"/>
                <a:ext cx="103361" cy="103361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C3F977CA-87EE-DBEC-BCF6-624B54FBF8B2}"/>
                  </a:ext>
                </a:extLst>
              </p:cNvPr>
              <p:cNvSpPr/>
              <p:nvPr/>
            </p:nvSpPr>
            <p:spPr>
              <a:xfrm>
                <a:off x="7562282" y="5071849"/>
                <a:ext cx="103361" cy="103361"/>
              </a:xfrm>
              <a:prstGeom prst="rect">
                <a:avLst/>
              </a:prstGeom>
              <a:solidFill>
                <a:srgbClr val="0A04EC"/>
              </a:solidFill>
              <a:ln w="3175">
                <a:solidFill>
                  <a:srgbClr val="0A04E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00F70C98-3052-B54B-B35D-352212C2E84B}"/>
                </a:ext>
              </a:extLst>
            </p:cNvPr>
            <p:cNvGrpSpPr/>
            <p:nvPr/>
          </p:nvGrpSpPr>
          <p:grpSpPr>
            <a:xfrm>
              <a:off x="9879072" y="4632293"/>
              <a:ext cx="612117" cy="922372"/>
              <a:chOff x="7499847" y="4881069"/>
              <a:chExt cx="612117" cy="922372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6693BA61-1F7E-D5B5-BBD4-3556EC49B282}"/>
                  </a:ext>
                </a:extLst>
              </p:cNvPr>
              <p:cNvSpPr txBox="1"/>
              <p:nvPr/>
            </p:nvSpPr>
            <p:spPr>
              <a:xfrm>
                <a:off x="7499847" y="5172499"/>
                <a:ext cx="526106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Source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: Na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583D0835-EB0C-B3A3-F3A4-B2A0156B6A6C}"/>
                  </a:ext>
                </a:extLst>
              </p:cNvPr>
              <p:cNvSpPr txBox="1"/>
              <p:nvPr/>
            </p:nvSpPr>
            <p:spPr>
              <a:xfrm>
                <a:off x="7617918" y="4881069"/>
                <a:ext cx="4940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03461118-0FB9-710D-85AE-1B1B1EC671C0}"/>
                  </a:ext>
                </a:extLst>
              </p:cNvPr>
              <p:cNvSpPr txBox="1"/>
              <p:nvPr/>
            </p:nvSpPr>
            <p:spPr>
              <a:xfrm>
                <a:off x="7614710" y="5022391"/>
                <a:ext cx="4972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1% O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id="{EEFF311D-FD15-36D2-B07B-358A75567BEF}"/>
                  </a:ext>
                </a:extLst>
              </p:cNvPr>
              <p:cNvSpPr/>
              <p:nvPr/>
            </p:nvSpPr>
            <p:spPr>
              <a:xfrm>
                <a:off x="7560330" y="4930631"/>
                <a:ext cx="103361" cy="103361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05" name="Rectangle 104">
                <a:extLst>
                  <a:ext uri="{FF2B5EF4-FFF2-40B4-BE49-F238E27FC236}">
                    <a16:creationId xmlns:a16="http://schemas.microsoft.com/office/drawing/2014/main" id="{2495D729-0338-ED67-A6B4-F347BCF63C3E}"/>
                  </a:ext>
                </a:extLst>
              </p:cNvPr>
              <p:cNvSpPr/>
              <p:nvPr/>
            </p:nvSpPr>
            <p:spPr>
              <a:xfrm>
                <a:off x="7562282" y="5071849"/>
                <a:ext cx="103361" cy="103361"/>
              </a:xfrm>
              <a:prstGeom prst="rect">
                <a:avLst/>
              </a:prstGeom>
              <a:solidFill>
                <a:srgbClr val="0A04EC"/>
              </a:solidFill>
              <a:ln w="3175">
                <a:solidFill>
                  <a:srgbClr val="0A04E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C392121C-4801-8FA8-1D39-D52229220C59}"/>
                </a:ext>
              </a:extLst>
            </p:cNvPr>
            <p:cNvSpPr txBox="1"/>
            <p:nvPr/>
          </p:nvSpPr>
          <p:spPr>
            <a:xfrm>
              <a:off x="7847148" y="492102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H</a:t>
              </a:r>
              <a:endParaRPr lang="en-US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16023D9F-F2CF-A2B8-A3C5-1AFE731538BE}"/>
                </a:ext>
              </a:extLst>
            </p:cNvPr>
            <p:cNvSpPr txBox="1"/>
            <p:nvPr/>
          </p:nvSpPr>
          <p:spPr>
            <a:xfrm>
              <a:off x="9209753" y="489067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H</a:t>
              </a:r>
              <a:endParaRPr lang="en-US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69E2D77-E794-3362-E097-01A7DFB1EAB5}"/>
                </a:ext>
              </a:extLst>
            </p:cNvPr>
            <p:cNvSpPr txBox="1"/>
            <p:nvPr/>
          </p:nvSpPr>
          <p:spPr>
            <a:xfrm>
              <a:off x="3737908" y="500281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H</a:t>
              </a:r>
              <a:endParaRPr lang="en-US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5DADE76-1D0A-F279-2BE0-6BE7914D7653}"/>
                </a:ext>
              </a:extLst>
            </p:cNvPr>
            <p:cNvSpPr txBox="1"/>
            <p:nvPr/>
          </p:nvSpPr>
          <p:spPr>
            <a:xfrm>
              <a:off x="5206900" y="500281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H</a:t>
              </a:r>
              <a:endParaRPr lang="en-US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06210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1407</TotalTime>
  <Words>850</Words>
  <Application>Microsoft Office PowerPoint</Application>
  <PresentationFormat>Widescreen</PresentationFormat>
  <Paragraphs>366</Paragraphs>
  <Slides>9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SPW 13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 Olson</dc:creator>
  <cp:lastModifiedBy>K Olson</cp:lastModifiedBy>
  <cp:revision>970</cp:revision>
  <dcterms:created xsi:type="dcterms:W3CDTF">2022-02-05T13:57:38Z</dcterms:created>
  <dcterms:modified xsi:type="dcterms:W3CDTF">2024-04-08T12:22:36Z</dcterms:modified>
</cp:coreProperties>
</file>